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heme/theme2.xml" ContentType="application/vnd.openxmlformats-officedocument.theme+xml"/>
  <Override PartName="/ppt/tags/tag63.xml" ContentType="application/vnd.openxmlformats-officedocument.presentationml.tags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ags/tag64.xml" ContentType="application/vnd.openxmlformats-officedocument.presentationml.tag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ags/tag65.xml" ContentType="application/vnd.openxmlformats-officedocument.presentationml.tag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ags/tag66.xml" ContentType="application/vnd.openxmlformats-officedocument.presentationml.tag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ags/tag67.xml" ContentType="application/vnd.openxmlformats-officedocument.presentationml.tag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ags/tag68.xml" ContentType="application/vnd.openxmlformats-officedocument.presentationml.tags+xml"/>
  <Override PartName="/ppt/notesSlides/notesSlide1.xml" ContentType="application/vnd.openxmlformats-officedocument.presentationml.notesSl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2"/>
  </p:notesMasterIdLst>
  <p:sldIdLst>
    <p:sldId id="410" r:id="rId2"/>
    <p:sldId id="411" r:id="rId3"/>
    <p:sldId id="412" r:id="rId4"/>
    <p:sldId id="413" r:id="rId5"/>
    <p:sldId id="414" r:id="rId6"/>
    <p:sldId id="415" r:id="rId7"/>
    <p:sldId id="259" r:id="rId8"/>
    <p:sldId id="257" r:id="rId9"/>
    <p:sldId id="347" r:id="rId10"/>
    <p:sldId id="350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30">
          <p15:clr>
            <a:srgbClr val="A4A3A4"/>
          </p15:clr>
        </p15:guide>
        <p15:guide id="2" pos="392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778" autoAdjust="0"/>
    <p:restoredTop sz="77954" autoAdjust="0"/>
  </p:normalViewPr>
  <p:slideViewPr>
    <p:cSldViewPr snapToGrid="0">
      <p:cViewPr>
        <p:scale>
          <a:sx n="100" d="100"/>
          <a:sy n="100" d="100"/>
        </p:scale>
        <p:origin x="978" y="-24"/>
      </p:cViewPr>
      <p:guideLst>
        <p:guide orient="horz" pos="2230"/>
        <p:guide pos="392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5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Zhangxi\AnnumArticle\20200921\V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1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12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13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14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800"/>
              <a:t> CP  </a:t>
            </a:r>
            <a:r>
              <a:rPr lang="en-US" sz="1800"/>
              <a:t>identity</a:t>
            </a:r>
          </a:p>
        </c:rich>
      </c:tx>
      <c:layout>
        <c:manualLayout>
          <c:xMode val="edge"/>
          <c:yMode val="edge"/>
          <c:x val="0.46348520900637868"/>
          <c:y val="4.1666666666666664E-2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2.67586506600033E-2"/>
          <c:y val="0.180555555555556"/>
          <c:w val="0.96129067304036098"/>
          <c:h val="0.68874999999999997"/>
        </c:manualLayout>
      </c:layout>
      <c:lineChart>
        <c:grouping val="standard"/>
        <c:varyColors val="0"/>
        <c:ser>
          <c:idx val="0"/>
          <c:order val="0"/>
          <c:tx>
            <c:strRef>
              <c:f>[工作簿5]Sheet1!$G$1</c:f>
              <c:strCache>
                <c:ptCount val="1"/>
                <c:pt idx="0">
                  <c:v>identity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[工作簿5]Sheet1!$G$2:$G$779</c:f>
              <c:numCache>
                <c:formatCode>General</c:formatCode>
                <c:ptCount val="778"/>
                <c:pt idx="0">
                  <c:v>0.75291828793774296</c:v>
                </c:pt>
                <c:pt idx="1">
                  <c:v>0.75291828793774296</c:v>
                </c:pt>
                <c:pt idx="2">
                  <c:v>0.75291828793774296</c:v>
                </c:pt>
                <c:pt idx="3">
                  <c:v>0.714007782101167</c:v>
                </c:pt>
                <c:pt idx="4">
                  <c:v>0.737354085603113</c:v>
                </c:pt>
                <c:pt idx="5">
                  <c:v>0.75097276264591395</c:v>
                </c:pt>
                <c:pt idx="6">
                  <c:v>0.75291828793774296</c:v>
                </c:pt>
                <c:pt idx="7">
                  <c:v>0.75291828793774296</c:v>
                </c:pt>
                <c:pt idx="8">
                  <c:v>0.75097276264591395</c:v>
                </c:pt>
                <c:pt idx="9">
                  <c:v>0.75097276264591395</c:v>
                </c:pt>
                <c:pt idx="10">
                  <c:v>0.75097276264591395</c:v>
                </c:pt>
                <c:pt idx="11">
                  <c:v>0.69649805447470803</c:v>
                </c:pt>
                <c:pt idx="12">
                  <c:v>0.71789883268482502</c:v>
                </c:pt>
                <c:pt idx="13">
                  <c:v>0.74708171206225704</c:v>
                </c:pt>
                <c:pt idx="14">
                  <c:v>0.64007782101167299</c:v>
                </c:pt>
                <c:pt idx="15">
                  <c:v>0.72178988326848204</c:v>
                </c:pt>
                <c:pt idx="16">
                  <c:v>0.72178988326848204</c:v>
                </c:pt>
                <c:pt idx="17">
                  <c:v>0.71206225680933899</c:v>
                </c:pt>
                <c:pt idx="18">
                  <c:v>0.75291828793774296</c:v>
                </c:pt>
                <c:pt idx="19">
                  <c:v>0.75097276264591395</c:v>
                </c:pt>
                <c:pt idx="20">
                  <c:v>0.74708171206225704</c:v>
                </c:pt>
                <c:pt idx="21">
                  <c:v>0.75097276264591395</c:v>
                </c:pt>
                <c:pt idx="22">
                  <c:v>0.71984435797665403</c:v>
                </c:pt>
                <c:pt idx="23">
                  <c:v>0.75291828793774296</c:v>
                </c:pt>
                <c:pt idx="24">
                  <c:v>0.71789883268482502</c:v>
                </c:pt>
                <c:pt idx="25">
                  <c:v>0.75097276264591395</c:v>
                </c:pt>
                <c:pt idx="26">
                  <c:v>0.70817120622568097</c:v>
                </c:pt>
                <c:pt idx="27">
                  <c:v>0.74513618677042803</c:v>
                </c:pt>
                <c:pt idx="28">
                  <c:v>0.71206225680933899</c:v>
                </c:pt>
                <c:pt idx="29">
                  <c:v>0.71206225680933899</c:v>
                </c:pt>
                <c:pt idx="30">
                  <c:v>0.75097276264591395</c:v>
                </c:pt>
                <c:pt idx="31">
                  <c:v>0.74513618677042803</c:v>
                </c:pt>
                <c:pt idx="32">
                  <c:v>0.71011673151750998</c:v>
                </c:pt>
                <c:pt idx="33">
                  <c:v>0.71206225680933899</c:v>
                </c:pt>
                <c:pt idx="34">
                  <c:v>0.72178988326848204</c:v>
                </c:pt>
                <c:pt idx="35">
                  <c:v>0.72957198443579796</c:v>
                </c:pt>
                <c:pt idx="36">
                  <c:v>0.74708171206225704</c:v>
                </c:pt>
                <c:pt idx="37">
                  <c:v>0.74708171206225704</c:v>
                </c:pt>
                <c:pt idx="38">
                  <c:v>0.71789883268482502</c:v>
                </c:pt>
                <c:pt idx="39">
                  <c:v>0.72178988326848204</c:v>
                </c:pt>
                <c:pt idx="40">
                  <c:v>0.56031128404669295</c:v>
                </c:pt>
                <c:pt idx="41">
                  <c:v>0.70622568093385196</c:v>
                </c:pt>
                <c:pt idx="42">
                  <c:v>0.75097276264591395</c:v>
                </c:pt>
                <c:pt idx="43">
                  <c:v>0.75486381322957197</c:v>
                </c:pt>
                <c:pt idx="44">
                  <c:v>0.72568093385214005</c:v>
                </c:pt>
                <c:pt idx="45">
                  <c:v>0.75486381322957197</c:v>
                </c:pt>
                <c:pt idx="46">
                  <c:v>0.71595330739299601</c:v>
                </c:pt>
                <c:pt idx="47">
                  <c:v>0.71206225680933899</c:v>
                </c:pt>
                <c:pt idx="48">
                  <c:v>0.72373540856031104</c:v>
                </c:pt>
                <c:pt idx="49">
                  <c:v>0.71789883268482502</c:v>
                </c:pt>
                <c:pt idx="50">
                  <c:v>0.71595330739299601</c:v>
                </c:pt>
                <c:pt idx="51">
                  <c:v>0.75680933852140098</c:v>
                </c:pt>
                <c:pt idx="52">
                  <c:v>0.74708171206225704</c:v>
                </c:pt>
                <c:pt idx="53">
                  <c:v>0.74513618677042803</c:v>
                </c:pt>
                <c:pt idx="54">
                  <c:v>0.75486381322957197</c:v>
                </c:pt>
                <c:pt idx="55">
                  <c:v>0.75291828793774296</c:v>
                </c:pt>
                <c:pt idx="56">
                  <c:v>0.72568093385214005</c:v>
                </c:pt>
                <c:pt idx="57">
                  <c:v>0.75097276264591395</c:v>
                </c:pt>
                <c:pt idx="58">
                  <c:v>0.74902723735408605</c:v>
                </c:pt>
                <c:pt idx="59">
                  <c:v>0.75097276264591395</c:v>
                </c:pt>
                <c:pt idx="60">
                  <c:v>0.73929961089494201</c:v>
                </c:pt>
                <c:pt idx="61">
                  <c:v>0.75875486381322998</c:v>
                </c:pt>
                <c:pt idx="62">
                  <c:v>0.72762645914396895</c:v>
                </c:pt>
                <c:pt idx="63">
                  <c:v>0.75875486381322998</c:v>
                </c:pt>
                <c:pt idx="64">
                  <c:v>0.75486381322957197</c:v>
                </c:pt>
                <c:pt idx="65">
                  <c:v>0.74708171206225704</c:v>
                </c:pt>
                <c:pt idx="66">
                  <c:v>0.75875486381322998</c:v>
                </c:pt>
                <c:pt idx="67">
                  <c:v>0.75680933852140098</c:v>
                </c:pt>
                <c:pt idx="68">
                  <c:v>0.75680933852140098</c:v>
                </c:pt>
                <c:pt idx="69">
                  <c:v>0.75680933852140098</c:v>
                </c:pt>
                <c:pt idx="70">
                  <c:v>0.72568093385214005</c:v>
                </c:pt>
                <c:pt idx="71">
                  <c:v>0.72568093385214005</c:v>
                </c:pt>
                <c:pt idx="72">
                  <c:v>0.75680933852140098</c:v>
                </c:pt>
                <c:pt idx="73">
                  <c:v>0.75680933852140098</c:v>
                </c:pt>
                <c:pt idx="74">
                  <c:v>0.72762645914396895</c:v>
                </c:pt>
                <c:pt idx="75">
                  <c:v>0.75680933852140098</c:v>
                </c:pt>
                <c:pt idx="76">
                  <c:v>0.72373540856031104</c:v>
                </c:pt>
                <c:pt idx="77">
                  <c:v>0.65758754863813196</c:v>
                </c:pt>
                <c:pt idx="78">
                  <c:v>0.75875486381322998</c:v>
                </c:pt>
                <c:pt idx="79">
                  <c:v>0.74708171206225704</c:v>
                </c:pt>
                <c:pt idx="80">
                  <c:v>0.74708171206225704</c:v>
                </c:pt>
                <c:pt idx="81">
                  <c:v>0.75486381322957197</c:v>
                </c:pt>
                <c:pt idx="82">
                  <c:v>0.73929961089494201</c:v>
                </c:pt>
                <c:pt idx="83">
                  <c:v>0.72762645914396895</c:v>
                </c:pt>
                <c:pt idx="84">
                  <c:v>0.72762645914396895</c:v>
                </c:pt>
                <c:pt idx="85">
                  <c:v>0.65953307392996097</c:v>
                </c:pt>
                <c:pt idx="86">
                  <c:v>0.76070038910505799</c:v>
                </c:pt>
                <c:pt idx="87">
                  <c:v>0.75486381322957197</c:v>
                </c:pt>
                <c:pt idx="88">
                  <c:v>0.72762645914396895</c:v>
                </c:pt>
                <c:pt idx="89">
                  <c:v>0.75097276264591395</c:v>
                </c:pt>
                <c:pt idx="90">
                  <c:v>0.75680933852140098</c:v>
                </c:pt>
                <c:pt idx="91">
                  <c:v>0.75486381322957197</c:v>
                </c:pt>
                <c:pt idx="92">
                  <c:v>0.72568093385214005</c:v>
                </c:pt>
                <c:pt idx="93">
                  <c:v>0.72373540856031104</c:v>
                </c:pt>
                <c:pt idx="94">
                  <c:v>0.75097276264591395</c:v>
                </c:pt>
                <c:pt idx="95">
                  <c:v>0.75486381322957197</c:v>
                </c:pt>
                <c:pt idx="96">
                  <c:v>0.75486381322957197</c:v>
                </c:pt>
                <c:pt idx="97">
                  <c:v>0.64007782101167299</c:v>
                </c:pt>
                <c:pt idx="98">
                  <c:v>0.75680933852140098</c:v>
                </c:pt>
                <c:pt idx="99">
                  <c:v>0.75680933852140098</c:v>
                </c:pt>
                <c:pt idx="100">
                  <c:v>0.75486381322957197</c:v>
                </c:pt>
                <c:pt idx="101">
                  <c:v>0.75291828793774296</c:v>
                </c:pt>
                <c:pt idx="102">
                  <c:v>0.75680933852140098</c:v>
                </c:pt>
                <c:pt idx="103">
                  <c:v>0.72178988326848204</c:v>
                </c:pt>
                <c:pt idx="104">
                  <c:v>0.75680933852140098</c:v>
                </c:pt>
                <c:pt idx="105">
                  <c:v>0.75486381322957197</c:v>
                </c:pt>
                <c:pt idx="106">
                  <c:v>0.72373540856031104</c:v>
                </c:pt>
                <c:pt idx="107">
                  <c:v>0.75291828793774296</c:v>
                </c:pt>
                <c:pt idx="108">
                  <c:v>0.75875486381322998</c:v>
                </c:pt>
                <c:pt idx="109">
                  <c:v>0.71595330739299601</c:v>
                </c:pt>
                <c:pt idx="110">
                  <c:v>0.75680933852140098</c:v>
                </c:pt>
                <c:pt idx="111">
                  <c:v>0.75875486381322998</c:v>
                </c:pt>
                <c:pt idx="112">
                  <c:v>0.75486381322957197</c:v>
                </c:pt>
                <c:pt idx="113">
                  <c:v>0.75486381322957197</c:v>
                </c:pt>
                <c:pt idx="114">
                  <c:v>0.75680933852140098</c:v>
                </c:pt>
                <c:pt idx="115">
                  <c:v>0.65175097276264604</c:v>
                </c:pt>
                <c:pt idx="116">
                  <c:v>0.72762645914396895</c:v>
                </c:pt>
                <c:pt idx="117">
                  <c:v>0.72568093385214005</c:v>
                </c:pt>
                <c:pt idx="118">
                  <c:v>0.71789883268482502</c:v>
                </c:pt>
                <c:pt idx="119">
                  <c:v>0.72762645914396895</c:v>
                </c:pt>
                <c:pt idx="120">
                  <c:v>0.72568093385214005</c:v>
                </c:pt>
                <c:pt idx="121">
                  <c:v>0.74513618677042803</c:v>
                </c:pt>
                <c:pt idx="122">
                  <c:v>0.71984435797665403</c:v>
                </c:pt>
                <c:pt idx="123">
                  <c:v>0.72762645914396895</c:v>
                </c:pt>
                <c:pt idx="124">
                  <c:v>0.72762645914396895</c:v>
                </c:pt>
                <c:pt idx="125">
                  <c:v>0.68287937743190696</c:v>
                </c:pt>
                <c:pt idx="126">
                  <c:v>0.75875486381322998</c:v>
                </c:pt>
                <c:pt idx="127">
                  <c:v>0.75291828793774296</c:v>
                </c:pt>
                <c:pt idx="128">
                  <c:v>0.71984435797665403</c:v>
                </c:pt>
                <c:pt idx="129">
                  <c:v>0.72178988326848204</c:v>
                </c:pt>
                <c:pt idx="130">
                  <c:v>0.72568093385214005</c:v>
                </c:pt>
                <c:pt idx="131">
                  <c:v>0.74124513618677002</c:v>
                </c:pt>
                <c:pt idx="132">
                  <c:v>0.72762645914396895</c:v>
                </c:pt>
                <c:pt idx="133">
                  <c:v>0.72568093385214005</c:v>
                </c:pt>
                <c:pt idx="134">
                  <c:v>0.72178988326848204</c:v>
                </c:pt>
                <c:pt idx="135">
                  <c:v>0.72568093385214005</c:v>
                </c:pt>
                <c:pt idx="136">
                  <c:v>0.72178988326848204</c:v>
                </c:pt>
                <c:pt idx="137">
                  <c:v>0.75680933852140098</c:v>
                </c:pt>
                <c:pt idx="138">
                  <c:v>0.72373540856031104</c:v>
                </c:pt>
                <c:pt idx="139">
                  <c:v>0.75486381322957197</c:v>
                </c:pt>
                <c:pt idx="140">
                  <c:v>0.72568093385214005</c:v>
                </c:pt>
                <c:pt idx="141">
                  <c:v>0.75486381322957197</c:v>
                </c:pt>
                <c:pt idx="142">
                  <c:v>0.72762645914396895</c:v>
                </c:pt>
                <c:pt idx="143">
                  <c:v>0.72762645914396895</c:v>
                </c:pt>
                <c:pt idx="144">
                  <c:v>0.75875486381322998</c:v>
                </c:pt>
                <c:pt idx="145">
                  <c:v>0.71984435797665403</c:v>
                </c:pt>
                <c:pt idx="146">
                  <c:v>0.72762645914396895</c:v>
                </c:pt>
                <c:pt idx="147">
                  <c:v>0.72568093385214005</c:v>
                </c:pt>
                <c:pt idx="148">
                  <c:v>0.72957198443579796</c:v>
                </c:pt>
                <c:pt idx="149">
                  <c:v>0.72373540856031104</c:v>
                </c:pt>
                <c:pt idx="150">
                  <c:v>0.72957198443579796</c:v>
                </c:pt>
                <c:pt idx="151">
                  <c:v>0.72762645914396895</c:v>
                </c:pt>
                <c:pt idx="152">
                  <c:v>0.67509727626459104</c:v>
                </c:pt>
                <c:pt idx="153">
                  <c:v>0.72373540856031104</c:v>
                </c:pt>
                <c:pt idx="154">
                  <c:v>0.72957198443579796</c:v>
                </c:pt>
                <c:pt idx="155">
                  <c:v>0.41439688715953299</c:v>
                </c:pt>
                <c:pt idx="156">
                  <c:v>0.75875486381322998</c:v>
                </c:pt>
                <c:pt idx="157">
                  <c:v>0.72568093385214005</c:v>
                </c:pt>
                <c:pt idx="158">
                  <c:v>0.75291828793774296</c:v>
                </c:pt>
                <c:pt idx="159">
                  <c:v>0.72762645914396895</c:v>
                </c:pt>
                <c:pt idx="160">
                  <c:v>0.72568093385214005</c:v>
                </c:pt>
                <c:pt idx="161">
                  <c:v>0.72762645914396895</c:v>
                </c:pt>
                <c:pt idx="162">
                  <c:v>0.72568093385214005</c:v>
                </c:pt>
                <c:pt idx="163">
                  <c:v>0.72373540856031104</c:v>
                </c:pt>
                <c:pt idx="164">
                  <c:v>0.73929961089494201</c:v>
                </c:pt>
                <c:pt idx="165">
                  <c:v>0.72762645914396895</c:v>
                </c:pt>
                <c:pt idx="166">
                  <c:v>0.72568093385214005</c:v>
                </c:pt>
                <c:pt idx="167">
                  <c:v>0.70817120622568097</c:v>
                </c:pt>
                <c:pt idx="168">
                  <c:v>0.76070038910505799</c:v>
                </c:pt>
                <c:pt idx="169">
                  <c:v>0.72957198443579796</c:v>
                </c:pt>
                <c:pt idx="170">
                  <c:v>0.72762645914396895</c:v>
                </c:pt>
                <c:pt idx="171">
                  <c:v>0.72568093385214005</c:v>
                </c:pt>
                <c:pt idx="172">
                  <c:v>0.72178988326848204</c:v>
                </c:pt>
                <c:pt idx="173">
                  <c:v>0.72957198443579796</c:v>
                </c:pt>
                <c:pt idx="174">
                  <c:v>0.72762645914396895</c:v>
                </c:pt>
                <c:pt idx="175">
                  <c:v>0.72762645914396895</c:v>
                </c:pt>
                <c:pt idx="176">
                  <c:v>0.75680933852140098</c:v>
                </c:pt>
                <c:pt idx="177">
                  <c:v>0.76070038910505799</c:v>
                </c:pt>
                <c:pt idx="178">
                  <c:v>0.72762645914396895</c:v>
                </c:pt>
                <c:pt idx="179">
                  <c:v>0.714007782101167</c:v>
                </c:pt>
                <c:pt idx="180">
                  <c:v>0.75097276264591395</c:v>
                </c:pt>
                <c:pt idx="181">
                  <c:v>0.75097276264591395</c:v>
                </c:pt>
                <c:pt idx="182">
                  <c:v>0.74513618677042803</c:v>
                </c:pt>
                <c:pt idx="183">
                  <c:v>0.75875486381322998</c:v>
                </c:pt>
                <c:pt idx="184">
                  <c:v>0.75875486381322998</c:v>
                </c:pt>
                <c:pt idx="185">
                  <c:v>0.70038910505836605</c:v>
                </c:pt>
                <c:pt idx="186">
                  <c:v>0.71984435797665403</c:v>
                </c:pt>
                <c:pt idx="187">
                  <c:v>0.72568093385214005</c:v>
                </c:pt>
                <c:pt idx="188">
                  <c:v>0.72957198443579796</c:v>
                </c:pt>
                <c:pt idx="189">
                  <c:v>0.72957198443579796</c:v>
                </c:pt>
                <c:pt idx="190">
                  <c:v>0.72957198443579796</c:v>
                </c:pt>
                <c:pt idx="191">
                  <c:v>0.75875486381322998</c:v>
                </c:pt>
                <c:pt idx="192">
                  <c:v>0.74902723735408605</c:v>
                </c:pt>
                <c:pt idx="193">
                  <c:v>0.72957198443579796</c:v>
                </c:pt>
                <c:pt idx="194">
                  <c:v>0.75680933852140098</c:v>
                </c:pt>
                <c:pt idx="195">
                  <c:v>0.73151750972762597</c:v>
                </c:pt>
                <c:pt idx="196">
                  <c:v>0.72957198443579796</c:v>
                </c:pt>
                <c:pt idx="197">
                  <c:v>0.42996108949416301</c:v>
                </c:pt>
                <c:pt idx="198">
                  <c:v>0.75097276264591395</c:v>
                </c:pt>
                <c:pt idx="199">
                  <c:v>0.72762645914396895</c:v>
                </c:pt>
                <c:pt idx="200">
                  <c:v>0.71789883268482502</c:v>
                </c:pt>
                <c:pt idx="201">
                  <c:v>0.73151750972762597</c:v>
                </c:pt>
                <c:pt idx="202">
                  <c:v>0.76070038910505799</c:v>
                </c:pt>
                <c:pt idx="203">
                  <c:v>0.71595330739299601</c:v>
                </c:pt>
                <c:pt idx="204">
                  <c:v>0.73151750972762597</c:v>
                </c:pt>
                <c:pt idx="205">
                  <c:v>0.76070038910505799</c:v>
                </c:pt>
                <c:pt idx="206">
                  <c:v>0.74902723735408605</c:v>
                </c:pt>
                <c:pt idx="207">
                  <c:v>0.73151750972762597</c:v>
                </c:pt>
                <c:pt idx="208">
                  <c:v>0.73151750972762597</c:v>
                </c:pt>
                <c:pt idx="209">
                  <c:v>0.73151750972762597</c:v>
                </c:pt>
                <c:pt idx="210">
                  <c:v>0.76070038910505799</c:v>
                </c:pt>
                <c:pt idx="211">
                  <c:v>0.73151750972762597</c:v>
                </c:pt>
                <c:pt idx="212">
                  <c:v>0.714007782101167</c:v>
                </c:pt>
                <c:pt idx="213">
                  <c:v>0.72568093385214005</c:v>
                </c:pt>
                <c:pt idx="214">
                  <c:v>0.72762645914396895</c:v>
                </c:pt>
                <c:pt idx="215">
                  <c:v>0.714007782101167</c:v>
                </c:pt>
                <c:pt idx="216">
                  <c:v>0.73151750972762597</c:v>
                </c:pt>
                <c:pt idx="217">
                  <c:v>0.73151750972762597</c:v>
                </c:pt>
                <c:pt idx="218">
                  <c:v>0.75875486381322998</c:v>
                </c:pt>
                <c:pt idx="219">
                  <c:v>0.72957198443579796</c:v>
                </c:pt>
                <c:pt idx="220">
                  <c:v>0.72957198443579796</c:v>
                </c:pt>
                <c:pt idx="221">
                  <c:v>0.69844357976653704</c:v>
                </c:pt>
                <c:pt idx="222">
                  <c:v>0.73151750972762597</c:v>
                </c:pt>
                <c:pt idx="223">
                  <c:v>0.72762645914396895</c:v>
                </c:pt>
                <c:pt idx="224">
                  <c:v>0.66536964980544699</c:v>
                </c:pt>
                <c:pt idx="225">
                  <c:v>0.73151750972762597</c:v>
                </c:pt>
                <c:pt idx="226">
                  <c:v>0.73151750972762597</c:v>
                </c:pt>
                <c:pt idx="227">
                  <c:v>0.70428015564202295</c:v>
                </c:pt>
                <c:pt idx="228">
                  <c:v>0.72373540856031104</c:v>
                </c:pt>
                <c:pt idx="229">
                  <c:v>0.72373540856031104</c:v>
                </c:pt>
                <c:pt idx="230">
                  <c:v>0.714007782101167</c:v>
                </c:pt>
                <c:pt idx="231">
                  <c:v>0.75875486381322998</c:v>
                </c:pt>
                <c:pt idx="232">
                  <c:v>0.72762645914396895</c:v>
                </c:pt>
                <c:pt idx="233">
                  <c:v>0.72568093385214005</c:v>
                </c:pt>
                <c:pt idx="234">
                  <c:v>0.73151750972762597</c:v>
                </c:pt>
                <c:pt idx="235">
                  <c:v>0.72762645914396895</c:v>
                </c:pt>
                <c:pt idx="236">
                  <c:v>0.72373540856031104</c:v>
                </c:pt>
                <c:pt idx="237">
                  <c:v>0.73151750972762597</c:v>
                </c:pt>
                <c:pt idx="238">
                  <c:v>0.75291828793774296</c:v>
                </c:pt>
                <c:pt idx="239">
                  <c:v>0.67509727626459104</c:v>
                </c:pt>
                <c:pt idx="240">
                  <c:v>0.75097276264591395</c:v>
                </c:pt>
                <c:pt idx="241">
                  <c:v>0.72762645914396895</c:v>
                </c:pt>
                <c:pt idx="242">
                  <c:v>0.71789883268482502</c:v>
                </c:pt>
                <c:pt idx="243">
                  <c:v>0.72762645914396895</c:v>
                </c:pt>
                <c:pt idx="244">
                  <c:v>0.72373540856031104</c:v>
                </c:pt>
                <c:pt idx="245">
                  <c:v>0.72178988326848204</c:v>
                </c:pt>
                <c:pt idx="246">
                  <c:v>0.73151750972762597</c:v>
                </c:pt>
                <c:pt idx="247">
                  <c:v>0.762645914396887</c:v>
                </c:pt>
                <c:pt idx="248">
                  <c:v>0.73929961089494201</c:v>
                </c:pt>
                <c:pt idx="249">
                  <c:v>0.70038910505836605</c:v>
                </c:pt>
                <c:pt idx="250">
                  <c:v>0.73151750972762597</c:v>
                </c:pt>
                <c:pt idx="251">
                  <c:v>0.74902723735408605</c:v>
                </c:pt>
                <c:pt idx="252">
                  <c:v>0.75680933852140098</c:v>
                </c:pt>
                <c:pt idx="253">
                  <c:v>0.72762645914396895</c:v>
                </c:pt>
                <c:pt idx="254">
                  <c:v>0.72762645914396895</c:v>
                </c:pt>
                <c:pt idx="255">
                  <c:v>0.72762645914396895</c:v>
                </c:pt>
                <c:pt idx="256">
                  <c:v>0.73151750972762597</c:v>
                </c:pt>
                <c:pt idx="257">
                  <c:v>0.62645914396887203</c:v>
                </c:pt>
                <c:pt idx="258">
                  <c:v>0.73151750972762597</c:v>
                </c:pt>
                <c:pt idx="259">
                  <c:v>0.72957198443579796</c:v>
                </c:pt>
                <c:pt idx="260">
                  <c:v>0.71595330739299601</c:v>
                </c:pt>
                <c:pt idx="261">
                  <c:v>0.73151750972762597</c:v>
                </c:pt>
                <c:pt idx="262">
                  <c:v>0.73151750972762597</c:v>
                </c:pt>
                <c:pt idx="263">
                  <c:v>0.73346303501945498</c:v>
                </c:pt>
                <c:pt idx="264">
                  <c:v>0.66342412451361898</c:v>
                </c:pt>
                <c:pt idx="265">
                  <c:v>0.72957198443579796</c:v>
                </c:pt>
                <c:pt idx="266">
                  <c:v>0.72373540856031104</c:v>
                </c:pt>
                <c:pt idx="267">
                  <c:v>0.73151750972762597</c:v>
                </c:pt>
                <c:pt idx="268">
                  <c:v>0.72568093385214005</c:v>
                </c:pt>
                <c:pt idx="269">
                  <c:v>0.72373540856031104</c:v>
                </c:pt>
                <c:pt idx="270">
                  <c:v>0.72762645914396895</c:v>
                </c:pt>
                <c:pt idx="271">
                  <c:v>0.72957198443579796</c:v>
                </c:pt>
                <c:pt idx="272">
                  <c:v>0.73151750972762597</c:v>
                </c:pt>
                <c:pt idx="273">
                  <c:v>0.75875486381322998</c:v>
                </c:pt>
                <c:pt idx="274">
                  <c:v>0.72957198443579796</c:v>
                </c:pt>
                <c:pt idx="275">
                  <c:v>0.72762645914396895</c:v>
                </c:pt>
                <c:pt idx="276">
                  <c:v>0.71984435797665403</c:v>
                </c:pt>
                <c:pt idx="277">
                  <c:v>0.72762645914396895</c:v>
                </c:pt>
                <c:pt idx="278">
                  <c:v>0.75291828793774296</c:v>
                </c:pt>
                <c:pt idx="279">
                  <c:v>0.72957198443579796</c:v>
                </c:pt>
                <c:pt idx="280">
                  <c:v>0.72568093385214005</c:v>
                </c:pt>
                <c:pt idx="281">
                  <c:v>0.72568093385214005</c:v>
                </c:pt>
                <c:pt idx="282">
                  <c:v>0.73151750972762597</c:v>
                </c:pt>
                <c:pt idx="283">
                  <c:v>0.73151750972762597</c:v>
                </c:pt>
                <c:pt idx="284">
                  <c:v>0.762645914396887</c:v>
                </c:pt>
                <c:pt idx="285">
                  <c:v>0.75291828793774296</c:v>
                </c:pt>
                <c:pt idx="286">
                  <c:v>0.72762645914396895</c:v>
                </c:pt>
                <c:pt idx="287">
                  <c:v>0.75291828793774296</c:v>
                </c:pt>
                <c:pt idx="288">
                  <c:v>0.72762645914396895</c:v>
                </c:pt>
                <c:pt idx="289">
                  <c:v>0.72957198443579796</c:v>
                </c:pt>
                <c:pt idx="290">
                  <c:v>0.73929961089494201</c:v>
                </c:pt>
                <c:pt idx="291">
                  <c:v>0.72762645914396895</c:v>
                </c:pt>
                <c:pt idx="292">
                  <c:v>0.72957198443579796</c:v>
                </c:pt>
                <c:pt idx="293">
                  <c:v>0.74513618677042803</c:v>
                </c:pt>
                <c:pt idx="294">
                  <c:v>0.73151750972762597</c:v>
                </c:pt>
                <c:pt idx="295">
                  <c:v>0.762645914396887</c:v>
                </c:pt>
                <c:pt idx="296">
                  <c:v>0.72178988326848204</c:v>
                </c:pt>
                <c:pt idx="297">
                  <c:v>0.72568093385214005</c:v>
                </c:pt>
                <c:pt idx="298">
                  <c:v>0.72957198443579796</c:v>
                </c:pt>
                <c:pt idx="299">
                  <c:v>0.68482490272373497</c:v>
                </c:pt>
                <c:pt idx="300">
                  <c:v>0.72957198443579796</c:v>
                </c:pt>
                <c:pt idx="301">
                  <c:v>0.73151750972762597</c:v>
                </c:pt>
                <c:pt idx="302">
                  <c:v>0.69844357976653704</c:v>
                </c:pt>
                <c:pt idx="303">
                  <c:v>0.72568093385214005</c:v>
                </c:pt>
                <c:pt idx="304">
                  <c:v>0.72957198443579796</c:v>
                </c:pt>
                <c:pt idx="305">
                  <c:v>0.762645914396887</c:v>
                </c:pt>
                <c:pt idx="306">
                  <c:v>0.762645914396887</c:v>
                </c:pt>
                <c:pt idx="307">
                  <c:v>0.73151750972762597</c:v>
                </c:pt>
                <c:pt idx="308">
                  <c:v>0.63618677042801597</c:v>
                </c:pt>
                <c:pt idx="309">
                  <c:v>0.72762645914396895</c:v>
                </c:pt>
                <c:pt idx="310">
                  <c:v>0.72957198443579796</c:v>
                </c:pt>
                <c:pt idx="311">
                  <c:v>0.71011673151750998</c:v>
                </c:pt>
                <c:pt idx="312">
                  <c:v>0.73151750972762597</c:v>
                </c:pt>
                <c:pt idx="313">
                  <c:v>0.72762645914396895</c:v>
                </c:pt>
                <c:pt idx="314">
                  <c:v>0.72957198443579796</c:v>
                </c:pt>
                <c:pt idx="315">
                  <c:v>0.72957198443579796</c:v>
                </c:pt>
                <c:pt idx="316">
                  <c:v>0.72957198443579796</c:v>
                </c:pt>
                <c:pt idx="317">
                  <c:v>0.66926070038910501</c:v>
                </c:pt>
                <c:pt idx="318">
                  <c:v>0.72957198443579796</c:v>
                </c:pt>
                <c:pt idx="319">
                  <c:v>0.72957198443579796</c:v>
                </c:pt>
                <c:pt idx="320">
                  <c:v>0.72178988326848204</c:v>
                </c:pt>
                <c:pt idx="321">
                  <c:v>0.73151750972762597</c:v>
                </c:pt>
                <c:pt idx="322">
                  <c:v>0.72957198443579796</c:v>
                </c:pt>
                <c:pt idx="323">
                  <c:v>0.72178988326848204</c:v>
                </c:pt>
                <c:pt idx="324">
                  <c:v>0.75486381322957197</c:v>
                </c:pt>
                <c:pt idx="325">
                  <c:v>0.73151750972762597</c:v>
                </c:pt>
                <c:pt idx="326">
                  <c:v>0.72568093385214005</c:v>
                </c:pt>
                <c:pt idx="327">
                  <c:v>0.73151750972762597</c:v>
                </c:pt>
                <c:pt idx="328">
                  <c:v>0.73151750972762597</c:v>
                </c:pt>
                <c:pt idx="329">
                  <c:v>0.71206225680933899</c:v>
                </c:pt>
                <c:pt idx="330">
                  <c:v>0.762645914396887</c:v>
                </c:pt>
                <c:pt idx="331">
                  <c:v>0.72957198443579796</c:v>
                </c:pt>
                <c:pt idx="332">
                  <c:v>0.75486381322957197</c:v>
                </c:pt>
                <c:pt idx="333">
                  <c:v>0.71206225680933899</c:v>
                </c:pt>
                <c:pt idx="334">
                  <c:v>0.73151750972762597</c:v>
                </c:pt>
                <c:pt idx="335">
                  <c:v>0.72373540856031104</c:v>
                </c:pt>
                <c:pt idx="336">
                  <c:v>0.73151750972762597</c:v>
                </c:pt>
                <c:pt idx="337">
                  <c:v>0.72957198443579796</c:v>
                </c:pt>
                <c:pt idx="338">
                  <c:v>0.69455252918287902</c:v>
                </c:pt>
                <c:pt idx="339">
                  <c:v>0.73151750972762597</c:v>
                </c:pt>
                <c:pt idx="340">
                  <c:v>0.72762645914396895</c:v>
                </c:pt>
                <c:pt idx="341">
                  <c:v>0.70038910505836605</c:v>
                </c:pt>
                <c:pt idx="342">
                  <c:v>0.72762645914396895</c:v>
                </c:pt>
                <c:pt idx="343">
                  <c:v>0.73151750972762597</c:v>
                </c:pt>
                <c:pt idx="344">
                  <c:v>0.71984435797665403</c:v>
                </c:pt>
                <c:pt idx="345">
                  <c:v>0.73151750972762597</c:v>
                </c:pt>
                <c:pt idx="346">
                  <c:v>0.73151750972762597</c:v>
                </c:pt>
                <c:pt idx="347">
                  <c:v>0.75097276264591395</c:v>
                </c:pt>
                <c:pt idx="348">
                  <c:v>0.74708171206225704</c:v>
                </c:pt>
                <c:pt idx="349">
                  <c:v>0.73151750972762597</c:v>
                </c:pt>
                <c:pt idx="350">
                  <c:v>0.75680933852140098</c:v>
                </c:pt>
                <c:pt idx="351">
                  <c:v>0.72178988326848204</c:v>
                </c:pt>
                <c:pt idx="352">
                  <c:v>0.76070038910505799</c:v>
                </c:pt>
                <c:pt idx="353">
                  <c:v>0.72957198443579796</c:v>
                </c:pt>
                <c:pt idx="354">
                  <c:v>0.72957198443579796</c:v>
                </c:pt>
                <c:pt idx="355">
                  <c:v>0.72957198443579796</c:v>
                </c:pt>
                <c:pt idx="356">
                  <c:v>0.68093385214007796</c:v>
                </c:pt>
                <c:pt idx="357">
                  <c:v>0.72957198443579796</c:v>
                </c:pt>
                <c:pt idx="358">
                  <c:v>0.72957198443579796</c:v>
                </c:pt>
                <c:pt idx="359">
                  <c:v>0.70622568093385196</c:v>
                </c:pt>
                <c:pt idx="360">
                  <c:v>0.71011673151750998</c:v>
                </c:pt>
                <c:pt idx="361">
                  <c:v>0.72957198443579796</c:v>
                </c:pt>
                <c:pt idx="362">
                  <c:v>0.67509727626459104</c:v>
                </c:pt>
                <c:pt idx="363">
                  <c:v>0.72957198443579796</c:v>
                </c:pt>
                <c:pt idx="364">
                  <c:v>0.73151750972762597</c:v>
                </c:pt>
                <c:pt idx="365">
                  <c:v>0.72957198443579796</c:v>
                </c:pt>
                <c:pt idx="366">
                  <c:v>0.72957198443579796</c:v>
                </c:pt>
                <c:pt idx="367">
                  <c:v>0.73151750972762597</c:v>
                </c:pt>
                <c:pt idx="368">
                  <c:v>0.76070038910505799</c:v>
                </c:pt>
                <c:pt idx="369">
                  <c:v>0.72762645914396895</c:v>
                </c:pt>
                <c:pt idx="370">
                  <c:v>0.72957198443579796</c:v>
                </c:pt>
                <c:pt idx="371">
                  <c:v>0.71984435797665403</c:v>
                </c:pt>
                <c:pt idx="372">
                  <c:v>0.762645914396887</c:v>
                </c:pt>
                <c:pt idx="373">
                  <c:v>0.76070038910505799</c:v>
                </c:pt>
                <c:pt idx="374">
                  <c:v>0.72373540856031104</c:v>
                </c:pt>
                <c:pt idx="375">
                  <c:v>0.73151750972762597</c:v>
                </c:pt>
                <c:pt idx="376">
                  <c:v>0.762645914396887</c:v>
                </c:pt>
                <c:pt idx="377">
                  <c:v>0.72762645914396895</c:v>
                </c:pt>
                <c:pt idx="378">
                  <c:v>0.75875486381322998</c:v>
                </c:pt>
                <c:pt idx="379">
                  <c:v>0.72568093385214005</c:v>
                </c:pt>
                <c:pt idx="380">
                  <c:v>0.47470817120622599</c:v>
                </c:pt>
                <c:pt idx="381">
                  <c:v>0.762645914396887</c:v>
                </c:pt>
                <c:pt idx="382">
                  <c:v>0.72957198443579796</c:v>
                </c:pt>
                <c:pt idx="383">
                  <c:v>0.71206225680933899</c:v>
                </c:pt>
                <c:pt idx="384">
                  <c:v>0.76070038910505799</c:v>
                </c:pt>
                <c:pt idx="385">
                  <c:v>0.762645914396887</c:v>
                </c:pt>
                <c:pt idx="386">
                  <c:v>0.72373540856031104</c:v>
                </c:pt>
                <c:pt idx="387">
                  <c:v>0.72762645914396895</c:v>
                </c:pt>
                <c:pt idx="388">
                  <c:v>0.73151750972762597</c:v>
                </c:pt>
                <c:pt idx="389">
                  <c:v>0.75097276264591395</c:v>
                </c:pt>
                <c:pt idx="390">
                  <c:v>0.762645914396887</c:v>
                </c:pt>
                <c:pt idx="391">
                  <c:v>0.76070038910505799</c:v>
                </c:pt>
                <c:pt idx="392">
                  <c:v>0.69260700389105101</c:v>
                </c:pt>
                <c:pt idx="393">
                  <c:v>0.72957198443579796</c:v>
                </c:pt>
                <c:pt idx="394">
                  <c:v>0.75875486381322998</c:v>
                </c:pt>
                <c:pt idx="395">
                  <c:v>0.67704280155642005</c:v>
                </c:pt>
                <c:pt idx="396">
                  <c:v>0.73151750972762597</c:v>
                </c:pt>
                <c:pt idx="397">
                  <c:v>0.73151750972762597</c:v>
                </c:pt>
                <c:pt idx="398">
                  <c:v>0.73151750972762597</c:v>
                </c:pt>
                <c:pt idx="399">
                  <c:v>0.762645914396887</c:v>
                </c:pt>
                <c:pt idx="400">
                  <c:v>0.72957198443579796</c:v>
                </c:pt>
                <c:pt idx="401">
                  <c:v>0.72762645914396895</c:v>
                </c:pt>
                <c:pt idx="402">
                  <c:v>0.72762645914396895</c:v>
                </c:pt>
                <c:pt idx="403">
                  <c:v>0.76070038910505799</c:v>
                </c:pt>
                <c:pt idx="404">
                  <c:v>0.70428015564202295</c:v>
                </c:pt>
                <c:pt idx="405">
                  <c:v>0.72957198443579796</c:v>
                </c:pt>
                <c:pt idx="406">
                  <c:v>0.72957198443579796</c:v>
                </c:pt>
                <c:pt idx="407">
                  <c:v>0.71595330739299601</c:v>
                </c:pt>
                <c:pt idx="408">
                  <c:v>0.72762645914396895</c:v>
                </c:pt>
                <c:pt idx="409">
                  <c:v>0.762645914396887</c:v>
                </c:pt>
                <c:pt idx="410">
                  <c:v>0.72957198443579796</c:v>
                </c:pt>
                <c:pt idx="411">
                  <c:v>0.73151750972762597</c:v>
                </c:pt>
                <c:pt idx="412">
                  <c:v>0.76070038910505799</c:v>
                </c:pt>
                <c:pt idx="413">
                  <c:v>0.70233463035019505</c:v>
                </c:pt>
                <c:pt idx="414">
                  <c:v>0.762645914396887</c:v>
                </c:pt>
                <c:pt idx="415">
                  <c:v>0.75875486381322998</c:v>
                </c:pt>
                <c:pt idx="416">
                  <c:v>0.62062256809338501</c:v>
                </c:pt>
                <c:pt idx="417">
                  <c:v>0.74902723735408605</c:v>
                </c:pt>
                <c:pt idx="418">
                  <c:v>0.72568093385214005</c:v>
                </c:pt>
                <c:pt idx="419">
                  <c:v>0.67509727626459104</c:v>
                </c:pt>
                <c:pt idx="420">
                  <c:v>0.73151750972762597</c:v>
                </c:pt>
                <c:pt idx="421">
                  <c:v>0.76070038910505799</c:v>
                </c:pt>
                <c:pt idx="422">
                  <c:v>0.416342412451362</c:v>
                </c:pt>
                <c:pt idx="423">
                  <c:v>0.73151750972762597</c:v>
                </c:pt>
                <c:pt idx="424">
                  <c:v>0.73151750972762597</c:v>
                </c:pt>
                <c:pt idx="425">
                  <c:v>0.75486381322957197</c:v>
                </c:pt>
                <c:pt idx="426">
                  <c:v>0.72762645914396895</c:v>
                </c:pt>
                <c:pt idx="427">
                  <c:v>0.72762645914396895</c:v>
                </c:pt>
                <c:pt idx="428">
                  <c:v>0.737354085603113</c:v>
                </c:pt>
                <c:pt idx="429">
                  <c:v>0.72373540856031104</c:v>
                </c:pt>
                <c:pt idx="430">
                  <c:v>0.72178988326848204</c:v>
                </c:pt>
                <c:pt idx="431">
                  <c:v>0.72568093385214005</c:v>
                </c:pt>
                <c:pt idx="432">
                  <c:v>0.75875486381322998</c:v>
                </c:pt>
                <c:pt idx="433">
                  <c:v>0.76070038910505799</c:v>
                </c:pt>
                <c:pt idx="434">
                  <c:v>0.72568093385214005</c:v>
                </c:pt>
                <c:pt idx="435">
                  <c:v>0.73151750972762597</c:v>
                </c:pt>
                <c:pt idx="436">
                  <c:v>0.72762645914396895</c:v>
                </c:pt>
                <c:pt idx="437">
                  <c:v>0.51945525291828798</c:v>
                </c:pt>
                <c:pt idx="438">
                  <c:v>0.72957198443579796</c:v>
                </c:pt>
                <c:pt idx="439">
                  <c:v>0.72568093385214005</c:v>
                </c:pt>
                <c:pt idx="440">
                  <c:v>0.75680933852140098</c:v>
                </c:pt>
                <c:pt idx="441">
                  <c:v>0.76070038910505799</c:v>
                </c:pt>
                <c:pt idx="442">
                  <c:v>0.72957198443579796</c:v>
                </c:pt>
                <c:pt idx="443">
                  <c:v>0.71789883268482502</c:v>
                </c:pt>
                <c:pt idx="444">
                  <c:v>0.75291828793774296</c:v>
                </c:pt>
                <c:pt idx="445">
                  <c:v>0.46692607003891101</c:v>
                </c:pt>
                <c:pt idx="446">
                  <c:v>0.71011673151750998</c:v>
                </c:pt>
                <c:pt idx="447">
                  <c:v>0.75291828793774296</c:v>
                </c:pt>
                <c:pt idx="448">
                  <c:v>0.72178988326848204</c:v>
                </c:pt>
                <c:pt idx="449">
                  <c:v>0.69844357976653704</c:v>
                </c:pt>
                <c:pt idx="450">
                  <c:v>0.76070038910505799</c:v>
                </c:pt>
                <c:pt idx="451">
                  <c:v>0.762645914396887</c:v>
                </c:pt>
                <c:pt idx="452">
                  <c:v>0.75680933852140098</c:v>
                </c:pt>
                <c:pt idx="453">
                  <c:v>0.72957198443579796</c:v>
                </c:pt>
                <c:pt idx="454">
                  <c:v>0.73151750972762597</c:v>
                </c:pt>
                <c:pt idx="455">
                  <c:v>0.72568093385214005</c:v>
                </c:pt>
                <c:pt idx="456">
                  <c:v>0.75680933852140098</c:v>
                </c:pt>
                <c:pt idx="457">
                  <c:v>0.72957198443579796</c:v>
                </c:pt>
                <c:pt idx="458">
                  <c:v>0.74124513618677002</c:v>
                </c:pt>
                <c:pt idx="459">
                  <c:v>0.76070038910505799</c:v>
                </c:pt>
                <c:pt idx="460">
                  <c:v>0.76070038910505799</c:v>
                </c:pt>
                <c:pt idx="461">
                  <c:v>0.75097276264591395</c:v>
                </c:pt>
                <c:pt idx="462">
                  <c:v>0.76070038910505799</c:v>
                </c:pt>
                <c:pt idx="463">
                  <c:v>0.762645914396887</c:v>
                </c:pt>
                <c:pt idx="464">
                  <c:v>0.71984435797665403</c:v>
                </c:pt>
                <c:pt idx="465">
                  <c:v>0.73151750972762597</c:v>
                </c:pt>
                <c:pt idx="466">
                  <c:v>0.762645914396887</c:v>
                </c:pt>
                <c:pt idx="467">
                  <c:v>0.75486381322957197</c:v>
                </c:pt>
                <c:pt idx="468">
                  <c:v>0.72957198443579796</c:v>
                </c:pt>
                <c:pt idx="469">
                  <c:v>0.762645914396887</c:v>
                </c:pt>
                <c:pt idx="470">
                  <c:v>0.72762645914396895</c:v>
                </c:pt>
                <c:pt idx="471">
                  <c:v>0.762645914396887</c:v>
                </c:pt>
                <c:pt idx="472">
                  <c:v>0.762645914396887</c:v>
                </c:pt>
                <c:pt idx="473">
                  <c:v>0.73151750972762597</c:v>
                </c:pt>
                <c:pt idx="474">
                  <c:v>0.762645914396887</c:v>
                </c:pt>
                <c:pt idx="475">
                  <c:v>0.76070038910505799</c:v>
                </c:pt>
                <c:pt idx="476">
                  <c:v>0.71595330739299601</c:v>
                </c:pt>
                <c:pt idx="477">
                  <c:v>0.75875486381322998</c:v>
                </c:pt>
                <c:pt idx="478">
                  <c:v>0.762645914396887</c:v>
                </c:pt>
                <c:pt idx="479">
                  <c:v>0.75875486381322998</c:v>
                </c:pt>
                <c:pt idx="480">
                  <c:v>0.75680933852140098</c:v>
                </c:pt>
                <c:pt idx="481">
                  <c:v>0.72762645914396895</c:v>
                </c:pt>
                <c:pt idx="482">
                  <c:v>0.69649805447470803</c:v>
                </c:pt>
                <c:pt idx="483">
                  <c:v>0.76070038910505799</c:v>
                </c:pt>
                <c:pt idx="484">
                  <c:v>0.76070038910505799</c:v>
                </c:pt>
                <c:pt idx="485">
                  <c:v>0.71011673151750998</c:v>
                </c:pt>
                <c:pt idx="486">
                  <c:v>0.762645914396887</c:v>
                </c:pt>
                <c:pt idx="487">
                  <c:v>0.75680933852140098</c:v>
                </c:pt>
                <c:pt idx="488">
                  <c:v>0.72178988326848204</c:v>
                </c:pt>
                <c:pt idx="489">
                  <c:v>0.762645914396887</c:v>
                </c:pt>
                <c:pt idx="490">
                  <c:v>0.76070038910505799</c:v>
                </c:pt>
                <c:pt idx="491">
                  <c:v>0.75486381322957197</c:v>
                </c:pt>
                <c:pt idx="492">
                  <c:v>0.76070038910505799</c:v>
                </c:pt>
                <c:pt idx="493">
                  <c:v>0.762645914396887</c:v>
                </c:pt>
                <c:pt idx="494">
                  <c:v>0.70622568093385196</c:v>
                </c:pt>
                <c:pt idx="495">
                  <c:v>0.75486381322957197</c:v>
                </c:pt>
                <c:pt idx="496">
                  <c:v>0.75680933852140098</c:v>
                </c:pt>
                <c:pt idx="497">
                  <c:v>0.762645914396887</c:v>
                </c:pt>
                <c:pt idx="498">
                  <c:v>0.75875486381322998</c:v>
                </c:pt>
                <c:pt idx="499">
                  <c:v>0.762645914396887</c:v>
                </c:pt>
                <c:pt idx="500">
                  <c:v>0.69844357976653704</c:v>
                </c:pt>
                <c:pt idx="501">
                  <c:v>0.75875486381322998</c:v>
                </c:pt>
                <c:pt idx="502">
                  <c:v>0.762645914396887</c:v>
                </c:pt>
                <c:pt idx="503">
                  <c:v>0.74124513618677002</c:v>
                </c:pt>
                <c:pt idx="504">
                  <c:v>0.762645914396887</c:v>
                </c:pt>
                <c:pt idx="505">
                  <c:v>0.75680933852140098</c:v>
                </c:pt>
                <c:pt idx="506">
                  <c:v>0.49416342412451397</c:v>
                </c:pt>
                <c:pt idx="507">
                  <c:v>0.737354085603113</c:v>
                </c:pt>
                <c:pt idx="508">
                  <c:v>0.75875486381322998</c:v>
                </c:pt>
                <c:pt idx="509">
                  <c:v>0.72373540856031104</c:v>
                </c:pt>
                <c:pt idx="510">
                  <c:v>0.76070038910505799</c:v>
                </c:pt>
                <c:pt idx="511">
                  <c:v>0.762645914396887</c:v>
                </c:pt>
                <c:pt idx="512">
                  <c:v>0.74902723735408605</c:v>
                </c:pt>
                <c:pt idx="513">
                  <c:v>0.762645914396887</c:v>
                </c:pt>
                <c:pt idx="514">
                  <c:v>0.76070038910505799</c:v>
                </c:pt>
                <c:pt idx="515">
                  <c:v>0.72178988326848204</c:v>
                </c:pt>
                <c:pt idx="516">
                  <c:v>0.75875486381322998</c:v>
                </c:pt>
                <c:pt idx="517">
                  <c:v>0.76070038910505799</c:v>
                </c:pt>
                <c:pt idx="518">
                  <c:v>0.73540856031128399</c:v>
                </c:pt>
                <c:pt idx="519">
                  <c:v>0.66926070038910501</c:v>
                </c:pt>
                <c:pt idx="520">
                  <c:v>0.76070038910505799</c:v>
                </c:pt>
                <c:pt idx="521">
                  <c:v>0.64980544747081703</c:v>
                </c:pt>
                <c:pt idx="522">
                  <c:v>0.70622568093385196</c:v>
                </c:pt>
                <c:pt idx="523">
                  <c:v>0.762645914396887</c:v>
                </c:pt>
                <c:pt idx="524">
                  <c:v>0.618677042801556</c:v>
                </c:pt>
                <c:pt idx="525">
                  <c:v>0.75875486381322998</c:v>
                </c:pt>
                <c:pt idx="526">
                  <c:v>0.75875486381322998</c:v>
                </c:pt>
                <c:pt idx="527">
                  <c:v>0.74902723735408605</c:v>
                </c:pt>
                <c:pt idx="528">
                  <c:v>0.72762645914396895</c:v>
                </c:pt>
                <c:pt idx="529">
                  <c:v>0.76070038910505799</c:v>
                </c:pt>
                <c:pt idx="530">
                  <c:v>0.71789883268482502</c:v>
                </c:pt>
                <c:pt idx="531">
                  <c:v>0.73151750972762597</c:v>
                </c:pt>
                <c:pt idx="532">
                  <c:v>0.75680933852140098</c:v>
                </c:pt>
                <c:pt idx="533">
                  <c:v>0.72957198443579796</c:v>
                </c:pt>
                <c:pt idx="534">
                  <c:v>0.762645914396887</c:v>
                </c:pt>
                <c:pt idx="535">
                  <c:v>0.762645914396887</c:v>
                </c:pt>
                <c:pt idx="536">
                  <c:v>0.75875486381322998</c:v>
                </c:pt>
                <c:pt idx="537">
                  <c:v>0.762645914396887</c:v>
                </c:pt>
                <c:pt idx="538">
                  <c:v>0.762645914396887</c:v>
                </c:pt>
                <c:pt idx="539">
                  <c:v>0.73929961089494201</c:v>
                </c:pt>
                <c:pt idx="540">
                  <c:v>0.73151750972762597</c:v>
                </c:pt>
                <c:pt idx="541">
                  <c:v>0.75875486381322998</c:v>
                </c:pt>
                <c:pt idx="542">
                  <c:v>0.714007782101167</c:v>
                </c:pt>
                <c:pt idx="543">
                  <c:v>0.72178988326848204</c:v>
                </c:pt>
                <c:pt idx="544">
                  <c:v>0.73151750972762597</c:v>
                </c:pt>
                <c:pt idx="545">
                  <c:v>0.68677042801556398</c:v>
                </c:pt>
                <c:pt idx="546">
                  <c:v>0.73151750972762597</c:v>
                </c:pt>
                <c:pt idx="547">
                  <c:v>0.72957198443579796</c:v>
                </c:pt>
                <c:pt idx="548">
                  <c:v>0.72762645914396895</c:v>
                </c:pt>
                <c:pt idx="549">
                  <c:v>0.762645914396887</c:v>
                </c:pt>
                <c:pt idx="550">
                  <c:v>0.762645914396887</c:v>
                </c:pt>
                <c:pt idx="551">
                  <c:v>0.72762645914396895</c:v>
                </c:pt>
                <c:pt idx="552">
                  <c:v>0.73151750972762597</c:v>
                </c:pt>
                <c:pt idx="553">
                  <c:v>0.72957198443579796</c:v>
                </c:pt>
                <c:pt idx="554">
                  <c:v>0.73151750972762597</c:v>
                </c:pt>
                <c:pt idx="555">
                  <c:v>0.76070038910505799</c:v>
                </c:pt>
                <c:pt idx="556">
                  <c:v>0.75486381322957197</c:v>
                </c:pt>
                <c:pt idx="557">
                  <c:v>0.64980544747081703</c:v>
                </c:pt>
                <c:pt idx="558">
                  <c:v>0.72762645914396895</c:v>
                </c:pt>
                <c:pt idx="559">
                  <c:v>0.76070038910505799</c:v>
                </c:pt>
                <c:pt idx="560">
                  <c:v>0.72373540856031104</c:v>
                </c:pt>
                <c:pt idx="561">
                  <c:v>0.72762645914396895</c:v>
                </c:pt>
                <c:pt idx="562">
                  <c:v>0.76070038910505799</c:v>
                </c:pt>
                <c:pt idx="563">
                  <c:v>0.69844357976653704</c:v>
                </c:pt>
                <c:pt idx="564">
                  <c:v>0.74708171206225704</c:v>
                </c:pt>
                <c:pt idx="565">
                  <c:v>0.73151750972762597</c:v>
                </c:pt>
                <c:pt idx="566">
                  <c:v>0.72568093385214005</c:v>
                </c:pt>
                <c:pt idx="567">
                  <c:v>0.75875486381322998</c:v>
                </c:pt>
                <c:pt idx="568">
                  <c:v>0.76070038910505799</c:v>
                </c:pt>
                <c:pt idx="569">
                  <c:v>0.75291828793774296</c:v>
                </c:pt>
                <c:pt idx="570">
                  <c:v>0.762645914396887</c:v>
                </c:pt>
                <c:pt idx="571">
                  <c:v>0.74902723735408605</c:v>
                </c:pt>
                <c:pt idx="572">
                  <c:v>0.63424124513618696</c:v>
                </c:pt>
                <c:pt idx="573">
                  <c:v>0.762645914396887</c:v>
                </c:pt>
                <c:pt idx="574">
                  <c:v>0.72957198443579796</c:v>
                </c:pt>
                <c:pt idx="575">
                  <c:v>0.68482490272373497</c:v>
                </c:pt>
                <c:pt idx="576">
                  <c:v>0.762645914396887</c:v>
                </c:pt>
                <c:pt idx="577">
                  <c:v>0.72957198443579796</c:v>
                </c:pt>
                <c:pt idx="578">
                  <c:v>0.75097276264591395</c:v>
                </c:pt>
                <c:pt idx="579">
                  <c:v>0.76070038910505799</c:v>
                </c:pt>
                <c:pt idx="580">
                  <c:v>0.72178988326848204</c:v>
                </c:pt>
                <c:pt idx="581">
                  <c:v>0.71595330739299601</c:v>
                </c:pt>
                <c:pt idx="582">
                  <c:v>0.75875486381322998</c:v>
                </c:pt>
                <c:pt idx="583">
                  <c:v>0.72373540856031104</c:v>
                </c:pt>
                <c:pt idx="584">
                  <c:v>0.72762645914396895</c:v>
                </c:pt>
                <c:pt idx="585">
                  <c:v>0.76070038910505799</c:v>
                </c:pt>
                <c:pt idx="586">
                  <c:v>0.75875486381322998</c:v>
                </c:pt>
                <c:pt idx="587">
                  <c:v>0.74124513618677002</c:v>
                </c:pt>
                <c:pt idx="588">
                  <c:v>0.76070038910505799</c:v>
                </c:pt>
                <c:pt idx="589">
                  <c:v>0.75875486381322998</c:v>
                </c:pt>
                <c:pt idx="590">
                  <c:v>0.74124513618677002</c:v>
                </c:pt>
                <c:pt idx="591">
                  <c:v>0.75680933852140098</c:v>
                </c:pt>
                <c:pt idx="592">
                  <c:v>0.75680933852140098</c:v>
                </c:pt>
                <c:pt idx="593">
                  <c:v>0.72568093385214005</c:v>
                </c:pt>
                <c:pt idx="594">
                  <c:v>0.75875486381322998</c:v>
                </c:pt>
                <c:pt idx="595">
                  <c:v>0.737354085603113</c:v>
                </c:pt>
                <c:pt idx="596">
                  <c:v>0.68093385214007796</c:v>
                </c:pt>
                <c:pt idx="597">
                  <c:v>0.71789883268482502</c:v>
                </c:pt>
                <c:pt idx="598">
                  <c:v>0.76070038910505799</c:v>
                </c:pt>
                <c:pt idx="599">
                  <c:v>0.72762645914396895</c:v>
                </c:pt>
                <c:pt idx="600">
                  <c:v>0.71984435797665403</c:v>
                </c:pt>
                <c:pt idx="601">
                  <c:v>0.75875486381322998</c:v>
                </c:pt>
                <c:pt idx="602">
                  <c:v>0.75680933852140098</c:v>
                </c:pt>
                <c:pt idx="603">
                  <c:v>0.762645914396887</c:v>
                </c:pt>
                <c:pt idx="604">
                  <c:v>0.76070038910505799</c:v>
                </c:pt>
                <c:pt idx="605">
                  <c:v>0.74902723735408605</c:v>
                </c:pt>
                <c:pt idx="606">
                  <c:v>0.76070038910505799</c:v>
                </c:pt>
                <c:pt idx="607">
                  <c:v>0.73151750972762597</c:v>
                </c:pt>
                <c:pt idx="608">
                  <c:v>0.72373540856031104</c:v>
                </c:pt>
                <c:pt idx="609">
                  <c:v>0.762645914396887</c:v>
                </c:pt>
                <c:pt idx="610">
                  <c:v>0.76070038910505799</c:v>
                </c:pt>
                <c:pt idx="611">
                  <c:v>0.74513618677042803</c:v>
                </c:pt>
                <c:pt idx="612">
                  <c:v>0.76070038910505799</c:v>
                </c:pt>
                <c:pt idx="613">
                  <c:v>0.762645914396887</c:v>
                </c:pt>
                <c:pt idx="614">
                  <c:v>0.76070038910505799</c:v>
                </c:pt>
                <c:pt idx="615">
                  <c:v>0.75875486381322998</c:v>
                </c:pt>
                <c:pt idx="616">
                  <c:v>0.52140077821011699</c:v>
                </c:pt>
                <c:pt idx="617">
                  <c:v>0.75097276264591395</c:v>
                </c:pt>
                <c:pt idx="618">
                  <c:v>0.714007782101167</c:v>
                </c:pt>
                <c:pt idx="619">
                  <c:v>0.762645914396887</c:v>
                </c:pt>
                <c:pt idx="620">
                  <c:v>0.75875486381322998</c:v>
                </c:pt>
                <c:pt idx="621">
                  <c:v>0.762645914396887</c:v>
                </c:pt>
                <c:pt idx="622">
                  <c:v>0.75680933852140098</c:v>
                </c:pt>
                <c:pt idx="623">
                  <c:v>0.70428015564202295</c:v>
                </c:pt>
                <c:pt idx="624">
                  <c:v>0.75680933852140098</c:v>
                </c:pt>
                <c:pt idx="625">
                  <c:v>0.72762645914396895</c:v>
                </c:pt>
                <c:pt idx="626">
                  <c:v>0.74708171206225704</c:v>
                </c:pt>
                <c:pt idx="627">
                  <c:v>0.73151750972762597</c:v>
                </c:pt>
                <c:pt idx="628">
                  <c:v>0.75875486381322998</c:v>
                </c:pt>
                <c:pt idx="629">
                  <c:v>0.72957198443579796</c:v>
                </c:pt>
                <c:pt idx="630">
                  <c:v>0.75680933852140098</c:v>
                </c:pt>
                <c:pt idx="631">
                  <c:v>0.75875486381322998</c:v>
                </c:pt>
                <c:pt idx="632">
                  <c:v>0.72957198443579796</c:v>
                </c:pt>
                <c:pt idx="633">
                  <c:v>0.72762645914396895</c:v>
                </c:pt>
                <c:pt idx="634">
                  <c:v>0.72762645914396895</c:v>
                </c:pt>
                <c:pt idx="635">
                  <c:v>0.72957198443579796</c:v>
                </c:pt>
                <c:pt idx="636">
                  <c:v>0.75875486381322998</c:v>
                </c:pt>
                <c:pt idx="637">
                  <c:v>0.76070038910505799</c:v>
                </c:pt>
                <c:pt idx="638">
                  <c:v>0.74319066147859902</c:v>
                </c:pt>
                <c:pt idx="639">
                  <c:v>0.75875486381322998</c:v>
                </c:pt>
                <c:pt idx="640">
                  <c:v>0.762645914396887</c:v>
                </c:pt>
                <c:pt idx="641">
                  <c:v>0.75291828793774296</c:v>
                </c:pt>
                <c:pt idx="642">
                  <c:v>0.762645914396887</c:v>
                </c:pt>
                <c:pt idx="643">
                  <c:v>0.762645914396887</c:v>
                </c:pt>
                <c:pt idx="644">
                  <c:v>0.72373540856031104</c:v>
                </c:pt>
                <c:pt idx="645">
                  <c:v>0.762645914396887</c:v>
                </c:pt>
                <c:pt idx="646">
                  <c:v>0.76070038910505799</c:v>
                </c:pt>
                <c:pt idx="647">
                  <c:v>0.67315175097276303</c:v>
                </c:pt>
                <c:pt idx="648">
                  <c:v>0.762645914396887</c:v>
                </c:pt>
                <c:pt idx="649">
                  <c:v>0.76070038910505799</c:v>
                </c:pt>
                <c:pt idx="650">
                  <c:v>0.70817120622568097</c:v>
                </c:pt>
                <c:pt idx="651">
                  <c:v>0.75291828793774296</c:v>
                </c:pt>
                <c:pt idx="652">
                  <c:v>0.74708171206225704</c:v>
                </c:pt>
                <c:pt idx="653">
                  <c:v>0.72178988326848204</c:v>
                </c:pt>
                <c:pt idx="654">
                  <c:v>0.762645914396887</c:v>
                </c:pt>
                <c:pt idx="655">
                  <c:v>0.76070038910505799</c:v>
                </c:pt>
                <c:pt idx="656">
                  <c:v>0.67898832684824895</c:v>
                </c:pt>
                <c:pt idx="657">
                  <c:v>0.762645914396887</c:v>
                </c:pt>
                <c:pt idx="658">
                  <c:v>0.762645914396887</c:v>
                </c:pt>
                <c:pt idx="659">
                  <c:v>0.75875486381322998</c:v>
                </c:pt>
                <c:pt idx="660">
                  <c:v>0.75486381322957197</c:v>
                </c:pt>
                <c:pt idx="661">
                  <c:v>0.76070038910505799</c:v>
                </c:pt>
                <c:pt idx="662">
                  <c:v>0.48249027237354097</c:v>
                </c:pt>
                <c:pt idx="663">
                  <c:v>0.75680933852140098</c:v>
                </c:pt>
                <c:pt idx="664">
                  <c:v>0.76070038910505799</c:v>
                </c:pt>
                <c:pt idx="665">
                  <c:v>0.71011673151750998</c:v>
                </c:pt>
                <c:pt idx="666">
                  <c:v>0.762645914396887</c:v>
                </c:pt>
                <c:pt idx="667">
                  <c:v>0.76070038910505799</c:v>
                </c:pt>
                <c:pt idx="668">
                  <c:v>0.65758754863813196</c:v>
                </c:pt>
                <c:pt idx="669">
                  <c:v>0.762645914396887</c:v>
                </c:pt>
                <c:pt idx="670">
                  <c:v>0.76070038910505799</c:v>
                </c:pt>
                <c:pt idx="671">
                  <c:v>0.74902723735408605</c:v>
                </c:pt>
                <c:pt idx="672">
                  <c:v>0.762645914396887</c:v>
                </c:pt>
                <c:pt idx="673">
                  <c:v>0.762645914396887</c:v>
                </c:pt>
                <c:pt idx="674">
                  <c:v>0.76070038910505799</c:v>
                </c:pt>
                <c:pt idx="675">
                  <c:v>0.76070038910505799</c:v>
                </c:pt>
                <c:pt idx="676">
                  <c:v>0.762645914396887</c:v>
                </c:pt>
                <c:pt idx="677">
                  <c:v>0.67120622568093402</c:v>
                </c:pt>
                <c:pt idx="678">
                  <c:v>0.762645914396887</c:v>
                </c:pt>
                <c:pt idx="679">
                  <c:v>0.76070038910505799</c:v>
                </c:pt>
                <c:pt idx="680">
                  <c:v>0.66147859922178998</c:v>
                </c:pt>
                <c:pt idx="681">
                  <c:v>0.75680933852140098</c:v>
                </c:pt>
                <c:pt idx="682">
                  <c:v>0.75875486381322998</c:v>
                </c:pt>
                <c:pt idx="683">
                  <c:v>0.70038910505836605</c:v>
                </c:pt>
                <c:pt idx="684">
                  <c:v>0.762645914396887</c:v>
                </c:pt>
                <c:pt idx="685">
                  <c:v>0.76070038910505799</c:v>
                </c:pt>
                <c:pt idx="686">
                  <c:v>0.74902723735408605</c:v>
                </c:pt>
                <c:pt idx="687">
                  <c:v>0.737354085603113</c:v>
                </c:pt>
                <c:pt idx="688">
                  <c:v>0.76070038910505799</c:v>
                </c:pt>
                <c:pt idx="689">
                  <c:v>0.72178988326848204</c:v>
                </c:pt>
                <c:pt idx="690">
                  <c:v>0.73540856031128399</c:v>
                </c:pt>
                <c:pt idx="691">
                  <c:v>0.76070038910505799</c:v>
                </c:pt>
                <c:pt idx="692">
                  <c:v>0.75875486381322998</c:v>
                </c:pt>
                <c:pt idx="693">
                  <c:v>0.75875486381322998</c:v>
                </c:pt>
                <c:pt idx="694">
                  <c:v>0.75875486381322998</c:v>
                </c:pt>
                <c:pt idx="695">
                  <c:v>0.75875486381322998</c:v>
                </c:pt>
                <c:pt idx="696">
                  <c:v>0.75680933852140098</c:v>
                </c:pt>
                <c:pt idx="697">
                  <c:v>0.76070038910505799</c:v>
                </c:pt>
                <c:pt idx="698">
                  <c:v>0.75875486381322998</c:v>
                </c:pt>
                <c:pt idx="699">
                  <c:v>0.75486381322957197</c:v>
                </c:pt>
                <c:pt idx="700">
                  <c:v>0.75875486381322998</c:v>
                </c:pt>
                <c:pt idx="701">
                  <c:v>0.73929961089494201</c:v>
                </c:pt>
                <c:pt idx="702">
                  <c:v>0.76070038910505799</c:v>
                </c:pt>
                <c:pt idx="703">
                  <c:v>0.75875486381322998</c:v>
                </c:pt>
                <c:pt idx="704">
                  <c:v>0.75875486381322998</c:v>
                </c:pt>
                <c:pt idx="705">
                  <c:v>0.75680933852140098</c:v>
                </c:pt>
                <c:pt idx="706">
                  <c:v>0.75291828793774296</c:v>
                </c:pt>
                <c:pt idx="707">
                  <c:v>0.643968871595331</c:v>
                </c:pt>
                <c:pt idx="708">
                  <c:v>0.75680933852140098</c:v>
                </c:pt>
                <c:pt idx="709">
                  <c:v>0.75486381322957197</c:v>
                </c:pt>
                <c:pt idx="710">
                  <c:v>0.76070038910505799</c:v>
                </c:pt>
                <c:pt idx="711">
                  <c:v>0.75875486381322998</c:v>
                </c:pt>
                <c:pt idx="712">
                  <c:v>0.762645914396887</c:v>
                </c:pt>
                <c:pt idx="713">
                  <c:v>0.73540856031128399</c:v>
                </c:pt>
                <c:pt idx="714">
                  <c:v>0.75875486381322998</c:v>
                </c:pt>
                <c:pt idx="715">
                  <c:v>0.75291828793774296</c:v>
                </c:pt>
                <c:pt idx="716">
                  <c:v>0.73151750972762597</c:v>
                </c:pt>
                <c:pt idx="717">
                  <c:v>0.76070038910505799</c:v>
                </c:pt>
                <c:pt idx="718">
                  <c:v>0.76070038910505799</c:v>
                </c:pt>
                <c:pt idx="719">
                  <c:v>0.73540856031128399</c:v>
                </c:pt>
                <c:pt idx="720">
                  <c:v>0.762645914396887</c:v>
                </c:pt>
                <c:pt idx="721">
                  <c:v>0.75680933852140098</c:v>
                </c:pt>
                <c:pt idx="722">
                  <c:v>0.71984435797665403</c:v>
                </c:pt>
                <c:pt idx="723">
                  <c:v>0.75680933852140098</c:v>
                </c:pt>
                <c:pt idx="724">
                  <c:v>0.75486381322957197</c:v>
                </c:pt>
                <c:pt idx="725">
                  <c:v>0.74708171206225704</c:v>
                </c:pt>
                <c:pt idx="726">
                  <c:v>0.75680933852140098</c:v>
                </c:pt>
                <c:pt idx="727">
                  <c:v>0.75097276264591395</c:v>
                </c:pt>
                <c:pt idx="728">
                  <c:v>0.75097276264591395</c:v>
                </c:pt>
                <c:pt idx="729">
                  <c:v>0.75097276264591395</c:v>
                </c:pt>
                <c:pt idx="730">
                  <c:v>0.75291828793774296</c:v>
                </c:pt>
                <c:pt idx="731">
                  <c:v>0.73929961089494201</c:v>
                </c:pt>
                <c:pt idx="732">
                  <c:v>0.75097276264591395</c:v>
                </c:pt>
                <c:pt idx="733">
                  <c:v>0.75291828793774296</c:v>
                </c:pt>
                <c:pt idx="734">
                  <c:v>0.73346303501945498</c:v>
                </c:pt>
                <c:pt idx="735">
                  <c:v>0.71206225680933899</c:v>
                </c:pt>
                <c:pt idx="736">
                  <c:v>0.75291828793774296</c:v>
                </c:pt>
                <c:pt idx="737">
                  <c:v>0.71595330739299601</c:v>
                </c:pt>
                <c:pt idx="738">
                  <c:v>0.75291828793774296</c:v>
                </c:pt>
                <c:pt idx="739">
                  <c:v>0.75680933852140098</c:v>
                </c:pt>
                <c:pt idx="740">
                  <c:v>0.71789883268482502</c:v>
                </c:pt>
                <c:pt idx="741">
                  <c:v>0.75680933852140098</c:v>
                </c:pt>
                <c:pt idx="742">
                  <c:v>0.75291828793774296</c:v>
                </c:pt>
                <c:pt idx="743">
                  <c:v>0.72373540856031104</c:v>
                </c:pt>
                <c:pt idx="744">
                  <c:v>0.72373540856031104</c:v>
                </c:pt>
                <c:pt idx="745">
                  <c:v>0.74902723735408605</c:v>
                </c:pt>
                <c:pt idx="746">
                  <c:v>0.68093385214007796</c:v>
                </c:pt>
                <c:pt idx="747">
                  <c:v>0.75486381322957197</c:v>
                </c:pt>
                <c:pt idx="748">
                  <c:v>0.75097276264591395</c:v>
                </c:pt>
                <c:pt idx="749">
                  <c:v>0.70817120622568097</c:v>
                </c:pt>
                <c:pt idx="750">
                  <c:v>0.75291828793774296</c:v>
                </c:pt>
                <c:pt idx="751">
                  <c:v>0.75097276264591395</c:v>
                </c:pt>
                <c:pt idx="752">
                  <c:v>0.737354085603113</c:v>
                </c:pt>
                <c:pt idx="753">
                  <c:v>0.75875486381322998</c:v>
                </c:pt>
                <c:pt idx="754">
                  <c:v>0.75875486381322998</c:v>
                </c:pt>
                <c:pt idx="755">
                  <c:v>0.71595330739299601</c:v>
                </c:pt>
                <c:pt idx="756">
                  <c:v>0.75875486381322998</c:v>
                </c:pt>
                <c:pt idx="757">
                  <c:v>0.75680933852140098</c:v>
                </c:pt>
                <c:pt idx="758">
                  <c:v>0.74513618677042803</c:v>
                </c:pt>
                <c:pt idx="759">
                  <c:v>0.75875486381322998</c:v>
                </c:pt>
                <c:pt idx="760">
                  <c:v>0.75875486381322998</c:v>
                </c:pt>
                <c:pt idx="761">
                  <c:v>0.72568093385214005</c:v>
                </c:pt>
                <c:pt idx="762">
                  <c:v>0.72568093385214005</c:v>
                </c:pt>
                <c:pt idx="763">
                  <c:v>0.72762645914396895</c:v>
                </c:pt>
                <c:pt idx="764">
                  <c:v>0.714007782101167</c:v>
                </c:pt>
                <c:pt idx="765">
                  <c:v>0.714007782101167</c:v>
                </c:pt>
                <c:pt idx="766">
                  <c:v>0.75875486381322998</c:v>
                </c:pt>
                <c:pt idx="767">
                  <c:v>0.73346303501945498</c:v>
                </c:pt>
                <c:pt idx="768">
                  <c:v>0.69844357976653704</c:v>
                </c:pt>
                <c:pt idx="769">
                  <c:v>0.73540856031128399</c:v>
                </c:pt>
                <c:pt idx="770">
                  <c:v>0.70817120622568097</c:v>
                </c:pt>
                <c:pt idx="771">
                  <c:v>0.75291828793774296</c:v>
                </c:pt>
                <c:pt idx="772">
                  <c:v>0.75291828793774296</c:v>
                </c:pt>
                <c:pt idx="773">
                  <c:v>0.752918287937742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B5B-4BBF-B3E0-B8326CD9E7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7169538"/>
        <c:axId val="582785731"/>
      </c:lineChart>
      <c:catAx>
        <c:axId val="66716953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82785731"/>
        <c:crosses val="autoZero"/>
        <c:auto val="1"/>
        <c:lblAlgn val="ctr"/>
        <c:lblOffset val="100"/>
        <c:noMultiLvlLbl val="0"/>
      </c:catAx>
      <c:valAx>
        <c:axId val="582785731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6716953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800"/>
              <a:t>V2 </a:t>
            </a:r>
            <a:r>
              <a:rPr lang="en-US" sz="1800"/>
              <a:t>identity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[V2.xlsx]Sheet1!$G$1</c:f>
              <c:strCache>
                <c:ptCount val="1"/>
                <c:pt idx="0">
                  <c:v>identity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[V2.xlsx]Sheet1!$G$2:$G$349</c:f>
              <c:numCache>
                <c:formatCode>General</c:formatCode>
                <c:ptCount val="348"/>
                <c:pt idx="0">
                  <c:v>0.77181208053691297</c:v>
                </c:pt>
                <c:pt idx="1">
                  <c:v>0.77181208053691297</c:v>
                </c:pt>
                <c:pt idx="2">
                  <c:v>0.77181208053691297</c:v>
                </c:pt>
                <c:pt idx="3">
                  <c:v>0.76845637583892601</c:v>
                </c:pt>
                <c:pt idx="4">
                  <c:v>0.77181208053691297</c:v>
                </c:pt>
                <c:pt idx="5">
                  <c:v>0.76845637583892601</c:v>
                </c:pt>
                <c:pt idx="6">
                  <c:v>0.778523489932886</c:v>
                </c:pt>
                <c:pt idx="7">
                  <c:v>0.78187919463087296</c:v>
                </c:pt>
                <c:pt idx="8">
                  <c:v>0.51677852348993303</c:v>
                </c:pt>
                <c:pt idx="9">
                  <c:v>0.78187919463087296</c:v>
                </c:pt>
                <c:pt idx="10">
                  <c:v>0.78187919463087296</c:v>
                </c:pt>
                <c:pt idx="11">
                  <c:v>0.74161073825503399</c:v>
                </c:pt>
                <c:pt idx="12">
                  <c:v>0.77516778523489904</c:v>
                </c:pt>
                <c:pt idx="13">
                  <c:v>0.78187919463087296</c:v>
                </c:pt>
                <c:pt idx="14">
                  <c:v>0.70805369127516804</c:v>
                </c:pt>
                <c:pt idx="15">
                  <c:v>0.69798657718120805</c:v>
                </c:pt>
                <c:pt idx="16">
                  <c:v>0.78187919463087296</c:v>
                </c:pt>
                <c:pt idx="17">
                  <c:v>0.61409395973154401</c:v>
                </c:pt>
                <c:pt idx="18">
                  <c:v>0.77516778523489904</c:v>
                </c:pt>
                <c:pt idx="19">
                  <c:v>0.78187919463087296</c:v>
                </c:pt>
                <c:pt idx="20">
                  <c:v>0.73825503355704702</c:v>
                </c:pt>
                <c:pt idx="21">
                  <c:v>0.778523489932886</c:v>
                </c:pt>
                <c:pt idx="22">
                  <c:v>0.78187919463087296</c:v>
                </c:pt>
                <c:pt idx="23">
                  <c:v>0.68120805369127502</c:v>
                </c:pt>
                <c:pt idx="24">
                  <c:v>0.78187919463087296</c:v>
                </c:pt>
                <c:pt idx="25">
                  <c:v>0.778523489932886</c:v>
                </c:pt>
                <c:pt idx="26">
                  <c:v>0.74832214765100702</c:v>
                </c:pt>
                <c:pt idx="27">
                  <c:v>0.778523489932886</c:v>
                </c:pt>
                <c:pt idx="28">
                  <c:v>0.78187919463087296</c:v>
                </c:pt>
                <c:pt idx="29">
                  <c:v>0.68120805369127502</c:v>
                </c:pt>
                <c:pt idx="30">
                  <c:v>0.77516778523489904</c:v>
                </c:pt>
                <c:pt idx="31">
                  <c:v>0.78187919463087296</c:v>
                </c:pt>
                <c:pt idx="32">
                  <c:v>0.73489932885905995</c:v>
                </c:pt>
                <c:pt idx="33">
                  <c:v>0.75503355704698005</c:v>
                </c:pt>
                <c:pt idx="34">
                  <c:v>0.778523489932886</c:v>
                </c:pt>
                <c:pt idx="35">
                  <c:v>0.66442953020134199</c:v>
                </c:pt>
                <c:pt idx="36">
                  <c:v>0.77181208053691297</c:v>
                </c:pt>
                <c:pt idx="37">
                  <c:v>0.778523489932886</c:v>
                </c:pt>
                <c:pt idx="38">
                  <c:v>0.74832214765100702</c:v>
                </c:pt>
                <c:pt idx="39">
                  <c:v>0.778523489932886</c:v>
                </c:pt>
                <c:pt idx="40">
                  <c:v>0.77516778523489904</c:v>
                </c:pt>
                <c:pt idx="41">
                  <c:v>0.72483221476510096</c:v>
                </c:pt>
                <c:pt idx="42">
                  <c:v>0.778523489932886</c:v>
                </c:pt>
                <c:pt idx="43">
                  <c:v>0.78187919463087296</c:v>
                </c:pt>
                <c:pt idx="44">
                  <c:v>0.73489932885905995</c:v>
                </c:pt>
                <c:pt idx="45">
                  <c:v>0.778523489932886</c:v>
                </c:pt>
                <c:pt idx="46">
                  <c:v>0.778523489932886</c:v>
                </c:pt>
                <c:pt idx="47">
                  <c:v>0.77181208053691297</c:v>
                </c:pt>
                <c:pt idx="48">
                  <c:v>0.75838926174496601</c:v>
                </c:pt>
                <c:pt idx="49">
                  <c:v>0.78187919463087296</c:v>
                </c:pt>
                <c:pt idx="50">
                  <c:v>0.73825503355704702</c:v>
                </c:pt>
                <c:pt idx="51">
                  <c:v>0.778523489932886</c:v>
                </c:pt>
                <c:pt idx="52">
                  <c:v>0.78187919463087296</c:v>
                </c:pt>
                <c:pt idx="53">
                  <c:v>0.77516778523489904</c:v>
                </c:pt>
                <c:pt idx="54">
                  <c:v>0.778523489932886</c:v>
                </c:pt>
                <c:pt idx="55">
                  <c:v>0.778523489932886</c:v>
                </c:pt>
                <c:pt idx="56">
                  <c:v>0.78187919463087296</c:v>
                </c:pt>
                <c:pt idx="57">
                  <c:v>0.68120805369127502</c:v>
                </c:pt>
                <c:pt idx="58">
                  <c:v>0.778523489932886</c:v>
                </c:pt>
                <c:pt idx="59">
                  <c:v>0.75838926174496601</c:v>
                </c:pt>
                <c:pt idx="60">
                  <c:v>0.78187919463087296</c:v>
                </c:pt>
                <c:pt idx="61">
                  <c:v>0.78187919463087296</c:v>
                </c:pt>
                <c:pt idx="62">
                  <c:v>0.69463087248322197</c:v>
                </c:pt>
                <c:pt idx="63">
                  <c:v>0.76845637583892601</c:v>
                </c:pt>
                <c:pt idx="64">
                  <c:v>0.77516778523489904</c:v>
                </c:pt>
                <c:pt idx="65">
                  <c:v>0.721476510067114</c:v>
                </c:pt>
                <c:pt idx="66">
                  <c:v>0.78187919463087296</c:v>
                </c:pt>
                <c:pt idx="67">
                  <c:v>0.77181208053691297</c:v>
                </c:pt>
                <c:pt idx="68">
                  <c:v>0.75167785234899298</c:v>
                </c:pt>
                <c:pt idx="69">
                  <c:v>0.77516778523489904</c:v>
                </c:pt>
                <c:pt idx="70">
                  <c:v>0.78187919463087296</c:v>
                </c:pt>
                <c:pt idx="71">
                  <c:v>0.778523489932886</c:v>
                </c:pt>
                <c:pt idx="72">
                  <c:v>0.76845637583892601</c:v>
                </c:pt>
                <c:pt idx="73">
                  <c:v>0.77516778523489904</c:v>
                </c:pt>
                <c:pt idx="74">
                  <c:v>0.74832214765100702</c:v>
                </c:pt>
                <c:pt idx="75">
                  <c:v>0.78187919463087296</c:v>
                </c:pt>
                <c:pt idx="76">
                  <c:v>0.77516778523489904</c:v>
                </c:pt>
                <c:pt idx="77">
                  <c:v>0.74161073825503399</c:v>
                </c:pt>
                <c:pt idx="78">
                  <c:v>0.58724832214765099</c:v>
                </c:pt>
                <c:pt idx="79">
                  <c:v>0.75167785234899298</c:v>
                </c:pt>
                <c:pt idx="80">
                  <c:v>0.73154362416107399</c:v>
                </c:pt>
                <c:pt idx="81">
                  <c:v>0.78187919463087296</c:v>
                </c:pt>
                <c:pt idx="82">
                  <c:v>0.78187919463087296</c:v>
                </c:pt>
                <c:pt idx="83">
                  <c:v>0.75167785234899298</c:v>
                </c:pt>
                <c:pt idx="84">
                  <c:v>0.77516778523489904</c:v>
                </c:pt>
                <c:pt idx="85">
                  <c:v>0.77181208053691297</c:v>
                </c:pt>
                <c:pt idx="86">
                  <c:v>0.73154362416107399</c:v>
                </c:pt>
                <c:pt idx="87">
                  <c:v>0.69127516778523501</c:v>
                </c:pt>
                <c:pt idx="88">
                  <c:v>0.778523489932886</c:v>
                </c:pt>
                <c:pt idx="89">
                  <c:v>0.75838926174496601</c:v>
                </c:pt>
                <c:pt idx="90">
                  <c:v>0.78523489932885904</c:v>
                </c:pt>
                <c:pt idx="91">
                  <c:v>0.77516778523489904</c:v>
                </c:pt>
                <c:pt idx="92">
                  <c:v>0.60067114093959695</c:v>
                </c:pt>
                <c:pt idx="93">
                  <c:v>0.778523489932886</c:v>
                </c:pt>
                <c:pt idx="94">
                  <c:v>0.78523489932885904</c:v>
                </c:pt>
                <c:pt idx="95">
                  <c:v>0.70134228187919501</c:v>
                </c:pt>
                <c:pt idx="96">
                  <c:v>0.74832214765100702</c:v>
                </c:pt>
                <c:pt idx="97">
                  <c:v>0.75167785234899298</c:v>
                </c:pt>
                <c:pt idx="98">
                  <c:v>0.75167785234899298</c:v>
                </c:pt>
                <c:pt idx="99">
                  <c:v>0.78187919463087296</c:v>
                </c:pt>
                <c:pt idx="100">
                  <c:v>0.778523489932886</c:v>
                </c:pt>
                <c:pt idx="101">
                  <c:v>0.75167785234899298</c:v>
                </c:pt>
                <c:pt idx="102">
                  <c:v>0.75838926174496601</c:v>
                </c:pt>
                <c:pt idx="103">
                  <c:v>0.78523489932885904</c:v>
                </c:pt>
                <c:pt idx="104">
                  <c:v>0.71476510067114096</c:v>
                </c:pt>
                <c:pt idx="105">
                  <c:v>0.78523489932885904</c:v>
                </c:pt>
                <c:pt idx="106">
                  <c:v>0.78523489932885904</c:v>
                </c:pt>
                <c:pt idx="107">
                  <c:v>0.63087248322147604</c:v>
                </c:pt>
                <c:pt idx="108">
                  <c:v>0.77181208053691297</c:v>
                </c:pt>
                <c:pt idx="109">
                  <c:v>0.78523489932885904</c:v>
                </c:pt>
                <c:pt idx="110">
                  <c:v>0.75503355704698005</c:v>
                </c:pt>
                <c:pt idx="111">
                  <c:v>0.78523489932885904</c:v>
                </c:pt>
                <c:pt idx="112">
                  <c:v>0.78523489932885904</c:v>
                </c:pt>
                <c:pt idx="113">
                  <c:v>0.73825503355704702</c:v>
                </c:pt>
                <c:pt idx="114">
                  <c:v>0.75838926174496601</c:v>
                </c:pt>
                <c:pt idx="115">
                  <c:v>0.778523489932886</c:v>
                </c:pt>
                <c:pt idx="116">
                  <c:v>0.76845637583892601</c:v>
                </c:pt>
                <c:pt idx="117">
                  <c:v>0.78523489932885904</c:v>
                </c:pt>
                <c:pt idx="118">
                  <c:v>0.78523489932885904</c:v>
                </c:pt>
                <c:pt idx="119">
                  <c:v>0.778523489932886</c:v>
                </c:pt>
                <c:pt idx="120">
                  <c:v>0.76174496644295298</c:v>
                </c:pt>
                <c:pt idx="121">
                  <c:v>0.78523489932885904</c:v>
                </c:pt>
                <c:pt idx="122">
                  <c:v>0.778523489932886</c:v>
                </c:pt>
                <c:pt idx="123">
                  <c:v>0.74832214765100702</c:v>
                </c:pt>
                <c:pt idx="124">
                  <c:v>0.78187919463087296</c:v>
                </c:pt>
                <c:pt idx="125">
                  <c:v>0.75838926174496601</c:v>
                </c:pt>
                <c:pt idx="126">
                  <c:v>0.74161073825503399</c:v>
                </c:pt>
                <c:pt idx="127">
                  <c:v>0.78187919463087296</c:v>
                </c:pt>
                <c:pt idx="128">
                  <c:v>0.73489932885905995</c:v>
                </c:pt>
                <c:pt idx="129">
                  <c:v>0.78523489932885904</c:v>
                </c:pt>
                <c:pt idx="130">
                  <c:v>0.78187919463087296</c:v>
                </c:pt>
                <c:pt idx="131">
                  <c:v>0.78187919463087296</c:v>
                </c:pt>
                <c:pt idx="132">
                  <c:v>0.76174496644295298</c:v>
                </c:pt>
                <c:pt idx="133">
                  <c:v>0.78523489932885904</c:v>
                </c:pt>
                <c:pt idx="134">
                  <c:v>0.74496644295301995</c:v>
                </c:pt>
                <c:pt idx="135">
                  <c:v>0.78187919463087296</c:v>
                </c:pt>
                <c:pt idx="136">
                  <c:v>0.78187919463087296</c:v>
                </c:pt>
                <c:pt idx="137">
                  <c:v>0.70805369127516804</c:v>
                </c:pt>
                <c:pt idx="138">
                  <c:v>0.78523489932885904</c:v>
                </c:pt>
                <c:pt idx="139">
                  <c:v>0.74832214765100702</c:v>
                </c:pt>
                <c:pt idx="140">
                  <c:v>0.74832214765100702</c:v>
                </c:pt>
                <c:pt idx="141">
                  <c:v>0.78187919463087296</c:v>
                </c:pt>
                <c:pt idx="142">
                  <c:v>0.77516778523489904</c:v>
                </c:pt>
                <c:pt idx="143">
                  <c:v>0.76174496644295298</c:v>
                </c:pt>
                <c:pt idx="144">
                  <c:v>0.68456375838926198</c:v>
                </c:pt>
                <c:pt idx="145">
                  <c:v>0.78187919463087296</c:v>
                </c:pt>
                <c:pt idx="146">
                  <c:v>0.73154362416107399</c:v>
                </c:pt>
                <c:pt idx="147">
                  <c:v>0.75503355704698005</c:v>
                </c:pt>
                <c:pt idx="148">
                  <c:v>0.78523489932885904</c:v>
                </c:pt>
                <c:pt idx="149">
                  <c:v>0.73489932885905995</c:v>
                </c:pt>
                <c:pt idx="150">
                  <c:v>0.78187919463087296</c:v>
                </c:pt>
                <c:pt idx="151">
                  <c:v>0.78523489932885904</c:v>
                </c:pt>
                <c:pt idx="152">
                  <c:v>0.70805369127516804</c:v>
                </c:pt>
                <c:pt idx="153">
                  <c:v>0.75838926174496601</c:v>
                </c:pt>
                <c:pt idx="154">
                  <c:v>0.78187919463087296</c:v>
                </c:pt>
                <c:pt idx="155">
                  <c:v>0.75503355704698005</c:v>
                </c:pt>
                <c:pt idx="156">
                  <c:v>0.78187919463087296</c:v>
                </c:pt>
                <c:pt idx="157">
                  <c:v>0.78187919463087296</c:v>
                </c:pt>
                <c:pt idx="158">
                  <c:v>0.70805369127516804</c:v>
                </c:pt>
                <c:pt idx="159">
                  <c:v>0.78187919463087296</c:v>
                </c:pt>
                <c:pt idx="160">
                  <c:v>0.78523489932885904</c:v>
                </c:pt>
                <c:pt idx="161">
                  <c:v>0.78523489932885904</c:v>
                </c:pt>
                <c:pt idx="162">
                  <c:v>0.78523489932885904</c:v>
                </c:pt>
                <c:pt idx="163">
                  <c:v>0.77181208053691297</c:v>
                </c:pt>
                <c:pt idx="164">
                  <c:v>0.75167785234899298</c:v>
                </c:pt>
                <c:pt idx="165">
                  <c:v>0.78187919463087296</c:v>
                </c:pt>
                <c:pt idx="166">
                  <c:v>0.78523489932885904</c:v>
                </c:pt>
                <c:pt idx="167">
                  <c:v>0.78523489932885904</c:v>
                </c:pt>
                <c:pt idx="168">
                  <c:v>0.78523489932885904</c:v>
                </c:pt>
                <c:pt idx="169">
                  <c:v>0.78523489932885904</c:v>
                </c:pt>
                <c:pt idx="170">
                  <c:v>0.78523489932885904</c:v>
                </c:pt>
                <c:pt idx="171">
                  <c:v>0.67785234899328894</c:v>
                </c:pt>
                <c:pt idx="172">
                  <c:v>0.77516778523489904</c:v>
                </c:pt>
                <c:pt idx="173">
                  <c:v>0.77516778523489904</c:v>
                </c:pt>
                <c:pt idx="174">
                  <c:v>0.58053691275167796</c:v>
                </c:pt>
                <c:pt idx="175">
                  <c:v>0.78523489932885904</c:v>
                </c:pt>
                <c:pt idx="176">
                  <c:v>0.76174496644295298</c:v>
                </c:pt>
                <c:pt idx="177">
                  <c:v>0.76174496644295298</c:v>
                </c:pt>
                <c:pt idx="178">
                  <c:v>0.78523489932885904</c:v>
                </c:pt>
                <c:pt idx="179">
                  <c:v>0.78523489932885904</c:v>
                </c:pt>
                <c:pt idx="180">
                  <c:v>0.778523489932886</c:v>
                </c:pt>
                <c:pt idx="181">
                  <c:v>0.78523489932885904</c:v>
                </c:pt>
                <c:pt idx="182">
                  <c:v>0.78523489932885904</c:v>
                </c:pt>
                <c:pt idx="183">
                  <c:v>0.78523489932885904</c:v>
                </c:pt>
                <c:pt idx="184">
                  <c:v>0.73825503355704702</c:v>
                </c:pt>
                <c:pt idx="185">
                  <c:v>0.778523489932886</c:v>
                </c:pt>
                <c:pt idx="186">
                  <c:v>0.76510067114094005</c:v>
                </c:pt>
                <c:pt idx="187">
                  <c:v>0.778523489932886</c:v>
                </c:pt>
                <c:pt idx="188">
                  <c:v>0.778523489932886</c:v>
                </c:pt>
                <c:pt idx="189">
                  <c:v>0.76845637583892601</c:v>
                </c:pt>
                <c:pt idx="190">
                  <c:v>0.78523489932885904</c:v>
                </c:pt>
                <c:pt idx="191">
                  <c:v>0.78187919463087296</c:v>
                </c:pt>
                <c:pt idx="192">
                  <c:v>0.77181208053691297</c:v>
                </c:pt>
                <c:pt idx="193">
                  <c:v>0.78187919463087296</c:v>
                </c:pt>
                <c:pt idx="194">
                  <c:v>0.78187919463087296</c:v>
                </c:pt>
                <c:pt idx="195">
                  <c:v>0.73154362416107399</c:v>
                </c:pt>
                <c:pt idx="196">
                  <c:v>0.78523489932885904</c:v>
                </c:pt>
                <c:pt idx="197">
                  <c:v>0.77516778523489904</c:v>
                </c:pt>
                <c:pt idx="198">
                  <c:v>0.78187919463087296</c:v>
                </c:pt>
                <c:pt idx="199">
                  <c:v>0.78523489932885904</c:v>
                </c:pt>
                <c:pt idx="200">
                  <c:v>0.55369127516778505</c:v>
                </c:pt>
                <c:pt idx="201">
                  <c:v>0.73825503355704702</c:v>
                </c:pt>
                <c:pt idx="202">
                  <c:v>0.77516778523489904</c:v>
                </c:pt>
                <c:pt idx="203">
                  <c:v>0.78187919463087296</c:v>
                </c:pt>
                <c:pt idx="204">
                  <c:v>0.75838926174496601</c:v>
                </c:pt>
                <c:pt idx="205">
                  <c:v>0.78187919463087296</c:v>
                </c:pt>
                <c:pt idx="206">
                  <c:v>0.78187919463087296</c:v>
                </c:pt>
                <c:pt idx="207">
                  <c:v>0.75838926174496601</c:v>
                </c:pt>
                <c:pt idx="208">
                  <c:v>0.78187919463087296</c:v>
                </c:pt>
                <c:pt idx="209">
                  <c:v>0.77181208053691297</c:v>
                </c:pt>
                <c:pt idx="210">
                  <c:v>0.75503355704698005</c:v>
                </c:pt>
                <c:pt idx="211">
                  <c:v>0.78187919463087296</c:v>
                </c:pt>
                <c:pt idx="212">
                  <c:v>0.76845637583892601</c:v>
                </c:pt>
                <c:pt idx="213">
                  <c:v>0.74496644295301995</c:v>
                </c:pt>
                <c:pt idx="214">
                  <c:v>0.78187919463087296</c:v>
                </c:pt>
                <c:pt idx="215">
                  <c:v>0.778523489932886</c:v>
                </c:pt>
                <c:pt idx="216">
                  <c:v>0.75838926174496601</c:v>
                </c:pt>
                <c:pt idx="217">
                  <c:v>0.75838926174496601</c:v>
                </c:pt>
                <c:pt idx="218">
                  <c:v>0.77181208053691297</c:v>
                </c:pt>
                <c:pt idx="219">
                  <c:v>0.76510067114094005</c:v>
                </c:pt>
                <c:pt idx="220">
                  <c:v>0.778523489932886</c:v>
                </c:pt>
                <c:pt idx="221">
                  <c:v>0.78523489932885904</c:v>
                </c:pt>
                <c:pt idx="222">
                  <c:v>0.78187919463087296</c:v>
                </c:pt>
                <c:pt idx="223">
                  <c:v>0.78523489932885904</c:v>
                </c:pt>
                <c:pt idx="224">
                  <c:v>0.78187919463087296</c:v>
                </c:pt>
                <c:pt idx="225">
                  <c:v>0.75503355704698005</c:v>
                </c:pt>
                <c:pt idx="226">
                  <c:v>0.78523489932885904</c:v>
                </c:pt>
                <c:pt idx="227">
                  <c:v>0.778523489932886</c:v>
                </c:pt>
                <c:pt idx="228">
                  <c:v>0.78187919463087296</c:v>
                </c:pt>
                <c:pt idx="229">
                  <c:v>0.778523489932886</c:v>
                </c:pt>
                <c:pt idx="230">
                  <c:v>0.78187919463087296</c:v>
                </c:pt>
                <c:pt idx="231">
                  <c:v>0.78187919463087296</c:v>
                </c:pt>
                <c:pt idx="232">
                  <c:v>0.78523489932885904</c:v>
                </c:pt>
                <c:pt idx="233">
                  <c:v>0.78187919463087296</c:v>
                </c:pt>
                <c:pt idx="234">
                  <c:v>0.78523489932885904</c:v>
                </c:pt>
                <c:pt idx="235">
                  <c:v>0.78187919463087296</c:v>
                </c:pt>
                <c:pt idx="236">
                  <c:v>0.778523489932886</c:v>
                </c:pt>
                <c:pt idx="237">
                  <c:v>0.69798657718120805</c:v>
                </c:pt>
                <c:pt idx="238">
                  <c:v>0.78187919463087296</c:v>
                </c:pt>
                <c:pt idx="239">
                  <c:v>0.76174496644295298</c:v>
                </c:pt>
                <c:pt idx="240">
                  <c:v>0.74161073825503399</c:v>
                </c:pt>
                <c:pt idx="241">
                  <c:v>0.75838926174496601</c:v>
                </c:pt>
                <c:pt idx="242">
                  <c:v>0.73154362416107399</c:v>
                </c:pt>
                <c:pt idx="243">
                  <c:v>0.78523489932885904</c:v>
                </c:pt>
                <c:pt idx="244">
                  <c:v>0.78187919463087296</c:v>
                </c:pt>
                <c:pt idx="245">
                  <c:v>0.68120805369127502</c:v>
                </c:pt>
                <c:pt idx="246">
                  <c:v>0.78523489932885904</c:v>
                </c:pt>
                <c:pt idx="247">
                  <c:v>0.77516778523489904</c:v>
                </c:pt>
                <c:pt idx="248">
                  <c:v>0.78187919463087296</c:v>
                </c:pt>
                <c:pt idx="249">
                  <c:v>0.76845637583892601</c:v>
                </c:pt>
                <c:pt idx="250">
                  <c:v>0.778523489932886</c:v>
                </c:pt>
                <c:pt idx="251">
                  <c:v>0.778523489932886</c:v>
                </c:pt>
                <c:pt idx="252">
                  <c:v>0.78187919463087296</c:v>
                </c:pt>
                <c:pt idx="253">
                  <c:v>0.778523489932886</c:v>
                </c:pt>
                <c:pt idx="254">
                  <c:v>0.75503355704698005</c:v>
                </c:pt>
                <c:pt idx="255">
                  <c:v>0.77516778523489904</c:v>
                </c:pt>
                <c:pt idx="256">
                  <c:v>0.77516778523489904</c:v>
                </c:pt>
                <c:pt idx="257">
                  <c:v>0.63087248322147604</c:v>
                </c:pt>
                <c:pt idx="258">
                  <c:v>0.77516778523489904</c:v>
                </c:pt>
                <c:pt idx="259">
                  <c:v>0.778523489932886</c:v>
                </c:pt>
                <c:pt idx="260">
                  <c:v>0.77181208053691297</c:v>
                </c:pt>
                <c:pt idx="261">
                  <c:v>0.778523489932886</c:v>
                </c:pt>
                <c:pt idx="262">
                  <c:v>0.778523489932886</c:v>
                </c:pt>
                <c:pt idx="263">
                  <c:v>0.73154362416107399</c:v>
                </c:pt>
                <c:pt idx="264">
                  <c:v>0.778523489932886</c:v>
                </c:pt>
                <c:pt idx="265">
                  <c:v>0.77516778523489904</c:v>
                </c:pt>
                <c:pt idx="266">
                  <c:v>0.77516778523489904</c:v>
                </c:pt>
                <c:pt idx="267">
                  <c:v>0.77181208053691297</c:v>
                </c:pt>
                <c:pt idx="268">
                  <c:v>0.78187919463087296</c:v>
                </c:pt>
                <c:pt idx="269">
                  <c:v>0.73489932885905995</c:v>
                </c:pt>
                <c:pt idx="270">
                  <c:v>0.75503355704698005</c:v>
                </c:pt>
                <c:pt idx="271">
                  <c:v>0.78187919463087296</c:v>
                </c:pt>
                <c:pt idx="272">
                  <c:v>0.75167785234899298</c:v>
                </c:pt>
                <c:pt idx="273">
                  <c:v>0.778523489932886</c:v>
                </c:pt>
                <c:pt idx="274">
                  <c:v>0.778523489932886</c:v>
                </c:pt>
                <c:pt idx="275">
                  <c:v>0.70134228187919501</c:v>
                </c:pt>
                <c:pt idx="276">
                  <c:v>0.78187919463087296</c:v>
                </c:pt>
                <c:pt idx="277">
                  <c:v>0.78187919463087296</c:v>
                </c:pt>
                <c:pt idx="278">
                  <c:v>0.76845637583892601</c:v>
                </c:pt>
                <c:pt idx="279">
                  <c:v>0.778523489932886</c:v>
                </c:pt>
                <c:pt idx="280">
                  <c:v>0.77516778523489904</c:v>
                </c:pt>
                <c:pt idx="281">
                  <c:v>0.75167785234899298</c:v>
                </c:pt>
                <c:pt idx="282">
                  <c:v>0.74496644295301995</c:v>
                </c:pt>
                <c:pt idx="283">
                  <c:v>0.75503355704698005</c:v>
                </c:pt>
                <c:pt idx="284">
                  <c:v>0.778523489932886</c:v>
                </c:pt>
                <c:pt idx="285">
                  <c:v>0.644295302013423</c:v>
                </c:pt>
                <c:pt idx="286">
                  <c:v>0.75503355704698005</c:v>
                </c:pt>
                <c:pt idx="287">
                  <c:v>0.77516778523489904</c:v>
                </c:pt>
                <c:pt idx="288">
                  <c:v>0.70805369127516804</c:v>
                </c:pt>
                <c:pt idx="289">
                  <c:v>0.76510067114094005</c:v>
                </c:pt>
                <c:pt idx="290">
                  <c:v>0.778523489932886</c:v>
                </c:pt>
                <c:pt idx="291">
                  <c:v>0.76174496644295298</c:v>
                </c:pt>
                <c:pt idx="292">
                  <c:v>0.78187919463087296</c:v>
                </c:pt>
                <c:pt idx="293">
                  <c:v>0.778523489932886</c:v>
                </c:pt>
                <c:pt idx="294">
                  <c:v>0.77181208053691297</c:v>
                </c:pt>
                <c:pt idx="295">
                  <c:v>0.75503355704698005</c:v>
                </c:pt>
                <c:pt idx="296">
                  <c:v>0.74161073825503399</c:v>
                </c:pt>
                <c:pt idx="297">
                  <c:v>0.77181208053691297</c:v>
                </c:pt>
                <c:pt idx="298">
                  <c:v>0.75167785234899298</c:v>
                </c:pt>
                <c:pt idx="299">
                  <c:v>0.77181208053691297</c:v>
                </c:pt>
                <c:pt idx="300">
                  <c:v>0.76174496644295298</c:v>
                </c:pt>
                <c:pt idx="301">
                  <c:v>0.74832214765100702</c:v>
                </c:pt>
                <c:pt idx="302">
                  <c:v>0.78187919463087296</c:v>
                </c:pt>
                <c:pt idx="303">
                  <c:v>0.778523489932886</c:v>
                </c:pt>
                <c:pt idx="304">
                  <c:v>0.778523489932886</c:v>
                </c:pt>
                <c:pt idx="305">
                  <c:v>0.76845637583892601</c:v>
                </c:pt>
                <c:pt idx="306">
                  <c:v>0.77516778523489904</c:v>
                </c:pt>
                <c:pt idx="307">
                  <c:v>0.78187919463087296</c:v>
                </c:pt>
                <c:pt idx="308">
                  <c:v>0.78523489932885904</c:v>
                </c:pt>
                <c:pt idx="309">
                  <c:v>0.77516778523489904</c:v>
                </c:pt>
                <c:pt idx="310">
                  <c:v>0.78523489932885904</c:v>
                </c:pt>
                <c:pt idx="311">
                  <c:v>0.78187919463087296</c:v>
                </c:pt>
                <c:pt idx="312">
                  <c:v>0.69463087248322197</c:v>
                </c:pt>
                <c:pt idx="313">
                  <c:v>0.76845637583892601</c:v>
                </c:pt>
                <c:pt idx="314">
                  <c:v>0.78523489932885904</c:v>
                </c:pt>
                <c:pt idx="315">
                  <c:v>0.41610738255033602</c:v>
                </c:pt>
                <c:pt idx="316">
                  <c:v>0.78187919463087296</c:v>
                </c:pt>
                <c:pt idx="317">
                  <c:v>0.778523489932886</c:v>
                </c:pt>
                <c:pt idx="318">
                  <c:v>0.77181208053691297</c:v>
                </c:pt>
                <c:pt idx="319">
                  <c:v>0.778523489932886</c:v>
                </c:pt>
                <c:pt idx="320">
                  <c:v>0.778523489932886</c:v>
                </c:pt>
                <c:pt idx="321">
                  <c:v>0.778523489932886</c:v>
                </c:pt>
                <c:pt idx="322">
                  <c:v>0.77516778523489904</c:v>
                </c:pt>
                <c:pt idx="323">
                  <c:v>0.74832214765100702</c:v>
                </c:pt>
                <c:pt idx="324">
                  <c:v>0.74161073825503399</c:v>
                </c:pt>
                <c:pt idx="325">
                  <c:v>0.78187919463087296</c:v>
                </c:pt>
                <c:pt idx="326">
                  <c:v>0.77516778523489904</c:v>
                </c:pt>
                <c:pt idx="327">
                  <c:v>0.72818791946308703</c:v>
                </c:pt>
                <c:pt idx="328">
                  <c:v>0.78523489932885904</c:v>
                </c:pt>
                <c:pt idx="329">
                  <c:v>0.78523489932885904</c:v>
                </c:pt>
                <c:pt idx="330">
                  <c:v>0.78523489932885904</c:v>
                </c:pt>
                <c:pt idx="331">
                  <c:v>0.778523489932886</c:v>
                </c:pt>
                <c:pt idx="332">
                  <c:v>0.78187919463087296</c:v>
                </c:pt>
                <c:pt idx="333">
                  <c:v>0.76510067114094005</c:v>
                </c:pt>
                <c:pt idx="334">
                  <c:v>0.78523489932885904</c:v>
                </c:pt>
                <c:pt idx="335">
                  <c:v>0.778523489932886</c:v>
                </c:pt>
                <c:pt idx="336">
                  <c:v>0.778523489932886</c:v>
                </c:pt>
                <c:pt idx="337">
                  <c:v>0.778523489932886</c:v>
                </c:pt>
                <c:pt idx="338">
                  <c:v>0.78187919463087296</c:v>
                </c:pt>
                <c:pt idx="339">
                  <c:v>0.73489932885905995</c:v>
                </c:pt>
                <c:pt idx="340">
                  <c:v>0.74496644295301995</c:v>
                </c:pt>
                <c:pt idx="341">
                  <c:v>0.74832214765100702</c:v>
                </c:pt>
                <c:pt idx="342">
                  <c:v>0.75503355704698005</c:v>
                </c:pt>
                <c:pt idx="343">
                  <c:v>0.76845637583892601</c:v>
                </c:pt>
                <c:pt idx="344">
                  <c:v>0.76174496644295298</c:v>
                </c:pt>
                <c:pt idx="345">
                  <c:v>0.71812080536912704</c:v>
                </c:pt>
                <c:pt idx="346">
                  <c:v>0.71812080536912704</c:v>
                </c:pt>
                <c:pt idx="347">
                  <c:v>0.714765100671140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804-4FFA-AD64-9865B90025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746183518"/>
        <c:axId val="795161367"/>
      </c:lineChart>
      <c:catAx>
        <c:axId val="74618351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795161367"/>
        <c:crosses val="autoZero"/>
        <c:auto val="1"/>
        <c:lblAlgn val="ctr"/>
        <c:lblOffset val="100"/>
        <c:noMultiLvlLbl val="0"/>
      </c:catAx>
      <c:valAx>
        <c:axId val="795161367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74618351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800"/>
              <a:t>C1 </a:t>
            </a:r>
            <a:r>
              <a:rPr lang="en-US" sz="1800"/>
              <a:t>identity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[工作簿11]Sheet1!$G$1</c:f>
              <c:strCache>
                <c:ptCount val="1"/>
                <c:pt idx="0">
                  <c:v>identity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[工作簿11]Sheet1!$G$2:$G$1078</c:f>
              <c:numCache>
                <c:formatCode>General</c:formatCode>
                <c:ptCount val="1077"/>
                <c:pt idx="0">
                  <c:v>0.603883495145631</c:v>
                </c:pt>
                <c:pt idx="1">
                  <c:v>0.603883495145631</c:v>
                </c:pt>
                <c:pt idx="2">
                  <c:v>0.603883495145631</c:v>
                </c:pt>
                <c:pt idx="3">
                  <c:v>0.603883495145631</c:v>
                </c:pt>
                <c:pt idx="4">
                  <c:v>0.603883495145631</c:v>
                </c:pt>
                <c:pt idx="5">
                  <c:v>0.603883495145631</c:v>
                </c:pt>
                <c:pt idx="6">
                  <c:v>0.594174757281553</c:v>
                </c:pt>
                <c:pt idx="7">
                  <c:v>0.594174757281553</c:v>
                </c:pt>
                <c:pt idx="8">
                  <c:v>0.594174757281553</c:v>
                </c:pt>
                <c:pt idx="9">
                  <c:v>0.92815533980582499</c:v>
                </c:pt>
                <c:pt idx="10">
                  <c:v>0.91262135922330101</c:v>
                </c:pt>
                <c:pt idx="11">
                  <c:v>0.72233009708737905</c:v>
                </c:pt>
                <c:pt idx="12">
                  <c:v>0.574757281553398</c:v>
                </c:pt>
                <c:pt idx="13">
                  <c:v>0.574757281553398</c:v>
                </c:pt>
                <c:pt idx="14">
                  <c:v>0.76699029126213603</c:v>
                </c:pt>
                <c:pt idx="15">
                  <c:v>0.53009708737864103</c:v>
                </c:pt>
                <c:pt idx="16">
                  <c:v>0.56893203883495103</c:v>
                </c:pt>
                <c:pt idx="17">
                  <c:v>0.72233009708737905</c:v>
                </c:pt>
                <c:pt idx="18">
                  <c:v>0.97669902912621398</c:v>
                </c:pt>
                <c:pt idx="19">
                  <c:v>0.97475728155339803</c:v>
                </c:pt>
                <c:pt idx="20">
                  <c:v>0.73592233009708696</c:v>
                </c:pt>
                <c:pt idx="21">
                  <c:v>0.82718446601941797</c:v>
                </c:pt>
                <c:pt idx="22">
                  <c:v>0.811650485436893</c:v>
                </c:pt>
                <c:pt idx="23">
                  <c:v>0.92233009708737901</c:v>
                </c:pt>
                <c:pt idx="24">
                  <c:v>0.92427184466019396</c:v>
                </c:pt>
                <c:pt idx="25">
                  <c:v>0.96504854368932003</c:v>
                </c:pt>
                <c:pt idx="26">
                  <c:v>0.95339805825242696</c:v>
                </c:pt>
                <c:pt idx="27">
                  <c:v>0.56699029126213596</c:v>
                </c:pt>
                <c:pt idx="28">
                  <c:v>0.96699029126213598</c:v>
                </c:pt>
                <c:pt idx="29">
                  <c:v>0.93592233009708703</c:v>
                </c:pt>
                <c:pt idx="30">
                  <c:v>0.88349514563106801</c:v>
                </c:pt>
                <c:pt idx="31">
                  <c:v>0.89514563106796097</c:v>
                </c:pt>
                <c:pt idx="32">
                  <c:v>0.92233009708737901</c:v>
                </c:pt>
                <c:pt idx="33">
                  <c:v>0.97864077669902905</c:v>
                </c:pt>
                <c:pt idx="34">
                  <c:v>0.97669902912621398</c:v>
                </c:pt>
                <c:pt idx="35">
                  <c:v>0.88543689320388397</c:v>
                </c:pt>
                <c:pt idx="36">
                  <c:v>0.94757281553398098</c:v>
                </c:pt>
                <c:pt idx="37">
                  <c:v>0.96893203883495105</c:v>
                </c:pt>
                <c:pt idx="38">
                  <c:v>0.85631067961165097</c:v>
                </c:pt>
                <c:pt idx="39">
                  <c:v>0.94368932038834996</c:v>
                </c:pt>
                <c:pt idx="40">
                  <c:v>0.94757281553398098</c:v>
                </c:pt>
                <c:pt idx="41">
                  <c:v>0.96504854368932003</c:v>
                </c:pt>
                <c:pt idx="42">
                  <c:v>0.980582524271845</c:v>
                </c:pt>
                <c:pt idx="43">
                  <c:v>0.97281553398058296</c:v>
                </c:pt>
                <c:pt idx="44">
                  <c:v>0.82524271844660202</c:v>
                </c:pt>
                <c:pt idx="45">
                  <c:v>0.94951456310679605</c:v>
                </c:pt>
                <c:pt idx="46">
                  <c:v>0.97281553398058296</c:v>
                </c:pt>
                <c:pt idx="47">
                  <c:v>0.57087378640776698</c:v>
                </c:pt>
                <c:pt idx="48">
                  <c:v>0.970873786407767</c:v>
                </c:pt>
                <c:pt idx="49">
                  <c:v>0.96893203883495105</c:v>
                </c:pt>
                <c:pt idx="50">
                  <c:v>0.78252427184466</c:v>
                </c:pt>
                <c:pt idx="51">
                  <c:v>0.97281553398058296</c:v>
                </c:pt>
                <c:pt idx="52">
                  <c:v>0.94757281553398098</c:v>
                </c:pt>
                <c:pt idx="53">
                  <c:v>0.85436893203883502</c:v>
                </c:pt>
                <c:pt idx="54">
                  <c:v>0.97864077669902905</c:v>
                </c:pt>
                <c:pt idx="55">
                  <c:v>0.97669902912621398</c:v>
                </c:pt>
                <c:pt idx="56">
                  <c:v>0.62135922330097104</c:v>
                </c:pt>
                <c:pt idx="57">
                  <c:v>0.73592233009708696</c:v>
                </c:pt>
                <c:pt idx="58">
                  <c:v>0.96893203883495105</c:v>
                </c:pt>
                <c:pt idx="59">
                  <c:v>0.642718446601942</c:v>
                </c:pt>
                <c:pt idx="60">
                  <c:v>0.97475728155339803</c:v>
                </c:pt>
                <c:pt idx="61">
                  <c:v>0.97475728155339803</c:v>
                </c:pt>
                <c:pt idx="62">
                  <c:v>0.70291262135922306</c:v>
                </c:pt>
                <c:pt idx="63">
                  <c:v>0.94563106796116503</c:v>
                </c:pt>
                <c:pt idx="64">
                  <c:v>0.95922330097087405</c:v>
                </c:pt>
                <c:pt idx="65">
                  <c:v>0.840776699029126</c:v>
                </c:pt>
                <c:pt idx="66">
                  <c:v>0.86407766990291301</c:v>
                </c:pt>
                <c:pt idx="67">
                  <c:v>0.97864077669902905</c:v>
                </c:pt>
                <c:pt idx="68">
                  <c:v>0.69126213592232999</c:v>
                </c:pt>
                <c:pt idx="69">
                  <c:v>0.61553398058252395</c:v>
                </c:pt>
                <c:pt idx="70">
                  <c:v>0.92427184466019396</c:v>
                </c:pt>
                <c:pt idx="71">
                  <c:v>0.72621359223300996</c:v>
                </c:pt>
                <c:pt idx="72">
                  <c:v>0.94757281553398098</c:v>
                </c:pt>
                <c:pt idx="73">
                  <c:v>0.94368932038834996</c:v>
                </c:pt>
                <c:pt idx="74">
                  <c:v>0.93786407766990298</c:v>
                </c:pt>
                <c:pt idx="75">
                  <c:v>0.92621359223301003</c:v>
                </c:pt>
                <c:pt idx="76">
                  <c:v>0.93786407766990298</c:v>
                </c:pt>
                <c:pt idx="77">
                  <c:v>0.66601941747572801</c:v>
                </c:pt>
                <c:pt idx="78">
                  <c:v>0.94368932038834996</c:v>
                </c:pt>
                <c:pt idx="79">
                  <c:v>0.96893203883495105</c:v>
                </c:pt>
                <c:pt idx="80">
                  <c:v>0.89708737864077703</c:v>
                </c:pt>
                <c:pt idx="81">
                  <c:v>0.90679611650485403</c:v>
                </c:pt>
                <c:pt idx="82">
                  <c:v>0.95922330097087405</c:v>
                </c:pt>
                <c:pt idx="83">
                  <c:v>0.82912621359223304</c:v>
                </c:pt>
                <c:pt idx="84">
                  <c:v>0.970873786407767</c:v>
                </c:pt>
                <c:pt idx="85">
                  <c:v>0.97864077669902905</c:v>
                </c:pt>
                <c:pt idx="86">
                  <c:v>0.89126213592232995</c:v>
                </c:pt>
                <c:pt idx="87">
                  <c:v>0.92427184466019396</c:v>
                </c:pt>
                <c:pt idx="88">
                  <c:v>0.92621359223301003</c:v>
                </c:pt>
                <c:pt idx="89">
                  <c:v>0.88155339805825195</c:v>
                </c:pt>
                <c:pt idx="90">
                  <c:v>0.94757281553398098</c:v>
                </c:pt>
                <c:pt idx="91">
                  <c:v>0.95145631067961201</c:v>
                </c:pt>
                <c:pt idx="92">
                  <c:v>0.93592233009708703</c:v>
                </c:pt>
                <c:pt idx="93">
                  <c:v>0.77669902912621402</c:v>
                </c:pt>
                <c:pt idx="94">
                  <c:v>0.97864077669902905</c:v>
                </c:pt>
                <c:pt idx="95">
                  <c:v>0.811650485436893</c:v>
                </c:pt>
                <c:pt idx="96">
                  <c:v>0.68155339805825199</c:v>
                </c:pt>
                <c:pt idx="97">
                  <c:v>0.80970873786407804</c:v>
                </c:pt>
                <c:pt idx="98">
                  <c:v>0.88737864077669903</c:v>
                </c:pt>
                <c:pt idx="99">
                  <c:v>0.76699029126213603</c:v>
                </c:pt>
                <c:pt idx="100">
                  <c:v>0.80388349514563096</c:v>
                </c:pt>
                <c:pt idx="101">
                  <c:v>0.76504854368931996</c:v>
                </c:pt>
                <c:pt idx="102">
                  <c:v>0.89902912621359199</c:v>
                </c:pt>
                <c:pt idx="103">
                  <c:v>0.97669902912621398</c:v>
                </c:pt>
                <c:pt idx="104">
                  <c:v>0.86796116504854404</c:v>
                </c:pt>
                <c:pt idx="105">
                  <c:v>0.73203883495145605</c:v>
                </c:pt>
                <c:pt idx="106">
                  <c:v>0.93980582524271905</c:v>
                </c:pt>
                <c:pt idx="107">
                  <c:v>0.90097087378640806</c:v>
                </c:pt>
                <c:pt idx="108">
                  <c:v>0.94563106796116503</c:v>
                </c:pt>
                <c:pt idx="109">
                  <c:v>0.94757281553398098</c:v>
                </c:pt>
                <c:pt idx="110">
                  <c:v>0.73786407766990303</c:v>
                </c:pt>
                <c:pt idx="111">
                  <c:v>0.97864077669902905</c:v>
                </c:pt>
                <c:pt idx="112">
                  <c:v>0.980582524271845</c:v>
                </c:pt>
                <c:pt idx="113">
                  <c:v>0.85242718446601895</c:v>
                </c:pt>
                <c:pt idx="114">
                  <c:v>0.88349514563106801</c:v>
                </c:pt>
                <c:pt idx="115">
                  <c:v>0.89708737864077703</c:v>
                </c:pt>
                <c:pt idx="116">
                  <c:v>0.72233009708737905</c:v>
                </c:pt>
                <c:pt idx="117">
                  <c:v>0.85242718446601895</c:v>
                </c:pt>
                <c:pt idx="118">
                  <c:v>0.86019417475728199</c:v>
                </c:pt>
                <c:pt idx="119">
                  <c:v>0.81747572815533998</c:v>
                </c:pt>
                <c:pt idx="120">
                  <c:v>0.97669902912621398</c:v>
                </c:pt>
                <c:pt idx="121">
                  <c:v>0.970873786407767</c:v>
                </c:pt>
                <c:pt idx="122">
                  <c:v>0.92621359223301003</c:v>
                </c:pt>
                <c:pt idx="123">
                  <c:v>0.80582524271844702</c:v>
                </c:pt>
                <c:pt idx="124">
                  <c:v>0.80776699029126198</c:v>
                </c:pt>
                <c:pt idx="125">
                  <c:v>0.97864077669902905</c:v>
                </c:pt>
                <c:pt idx="126">
                  <c:v>0.97864077669902905</c:v>
                </c:pt>
                <c:pt idx="127">
                  <c:v>0.72815533980582503</c:v>
                </c:pt>
                <c:pt idx="128">
                  <c:v>0.84660194174757297</c:v>
                </c:pt>
                <c:pt idx="129">
                  <c:v>0.97669902912621398</c:v>
                </c:pt>
                <c:pt idx="130">
                  <c:v>0.97864077669902905</c:v>
                </c:pt>
                <c:pt idx="131">
                  <c:v>0.78640776699029102</c:v>
                </c:pt>
                <c:pt idx="132">
                  <c:v>0.89708737864077703</c:v>
                </c:pt>
                <c:pt idx="133">
                  <c:v>0.73398058252427201</c:v>
                </c:pt>
                <c:pt idx="134">
                  <c:v>0.94174757281553401</c:v>
                </c:pt>
                <c:pt idx="135">
                  <c:v>0.66019417475728204</c:v>
                </c:pt>
                <c:pt idx="136">
                  <c:v>0.97864077669902905</c:v>
                </c:pt>
                <c:pt idx="137">
                  <c:v>0.70679611650485397</c:v>
                </c:pt>
                <c:pt idx="138">
                  <c:v>0.93398058252427196</c:v>
                </c:pt>
                <c:pt idx="139">
                  <c:v>0.92233009708737901</c:v>
                </c:pt>
                <c:pt idx="140">
                  <c:v>0.88543689320388397</c:v>
                </c:pt>
                <c:pt idx="141">
                  <c:v>0.91262135922330101</c:v>
                </c:pt>
                <c:pt idx="142">
                  <c:v>0.87766990291262104</c:v>
                </c:pt>
                <c:pt idx="143">
                  <c:v>0.83300970873786395</c:v>
                </c:pt>
                <c:pt idx="144">
                  <c:v>0.97669902912621398</c:v>
                </c:pt>
                <c:pt idx="145">
                  <c:v>0.97475728155339803</c:v>
                </c:pt>
                <c:pt idx="146">
                  <c:v>0.83689320388349497</c:v>
                </c:pt>
                <c:pt idx="147">
                  <c:v>0.82718446601941797</c:v>
                </c:pt>
                <c:pt idx="148">
                  <c:v>0.94368932038834996</c:v>
                </c:pt>
                <c:pt idx="149">
                  <c:v>0.65436893203883495</c:v>
                </c:pt>
                <c:pt idx="150">
                  <c:v>0.97864077669902905</c:v>
                </c:pt>
                <c:pt idx="151">
                  <c:v>0.97864077669902905</c:v>
                </c:pt>
                <c:pt idx="152">
                  <c:v>0.87378640776699001</c:v>
                </c:pt>
                <c:pt idx="153">
                  <c:v>0.95339805825242696</c:v>
                </c:pt>
                <c:pt idx="154">
                  <c:v>0.96504854368932003</c:v>
                </c:pt>
                <c:pt idx="155">
                  <c:v>0.63495145631067995</c:v>
                </c:pt>
                <c:pt idx="156">
                  <c:v>0.67572815533980601</c:v>
                </c:pt>
                <c:pt idx="157">
                  <c:v>0.980582524271845</c:v>
                </c:pt>
                <c:pt idx="158">
                  <c:v>0.97475728155339803</c:v>
                </c:pt>
                <c:pt idx="159">
                  <c:v>0.97669902912621398</c:v>
                </c:pt>
                <c:pt idx="160">
                  <c:v>0.97864077669902905</c:v>
                </c:pt>
                <c:pt idx="161">
                  <c:v>0.97669902912621398</c:v>
                </c:pt>
                <c:pt idx="162">
                  <c:v>0.66213592233009699</c:v>
                </c:pt>
                <c:pt idx="163">
                  <c:v>0.67961165048543704</c:v>
                </c:pt>
                <c:pt idx="164">
                  <c:v>0.67961165048543704</c:v>
                </c:pt>
                <c:pt idx="165">
                  <c:v>0.97475728155339803</c:v>
                </c:pt>
                <c:pt idx="166">
                  <c:v>0.95728155339805798</c:v>
                </c:pt>
                <c:pt idx="167">
                  <c:v>0.62524271844660195</c:v>
                </c:pt>
                <c:pt idx="168">
                  <c:v>0.980582524271845</c:v>
                </c:pt>
                <c:pt idx="169">
                  <c:v>0.97669902912621398</c:v>
                </c:pt>
                <c:pt idx="170">
                  <c:v>0.792233009708738</c:v>
                </c:pt>
                <c:pt idx="171">
                  <c:v>0.87572815533980597</c:v>
                </c:pt>
                <c:pt idx="172">
                  <c:v>0.97864077669902905</c:v>
                </c:pt>
                <c:pt idx="173">
                  <c:v>0.75145631067961205</c:v>
                </c:pt>
                <c:pt idx="174">
                  <c:v>0.980582524271845</c:v>
                </c:pt>
                <c:pt idx="175">
                  <c:v>0.97475728155339803</c:v>
                </c:pt>
                <c:pt idx="176">
                  <c:v>0.92038834951456305</c:v>
                </c:pt>
                <c:pt idx="177">
                  <c:v>0.93009708737864105</c:v>
                </c:pt>
                <c:pt idx="178">
                  <c:v>0.94563106796116503</c:v>
                </c:pt>
                <c:pt idx="179">
                  <c:v>0.71844660194174803</c:v>
                </c:pt>
                <c:pt idx="180">
                  <c:v>0.980582524271845</c:v>
                </c:pt>
                <c:pt idx="181">
                  <c:v>0.980582524271845</c:v>
                </c:pt>
                <c:pt idx="182">
                  <c:v>0.67184466019417499</c:v>
                </c:pt>
                <c:pt idx="183">
                  <c:v>0.961165048543689</c:v>
                </c:pt>
                <c:pt idx="184">
                  <c:v>0.980582524271845</c:v>
                </c:pt>
                <c:pt idx="185">
                  <c:v>0.87378640776699001</c:v>
                </c:pt>
                <c:pt idx="186">
                  <c:v>0.97864077669902905</c:v>
                </c:pt>
                <c:pt idx="187">
                  <c:v>0.97281553398058296</c:v>
                </c:pt>
                <c:pt idx="188">
                  <c:v>0.83300970873786395</c:v>
                </c:pt>
                <c:pt idx="189">
                  <c:v>0.97864077669902905</c:v>
                </c:pt>
                <c:pt idx="190">
                  <c:v>0.97475728155339803</c:v>
                </c:pt>
                <c:pt idx="191">
                  <c:v>0.91844660194174799</c:v>
                </c:pt>
                <c:pt idx="192">
                  <c:v>0.95145631067961201</c:v>
                </c:pt>
                <c:pt idx="193">
                  <c:v>0.97864077669902905</c:v>
                </c:pt>
                <c:pt idx="194">
                  <c:v>0.92621359223301003</c:v>
                </c:pt>
                <c:pt idx="195">
                  <c:v>0.97864077669902905</c:v>
                </c:pt>
                <c:pt idx="196">
                  <c:v>0.97669902912621398</c:v>
                </c:pt>
                <c:pt idx="197">
                  <c:v>0.555339805825243</c:v>
                </c:pt>
                <c:pt idx="198">
                  <c:v>0.97864077669902905</c:v>
                </c:pt>
                <c:pt idx="199">
                  <c:v>0.97669902912621398</c:v>
                </c:pt>
                <c:pt idx="200">
                  <c:v>0.71844660194174803</c:v>
                </c:pt>
                <c:pt idx="201">
                  <c:v>0.94951456310679605</c:v>
                </c:pt>
                <c:pt idx="202">
                  <c:v>0.62135922330097104</c:v>
                </c:pt>
                <c:pt idx="203">
                  <c:v>0.96504854368932003</c:v>
                </c:pt>
                <c:pt idx="204">
                  <c:v>0.811650485436893</c:v>
                </c:pt>
                <c:pt idx="205">
                  <c:v>0.970873786407767</c:v>
                </c:pt>
                <c:pt idx="206">
                  <c:v>0.66019417475728204</c:v>
                </c:pt>
                <c:pt idx="207">
                  <c:v>0.97475728155339803</c:v>
                </c:pt>
                <c:pt idx="208">
                  <c:v>0.95145631067961201</c:v>
                </c:pt>
                <c:pt idx="209">
                  <c:v>0.66796116504854397</c:v>
                </c:pt>
                <c:pt idx="210">
                  <c:v>0.85825242718446604</c:v>
                </c:pt>
                <c:pt idx="211">
                  <c:v>0.91067961165048505</c:v>
                </c:pt>
                <c:pt idx="212">
                  <c:v>0.63495145631067995</c:v>
                </c:pt>
                <c:pt idx="213">
                  <c:v>0.97864077669902905</c:v>
                </c:pt>
                <c:pt idx="214">
                  <c:v>0.97281553398058296</c:v>
                </c:pt>
                <c:pt idx="215">
                  <c:v>0.68349514563106795</c:v>
                </c:pt>
                <c:pt idx="216">
                  <c:v>0.77087378640776705</c:v>
                </c:pt>
                <c:pt idx="217">
                  <c:v>0.95339805825242696</c:v>
                </c:pt>
                <c:pt idx="218">
                  <c:v>0.69126213592232999</c:v>
                </c:pt>
                <c:pt idx="219">
                  <c:v>0.67184466019417499</c:v>
                </c:pt>
                <c:pt idx="220">
                  <c:v>0.97864077669902905</c:v>
                </c:pt>
                <c:pt idx="221">
                  <c:v>0.555339805825243</c:v>
                </c:pt>
                <c:pt idx="222">
                  <c:v>0.95339805825242696</c:v>
                </c:pt>
                <c:pt idx="223">
                  <c:v>0.95339805825242696</c:v>
                </c:pt>
                <c:pt idx="224">
                  <c:v>0.95339805825242696</c:v>
                </c:pt>
                <c:pt idx="225">
                  <c:v>0.97864077669902905</c:v>
                </c:pt>
                <c:pt idx="226">
                  <c:v>0.97864077669902905</c:v>
                </c:pt>
                <c:pt idx="227">
                  <c:v>0.97669902912621398</c:v>
                </c:pt>
                <c:pt idx="228">
                  <c:v>0.97864077669902905</c:v>
                </c:pt>
                <c:pt idx="229">
                  <c:v>0.97864077669902905</c:v>
                </c:pt>
                <c:pt idx="230">
                  <c:v>0.78058252427184505</c:v>
                </c:pt>
                <c:pt idx="231">
                  <c:v>0.88155339805825195</c:v>
                </c:pt>
                <c:pt idx="232">
                  <c:v>0.97281553398058296</c:v>
                </c:pt>
                <c:pt idx="233">
                  <c:v>0.71456310679611601</c:v>
                </c:pt>
                <c:pt idx="234">
                  <c:v>0.72621359223300996</c:v>
                </c:pt>
                <c:pt idx="235">
                  <c:v>0.74951456310679598</c:v>
                </c:pt>
                <c:pt idx="236">
                  <c:v>0.79417475728155296</c:v>
                </c:pt>
                <c:pt idx="237">
                  <c:v>0.95339805825242696</c:v>
                </c:pt>
                <c:pt idx="238">
                  <c:v>0.95533980582524303</c:v>
                </c:pt>
                <c:pt idx="239">
                  <c:v>0.93203883495145601</c:v>
                </c:pt>
                <c:pt idx="240">
                  <c:v>0.96699029126213598</c:v>
                </c:pt>
                <c:pt idx="241">
                  <c:v>0.980582524271845</c:v>
                </c:pt>
                <c:pt idx="242">
                  <c:v>0.95145631067961201</c:v>
                </c:pt>
                <c:pt idx="243">
                  <c:v>0.94174757281553401</c:v>
                </c:pt>
                <c:pt idx="244">
                  <c:v>0.59805825242718402</c:v>
                </c:pt>
                <c:pt idx="245">
                  <c:v>0.91067961165048505</c:v>
                </c:pt>
                <c:pt idx="246">
                  <c:v>0.97669902912621398</c:v>
                </c:pt>
                <c:pt idx="247">
                  <c:v>0.95728155339805798</c:v>
                </c:pt>
                <c:pt idx="248">
                  <c:v>0.801941747572816</c:v>
                </c:pt>
                <c:pt idx="249">
                  <c:v>0.88932038834951499</c:v>
                </c:pt>
                <c:pt idx="250">
                  <c:v>0.97475728155339803</c:v>
                </c:pt>
                <c:pt idx="251">
                  <c:v>0.95339805825242696</c:v>
                </c:pt>
                <c:pt idx="252">
                  <c:v>0.90291262135922301</c:v>
                </c:pt>
                <c:pt idx="253">
                  <c:v>0.97864077669902905</c:v>
                </c:pt>
                <c:pt idx="254">
                  <c:v>0.94757281553398098</c:v>
                </c:pt>
                <c:pt idx="255">
                  <c:v>0.96504854368932003</c:v>
                </c:pt>
                <c:pt idx="256">
                  <c:v>0.97475728155339803</c:v>
                </c:pt>
                <c:pt idx="257">
                  <c:v>0.95533980582524303</c:v>
                </c:pt>
                <c:pt idx="258">
                  <c:v>0.97864077669902905</c:v>
                </c:pt>
                <c:pt idx="259">
                  <c:v>0.96504854368932003</c:v>
                </c:pt>
                <c:pt idx="260">
                  <c:v>0.97864077669902905</c:v>
                </c:pt>
                <c:pt idx="261">
                  <c:v>0.97669902912621398</c:v>
                </c:pt>
                <c:pt idx="262">
                  <c:v>0.97864077669902905</c:v>
                </c:pt>
                <c:pt idx="263">
                  <c:v>0.94757281553398098</c:v>
                </c:pt>
                <c:pt idx="264">
                  <c:v>0.980582524271845</c:v>
                </c:pt>
                <c:pt idx="265">
                  <c:v>0.97669902912621398</c:v>
                </c:pt>
                <c:pt idx="266">
                  <c:v>0.77864077669902898</c:v>
                </c:pt>
                <c:pt idx="267">
                  <c:v>0.97864077669902905</c:v>
                </c:pt>
                <c:pt idx="268">
                  <c:v>0.97475728155339803</c:v>
                </c:pt>
                <c:pt idx="269">
                  <c:v>0.93980582524271905</c:v>
                </c:pt>
                <c:pt idx="270">
                  <c:v>0.92038834951456305</c:v>
                </c:pt>
                <c:pt idx="271">
                  <c:v>0.97864077669902905</c:v>
                </c:pt>
                <c:pt idx="272">
                  <c:v>0.94563106796116503</c:v>
                </c:pt>
                <c:pt idx="273">
                  <c:v>0.97864077669902905</c:v>
                </c:pt>
                <c:pt idx="274">
                  <c:v>0.97864077669902905</c:v>
                </c:pt>
                <c:pt idx="275">
                  <c:v>0.97281553398058296</c:v>
                </c:pt>
                <c:pt idx="276">
                  <c:v>0.96699029126213598</c:v>
                </c:pt>
                <c:pt idx="277">
                  <c:v>0.56504854368932</c:v>
                </c:pt>
                <c:pt idx="278">
                  <c:v>0.970873786407767</c:v>
                </c:pt>
                <c:pt idx="279">
                  <c:v>0.97669902912621398</c:v>
                </c:pt>
                <c:pt idx="280">
                  <c:v>0.970873786407767</c:v>
                </c:pt>
                <c:pt idx="281">
                  <c:v>0.96699029126213598</c:v>
                </c:pt>
                <c:pt idx="282">
                  <c:v>0.97864077669902905</c:v>
                </c:pt>
                <c:pt idx="283">
                  <c:v>0.97669902912621398</c:v>
                </c:pt>
                <c:pt idx="284">
                  <c:v>0.60194174757281504</c:v>
                </c:pt>
                <c:pt idx="285">
                  <c:v>0.75922330097087398</c:v>
                </c:pt>
                <c:pt idx="286">
                  <c:v>0.76116504854368905</c:v>
                </c:pt>
                <c:pt idx="287">
                  <c:v>0.87184466019417495</c:v>
                </c:pt>
                <c:pt idx="288">
                  <c:v>0.78252427184466</c:v>
                </c:pt>
                <c:pt idx="289">
                  <c:v>0.78834951456310698</c:v>
                </c:pt>
                <c:pt idx="290">
                  <c:v>0.78834951456310698</c:v>
                </c:pt>
                <c:pt idx="291">
                  <c:v>0.74951456310679598</c:v>
                </c:pt>
                <c:pt idx="292">
                  <c:v>0.91067961165048505</c:v>
                </c:pt>
                <c:pt idx="293">
                  <c:v>0.74174757281553405</c:v>
                </c:pt>
                <c:pt idx="294">
                  <c:v>0.97864077669902905</c:v>
                </c:pt>
                <c:pt idx="295">
                  <c:v>0.97475728155339803</c:v>
                </c:pt>
                <c:pt idx="296">
                  <c:v>0.8</c:v>
                </c:pt>
                <c:pt idx="297">
                  <c:v>0.980582524271845</c:v>
                </c:pt>
                <c:pt idx="298">
                  <c:v>0.97669902912621398</c:v>
                </c:pt>
                <c:pt idx="299">
                  <c:v>0.89126213592232995</c:v>
                </c:pt>
                <c:pt idx="300">
                  <c:v>0.97475728155339803</c:v>
                </c:pt>
                <c:pt idx="301">
                  <c:v>0.97475728155339803</c:v>
                </c:pt>
                <c:pt idx="302">
                  <c:v>0.78252427184466</c:v>
                </c:pt>
                <c:pt idx="303">
                  <c:v>0.71262135922330105</c:v>
                </c:pt>
                <c:pt idx="304">
                  <c:v>0.97864077669902905</c:v>
                </c:pt>
                <c:pt idx="305">
                  <c:v>0.81553398058252402</c:v>
                </c:pt>
                <c:pt idx="306">
                  <c:v>0.97864077669902905</c:v>
                </c:pt>
                <c:pt idx="307">
                  <c:v>0.97864077669902905</c:v>
                </c:pt>
                <c:pt idx="308">
                  <c:v>0.840776699029126</c:v>
                </c:pt>
                <c:pt idx="309">
                  <c:v>0.62524271844660195</c:v>
                </c:pt>
                <c:pt idx="310">
                  <c:v>0.97864077669902905</c:v>
                </c:pt>
                <c:pt idx="311">
                  <c:v>0.811650485436893</c:v>
                </c:pt>
                <c:pt idx="312">
                  <c:v>0.96699029126213598</c:v>
                </c:pt>
                <c:pt idx="313">
                  <c:v>0.97475728155339803</c:v>
                </c:pt>
                <c:pt idx="314">
                  <c:v>0.67572815533980601</c:v>
                </c:pt>
                <c:pt idx="315">
                  <c:v>0.97475728155339803</c:v>
                </c:pt>
                <c:pt idx="316">
                  <c:v>0.97864077669902905</c:v>
                </c:pt>
                <c:pt idx="317">
                  <c:v>0.76116504854368905</c:v>
                </c:pt>
                <c:pt idx="318">
                  <c:v>0.97475728155339803</c:v>
                </c:pt>
                <c:pt idx="319">
                  <c:v>0.97475728155339803</c:v>
                </c:pt>
                <c:pt idx="320">
                  <c:v>0.93786407766990298</c:v>
                </c:pt>
                <c:pt idx="321">
                  <c:v>0.97669902912621398</c:v>
                </c:pt>
                <c:pt idx="322">
                  <c:v>0.97864077669902905</c:v>
                </c:pt>
                <c:pt idx="323">
                  <c:v>0.94368932038834996</c:v>
                </c:pt>
                <c:pt idx="324">
                  <c:v>0.96504854368932003</c:v>
                </c:pt>
                <c:pt idx="325">
                  <c:v>0.97864077669902905</c:v>
                </c:pt>
                <c:pt idx="326">
                  <c:v>0.87184466019417495</c:v>
                </c:pt>
                <c:pt idx="327">
                  <c:v>0.594174757281553</c:v>
                </c:pt>
                <c:pt idx="328">
                  <c:v>0.78640776699029102</c:v>
                </c:pt>
                <c:pt idx="329">
                  <c:v>0.77475728155339796</c:v>
                </c:pt>
                <c:pt idx="330">
                  <c:v>0.67766990291262097</c:v>
                </c:pt>
                <c:pt idx="331">
                  <c:v>0.980582524271845</c:v>
                </c:pt>
                <c:pt idx="332">
                  <c:v>0.82524271844660202</c:v>
                </c:pt>
                <c:pt idx="333">
                  <c:v>0.97669902912621398</c:v>
                </c:pt>
                <c:pt idx="334">
                  <c:v>0.97864077669902905</c:v>
                </c:pt>
                <c:pt idx="335">
                  <c:v>0.78834951456310698</c:v>
                </c:pt>
                <c:pt idx="336">
                  <c:v>0.79029126213592205</c:v>
                </c:pt>
                <c:pt idx="337">
                  <c:v>0.57087378640776698</c:v>
                </c:pt>
                <c:pt idx="338">
                  <c:v>0.75922330097087398</c:v>
                </c:pt>
                <c:pt idx="339">
                  <c:v>0.97475728155339803</c:v>
                </c:pt>
                <c:pt idx="340">
                  <c:v>0.97864077669902905</c:v>
                </c:pt>
                <c:pt idx="341">
                  <c:v>0.840776699029126</c:v>
                </c:pt>
                <c:pt idx="342">
                  <c:v>0.821359223300971</c:v>
                </c:pt>
                <c:pt idx="343">
                  <c:v>0.76116504854368905</c:v>
                </c:pt>
                <c:pt idx="344">
                  <c:v>0.8</c:v>
                </c:pt>
                <c:pt idx="345">
                  <c:v>0.97864077669902905</c:v>
                </c:pt>
                <c:pt idx="346">
                  <c:v>0.97475728155339803</c:v>
                </c:pt>
                <c:pt idx="347">
                  <c:v>0.82718446601941797</c:v>
                </c:pt>
                <c:pt idx="348">
                  <c:v>0.97475728155339803</c:v>
                </c:pt>
                <c:pt idx="349">
                  <c:v>0.97669902912621398</c:v>
                </c:pt>
                <c:pt idx="350">
                  <c:v>0.59029126213592198</c:v>
                </c:pt>
                <c:pt idx="351">
                  <c:v>0.90291262135922301</c:v>
                </c:pt>
                <c:pt idx="352">
                  <c:v>0.97864077669902905</c:v>
                </c:pt>
                <c:pt idx="353">
                  <c:v>0.93592233009708703</c:v>
                </c:pt>
                <c:pt idx="354">
                  <c:v>0.970873786407767</c:v>
                </c:pt>
                <c:pt idx="355">
                  <c:v>0.97669902912621398</c:v>
                </c:pt>
                <c:pt idx="356">
                  <c:v>0.88349514563106801</c:v>
                </c:pt>
                <c:pt idx="357">
                  <c:v>0.821359223300971</c:v>
                </c:pt>
                <c:pt idx="358">
                  <c:v>0.96699029126213598</c:v>
                </c:pt>
                <c:pt idx="359">
                  <c:v>0.56504854368932</c:v>
                </c:pt>
                <c:pt idx="360">
                  <c:v>0.86601941747572797</c:v>
                </c:pt>
                <c:pt idx="361">
                  <c:v>0.97864077669902905</c:v>
                </c:pt>
                <c:pt idx="362">
                  <c:v>0.94368932038834996</c:v>
                </c:pt>
                <c:pt idx="363">
                  <c:v>0.97475728155339803</c:v>
                </c:pt>
                <c:pt idx="364">
                  <c:v>0.97864077669902905</c:v>
                </c:pt>
                <c:pt idx="365">
                  <c:v>0.65242718446601899</c:v>
                </c:pt>
                <c:pt idx="366">
                  <c:v>0.90679611650485403</c:v>
                </c:pt>
                <c:pt idx="367">
                  <c:v>0.970873786407767</c:v>
                </c:pt>
                <c:pt idx="368">
                  <c:v>0.81747572815533998</c:v>
                </c:pt>
                <c:pt idx="369">
                  <c:v>0.88932038834951499</c:v>
                </c:pt>
                <c:pt idx="370">
                  <c:v>0.97864077669902905</c:v>
                </c:pt>
                <c:pt idx="371">
                  <c:v>0.86407766990291301</c:v>
                </c:pt>
                <c:pt idx="372">
                  <c:v>0.97864077669902905</c:v>
                </c:pt>
                <c:pt idx="373">
                  <c:v>0.97669902912621398</c:v>
                </c:pt>
                <c:pt idx="374">
                  <c:v>0.82330097087378595</c:v>
                </c:pt>
                <c:pt idx="375">
                  <c:v>0.97864077669902905</c:v>
                </c:pt>
                <c:pt idx="376">
                  <c:v>0.980582524271845</c:v>
                </c:pt>
                <c:pt idx="377">
                  <c:v>0.85048543689320399</c:v>
                </c:pt>
                <c:pt idx="378">
                  <c:v>0.78834951456310698</c:v>
                </c:pt>
                <c:pt idx="379">
                  <c:v>0.79029126213592205</c:v>
                </c:pt>
                <c:pt idx="380">
                  <c:v>0.58834951456310702</c:v>
                </c:pt>
                <c:pt idx="381">
                  <c:v>0.97669902912621398</c:v>
                </c:pt>
                <c:pt idx="382">
                  <c:v>0.97864077669902905</c:v>
                </c:pt>
                <c:pt idx="383">
                  <c:v>0.86601941747572797</c:v>
                </c:pt>
                <c:pt idx="384">
                  <c:v>0.92233009708737901</c:v>
                </c:pt>
                <c:pt idx="385">
                  <c:v>0.97864077669902905</c:v>
                </c:pt>
                <c:pt idx="386">
                  <c:v>0.78640776699029102</c:v>
                </c:pt>
                <c:pt idx="387">
                  <c:v>0.96893203883495105</c:v>
                </c:pt>
                <c:pt idx="388">
                  <c:v>0.97669902912621398</c:v>
                </c:pt>
                <c:pt idx="389">
                  <c:v>0.89514563106796097</c:v>
                </c:pt>
                <c:pt idx="390">
                  <c:v>0.97864077669902905</c:v>
                </c:pt>
                <c:pt idx="391">
                  <c:v>0.97864077669902905</c:v>
                </c:pt>
                <c:pt idx="392">
                  <c:v>0.811650485436893</c:v>
                </c:pt>
                <c:pt idx="393">
                  <c:v>0.97475728155339803</c:v>
                </c:pt>
                <c:pt idx="394">
                  <c:v>0.97669902912621398</c:v>
                </c:pt>
                <c:pt idx="395">
                  <c:v>0.92621359223301003</c:v>
                </c:pt>
                <c:pt idx="396">
                  <c:v>0.97281553398058296</c:v>
                </c:pt>
                <c:pt idx="397">
                  <c:v>0.97669902912621398</c:v>
                </c:pt>
                <c:pt idx="398">
                  <c:v>0.80776699029126198</c:v>
                </c:pt>
                <c:pt idx="399">
                  <c:v>0.95533980582524303</c:v>
                </c:pt>
                <c:pt idx="400">
                  <c:v>0.95533980582524303</c:v>
                </c:pt>
                <c:pt idx="401">
                  <c:v>0.772815533980583</c:v>
                </c:pt>
                <c:pt idx="402">
                  <c:v>0.97669902912621398</c:v>
                </c:pt>
                <c:pt idx="403">
                  <c:v>0.97669902912621398</c:v>
                </c:pt>
                <c:pt idx="404">
                  <c:v>0.88737864077669903</c:v>
                </c:pt>
                <c:pt idx="405">
                  <c:v>0.87572815533980597</c:v>
                </c:pt>
                <c:pt idx="406">
                  <c:v>0.87961165048543699</c:v>
                </c:pt>
                <c:pt idx="407">
                  <c:v>0.68155339805825199</c:v>
                </c:pt>
                <c:pt idx="408">
                  <c:v>0.980582524271845</c:v>
                </c:pt>
                <c:pt idx="409">
                  <c:v>0.97864077669902905</c:v>
                </c:pt>
                <c:pt idx="410">
                  <c:v>0.85436893203883502</c:v>
                </c:pt>
                <c:pt idx="411">
                  <c:v>0.69708737864077697</c:v>
                </c:pt>
                <c:pt idx="412">
                  <c:v>0.97669902912621398</c:v>
                </c:pt>
                <c:pt idx="413">
                  <c:v>0.76116504854368905</c:v>
                </c:pt>
                <c:pt idx="414">
                  <c:v>0.980582524271845</c:v>
                </c:pt>
                <c:pt idx="415">
                  <c:v>0.97669902912621398</c:v>
                </c:pt>
                <c:pt idx="416">
                  <c:v>0.71067961165048499</c:v>
                </c:pt>
                <c:pt idx="417">
                  <c:v>0.81941747572815504</c:v>
                </c:pt>
                <c:pt idx="418">
                  <c:v>0.93009708737864105</c:v>
                </c:pt>
                <c:pt idx="419">
                  <c:v>0.90097087378640806</c:v>
                </c:pt>
                <c:pt idx="420">
                  <c:v>0.96310679611650496</c:v>
                </c:pt>
                <c:pt idx="421">
                  <c:v>0.97864077669902905</c:v>
                </c:pt>
                <c:pt idx="422">
                  <c:v>0.64466019417475695</c:v>
                </c:pt>
                <c:pt idx="423">
                  <c:v>0.763106796116505</c:v>
                </c:pt>
                <c:pt idx="424">
                  <c:v>0.68932038834951503</c:v>
                </c:pt>
                <c:pt idx="425">
                  <c:v>0.73398058252427201</c:v>
                </c:pt>
                <c:pt idx="426">
                  <c:v>0.95533980582524303</c:v>
                </c:pt>
                <c:pt idx="427">
                  <c:v>0.95145631067961201</c:v>
                </c:pt>
                <c:pt idx="428">
                  <c:v>0.76893203883495098</c:v>
                </c:pt>
                <c:pt idx="429">
                  <c:v>0.75533980582524296</c:v>
                </c:pt>
                <c:pt idx="430">
                  <c:v>0.95339805825242696</c:v>
                </c:pt>
                <c:pt idx="431">
                  <c:v>0.57087378640776698</c:v>
                </c:pt>
                <c:pt idx="432">
                  <c:v>0.79805825242718398</c:v>
                </c:pt>
                <c:pt idx="433">
                  <c:v>0.84271844660194195</c:v>
                </c:pt>
                <c:pt idx="434">
                  <c:v>0.94563106796116503</c:v>
                </c:pt>
                <c:pt idx="435">
                  <c:v>0.97475728155339803</c:v>
                </c:pt>
                <c:pt idx="436">
                  <c:v>0.97864077669902905</c:v>
                </c:pt>
                <c:pt idx="437">
                  <c:v>0.75922330097087398</c:v>
                </c:pt>
                <c:pt idx="438">
                  <c:v>0.95533980582524303</c:v>
                </c:pt>
                <c:pt idx="439">
                  <c:v>0.97864077669902905</c:v>
                </c:pt>
                <c:pt idx="440">
                  <c:v>0.76116504854368905</c:v>
                </c:pt>
                <c:pt idx="441">
                  <c:v>0.89320388349514601</c:v>
                </c:pt>
                <c:pt idx="442">
                  <c:v>0.77087378640776705</c:v>
                </c:pt>
                <c:pt idx="443">
                  <c:v>0.81941747572815504</c:v>
                </c:pt>
                <c:pt idx="444">
                  <c:v>0.83689320388349497</c:v>
                </c:pt>
                <c:pt idx="445">
                  <c:v>0.97864077669902905</c:v>
                </c:pt>
                <c:pt idx="446">
                  <c:v>0.83495145631068002</c:v>
                </c:pt>
                <c:pt idx="447">
                  <c:v>0.594174757281553</c:v>
                </c:pt>
                <c:pt idx="448">
                  <c:v>0.97864077669902905</c:v>
                </c:pt>
                <c:pt idx="449">
                  <c:v>0.59029126213592198</c:v>
                </c:pt>
                <c:pt idx="450">
                  <c:v>0.96699029126213598</c:v>
                </c:pt>
                <c:pt idx="451">
                  <c:v>0.801941747572816</c:v>
                </c:pt>
                <c:pt idx="452">
                  <c:v>0.68155339805825199</c:v>
                </c:pt>
                <c:pt idx="453">
                  <c:v>0.97864077669902905</c:v>
                </c:pt>
                <c:pt idx="454">
                  <c:v>0.97864077669902905</c:v>
                </c:pt>
                <c:pt idx="455">
                  <c:v>0.67961165048543704</c:v>
                </c:pt>
                <c:pt idx="456">
                  <c:v>0.78446601941747596</c:v>
                </c:pt>
                <c:pt idx="457">
                  <c:v>0.78640776699029102</c:v>
                </c:pt>
                <c:pt idx="458">
                  <c:v>0.63106796116504904</c:v>
                </c:pt>
                <c:pt idx="459">
                  <c:v>0.92038834951456305</c:v>
                </c:pt>
                <c:pt idx="460">
                  <c:v>0.90291262135922301</c:v>
                </c:pt>
                <c:pt idx="461">
                  <c:v>0.77087378640776705</c:v>
                </c:pt>
                <c:pt idx="462">
                  <c:v>0.97669902912621398</c:v>
                </c:pt>
                <c:pt idx="463">
                  <c:v>0.97475728155339803</c:v>
                </c:pt>
                <c:pt idx="464">
                  <c:v>0.70485436893203901</c:v>
                </c:pt>
                <c:pt idx="465">
                  <c:v>0.97864077669902905</c:v>
                </c:pt>
                <c:pt idx="466">
                  <c:v>0.86601941747572797</c:v>
                </c:pt>
                <c:pt idx="467">
                  <c:v>0.61165048543689304</c:v>
                </c:pt>
                <c:pt idx="468">
                  <c:v>0.97864077669902905</c:v>
                </c:pt>
                <c:pt idx="469">
                  <c:v>0.97864077669902905</c:v>
                </c:pt>
                <c:pt idx="470">
                  <c:v>0.642718446601942</c:v>
                </c:pt>
                <c:pt idx="471">
                  <c:v>0.97864077669902905</c:v>
                </c:pt>
                <c:pt idx="472">
                  <c:v>0.75533980582524296</c:v>
                </c:pt>
                <c:pt idx="473">
                  <c:v>0.92621359223301003</c:v>
                </c:pt>
                <c:pt idx="474">
                  <c:v>0.68932038834951503</c:v>
                </c:pt>
                <c:pt idx="475">
                  <c:v>0.980582524271845</c:v>
                </c:pt>
                <c:pt idx="476">
                  <c:v>0.86796116504854404</c:v>
                </c:pt>
                <c:pt idx="477">
                  <c:v>0.87184466019417495</c:v>
                </c:pt>
                <c:pt idx="478">
                  <c:v>0.980582524271845</c:v>
                </c:pt>
                <c:pt idx="479">
                  <c:v>0.78058252427184505</c:v>
                </c:pt>
                <c:pt idx="480">
                  <c:v>0.97864077669902905</c:v>
                </c:pt>
                <c:pt idx="481">
                  <c:v>0.97864077669902905</c:v>
                </c:pt>
                <c:pt idx="482">
                  <c:v>0.87378640776699001</c:v>
                </c:pt>
                <c:pt idx="483">
                  <c:v>0.97864077669902905</c:v>
                </c:pt>
                <c:pt idx="484">
                  <c:v>0.91844660194174799</c:v>
                </c:pt>
                <c:pt idx="485">
                  <c:v>0.93980582524271905</c:v>
                </c:pt>
                <c:pt idx="486">
                  <c:v>0.97475728155339803</c:v>
                </c:pt>
                <c:pt idx="487">
                  <c:v>0.97669902912621398</c:v>
                </c:pt>
                <c:pt idx="488">
                  <c:v>0.93009708737864105</c:v>
                </c:pt>
                <c:pt idx="489">
                  <c:v>0.97475728155339803</c:v>
                </c:pt>
                <c:pt idx="490">
                  <c:v>0.97864077669902905</c:v>
                </c:pt>
                <c:pt idx="491">
                  <c:v>0.95339805825242696</c:v>
                </c:pt>
                <c:pt idx="492">
                  <c:v>0.91844660194174799</c:v>
                </c:pt>
                <c:pt idx="493">
                  <c:v>0.97864077669902905</c:v>
                </c:pt>
                <c:pt idx="494">
                  <c:v>0.96310679611650496</c:v>
                </c:pt>
                <c:pt idx="495">
                  <c:v>0.97475728155339803</c:v>
                </c:pt>
                <c:pt idx="496">
                  <c:v>0.56504854368932</c:v>
                </c:pt>
                <c:pt idx="497">
                  <c:v>0.94563106796116503</c:v>
                </c:pt>
                <c:pt idx="498">
                  <c:v>0.64854368932038797</c:v>
                </c:pt>
                <c:pt idx="499">
                  <c:v>0.68737864077669897</c:v>
                </c:pt>
                <c:pt idx="500">
                  <c:v>0.57087378640776698</c:v>
                </c:pt>
                <c:pt idx="501">
                  <c:v>0.97864077669902905</c:v>
                </c:pt>
                <c:pt idx="502">
                  <c:v>0.97864077669902905</c:v>
                </c:pt>
                <c:pt idx="503">
                  <c:v>0.97864077669902905</c:v>
                </c:pt>
                <c:pt idx="504">
                  <c:v>0.96310679611650496</c:v>
                </c:pt>
                <c:pt idx="505">
                  <c:v>0.97864077669902905</c:v>
                </c:pt>
                <c:pt idx="506">
                  <c:v>0.93592233009708703</c:v>
                </c:pt>
                <c:pt idx="507">
                  <c:v>0.96310679611650496</c:v>
                </c:pt>
                <c:pt idx="508">
                  <c:v>0.97669902912621398</c:v>
                </c:pt>
                <c:pt idx="509">
                  <c:v>0.93398058252427196</c:v>
                </c:pt>
                <c:pt idx="510">
                  <c:v>0.95339805825242696</c:v>
                </c:pt>
                <c:pt idx="511">
                  <c:v>0.93592233009708703</c:v>
                </c:pt>
                <c:pt idx="512">
                  <c:v>0.90097087378640806</c:v>
                </c:pt>
                <c:pt idx="513">
                  <c:v>0.92621359223301003</c:v>
                </c:pt>
                <c:pt idx="514">
                  <c:v>0.95728155339805798</c:v>
                </c:pt>
                <c:pt idx="515">
                  <c:v>0.93398058252427196</c:v>
                </c:pt>
                <c:pt idx="516">
                  <c:v>0.97669902912621398</c:v>
                </c:pt>
                <c:pt idx="517">
                  <c:v>0.980582524271845</c:v>
                </c:pt>
                <c:pt idx="518">
                  <c:v>0.96893203883495105</c:v>
                </c:pt>
                <c:pt idx="519">
                  <c:v>0.66213592233009699</c:v>
                </c:pt>
                <c:pt idx="520">
                  <c:v>0.52233009708737899</c:v>
                </c:pt>
                <c:pt idx="521">
                  <c:v>0.64466019417475695</c:v>
                </c:pt>
                <c:pt idx="522">
                  <c:v>0.71844660194174803</c:v>
                </c:pt>
                <c:pt idx="523">
                  <c:v>0.72815533980582503</c:v>
                </c:pt>
                <c:pt idx="524">
                  <c:v>0.68737864077669897</c:v>
                </c:pt>
                <c:pt idx="525">
                  <c:v>0.94174757281553401</c:v>
                </c:pt>
                <c:pt idx="526">
                  <c:v>0.94174757281553401</c:v>
                </c:pt>
                <c:pt idx="527">
                  <c:v>0.76504854368931996</c:v>
                </c:pt>
                <c:pt idx="528">
                  <c:v>0.55922330097087403</c:v>
                </c:pt>
                <c:pt idx="529">
                  <c:v>0.68932038834951503</c:v>
                </c:pt>
                <c:pt idx="530">
                  <c:v>0.65825242718446597</c:v>
                </c:pt>
                <c:pt idx="531">
                  <c:v>0.97281553398058296</c:v>
                </c:pt>
                <c:pt idx="532">
                  <c:v>0.72233009708737905</c:v>
                </c:pt>
                <c:pt idx="533">
                  <c:v>0.59805825242718402</c:v>
                </c:pt>
                <c:pt idx="534">
                  <c:v>0.68737864077669897</c:v>
                </c:pt>
                <c:pt idx="535">
                  <c:v>0.60776699029126202</c:v>
                </c:pt>
                <c:pt idx="536">
                  <c:v>0.77864077669902898</c:v>
                </c:pt>
                <c:pt idx="537">
                  <c:v>0.97475728155339803</c:v>
                </c:pt>
                <c:pt idx="538">
                  <c:v>0.93980582524271905</c:v>
                </c:pt>
                <c:pt idx="539">
                  <c:v>0.97281553398058296</c:v>
                </c:pt>
                <c:pt idx="540">
                  <c:v>0.56504854368932</c:v>
                </c:pt>
                <c:pt idx="541">
                  <c:v>0.96310679611650496</c:v>
                </c:pt>
                <c:pt idx="542">
                  <c:v>0.970873786407767</c:v>
                </c:pt>
                <c:pt idx="543">
                  <c:v>0.94368932038834996</c:v>
                </c:pt>
                <c:pt idx="544">
                  <c:v>0.92621359223301003</c:v>
                </c:pt>
                <c:pt idx="545">
                  <c:v>0.970873786407767</c:v>
                </c:pt>
                <c:pt idx="546">
                  <c:v>0.97864077669902905</c:v>
                </c:pt>
                <c:pt idx="547">
                  <c:v>0.97475728155339803</c:v>
                </c:pt>
                <c:pt idx="548">
                  <c:v>0.64660194174757302</c:v>
                </c:pt>
                <c:pt idx="549">
                  <c:v>0.97475728155339803</c:v>
                </c:pt>
                <c:pt idx="550">
                  <c:v>0.93980582524271905</c:v>
                </c:pt>
                <c:pt idx="551">
                  <c:v>0.93786407766990298</c:v>
                </c:pt>
                <c:pt idx="552">
                  <c:v>0.54757281553398096</c:v>
                </c:pt>
                <c:pt idx="553">
                  <c:v>0.82330097087378595</c:v>
                </c:pt>
                <c:pt idx="554">
                  <c:v>0.66796116504854397</c:v>
                </c:pt>
                <c:pt idx="555">
                  <c:v>0.980582524271845</c:v>
                </c:pt>
                <c:pt idx="556">
                  <c:v>0.92621359223301003</c:v>
                </c:pt>
                <c:pt idx="557">
                  <c:v>0.92038834951456305</c:v>
                </c:pt>
                <c:pt idx="558">
                  <c:v>0.980582524271845</c:v>
                </c:pt>
                <c:pt idx="559">
                  <c:v>0.97669902912621398</c:v>
                </c:pt>
                <c:pt idx="560">
                  <c:v>0.831067961165049</c:v>
                </c:pt>
                <c:pt idx="561">
                  <c:v>0.980582524271845</c:v>
                </c:pt>
                <c:pt idx="562">
                  <c:v>0.980582524271845</c:v>
                </c:pt>
                <c:pt idx="563">
                  <c:v>0.95533980582524303</c:v>
                </c:pt>
                <c:pt idx="564">
                  <c:v>0.980582524271845</c:v>
                </c:pt>
                <c:pt idx="565">
                  <c:v>0.97669902912621398</c:v>
                </c:pt>
                <c:pt idx="566">
                  <c:v>0.91067961165048505</c:v>
                </c:pt>
                <c:pt idx="567">
                  <c:v>0.83495145631068002</c:v>
                </c:pt>
                <c:pt idx="568">
                  <c:v>0.97864077669902905</c:v>
                </c:pt>
                <c:pt idx="569">
                  <c:v>0.89902912621359199</c:v>
                </c:pt>
                <c:pt idx="570">
                  <c:v>0.97864077669902905</c:v>
                </c:pt>
                <c:pt idx="571">
                  <c:v>0.970873786407767</c:v>
                </c:pt>
                <c:pt idx="572">
                  <c:v>0.97475728155339803</c:v>
                </c:pt>
                <c:pt idx="573">
                  <c:v>0.97864077669902905</c:v>
                </c:pt>
                <c:pt idx="574">
                  <c:v>0.97669902912621398</c:v>
                </c:pt>
                <c:pt idx="575">
                  <c:v>0.96699029126213598</c:v>
                </c:pt>
                <c:pt idx="576">
                  <c:v>0.97669902912621398</c:v>
                </c:pt>
                <c:pt idx="577">
                  <c:v>0.97669902912621398</c:v>
                </c:pt>
                <c:pt idx="578">
                  <c:v>0.83883495145631104</c:v>
                </c:pt>
                <c:pt idx="579">
                  <c:v>0.94951456310679605</c:v>
                </c:pt>
                <c:pt idx="580">
                  <c:v>0.97281553398058296</c:v>
                </c:pt>
                <c:pt idx="581">
                  <c:v>0.67572815533980601</c:v>
                </c:pt>
                <c:pt idx="582">
                  <c:v>0.97864077669902905</c:v>
                </c:pt>
                <c:pt idx="583">
                  <c:v>0.97864077669902905</c:v>
                </c:pt>
                <c:pt idx="584">
                  <c:v>0.97864077669902905</c:v>
                </c:pt>
                <c:pt idx="585">
                  <c:v>0.97864077669902905</c:v>
                </c:pt>
                <c:pt idx="586">
                  <c:v>0.97669902912621398</c:v>
                </c:pt>
                <c:pt idx="587">
                  <c:v>0.96893203883495105</c:v>
                </c:pt>
                <c:pt idx="588">
                  <c:v>0.92621359223301003</c:v>
                </c:pt>
                <c:pt idx="589">
                  <c:v>0.93980582524271905</c:v>
                </c:pt>
                <c:pt idx="590">
                  <c:v>0.75339805825242701</c:v>
                </c:pt>
                <c:pt idx="591">
                  <c:v>0.89320388349514601</c:v>
                </c:pt>
                <c:pt idx="592">
                  <c:v>0.70679611650485397</c:v>
                </c:pt>
                <c:pt idx="593">
                  <c:v>0.555339805825243</c:v>
                </c:pt>
                <c:pt idx="594">
                  <c:v>0.97669902912621398</c:v>
                </c:pt>
                <c:pt idx="595">
                  <c:v>0.97864077669902905</c:v>
                </c:pt>
                <c:pt idx="596">
                  <c:v>0.97864077669902905</c:v>
                </c:pt>
                <c:pt idx="597">
                  <c:v>0.97475728155339803</c:v>
                </c:pt>
                <c:pt idx="598">
                  <c:v>0.79611650485436902</c:v>
                </c:pt>
                <c:pt idx="599">
                  <c:v>0.53398058252427205</c:v>
                </c:pt>
                <c:pt idx="600">
                  <c:v>0.65631067961165002</c:v>
                </c:pt>
                <c:pt idx="601">
                  <c:v>0.83495145631068002</c:v>
                </c:pt>
                <c:pt idx="602">
                  <c:v>0.69708737864077697</c:v>
                </c:pt>
                <c:pt idx="603">
                  <c:v>0.87766990291262104</c:v>
                </c:pt>
                <c:pt idx="604">
                  <c:v>0.970873786407767</c:v>
                </c:pt>
                <c:pt idx="605">
                  <c:v>0.801941747572816</c:v>
                </c:pt>
                <c:pt idx="606">
                  <c:v>0.980582524271845</c:v>
                </c:pt>
                <c:pt idx="607">
                  <c:v>0.97864077669902905</c:v>
                </c:pt>
                <c:pt idx="608">
                  <c:v>0.78834951456310698</c:v>
                </c:pt>
                <c:pt idx="609">
                  <c:v>0.96893203883495105</c:v>
                </c:pt>
                <c:pt idx="610">
                  <c:v>0.97475728155339803</c:v>
                </c:pt>
                <c:pt idx="611">
                  <c:v>0.79805825242718398</c:v>
                </c:pt>
                <c:pt idx="612">
                  <c:v>0.65436893203883495</c:v>
                </c:pt>
                <c:pt idx="613">
                  <c:v>0.92815533980582499</c:v>
                </c:pt>
                <c:pt idx="614">
                  <c:v>0.44271844660194198</c:v>
                </c:pt>
                <c:pt idx="615">
                  <c:v>0.74757281553398103</c:v>
                </c:pt>
                <c:pt idx="616">
                  <c:v>0.73592233009708696</c:v>
                </c:pt>
                <c:pt idx="617">
                  <c:v>0.97281553398058296</c:v>
                </c:pt>
                <c:pt idx="618">
                  <c:v>0.74757281553398103</c:v>
                </c:pt>
                <c:pt idx="619">
                  <c:v>0.97281553398058296</c:v>
                </c:pt>
                <c:pt idx="620">
                  <c:v>0.96310679611650496</c:v>
                </c:pt>
                <c:pt idx="621">
                  <c:v>0.97864077669902905</c:v>
                </c:pt>
                <c:pt idx="622">
                  <c:v>0.97864077669902905</c:v>
                </c:pt>
                <c:pt idx="623">
                  <c:v>0.97864077669902905</c:v>
                </c:pt>
                <c:pt idx="624">
                  <c:v>0.980582524271845</c:v>
                </c:pt>
                <c:pt idx="625">
                  <c:v>0.97864077669902905</c:v>
                </c:pt>
                <c:pt idx="626">
                  <c:v>0.97864077669902905</c:v>
                </c:pt>
                <c:pt idx="627">
                  <c:v>0.97669902912621398</c:v>
                </c:pt>
                <c:pt idx="628">
                  <c:v>0.97864077669902905</c:v>
                </c:pt>
                <c:pt idx="629">
                  <c:v>0.97475728155339803</c:v>
                </c:pt>
                <c:pt idx="630">
                  <c:v>0.97864077669902905</c:v>
                </c:pt>
                <c:pt idx="631">
                  <c:v>0.97864077669902905</c:v>
                </c:pt>
                <c:pt idx="632">
                  <c:v>0.82718446601941797</c:v>
                </c:pt>
                <c:pt idx="633">
                  <c:v>0.97669902912621398</c:v>
                </c:pt>
                <c:pt idx="634">
                  <c:v>0.84466019417475702</c:v>
                </c:pt>
                <c:pt idx="635">
                  <c:v>0.90485436893203897</c:v>
                </c:pt>
                <c:pt idx="636">
                  <c:v>0.97669902912621398</c:v>
                </c:pt>
                <c:pt idx="637">
                  <c:v>0.97669902912621398</c:v>
                </c:pt>
                <c:pt idx="638">
                  <c:v>0.94368932038834996</c:v>
                </c:pt>
                <c:pt idx="639">
                  <c:v>0.980582524271845</c:v>
                </c:pt>
                <c:pt idx="640">
                  <c:v>0.980582524271845</c:v>
                </c:pt>
                <c:pt idx="641">
                  <c:v>0.65436893203883495</c:v>
                </c:pt>
                <c:pt idx="642">
                  <c:v>0.90097087378640806</c:v>
                </c:pt>
                <c:pt idx="643">
                  <c:v>0.74563106796116496</c:v>
                </c:pt>
                <c:pt idx="644">
                  <c:v>0.65631067961165002</c:v>
                </c:pt>
                <c:pt idx="645">
                  <c:v>0.88543689320388397</c:v>
                </c:pt>
                <c:pt idx="646">
                  <c:v>0.97475728155339803</c:v>
                </c:pt>
                <c:pt idx="647">
                  <c:v>0.93009708737864105</c:v>
                </c:pt>
                <c:pt idx="648">
                  <c:v>0.97475728155339803</c:v>
                </c:pt>
                <c:pt idx="649">
                  <c:v>0.97864077669902905</c:v>
                </c:pt>
                <c:pt idx="650">
                  <c:v>0.78446601941747596</c:v>
                </c:pt>
                <c:pt idx="651">
                  <c:v>0.89902912621359199</c:v>
                </c:pt>
                <c:pt idx="652">
                  <c:v>0.97864077669902905</c:v>
                </c:pt>
                <c:pt idx="653">
                  <c:v>0.73786407766990303</c:v>
                </c:pt>
                <c:pt idx="654">
                  <c:v>0.97475728155339803</c:v>
                </c:pt>
                <c:pt idx="655">
                  <c:v>0.980582524271845</c:v>
                </c:pt>
                <c:pt idx="656">
                  <c:v>0.71067961165048499</c:v>
                </c:pt>
                <c:pt idx="657">
                  <c:v>0.97669902912621398</c:v>
                </c:pt>
                <c:pt idx="658">
                  <c:v>0.980582524271845</c:v>
                </c:pt>
                <c:pt idx="659">
                  <c:v>0.93009708737864105</c:v>
                </c:pt>
                <c:pt idx="660">
                  <c:v>0.980582524271845</c:v>
                </c:pt>
                <c:pt idx="661">
                  <c:v>0.980582524271845</c:v>
                </c:pt>
                <c:pt idx="662">
                  <c:v>0.95922330097087405</c:v>
                </c:pt>
                <c:pt idx="663">
                  <c:v>0.97864077669902905</c:v>
                </c:pt>
                <c:pt idx="664">
                  <c:v>0.97669902912621398</c:v>
                </c:pt>
                <c:pt idx="665">
                  <c:v>0.89902912621359199</c:v>
                </c:pt>
                <c:pt idx="666">
                  <c:v>0.94563106796116503</c:v>
                </c:pt>
                <c:pt idx="667">
                  <c:v>0.94563106796116503</c:v>
                </c:pt>
                <c:pt idx="668">
                  <c:v>0.80776699029126198</c:v>
                </c:pt>
                <c:pt idx="669">
                  <c:v>0.89902912621359199</c:v>
                </c:pt>
                <c:pt idx="670">
                  <c:v>0.97864077669902905</c:v>
                </c:pt>
                <c:pt idx="671">
                  <c:v>0.831067961165049</c:v>
                </c:pt>
                <c:pt idx="672">
                  <c:v>0.961165048543689</c:v>
                </c:pt>
                <c:pt idx="673">
                  <c:v>0.980582524271845</c:v>
                </c:pt>
                <c:pt idx="674">
                  <c:v>0.69320388349514594</c:v>
                </c:pt>
                <c:pt idx="675">
                  <c:v>0.980582524271845</c:v>
                </c:pt>
                <c:pt idx="676">
                  <c:v>0.97669902912621398</c:v>
                </c:pt>
                <c:pt idx="677">
                  <c:v>0.71844660194174803</c:v>
                </c:pt>
                <c:pt idx="678">
                  <c:v>0.980582524271845</c:v>
                </c:pt>
                <c:pt idx="679">
                  <c:v>0.97864077669902905</c:v>
                </c:pt>
                <c:pt idx="680">
                  <c:v>0.67961165048543704</c:v>
                </c:pt>
                <c:pt idx="681">
                  <c:v>0.980582524271845</c:v>
                </c:pt>
                <c:pt idx="682">
                  <c:v>0.980582524271845</c:v>
                </c:pt>
                <c:pt idx="683">
                  <c:v>0.801941747572816</c:v>
                </c:pt>
                <c:pt idx="684">
                  <c:v>0.97669902912621398</c:v>
                </c:pt>
                <c:pt idx="685">
                  <c:v>0.96699029126213598</c:v>
                </c:pt>
                <c:pt idx="686">
                  <c:v>0.970873786407767</c:v>
                </c:pt>
                <c:pt idx="687">
                  <c:v>0.97864077669902905</c:v>
                </c:pt>
                <c:pt idx="688">
                  <c:v>0.97864077669902905</c:v>
                </c:pt>
                <c:pt idx="689">
                  <c:v>0.97864077669902905</c:v>
                </c:pt>
                <c:pt idx="690">
                  <c:v>0.980582524271845</c:v>
                </c:pt>
                <c:pt idx="691">
                  <c:v>0.97864077669902905</c:v>
                </c:pt>
                <c:pt idx="692">
                  <c:v>0.86213592233009695</c:v>
                </c:pt>
                <c:pt idx="693">
                  <c:v>0.91844660194174799</c:v>
                </c:pt>
                <c:pt idx="694">
                  <c:v>0.980582524271845</c:v>
                </c:pt>
                <c:pt idx="695">
                  <c:v>0.85048543689320399</c:v>
                </c:pt>
                <c:pt idx="696">
                  <c:v>0.97669902912621398</c:v>
                </c:pt>
                <c:pt idx="697">
                  <c:v>0.97864077669902905</c:v>
                </c:pt>
                <c:pt idx="698">
                  <c:v>0.74757281553398103</c:v>
                </c:pt>
                <c:pt idx="699">
                  <c:v>0.76116504854368905</c:v>
                </c:pt>
                <c:pt idx="700">
                  <c:v>0.97864077669902905</c:v>
                </c:pt>
                <c:pt idx="701">
                  <c:v>0.85242718446601895</c:v>
                </c:pt>
                <c:pt idx="702">
                  <c:v>0.980582524271845</c:v>
                </c:pt>
                <c:pt idx="703">
                  <c:v>0.97475728155339803</c:v>
                </c:pt>
                <c:pt idx="704">
                  <c:v>0.80776699029126198</c:v>
                </c:pt>
                <c:pt idx="705">
                  <c:v>0.97669902912621398</c:v>
                </c:pt>
                <c:pt idx="706">
                  <c:v>0.95922330097087405</c:v>
                </c:pt>
                <c:pt idx="707">
                  <c:v>0.92815533980582499</c:v>
                </c:pt>
                <c:pt idx="708">
                  <c:v>0.980582524271845</c:v>
                </c:pt>
                <c:pt idx="709">
                  <c:v>0.97669902912621398</c:v>
                </c:pt>
                <c:pt idx="710">
                  <c:v>0.91067961165048505</c:v>
                </c:pt>
                <c:pt idx="711">
                  <c:v>0.980582524271845</c:v>
                </c:pt>
                <c:pt idx="712">
                  <c:v>0.980582524271845</c:v>
                </c:pt>
                <c:pt idx="713">
                  <c:v>0.970873786407767</c:v>
                </c:pt>
                <c:pt idx="714">
                  <c:v>0.97864077669902905</c:v>
                </c:pt>
                <c:pt idx="715">
                  <c:v>0.980582524271845</c:v>
                </c:pt>
                <c:pt idx="716">
                  <c:v>0.97475728155339803</c:v>
                </c:pt>
                <c:pt idx="717">
                  <c:v>0.92038834951456305</c:v>
                </c:pt>
                <c:pt idx="718">
                  <c:v>0.97864077669902905</c:v>
                </c:pt>
                <c:pt idx="719">
                  <c:v>0.70873786407767003</c:v>
                </c:pt>
                <c:pt idx="720">
                  <c:v>0.97864077669902905</c:v>
                </c:pt>
                <c:pt idx="721">
                  <c:v>0.980582524271845</c:v>
                </c:pt>
                <c:pt idx="722">
                  <c:v>0.93786407766990298</c:v>
                </c:pt>
                <c:pt idx="723">
                  <c:v>0.97864077669902905</c:v>
                </c:pt>
                <c:pt idx="724">
                  <c:v>0.980582524271845</c:v>
                </c:pt>
                <c:pt idx="725">
                  <c:v>0.78058252427184505</c:v>
                </c:pt>
                <c:pt idx="726">
                  <c:v>0.980582524271845</c:v>
                </c:pt>
                <c:pt idx="727">
                  <c:v>0.980582524271845</c:v>
                </c:pt>
                <c:pt idx="728">
                  <c:v>0.96504854368932003</c:v>
                </c:pt>
                <c:pt idx="729">
                  <c:v>0.83300970873786395</c:v>
                </c:pt>
                <c:pt idx="730">
                  <c:v>0.97281553398058296</c:v>
                </c:pt>
                <c:pt idx="731">
                  <c:v>0.840776699029126</c:v>
                </c:pt>
                <c:pt idx="732">
                  <c:v>0.980582524271845</c:v>
                </c:pt>
                <c:pt idx="733">
                  <c:v>0.980582524271845</c:v>
                </c:pt>
                <c:pt idx="734">
                  <c:v>0.80776699029126198</c:v>
                </c:pt>
                <c:pt idx="735">
                  <c:v>0.91067961165048505</c:v>
                </c:pt>
                <c:pt idx="736">
                  <c:v>0.97864077669902905</c:v>
                </c:pt>
                <c:pt idx="737">
                  <c:v>0.801941747572816</c:v>
                </c:pt>
                <c:pt idx="738">
                  <c:v>0.97475728155339803</c:v>
                </c:pt>
                <c:pt idx="739">
                  <c:v>0.97475728155339803</c:v>
                </c:pt>
                <c:pt idx="740">
                  <c:v>0.67961165048543704</c:v>
                </c:pt>
                <c:pt idx="741">
                  <c:v>0.97864077669902905</c:v>
                </c:pt>
                <c:pt idx="742">
                  <c:v>0.95145631067961201</c:v>
                </c:pt>
                <c:pt idx="743">
                  <c:v>0.93980582524271905</c:v>
                </c:pt>
                <c:pt idx="744">
                  <c:v>0.980582524271845</c:v>
                </c:pt>
                <c:pt idx="745">
                  <c:v>0.97281553398058296</c:v>
                </c:pt>
                <c:pt idx="746">
                  <c:v>0.79805825242718398</c:v>
                </c:pt>
                <c:pt idx="747">
                  <c:v>0.961165048543689</c:v>
                </c:pt>
                <c:pt idx="748">
                  <c:v>0.97864077669902905</c:v>
                </c:pt>
                <c:pt idx="749">
                  <c:v>0.84660194174757297</c:v>
                </c:pt>
                <c:pt idx="750">
                  <c:v>0.97864077669902905</c:v>
                </c:pt>
                <c:pt idx="751">
                  <c:v>0.96310679611650496</c:v>
                </c:pt>
                <c:pt idx="752">
                  <c:v>0.90873786407766999</c:v>
                </c:pt>
                <c:pt idx="753">
                  <c:v>0.961165048543689</c:v>
                </c:pt>
                <c:pt idx="754">
                  <c:v>0.85436893203883502</c:v>
                </c:pt>
                <c:pt idx="755">
                  <c:v>0.87961165048543699</c:v>
                </c:pt>
                <c:pt idx="756">
                  <c:v>0.97864077669902905</c:v>
                </c:pt>
                <c:pt idx="757">
                  <c:v>0.97669902912621398</c:v>
                </c:pt>
                <c:pt idx="758">
                  <c:v>0.95922330097087405</c:v>
                </c:pt>
                <c:pt idx="759">
                  <c:v>0.88737864077669903</c:v>
                </c:pt>
                <c:pt idx="760">
                  <c:v>0.980582524271845</c:v>
                </c:pt>
                <c:pt idx="761">
                  <c:v>0.96504854368932003</c:v>
                </c:pt>
                <c:pt idx="762">
                  <c:v>0.980582524271845</c:v>
                </c:pt>
                <c:pt idx="763">
                  <c:v>0.79029126213592205</c:v>
                </c:pt>
                <c:pt idx="764">
                  <c:v>0.77475728155339796</c:v>
                </c:pt>
                <c:pt idx="765">
                  <c:v>0.980582524271845</c:v>
                </c:pt>
                <c:pt idx="766">
                  <c:v>0.97864077669902905</c:v>
                </c:pt>
                <c:pt idx="767">
                  <c:v>0.97864077669902905</c:v>
                </c:pt>
                <c:pt idx="768">
                  <c:v>0.97864077669902905</c:v>
                </c:pt>
                <c:pt idx="769">
                  <c:v>0.89320388349514601</c:v>
                </c:pt>
                <c:pt idx="770">
                  <c:v>0.86213592233009695</c:v>
                </c:pt>
                <c:pt idx="771">
                  <c:v>0.980582524271845</c:v>
                </c:pt>
                <c:pt idx="772">
                  <c:v>0.980582524271845</c:v>
                </c:pt>
                <c:pt idx="773">
                  <c:v>0.96699029126213598</c:v>
                </c:pt>
                <c:pt idx="774">
                  <c:v>0.96699029126213598</c:v>
                </c:pt>
                <c:pt idx="775">
                  <c:v>0.97864077669902905</c:v>
                </c:pt>
                <c:pt idx="776">
                  <c:v>0.96504854368932003</c:v>
                </c:pt>
                <c:pt idx="777">
                  <c:v>0.96893203883495105</c:v>
                </c:pt>
                <c:pt idx="778">
                  <c:v>0.97864077669902905</c:v>
                </c:pt>
                <c:pt idx="779">
                  <c:v>0.91067961165048505</c:v>
                </c:pt>
                <c:pt idx="780">
                  <c:v>0.97864077669902905</c:v>
                </c:pt>
                <c:pt idx="781">
                  <c:v>0.980582524271845</c:v>
                </c:pt>
                <c:pt idx="782">
                  <c:v>0.97864077669902905</c:v>
                </c:pt>
                <c:pt idx="783">
                  <c:v>0.980582524271845</c:v>
                </c:pt>
                <c:pt idx="784">
                  <c:v>0.980582524271845</c:v>
                </c:pt>
                <c:pt idx="785">
                  <c:v>0.97864077669902905</c:v>
                </c:pt>
                <c:pt idx="786">
                  <c:v>0.980582524271845</c:v>
                </c:pt>
                <c:pt idx="787">
                  <c:v>0.97864077669902905</c:v>
                </c:pt>
                <c:pt idx="788">
                  <c:v>0.87572815533980597</c:v>
                </c:pt>
                <c:pt idx="789">
                  <c:v>0.95922330097087405</c:v>
                </c:pt>
                <c:pt idx="790">
                  <c:v>0.980582524271845</c:v>
                </c:pt>
                <c:pt idx="791">
                  <c:v>0.78640776699029102</c:v>
                </c:pt>
                <c:pt idx="792">
                  <c:v>0.97864077669902905</c:v>
                </c:pt>
                <c:pt idx="793">
                  <c:v>0.980582524271845</c:v>
                </c:pt>
                <c:pt idx="794">
                  <c:v>0.94951456310679605</c:v>
                </c:pt>
                <c:pt idx="795">
                  <c:v>0.97864077669902905</c:v>
                </c:pt>
                <c:pt idx="796">
                  <c:v>0.980582524271845</c:v>
                </c:pt>
                <c:pt idx="797">
                  <c:v>0.81941747572815504</c:v>
                </c:pt>
                <c:pt idx="798">
                  <c:v>0.97864077669902905</c:v>
                </c:pt>
                <c:pt idx="799">
                  <c:v>0.97669902912621398</c:v>
                </c:pt>
                <c:pt idx="800">
                  <c:v>0.90291262135922301</c:v>
                </c:pt>
                <c:pt idx="801">
                  <c:v>0.82524271844660202</c:v>
                </c:pt>
                <c:pt idx="802">
                  <c:v>0.97864077669902905</c:v>
                </c:pt>
                <c:pt idx="803">
                  <c:v>0.97281553398058296</c:v>
                </c:pt>
                <c:pt idx="804">
                  <c:v>0.980582524271845</c:v>
                </c:pt>
                <c:pt idx="805">
                  <c:v>0.980582524271845</c:v>
                </c:pt>
                <c:pt idx="806">
                  <c:v>0.89126213592232995</c:v>
                </c:pt>
                <c:pt idx="807">
                  <c:v>0.980582524271845</c:v>
                </c:pt>
                <c:pt idx="808">
                  <c:v>0.97669902912621398</c:v>
                </c:pt>
                <c:pt idx="809">
                  <c:v>0.96310679611650496</c:v>
                </c:pt>
                <c:pt idx="810">
                  <c:v>0.97475728155339803</c:v>
                </c:pt>
                <c:pt idx="811">
                  <c:v>0.97669902912621398</c:v>
                </c:pt>
                <c:pt idx="812">
                  <c:v>0.71456310679611601</c:v>
                </c:pt>
                <c:pt idx="813">
                  <c:v>0.97475728155339803</c:v>
                </c:pt>
                <c:pt idx="814">
                  <c:v>0.97475728155339803</c:v>
                </c:pt>
                <c:pt idx="815">
                  <c:v>0.68349514563106795</c:v>
                </c:pt>
                <c:pt idx="816">
                  <c:v>0.97669902912621398</c:v>
                </c:pt>
                <c:pt idx="817">
                  <c:v>0.97281553398058296</c:v>
                </c:pt>
                <c:pt idx="818">
                  <c:v>0.94757281553398098</c:v>
                </c:pt>
                <c:pt idx="819">
                  <c:v>0.97864077669902905</c:v>
                </c:pt>
                <c:pt idx="820">
                  <c:v>0.980582524271845</c:v>
                </c:pt>
                <c:pt idx="821">
                  <c:v>0.84660194174757297</c:v>
                </c:pt>
                <c:pt idx="822">
                  <c:v>0.97475728155339803</c:v>
                </c:pt>
                <c:pt idx="823">
                  <c:v>0.97669902912621398</c:v>
                </c:pt>
                <c:pt idx="824">
                  <c:v>0.97864077669902905</c:v>
                </c:pt>
                <c:pt idx="825">
                  <c:v>0.97864077669902905</c:v>
                </c:pt>
                <c:pt idx="826">
                  <c:v>0.97669902912621398</c:v>
                </c:pt>
                <c:pt idx="827">
                  <c:v>0.961165048543689</c:v>
                </c:pt>
                <c:pt idx="828">
                  <c:v>0.96504854368932003</c:v>
                </c:pt>
                <c:pt idx="829">
                  <c:v>0.97864077669902905</c:v>
                </c:pt>
                <c:pt idx="830">
                  <c:v>0.97669902912621398</c:v>
                </c:pt>
                <c:pt idx="831">
                  <c:v>0.97864077669902905</c:v>
                </c:pt>
                <c:pt idx="832">
                  <c:v>0.97864077669902905</c:v>
                </c:pt>
                <c:pt idx="833">
                  <c:v>0.71262135922330105</c:v>
                </c:pt>
                <c:pt idx="834">
                  <c:v>0.97669902912621398</c:v>
                </c:pt>
                <c:pt idx="835">
                  <c:v>0.970873786407767</c:v>
                </c:pt>
                <c:pt idx="836">
                  <c:v>0.95728155339805798</c:v>
                </c:pt>
                <c:pt idx="837">
                  <c:v>0.97475728155339803</c:v>
                </c:pt>
                <c:pt idx="838">
                  <c:v>0.97864077669902905</c:v>
                </c:pt>
                <c:pt idx="839">
                  <c:v>0.97281553398058296</c:v>
                </c:pt>
                <c:pt idx="840">
                  <c:v>0.97864077669902905</c:v>
                </c:pt>
                <c:pt idx="841">
                  <c:v>0.97669902912621398</c:v>
                </c:pt>
                <c:pt idx="842">
                  <c:v>0.97669902912621398</c:v>
                </c:pt>
                <c:pt idx="843">
                  <c:v>0.97669902912621398</c:v>
                </c:pt>
                <c:pt idx="844">
                  <c:v>0.97475728155339803</c:v>
                </c:pt>
                <c:pt idx="845">
                  <c:v>0.95728155339805798</c:v>
                </c:pt>
                <c:pt idx="846">
                  <c:v>0.93009708737864105</c:v>
                </c:pt>
                <c:pt idx="847">
                  <c:v>0.92815533980582499</c:v>
                </c:pt>
                <c:pt idx="848">
                  <c:v>0.92427184466019396</c:v>
                </c:pt>
                <c:pt idx="849">
                  <c:v>0.97864077669902905</c:v>
                </c:pt>
                <c:pt idx="850">
                  <c:v>0.97669902912621398</c:v>
                </c:pt>
                <c:pt idx="851">
                  <c:v>0.92233009708737901</c:v>
                </c:pt>
                <c:pt idx="852">
                  <c:v>0.97281553398058296</c:v>
                </c:pt>
                <c:pt idx="853">
                  <c:v>0.97475728155339803</c:v>
                </c:pt>
                <c:pt idx="854">
                  <c:v>0.89126213592232995</c:v>
                </c:pt>
                <c:pt idx="855">
                  <c:v>0.970873786407767</c:v>
                </c:pt>
                <c:pt idx="856">
                  <c:v>0.97864077669902905</c:v>
                </c:pt>
                <c:pt idx="857">
                  <c:v>0.85048543689320399</c:v>
                </c:pt>
                <c:pt idx="858">
                  <c:v>0.97281553398058296</c:v>
                </c:pt>
                <c:pt idx="859">
                  <c:v>0.97669902912621398</c:v>
                </c:pt>
                <c:pt idx="860">
                  <c:v>0.93398058252427196</c:v>
                </c:pt>
                <c:pt idx="861">
                  <c:v>0.97669902912621398</c:v>
                </c:pt>
                <c:pt idx="862">
                  <c:v>0.97669902912621398</c:v>
                </c:pt>
                <c:pt idx="863">
                  <c:v>0.81747572815533998</c:v>
                </c:pt>
                <c:pt idx="864">
                  <c:v>0.97669902912621398</c:v>
                </c:pt>
                <c:pt idx="865">
                  <c:v>0.97669902912621398</c:v>
                </c:pt>
                <c:pt idx="866">
                  <c:v>0.81553398058252402</c:v>
                </c:pt>
                <c:pt idx="867">
                  <c:v>0.96504854368932003</c:v>
                </c:pt>
                <c:pt idx="868">
                  <c:v>0.97864077669902905</c:v>
                </c:pt>
                <c:pt idx="869">
                  <c:v>0.79029126213592205</c:v>
                </c:pt>
                <c:pt idx="870">
                  <c:v>0.84660194174757297</c:v>
                </c:pt>
                <c:pt idx="871">
                  <c:v>0.97864077669902905</c:v>
                </c:pt>
                <c:pt idx="872">
                  <c:v>0.97864077669902905</c:v>
                </c:pt>
                <c:pt idx="873">
                  <c:v>0.97864077669902905</c:v>
                </c:pt>
                <c:pt idx="874">
                  <c:v>0.97864077669902905</c:v>
                </c:pt>
                <c:pt idx="875">
                  <c:v>0.97669902912621398</c:v>
                </c:pt>
                <c:pt idx="876">
                  <c:v>0.97864077669902905</c:v>
                </c:pt>
                <c:pt idx="877">
                  <c:v>0.97864077669902905</c:v>
                </c:pt>
                <c:pt idx="878">
                  <c:v>0.97669902912621398</c:v>
                </c:pt>
                <c:pt idx="879">
                  <c:v>0.97864077669902905</c:v>
                </c:pt>
                <c:pt idx="880">
                  <c:v>0.97669902912621398</c:v>
                </c:pt>
                <c:pt idx="881">
                  <c:v>0.97669902912621398</c:v>
                </c:pt>
                <c:pt idx="882">
                  <c:v>0.97864077669902905</c:v>
                </c:pt>
                <c:pt idx="883">
                  <c:v>0.97864077669902905</c:v>
                </c:pt>
                <c:pt idx="884">
                  <c:v>0.70679611650485397</c:v>
                </c:pt>
                <c:pt idx="885">
                  <c:v>0.97864077669902905</c:v>
                </c:pt>
                <c:pt idx="886">
                  <c:v>0.980582524271845</c:v>
                </c:pt>
                <c:pt idx="887">
                  <c:v>0.88155339805825195</c:v>
                </c:pt>
                <c:pt idx="888">
                  <c:v>0.97864077669902905</c:v>
                </c:pt>
                <c:pt idx="889">
                  <c:v>0.97864077669902905</c:v>
                </c:pt>
                <c:pt idx="890">
                  <c:v>0.86213592233009695</c:v>
                </c:pt>
                <c:pt idx="891">
                  <c:v>0.97864077669902905</c:v>
                </c:pt>
                <c:pt idx="892">
                  <c:v>0.97475728155339803</c:v>
                </c:pt>
                <c:pt idx="893">
                  <c:v>0.93009708737864105</c:v>
                </c:pt>
                <c:pt idx="894">
                  <c:v>0.96504854368932003</c:v>
                </c:pt>
                <c:pt idx="895">
                  <c:v>0.97475728155339803</c:v>
                </c:pt>
                <c:pt idx="896">
                  <c:v>0.94757281553398098</c:v>
                </c:pt>
                <c:pt idx="897">
                  <c:v>0.97864077669902905</c:v>
                </c:pt>
                <c:pt idx="898">
                  <c:v>0.97669902912621398</c:v>
                </c:pt>
                <c:pt idx="899">
                  <c:v>0.96310679611650496</c:v>
                </c:pt>
                <c:pt idx="900">
                  <c:v>0.97669902912621398</c:v>
                </c:pt>
                <c:pt idx="901">
                  <c:v>0.97475728155339803</c:v>
                </c:pt>
                <c:pt idx="902">
                  <c:v>0.90485436893203897</c:v>
                </c:pt>
                <c:pt idx="903">
                  <c:v>0.970873786407767</c:v>
                </c:pt>
                <c:pt idx="904">
                  <c:v>0.97475728155339803</c:v>
                </c:pt>
                <c:pt idx="905">
                  <c:v>0.91456310679611696</c:v>
                </c:pt>
                <c:pt idx="906">
                  <c:v>0.97864077669902905</c:v>
                </c:pt>
                <c:pt idx="907">
                  <c:v>0.97669902912621398</c:v>
                </c:pt>
                <c:pt idx="908">
                  <c:v>0.970873786407767</c:v>
                </c:pt>
                <c:pt idx="909">
                  <c:v>0.970873786407767</c:v>
                </c:pt>
                <c:pt idx="910">
                  <c:v>0.97864077669902905</c:v>
                </c:pt>
                <c:pt idx="911">
                  <c:v>0.97864077669902905</c:v>
                </c:pt>
                <c:pt idx="912">
                  <c:v>0.97669902912621398</c:v>
                </c:pt>
                <c:pt idx="913">
                  <c:v>0.94951456310679605</c:v>
                </c:pt>
                <c:pt idx="914">
                  <c:v>0.87378640776699001</c:v>
                </c:pt>
                <c:pt idx="915">
                  <c:v>0.97475728155339803</c:v>
                </c:pt>
                <c:pt idx="916">
                  <c:v>0.97475728155339803</c:v>
                </c:pt>
                <c:pt idx="917">
                  <c:v>0.89126213592232995</c:v>
                </c:pt>
                <c:pt idx="918">
                  <c:v>0.97864077669902905</c:v>
                </c:pt>
                <c:pt idx="919">
                  <c:v>0.97669902912621398</c:v>
                </c:pt>
                <c:pt idx="920">
                  <c:v>0.73980582524271798</c:v>
                </c:pt>
                <c:pt idx="921">
                  <c:v>0.90485436893203897</c:v>
                </c:pt>
                <c:pt idx="922">
                  <c:v>0.8</c:v>
                </c:pt>
                <c:pt idx="923">
                  <c:v>0.75922330097087398</c:v>
                </c:pt>
                <c:pt idx="924">
                  <c:v>0.97864077669902905</c:v>
                </c:pt>
                <c:pt idx="925">
                  <c:v>0.97864077669902905</c:v>
                </c:pt>
                <c:pt idx="926">
                  <c:v>0.811650485436893</c:v>
                </c:pt>
                <c:pt idx="927">
                  <c:v>0.84466019417475702</c:v>
                </c:pt>
                <c:pt idx="928">
                  <c:v>0.84660194174757297</c:v>
                </c:pt>
                <c:pt idx="929">
                  <c:v>0.78446601941747596</c:v>
                </c:pt>
                <c:pt idx="930">
                  <c:v>0.97864077669902905</c:v>
                </c:pt>
                <c:pt idx="931">
                  <c:v>0.90291262135922301</c:v>
                </c:pt>
                <c:pt idx="932">
                  <c:v>0.97864077669902905</c:v>
                </c:pt>
                <c:pt idx="933">
                  <c:v>0.970873786407767</c:v>
                </c:pt>
                <c:pt idx="934">
                  <c:v>0.66407766990291295</c:v>
                </c:pt>
                <c:pt idx="935">
                  <c:v>0.72621359223300996</c:v>
                </c:pt>
                <c:pt idx="936">
                  <c:v>0.97281553398058296</c:v>
                </c:pt>
                <c:pt idx="937">
                  <c:v>0.97475728155339803</c:v>
                </c:pt>
                <c:pt idx="938">
                  <c:v>0.78640776699029102</c:v>
                </c:pt>
                <c:pt idx="939">
                  <c:v>0.97475728155339803</c:v>
                </c:pt>
                <c:pt idx="940">
                  <c:v>0.92038834951456305</c:v>
                </c:pt>
                <c:pt idx="941">
                  <c:v>0.85242718446601895</c:v>
                </c:pt>
                <c:pt idx="942">
                  <c:v>0.84854368932038804</c:v>
                </c:pt>
                <c:pt idx="943">
                  <c:v>0.970873786407767</c:v>
                </c:pt>
                <c:pt idx="944">
                  <c:v>0.76699029126213603</c:v>
                </c:pt>
                <c:pt idx="945">
                  <c:v>0.96893203883495105</c:v>
                </c:pt>
                <c:pt idx="946">
                  <c:v>0.97281553398058296</c:v>
                </c:pt>
                <c:pt idx="947">
                  <c:v>0.78252427184466</c:v>
                </c:pt>
                <c:pt idx="948">
                  <c:v>0.97475728155339803</c:v>
                </c:pt>
                <c:pt idx="949">
                  <c:v>0.97669902912621398</c:v>
                </c:pt>
                <c:pt idx="950">
                  <c:v>0.85631067961165097</c:v>
                </c:pt>
                <c:pt idx="951">
                  <c:v>0.93980582524271905</c:v>
                </c:pt>
                <c:pt idx="952">
                  <c:v>0.93980582524271905</c:v>
                </c:pt>
                <c:pt idx="953">
                  <c:v>0.93203883495145601</c:v>
                </c:pt>
                <c:pt idx="954">
                  <c:v>0.97864077669902905</c:v>
                </c:pt>
                <c:pt idx="955">
                  <c:v>0.97475728155339803</c:v>
                </c:pt>
                <c:pt idx="956">
                  <c:v>0.83300970873786395</c:v>
                </c:pt>
                <c:pt idx="957">
                  <c:v>0.97475728155339803</c:v>
                </c:pt>
                <c:pt idx="958">
                  <c:v>0.97669902912621398</c:v>
                </c:pt>
                <c:pt idx="959">
                  <c:v>0.78058252427184505</c:v>
                </c:pt>
                <c:pt idx="960">
                  <c:v>0.74757281553398103</c:v>
                </c:pt>
                <c:pt idx="961">
                  <c:v>0.75145631067961205</c:v>
                </c:pt>
                <c:pt idx="962">
                  <c:v>0.79805825242718398</c:v>
                </c:pt>
                <c:pt idx="963">
                  <c:v>0.74368932038835001</c:v>
                </c:pt>
                <c:pt idx="964">
                  <c:v>0.96893203883495105</c:v>
                </c:pt>
                <c:pt idx="965">
                  <c:v>0.69708737864077697</c:v>
                </c:pt>
                <c:pt idx="966">
                  <c:v>0.79611650485436902</c:v>
                </c:pt>
                <c:pt idx="967">
                  <c:v>0.97475728155339803</c:v>
                </c:pt>
                <c:pt idx="968">
                  <c:v>0.68737864077669897</c:v>
                </c:pt>
                <c:pt idx="969">
                  <c:v>0.92815533980582499</c:v>
                </c:pt>
                <c:pt idx="970">
                  <c:v>0.87572815533980597</c:v>
                </c:pt>
                <c:pt idx="971">
                  <c:v>0.95145631067961201</c:v>
                </c:pt>
                <c:pt idx="972">
                  <c:v>0.95339805825242696</c:v>
                </c:pt>
                <c:pt idx="973">
                  <c:v>0.95145631067961201</c:v>
                </c:pt>
                <c:pt idx="974">
                  <c:v>0.84660194174757297</c:v>
                </c:pt>
                <c:pt idx="975">
                  <c:v>0.970873786407767</c:v>
                </c:pt>
                <c:pt idx="976">
                  <c:v>0.97475728155339803</c:v>
                </c:pt>
                <c:pt idx="977">
                  <c:v>0.97475728155339803</c:v>
                </c:pt>
                <c:pt idx="978">
                  <c:v>0.92233009708737901</c:v>
                </c:pt>
                <c:pt idx="979">
                  <c:v>0.97475728155339803</c:v>
                </c:pt>
                <c:pt idx="980">
                  <c:v>0.801941747572816</c:v>
                </c:pt>
                <c:pt idx="981">
                  <c:v>0.772815533980583</c:v>
                </c:pt>
                <c:pt idx="982">
                  <c:v>0.97281553398058296</c:v>
                </c:pt>
                <c:pt idx="983">
                  <c:v>0.72815533980582503</c:v>
                </c:pt>
                <c:pt idx="984">
                  <c:v>0.97281553398058296</c:v>
                </c:pt>
                <c:pt idx="985">
                  <c:v>0.93203883495145601</c:v>
                </c:pt>
                <c:pt idx="986">
                  <c:v>0.82718446601941797</c:v>
                </c:pt>
                <c:pt idx="987">
                  <c:v>0.97475728155339803</c:v>
                </c:pt>
                <c:pt idx="988">
                  <c:v>0.97475728155339803</c:v>
                </c:pt>
                <c:pt idx="989">
                  <c:v>0.97475728155339803</c:v>
                </c:pt>
                <c:pt idx="990">
                  <c:v>0.97475728155339803</c:v>
                </c:pt>
                <c:pt idx="991">
                  <c:v>0.97475728155339803</c:v>
                </c:pt>
                <c:pt idx="992">
                  <c:v>0.840776699029126</c:v>
                </c:pt>
                <c:pt idx="993">
                  <c:v>0.91844660194174799</c:v>
                </c:pt>
                <c:pt idx="994">
                  <c:v>0.623300970873786</c:v>
                </c:pt>
                <c:pt idx="995">
                  <c:v>0.90097087378640806</c:v>
                </c:pt>
                <c:pt idx="996">
                  <c:v>0.96699029126213598</c:v>
                </c:pt>
                <c:pt idx="997">
                  <c:v>0.97475728155339803</c:v>
                </c:pt>
                <c:pt idx="998">
                  <c:v>0.97281553398058296</c:v>
                </c:pt>
                <c:pt idx="999">
                  <c:v>0.79805825242718398</c:v>
                </c:pt>
                <c:pt idx="1000">
                  <c:v>0.970873786407767</c:v>
                </c:pt>
                <c:pt idx="1001">
                  <c:v>0.97475728155339803</c:v>
                </c:pt>
                <c:pt idx="1002">
                  <c:v>0.97281553398058296</c:v>
                </c:pt>
                <c:pt idx="1003">
                  <c:v>0.97475728155339803</c:v>
                </c:pt>
                <c:pt idx="1004">
                  <c:v>0.96699029126213598</c:v>
                </c:pt>
                <c:pt idx="1005">
                  <c:v>0.93203883495145601</c:v>
                </c:pt>
                <c:pt idx="1006">
                  <c:v>0.96893203883495105</c:v>
                </c:pt>
                <c:pt idx="1007">
                  <c:v>0.97475728155339803</c:v>
                </c:pt>
                <c:pt idx="1008">
                  <c:v>0.71067961165048499</c:v>
                </c:pt>
                <c:pt idx="1009">
                  <c:v>0.95145631067961201</c:v>
                </c:pt>
                <c:pt idx="1010">
                  <c:v>0.80582524271844702</c:v>
                </c:pt>
                <c:pt idx="1011">
                  <c:v>0.80776699029126198</c:v>
                </c:pt>
                <c:pt idx="1012">
                  <c:v>0.84466019417475702</c:v>
                </c:pt>
                <c:pt idx="1013">
                  <c:v>0.85436893203883502</c:v>
                </c:pt>
                <c:pt idx="1014">
                  <c:v>0.97475728155339803</c:v>
                </c:pt>
                <c:pt idx="1015">
                  <c:v>0.97281553398058296</c:v>
                </c:pt>
                <c:pt idx="1016">
                  <c:v>0.96893203883495105</c:v>
                </c:pt>
                <c:pt idx="1017">
                  <c:v>0.89902912621359199</c:v>
                </c:pt>
                <c:pt idx="1018">
                  <c:v>0.97475728155339803</c:v>
                </c:pt>
                <c:pt idx="1019">
                  <c:v>0.80582524271844702</c:v>
                </c:pt>
                <c:pt idx="1020">
                  <c:v>0.97475728155339803</c:v>
                </c:pt>
                <c:pt idx="1021">
                  <c:v>0.78834951456310698</c:v>
                </c:pt>
                <c:pt idx="1022">
                  <c:v>0.97475728155339803</c:v>
                </c:pt>
                <c:pt idx="1023">
                  <c:v>0.59029126213592198</c:v>
                </c:pt>
                <c:pt idx="1024">
                  <c:v>0.93786407766990298</c:v>
                </c:pt>
                <c:pt idx="1025">
                  <c:v>0.92815533980582499</c:v>
                </c:pt>
                <c:pt idx="1026">
                  <c:v>0.78640776699029102</c:v>
                </c:pt>
                <c:pt idx="1027">
                  <c:v>0.92038834951456305</c:v>
                </c:pt>
                <c:pt idx="1028">
                  <c:v>0.970873786407767</c:v>
                </c:pt>
                <c:pt idx="1029">
                  <c:v>0.78058252427184505</c:v>
                </c:pt>
                <c:pt idx="1030">
                  <c:v>0.613592233009709</c:v>
                </c:pt>
                <c:pt idx="1031">
                  <c:v>0.97281553398058296</c:v>
                </c:pt>
                <c:pt idx="1032">
                  <c:v>0.85631067961165097</c:v>
                </c:pt>
                <c:pt idx="1033">
                  <c:v>0.94368932038834996</c:v>
                </c:pt>
                <c:pt idx="1034">
                  <c:v>0.96504854368932003</c:v>
                </c:pt>
                <c:pt idx="1035">
                  <c:v>0.96893203883495105</c:v>
                </c:pt>
                <c:pt idx="1036">
                  <c:v>0.97281553398058296</c:v>
                </c:pt>
                <c:pt idx="1037">
                  <c:v>0.970873786407767</c:v>
                </c:pt>
                <c:pt idx="1038">
                  <c:v>0.84660194174757297</c:v>
                </c:pt>
                <c:pt idx="1039">
                  <c:v>0.88737864077669903</c:v>
                </c:pt>
                <c:pt idx="1040">
                  <c:v>0.970873786407767</c:v>
                </c:pt>
                <c:pt idx="1041">
                  <c:v>0.76699029126213603</c:v>
                </c:pt>
                <c:pt idx="1042">
                  <c:v>0.92621359223301003</c:v>
                </c:pt>
                <c:pt idx="1043">
                  <c:v>0.96893203883495105</c:v>
                </c:pt>
                <c:pt idx="1044">
                  <c:v>0.95728155339805798</c:v>
                </c:pt>
                <c:pt idx="1045">
                  <c:v>0.96699029126213598</c:v>
                </c:pt>
                <c:pt idx="1046">
                  <c:v>0.961165048543689</c:v>
                </c:pt>
                <c:pt idx="1047">
                  <c:v>0.93398058252427196</c:v>
                </c:pt>
                <c:pt idx="1048">
                  <c:v>0.74757281553398103</c:v>
                </c:pt>
                <c:pt idx="1049">
                  <c:v>0.77087378640776705</c:v>
                </c:pt>
                <c:pt idx="1050">
                  <c:v>0.69902912621359203</c:v>
                </c:pt>
                <c:pt idx="1051">
                  <c:v>0.94174757281553401</c:v>
                </c:pt>
                <c:pt idx="1052">
                  <c:v>0.961165048543689</c:v>
                </c:pt>
                <c:pt idx="1053">
                  <c:v>0.821359223300971</c:v>
                </c:pt>
                <c:pt idx="1054">
                  <c:v>0.89126213592232995</c:v>
                </c:pt>
                <c:pt idx="1055">
                  <c:v>0.95145631067961201</c:v>
                </c:pt>
                <c:pt idx="1056">
                  <c:v>0.86213592233009695</c:v>
                </c:pt>
                <c:pt idx="1057">
                  <c:v>0.95728155339805798</c:v>
                </c:pt>
                <c:pt idx="1058">
                  <c:v>0.95339805825242696</c:v>
                </c:pt>
                <c:pt idx="1059">
                  <c:v>0.93980582524271905</c:v>
                </c:pt>
                <c:pt idx="1060">
                  <c:v>0.95922330097087405</c:v>
                </c:pt>
                <c:pt idx="1061">
                  <c:v>0.84854368932038804</c:v>
                </c:pt>
                <c:pt idx="1062">
                  <c:v>0.80776699029126198</c:v>
                </c:pt>
                <c:pt idx="1063">
                  <c:v>0.83883495145631104</c:v>
                </c:pt>
                <c:pt idx="1064">
                  <c:v>0.70097087378640799</c:v>
                </c:pt>
                <c:pt idx="1065">
                  <c:v>0.75339805825242701</c:v>
                </c:pt>
                <c:pt idx="1066">
                  <c:v>0.70097087378640799</c:v>
                </c:pt>
                <c:pt idx="1067">
                  <c:v>0.70485436893203901</c:v>
                </c:pt>
                <c:pt idx="1068">
                  <c:v>0.72621359223300996</c:v>
                </c:pt>
                <c:pt idx="1069">
                  <c:v>0.69708737864077697</c:v>
                </c:pt>
                <c:pt idx="1070">
                  <c:v>0.73786407766990303</c:v>
                </c:pt>
                <c:pt idx="1071">
                  <c:v>0.66601941747572801</c:v>
                </c:pt>
                <c:pt idx="1072">
                  <c:v>0.73786407766990303</c:v>
                </c:pt>
                <c:pt idx="1073">
                  <c:v>0.74174757281553405</c:v>
                </c:pt>
                <c:pt idx="1074">
                  <c:v>0.69902912621359203</c:v>
                </c:pt>
                <c:pt idx="1075">
                  <c:v>0.71456310679611601</c:v>
                </c:pt>
                <c:pt idx="1076">
                  <c:v>0.712621359223301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973-401D-9A5C-17D396FECB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96067215"/>
        <c:axId val="73279394"/>
      </c:lineChart>
      <c:catAx>
        <c:axId val="596067215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73279394"/>
        <c:crosses val="autoZero"/>
        <c:auto val="1"/>
        <c:lblAlgn val="ctr"/>
        <c:lblOffset val="100"/>
        <c:noMultiLvlLbl val="0"/>
      </c:catAx>
      <c:valAx>
        <c:axId val="73279394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9606721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800"/>
              <a:t>C2 </a:t>
            </a:r>
            <a:r>
              <a:rPr lang="en-US" sz="1800"/>
              <a:t>identity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[工作簿12]Sheet1!$G$1</c:f>
              <c:strCache>
                <c:ptCount val="1"/>
                <c:pt idx="0">
                  <c:v>identity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[工作簿12]Sheet1!$G$2:$G$425</c:f>
              <c:numCache>
                <c:formatCode>General</c:formatCode>
                <c:ptCount val="424"/>
                <c:pt idx="0">
                  <c:v>0.79629629629629595</c:v>
                </c:pt>
                <c:pt idx="1">
                  <c:v>0.79629629629629595</c:v>
                </c:pt>
                <c:pt idx="2">
                  <c:v>0.79629629629629595</c:v>
                </c:pt>
                <c:pt idx="3">
                  <c:v>0.79629629629629595</c:v>
                </c:pt>
                <c:pt idx="4">
                  <c:v>0.78935185185185197</c:v>
                </c:pt>
                <c:pt idx="5">
                  <c:v>0.75925925925925897</c:v>
                </c:pt>
                <c:pt idx="6">
                  <c:v>0.58564814814814803</c:v>
                </c:pt>
                <c:pt idx="7">
                  <c:v>0.73611111111111105</c:v>
                </c:pt>
                <c:pt idx="8">
                  <c:v>0.78703703703703698</c:v>
                </c:pt>
                <c:pt idx="9">
                  <c:v>0.79629629629629595</c:v>
                </c:pt>
                <c:pt idx="10">
                  <c:v>0.79398148148148195</c:v>
                </c:pt>
                <c:pt idx="11">
                  <c:v>0.655092592592593</c:v>
                </c:pt>
                <c:pt idx="12">
                  <c:v>0.79398148148148195</c:v>
                </c:pt>
                <c:pt idx="13">
                  <c:v>0.79629629629629595</c:v>
                </c:pt>
                <c:pt idx="14">
                  <c:v>0.79629629629629595</c:v>
                </c:pt>
                <c:pt idx="15">
                  <c:v>0.79629629629629595</c:v>
                </c:pt>
                <c:pt idx="16">
                  <c:v>0.79166666666666696</c:v>
                </c:pt>
                <c:pt idx="17">
                  <c:v>0.75462962962962998</c:v>
                </c:pt>
                <c:pt idx="18">
                  <c:v>0.78935185185185197</c:v>
                </c:pt>
                <c:pt idx="19">
                  <c:v>0.79629629629629595</c:v>
                </c:pt>
                <c:pt idx="20">
                  <c:v>0.68981481481481499</c:v>
                </c:pt>
                <c:pt idx="21">
                  <c:v>0.78472222222222199</c:v>
                </c:pt>
                <c:pt idx="22">
                  <c:v>0.75462962962962998</c:v>
                </c:pt>
                <c:pt idx="23">
                  <c:v>0.70833333333333304</c:v>
                </c:pt>
                <c:pt idx="24">
                  <c:v>0.79166666666666696</c:v>
                </c:pt>
                <c:pt idx="25">
                  <c:v>0.77777777777777801</c:v>
                </c:pt>
                <c:pt idx="26">
                  <c:v>0.79861111111111105</c:v>
                </c:pt>
                <c:pt idx="27">
                  <c:v>0.79629629629629595</c:v>
                </c:pt>
                <c:pt idx="28">
                  <c:v>0.79166666666666696</c:v>
                </c:pt>
                <c:pt idx="29">
                  <c:v>0.74305555555555602</c:v>
                </c:pt>
                <c:pt idx="30">
                  <c:v>0.79861111111111105</c:v>
                </c:pt>
                <c:pt idx="31">
                  <c:v>0.77083333333333304</c:v>
                </c:pt>
                <c:pt idx="32">
                  <c:v>0.79861111111111105</c:v>
                </c:pt>
                <c:pt idx="33">
                  <c:v>0.75</c:v>
                </c:pt>
                <c:pt idx="34">
                  <c:v>0.79861111111111105</c:v>
                </c:pt>
                <c:pt idx="35">
                  <c:v>0.57638888888888895</c:v>
                </c:pt>
                <c:pt idx="36">
                  <c:v>0.77777777777777801</c:v>
                </c:pt>
                <c:pt idx="37">
                  <c:v>0.77083333333333304</c:v>
                </c:pt>
                <c:pt idx="38">
                  <c:v>0.74537037037037002</c:v>
                </c:pt>
                <c:pt idx="39">
                  <c:v>0.75462962962962998</c:v>
                </c:pt>
                <c:pt idx="40">
                  <c:v>0.8125</c:v>
                </c:pt>
                <c:pt idx="41">
                  <c:v>0.72916666666666696</c:v>
                </c:pt>
                <c:pt idx="42">
                  <c:v>0.59722222222222199</c:v>
                </c:pt>
                <c:pt idx="43">
                  <c:v>0.81481481481481499</c:v>
                </c:pt>
                <c:pt idx="44">
                  <c:v>0.782407407407407</c:v>
                </c:pt>
                <c:pt idx="45">
                  <c:v>0.78472222222222199</c:v>
                </c:pt>
                <c:pt idx="46">
                  <c:v>0.80787037037037002</c:v>
                </c:pt>
                <c:pt idx="47">
                  <c:v>0.81018518518518501</c:v>
                </c:pt>
                <c:pt idx="48">
                  <c:v>0.81712962962962998</c:v>
                </c:pt>
                <c:pt idx="49">
                  <c:v>0.81944444444444398</c:v>
                </c:pt>
                <c:pt idx="50">
                  <c:v>0.69675925925925897</c:v>
                </c:pt>
                <c:pt idx="51">
                  <c:v>0.72916666666666696</c:v>
                </c:pt>
                <c:pt idx="52">
                  <c:v>0.8125</c:v>
                </c:pt>
                <c:pt idx="53">
                  <c:v>0.73842592592592604</c:v>
                </c:pt>
                <c:pt idx="54">
                  <c:v>0.78935185185185197</c:v>
                </c:pt>
                <c:pt idx="55">
                  <c:v>0.8125</c:v>
                </c:pt>
                <c:pt idx="56">
                  <c:v>0.8125</c:v>
                </c:pt>
                <c:pt idx="57">
                  <c:v>0.81018518518518501</c:v>
                </c:pt>
                <c:pt idx="58">
                  <c:v>0.80324074074074103</c:v>
                </c:pt>
                <c:pt idx="59">
                  <c:v>0.77546296296296302</c:v>
                </c:pt>
                <c:pt idx="60">
                  <c:v>0.71527777777777801</c:v>
                </c:pt>
                <c:pt idx="61">
                  <c:v>0.75231481481481499</c:v>
                </c:pt>
                <c:pt idx="62">
                  <c:v>0.66666666666666696</c:v>
                </c:pt>
                <c:pt idx="63">
                  <c:v>0.78703703703703698</c:v>
                </c:pt>
                <c:pt idx="64">
                  <c:v>0.8125</c:v>
                </c:pt>
                <c:pt idx="65">
                  <c:v>0.72685185185185197</c:v>
                </c:pt>
                <c:pt idx="66">
                  <c:v>0.76388888888888895</c:v>
                </c:pt>
                <c:pt idx="67">
                  <c:v>0.81018518518518501</c:v>
                </c:pt>
                <c:pt idx="68">
                  <c:v>0.71296296296296302</c:v>
                </c:pt>
                <c:pt idx="69">
                  <c:v>0.81481481481481499</c:v>
                </c:pt>
                <c:pt idx="70">
                  <c:v>0.81481481481481499</c:v>
                </c:pt>
                <c:pt idx="71">
                  <c:v>0.79166666666666696</c:v>
                </c:pt>
                <c:pt idx="72">
                  <c:v>0.81712962962962998</c:v>
                </c:pt>
                <c:pt idx="73">
                  <c:v>0.76620370370370405</c:v>
                </c:pt>
                <c:pt idx="74">
                  <c:v>0.74074074074074103</c:v>
                </c:pt>
                <c:pt idx="75">
                  <c:v>0.8125</c:v>
                </c:pt>
                <c:pt idx="76">
                  <c:v>0.73611111111111105</c:v>
                </c:pt>
                <c:pt idx="77">
                  <c:v>0.75231481481481499</c:v>
                </c:pt>
                <c:pt idx="78">
                  <c:v>0.73611111111111105</c:v>
                </c:pt>
                <c:pt idx="79">
                  <c:v>0.72916666666666696</c:v>
                </c:pt>
                <c:pt idx="80">
                  <c:v>0.77314814814814803</c:v>
                </c:pt>
                <c:pt idx="81">
                  <c:v>0.67824074074074103</c:v>
                </c:pt>
                <c:pt idx="82">
                  <c:v>0.780092592592593</c:v>
                </c:pt>
                <c:pt idx="83">
                  <c:v>0.655092592592593</c:v>
                </c:pt>
                <c:pt idx="84">
                  <c:v>0.78935185185185197</c:v>
                </c:pt>
                <c:pt idx="85">
                  <c:v>0.81712962962962998</c:v>
                </c:pt>
                <c:pt idx="86">
                  <c:v>0.69907407407407396</c:v>
                </c:pt>
                <c:pt idx="87">
                  <c:v>0.76620370370370405</c:v>
                </c:pt>
                <c:pt idx="88">
                  <c:v>0.81481481481481499</c:v>
                </c:pt>
                <c:pt idx="89">
                  <c:v>0.76157407407407396</c:v>
                </c:pt>
                <c:pt idx="90">
                  <c:v>0.76388888888888895</c:v>
                </c:pt>
                <c:pt idx="91">
                  <c:v>0.70138888888888895</c:v>
                </c:pt>
                <c:pt idx="92">
                  <c:v>0.73611111111111105</c:v>
                </c:pt>
                <c:pt idx="93">
                  <c:v>0.72453703703703698</c:v>
                </c:pt>
                <c:pt idx="94">
                  <c:v>0.81481481481481499</c:v>
                </c:pt>
                <c:pt idx="95">
                  <c:v>0.64583333333333304</c:v>
                </c:pt>
                <c:pt idx="96">
                  <c:v>0.72916666666666696</c:v>
                </c:pt>
                <c:pt idx="97">
                  <c:v>0.81712962962962998</c:v>
                </c:pt>
                <c:pt idx="98">
                  <c:v>0.76851851851851805</c:v>
                </c:pt>
                <c:pt idx="99">
                  <c:v>0.8125</c:v>
                </c:pt>
                <c:pt idx="100">
                  <c:v>0.81481481481481499</c:v>
                </c:pt>
                <c:pt idx="101">
                  <c:v>0.76157407407407396</c:v>
                </c:pt>
                <c:pt idx="102">
                  <c:v>0.77777777777777801</c:v>
                </c:pt>
                <c:pt idx="103">
                  <c:v>0.81944444444444398</c:v>
                </c:pt>
                <c:pt idx="104">
                  <c:v>0.72453703703703698</c:v>
                </c:pt>
                <c:pt idx="105">
                  <c:v>0.79398148148148195</c:v>
                </c:pt>
                <c:pt idx="106">
                  <c:v>0.80324074074074103</c:v>
                </c:pt>
                <c:pt idx="107">
                  <c:v>0.780092592592593</c:v>
                </c:pt>
                <c:pt idx="108">
                  <c:v>0.81018518518518501</c:v>
                </c:pt>
                <c:pt idx="109">
                  <c:v>0.8125</c:v>
                </c:pt>
                <c:pt idx="110">
                  <c:v>0.73148148148148195</c:v>
                </c:pt>
                <c:pt idx="111">
                  <c:v>0.81712962962962998</c:v>
                </c:pt>
                <c:pt idx="112">
                  <c:v>0.81944444444444398</c:v>
                </c:pt>
                <c:pt idx="113">
                  <c:v>0.717592592592593</c:v>
                </c:pt>
                <c:pt idx="114">
                  <c:v>0.81712962962962998</c:v>
                </c:pt>
                <c:pt idx="115">
                  <c:v>0.81944444444444398</c:v>
                </c:pt>
                <c:pt idx="116">
                  <c:v>0.74537037037037002</c:v>
                </c:pt>
                <c:pt idx="117">
                  <c:v>0.80787037037037002</c:v>
                </c:pt>
                <c:pt idx="118">
                  <c:v>0.81944444444444398</c:v>
                </c:pt>
                <c:pt idx="119">
                  <c:v>0.75231481481481499</c:v>
                </c:pt>
                <c:pt idx="120">
                  <c:v>0.81944444444444398</c:v>
                </c:pt>
                <c:pt idx="121">
                  <c:v>0.81481481481481499</c:v>
                </c:pt>
                <c:pt idx="122">
                  <c:v>0.72685185185185197</c:v>
                </c:pt>
                <c:pt idx="123">
                  <c:v>0.81481481481481499</c:v>
                </c:pt>
                <c:pt idx="124">
                  <c:v>0.81018518518518501</c:v>
                </c:pt>
                <c:pt idx="125">
                  <c:v>0.73611111111111105</c:v>
                </c:pt>
                <c:pt idx="126">
                  <c:v>0.69907407407407396</c:v>
                </c:pt>
                <c:pt idx="127">
                  <c:v>0.79861111111111105</c:v>
                </c:pt>
                <c:pt idx="128">
                  <c:v>0.68981481481481499</c:v>
                </c:pt>
                <c:pt idx="129">
                  <c:v>0.75462962962962998</c:v>
                </c:pt>
                <c:pt idx="130">
                  <c:v>0.78935185185185197</c:v>
                </c:pt>
                <c:pt idx="131">
                  <c:v>0.74305555555555602</c:v>
                </c:pt>
                <c:pt idx="132">
                  <c:v>0.5625</c:v>
                </c:pt>
                <c:pt idx="133">
                  <c:v>0.81944444444444398</c:v>
                </c:pt>
                <c:pt idx="134">
                  <c:v>0.72222222222222199</c:v>
                </c:pt>
                <c:pt idx="135">
                  <c:v>0.77546296296296302</c:v>
                </c:pt>
                <c:pt idx="136">
                  <c:v>0.81944444444444398</c:v>
                </c:pt>
                <c:pt idx="137">
                  <c:v>0.76388888888888895</c:v>
                </c:pt>
                <c:pt idx="138">
                  <c:v>0.81944444444444398</c:v>
                </c:pt>
                <c:pt idx="139">
                  <c:v>0.81481481481481499</c:v>
                </c:pt>
                <c:pt idx="140">
                  <c:v>0.77546296296296302</c:v>
                </c:pt>
                <c:pt idx="141">
                  <c:v>0.75925925925925897</c:v>
                </c:pt>
                <c:pt idx="142">
                  <c:v>0.657407407407407</c:v>
                </c:pt>
                <c:pt idx="143">
                  <c:v>0.62962962962962998</c:v>
                </c:pt>
                <c:pt idx="144">
                  <c:v>0.80787037037037002</c:v>
                </c:pt>
                <c:pt idx="145">
                  <c:v>0.81018518518518501</c:v>
                </c:pt>
                <c:pt idx="146">
                  <c:v>0.68518518518518501</c:v>
                </c:pt>
                <c:pt idx="147">
                  <c:v>0.77314814814814803</c:v>
                </c:pt>
                <c:pt idx="148">
                  <c:v>0.81944444444444398</c:v>
                </c:pt>
                <c:pt idx="149">
                  <c:v>0.81944444444444398</c:v>
                </c:pt>
                <c:pt idx="150">
                  <c:v>0.81944444444444398</c:v>
                </c:pt>
                <c:pt idx="151">
                  <c:v>0.82175925925925897</c:v>
                </c:pt>
                <c:pt idx="152">
                  <c:v>0.81944444444444398</c:v>
                </c:pt>
                <c:pt idx="153">
                  <c:v>0.81944444444444398</c:v>
                </c:pt>
                <c:pt idx="154">
                  <c:v>0.82175925925925897</c:v>
                </c:pt>
                <c:pt idx="155">
                  <c:v>0.70370370370370405</c:v>
                </c:pt>
                <c:pt idx="156">
                  <c:v>0.79861111111111105</c:v>
                </c:pt>
                <c:pt idx="157">
                  <c:v>0.81712962962962998</c:v>
                </c:pt>
                <c:pt idx="158">
                  <c:v>0.80092592592592604</c:v>
                </c:pt>
                <c:pt idx="159">
                  <c:v>0.81944444444444398</c:v>
                </c:pt>
                <c:pt idx="160">
                  <c:v>0.81944444444444398</c:v>
                </c:pt>
                <c:pt idx="161">
                  <c:v>0.81481481481481499</c:v>
                </c:pt>
                <c:pt idx="162">
                  <c:v>0.76620370370370405</c:v>
                </c:pt>
                <c:pt idx="163">
                  <c:v>0.81944444444444398</c:v>
                </c:pt>
                <c:pt idx="164">
                  <c:v>0.81944444444444398</c:v>
                </c:pt>
                <c:pt idx="165">
                  <c:v>0.82175925925925897</c:v>
                </c:pt>
                <c:pt idx="166">
                  <c:v>0.82175925925925897</c:v>
                </c:pt>
                <c:pt idx="167">
                  <c:v>0.81712962962962998</c:v>
                </c:pt>
                <c:pt idx="168">
                  <c:v>0.77546296296296302</c:v>
                </c:pt>
                <c:pt idx="169">
                  <c:v>0.72916666666666696</c:v>
                </c:pt>
                <c:pt idx="170">
                  <c:v>0.73148148148148195</c:v>
                </c:pt>
                <c:pt idx="171">
                  <c:v>0.81018518518518501</c:v>
                </c:pt>
                <c:pt idx="172">
                  <c:v>0.81018518518518501</c:v>
                </c:pt>
                <c:pt idx="173">
                  <c:v>0.81712962962962998</c:v>
                </c:pt>
                <c:pt idx="174">
                  <c:v>0.780092592592593</c:v>
                </c:pt>
                <c:pt idx="175">
                  <c:v>0.77083333333333304</c:v>
                </c:pt>
                <c:pt idx="176">
                  <c:v>0.8125</c:v>
                </c:pt>
                <c:pt idx="177">
                  <c:v>0.81481481481481499</c:v>
                </c:pt>
                <c:pt idx="178">
                  <c:v>0.81712962962962998</c:v>
                </c:pt>
                <c:pt idx="179">
                  <c:v>0.81481481481481499</c:v>
                </c:pt>
                <c:pt idx="180">
                  <c:v>0.70833333333333304</c:v>
                </c:pt>
                <c:pt idx="181">
                  <c:v>0.75231481481481499</c:v>
                </c:pt>
                <c:pt idx="182">
                  <c:v>0.69212962962962998</c:v>
                </c:pt>
                <c:pt idx="183">
                  <c:v>0.81944444444444398</c:v>
                </c:pt>
                <c:pt idx="184">
                  <c:v>0.81944444444444398</c:v>
                </c:pt>
                <c:pt idx="185">
                  <c:v>0.81712962962962998</c:v>
                </c:pt>
                <c:pt idx="186">
                  <c:v>0.62731481481481499</c:v>
                </c:pt>
                <c:pt idx="187">
                  <c:v>0.80324074074074103</c:v>
                </c:pt>
                <c:pt idx="188">
                  <c:v>0.8125</c:v>
                </c:pt>
                <c:pt idx="189">
                  <c:v>0.717592592592593</c:v>
                </c:pt>
                <c:pt idx="190">
                  <c:v>0.65046296296296302</c:v>
                </c:pt>
                <c:pt idx="191">
                  <c:v>0.75231481481481499</c:v>
                </c:pt>
                <c:pt idx="192">
                  <c:v>0.81712962962962998</c:v>
                </c:pt>
                <c:pt idx="193">
                  <c:v>0.81944444444444398</c:v>
                </c:pt>
                <c:pt idx="194">
                  <c:v>0.76157407407407396</c:v>
                </c:pt>
                <c:pt idx="195">
                  <c:v>0.81481481481481499</c:v>
                </c:pt>
                <c:pt idx="196">
                  <c:v>0.81481481481481499</c:v>
                </c:pt>
                <c:pt idx="197">
                  <c:v>0.81944444444444398</c:v>
                </c:pt>
                <c:pt idx="198">
                  <c:v>0.8125</c:v>
                </c:pt>
                <c:pt idx="199">
                  <c:v>0.81712962962962998</c:v>
                </c:pt>
                <c:pt idx="200">
                  <c:v>0.81944444444444398</c:v>
                </c:pt>
                <c:pt idx="201">
                  <c:v>0.75462962962962998</c:v>
                </c:pt>
                <c:pt idx="202">
                  <c:v>0.82175925925925897</c:v>
                </c:pt>
                <c:pt idx="203">
                  <c:v>0.72453703703703698</c:v>
                </c:pt>
                <c:pt idx="204">
                  <c:v>0.81944444444444398</c:v>
                </c:pt>
                <c:pt idx="205">
                  <c:v>0.81944444444444398</c:v>
                </c:pt>
                <c:pt idx="206">
                  <c:v>0.76157407407407396</c:v>
                </c:pt>
                <c:pt idx="207">
                  <c:v>0.625</c:v>
                </c:pt>
                <c:pt idx="208">
                  <c:v>0.81481481481481499</c:v>
                </c:pt>
                <c:pt idx="209">
                  <c:v>0.77546296296296302</c:v>
                </c:pt>
                <c:pt idx="210">
                  <c:v>0.77314814814814803</c:v>
                </c:pt>
                <c:pt idx="211">
                  <c:v>0.79166666666666696</c:v>
                </c:pt>
                <c:pt idx="212">
                  <c:v>0.78935185185185197</c:v>
                </c:pt>
                <c:pt idx="213">
                  <c:v>0.78703703703703698</c:v>
                </c:pt>
                <c:pt idx="214">
                  <c:v>0.77777777777777801</c:v>
                </c:pt>
                <c:pt idx="215">
                  <c:v>0.81712962962962998</c:v>
                </c:pt>
                <c:pt idx="216">
                  <c:v>0.74768518518518501</c:v>
                </c:pt>
                <c:pt idx="217">
                  <c:v>0.71296296296296302</c:v>
                </c:pt>
                <c:pt idx="218">
                  <c:v>0.73379629629629595</c:v>
                </c:pt>
                <c:pt idx="219">
                  <c:v>0.66898148148148195</c:v>
                </c:pt>
                <c:pt idx="220">
                  <c:v>0.81018518518518501</c:v>
                </c:pt>
                <c:pt idx="221">
                  <c:v>0.81712962962962998</c:v>
                </c:pt>
                <c:pt idx="222">
                  <c:v>0.81944444444444398</c:v>
                </c:pt>
                <c:pt idx="223">
                  <c:v>0.81944444444444398</c:v>
                </c:pt>
                <c:pt idx="224">
                  <c:v>0.81481481481481499</c:v>
                </c:pt>
                <c:pt idx="225">
                  <c:v>0.81481481481481499</c:v>
                </c:pt>
                <c:pt idx="226">
                  <c:v>0.80787037037037002</c:v>
                </c:pt>
                <c:pt idx="227">
                  <c:v>0.81712962962962998</c:v>
                </c:pt>
                <c:pt idx="228">
                  <c:v>0.62962962962962998</c:v>
                </c:pt>
                <c:pt idx="229">
                  <c:v>0.81481481481481499</c:v>
                </c:pt>
                <c:pt idx="230">
                  <c:v>0.81712962962962998</c:v>
                </c:pt>
                <c:pt idx="231">
                  <c:v>0.81712962962962998</c:v>
                </c:pt>
                <c:pt idx="232">
                  <c:v>0.82175925925925897</c:v>
                </c:pt>
                <c:pt idx="233">
                  <c:v>0.82175925925925897</c:v>
                </c:pt>
                <c:pt idx="234">
                  <c:v>0.81481481481481499</c:v>
                </c:pt>
                <c:pt idx="235">
                  <c:v>0.80092592592592604</c:v>
                </c:pt>
                <c:pt idx="236">
                  <c:v>0.77546296296296302</c:v>
                </c:pt>
                <c:pt idx="237">
                  <c:v>0.80324074074074103</c:v>
                </c:pt>
                <c:pt idx="238">
                  <c:v>0.780092592592593</c:v>
                </c:pt>
                <c:pt idx="239">
                  <c:v>0.8125</c:v>
                </c:pt>
                <c:pt idx="240">
                  <c:v>0.70601851851851805</c:v>
                </c:pt>
                <c:pt idx="241">
                  <c:v>0.76851851851851805</c:v>
                </c:pt>
                <c:pt idx="242">
                  <c:v>0.76388888888888895</c:v>
                </c:pt>
                <c:pt idx="243">
                  <c:v>0.64351851851851805</c:v>
                </c:pt>
                <c:pt idx="244">
                  <c:v>0.63425925925925897</c:v>
                </c:pt>
                <c:pt idx="245">
                  <c:v>0.74768518518518501</c:v>
                </c:pt>
                <c:pt idx="246">
                  <c:v>0.63657407407407396</c:v>
                </c:pt>
                <c:pt idx="247">
                  <c:v>0.80787037037037002</c:v>
                </c:pt>
                <c:pt idx="248">
                  <c:v>0.81481481481481499</c:v>
                </c:pt>
                <c:pt idx="249">
                  <c:v>0.81712962962962998</c:v>
                </c:pt>
                <c:pt idx="250">
                  <c:v>0.719907407407407</c:v>
                </c:pt>
                <c:pt idx="251">
                  <c:v>0.62037037037037002</c:v>
                </c:pt>
                <c:pt idx="252">
                  <c:v>0.77083333333333304</c:v>
                </c:pt>
                <c:pt idx="253">
                  <c:v>0.67361111111111105</c:v>
                </c:pt>
                <c:pt idx="254">
                  <c:v>0.76157407407407396</c:v>
                </c:pt>
                <c:pt idx="255">
                  <c:v>0.71296296296296302</c:v>
                </c:pt>
                <c:pt idx="256">
                  <c:v>0.66435185185185197</c:v>
                </c:pt>
                <c:pt idx="257">
                  <c:v>0.74305555555555602</c:v>
                </c:pt>
                <c:pt idx="258">
                  <c:v>0.70138888888888895</c:v>
                </c:pt>
                <c:pt idx="259">
                  <c:v>0.8125</c:v>
                </c:pt>
                <c:pt idx="260">
                  <c:v>0.8125</c:v>
                </c:pt>
                <c:pt idx="261">
                  <c:v>0.78472222222222199</c:v>
                </c:pt>
                <c:pt idx="262">
                  <c:v>0.80787037037037002</c:v>
                </c:pt>
                <c:pt idx="263">
                  <c:v>0.82175925925925897</c:v>
                </c:pt>
                <c:pt idx="264">
                  <c:v>0.67361111111111105</c:v>
                </c:pt>
                <c:pt idx="265">
                  <c:v>0.67824074074074103</c:v>
                </c:pt>
                <c:pt idx="266">
                  <c:v>0.67361111111111105</c:v>
                </c:pt>
                <c:pt idx="267">
                  <c:v>0.67129629629629595</c:v>
                </c:pt>
                <c:pt idx="268">
                  <c:v>0.780092592592593</c:v>
                </c:pt>
                <c:pt idx="269">
                  <c:v>0.70601851851851805</c:v>
                </c:pt>
                <c:pt idx="270">
                  <c:v>0.719907407407407</c:v>
                </c:pt>
                <c:pt idx="271">
                  <c:v>0.80324074074074103</c:v>
                </c:pt>
                <c:pt idx="272">
                  <c:v>0.76388888888888895</c:v>
                </c:pt>
                <c:pt idx="273">
                  <c:v>0.75694444444444398</c:v>
                </c:pt>
                <c:pt idx="274">
                  <c:v>0.51851851851851805</c:v>
                </c:pt>
                <c:pt idx="275">
                  <c:v>0.8125</c:v>
                </c:pt>
                <c:pt idx="276">
                  <c:v>0.79398148148148195</c:v>
                </c:pt>
                <c:pt idx="277">
                  <c:v>0.76851851851851805</c:v>
                </c:pt>
                <c:pt idx="278">
                  <c:v>0.81481481481481499</c:v>
                </c:pt>
                <c:pt idx="279">
                  <c:v>0.77314814814814803</c:v>
                </c:pt>
                <c:pt idx="280">
                  <c:v>0.73148148148148195</c:v>
                </c:pt>
                <c:pt idx="281">
                  <c:v>0.76851851851851805</c:v>
                </c:pt>
                <c:pt idx="282">
                  <c:v>0.72685185185185197</c:v>
                </c:pt>
                <c:pt idx="283">
                  <c:v>0.72916666666666696</c:v>
                </c:pt>
                <c:pt idx="284">
                  <c:v>0.81944444444444398</c:v>
                </c:pt>
                <c:pt idx="285">
                  <c:v>0.71296296296296302</c:v>
                </c:pt>
                <c:pt idx="286">
                  <c:v>0.71527777777777801</c:v>
                </c:pt>
                <c:pt idx="287">
                  <c:v>0.75462962962962998</c:v>
                </c:pt>
                <c:pt idx="288">
                  <c:v>0.62731481481481499</c:v>
                </c:pt>
                <c:pt idx="289">
                  <c:v>0.76620370370370405</c:v>
                </c:pt>
                <c:pt idx="290">
                  <c:v>0.82175925925925897</c:v>
                </c:pt>
                <c:pt idx="291">
                  <c:v>0.65046296296296302</c:v>
                </c:pt>
                <c:pt idx="292">
                  <c:v>0.82175925925925897</c:v>
                </c:pt>
                <c:pt idx="293">
                  <c:v>0.81944444444444398</c:v>
                </c:pt>
                <c:pt idx="294">
                  <c:v>0.73148148148148195</c:v>
                </c:pt>
                <c:pt idx="295">
                  <c:v>0.80787037037037002</c:v>
                </c:pt>
                <c:pt idx="296">
                  <c:v>0.82175925925925897</c:v>
                </c:pt>
                <c:pt idx="297">
                  <c:v>0.69212962962962998</c:v>
                </c:pt>
                <c:pt idx="298">
                  <c:v>0.72222222222222199</c:v>
                </c:pt>
                <c:pt idx="299">
                  <c:v>0.75925925925925897</c:v>
                </c:pt>
                <c:pt idx="300">
                  <c:v>0.76851851851851805</c:v>
                </c:pt>
                <c:pt idx="301">
                  <c:v>0.81944444444444398</c:v>
                </c:pt>
                <c:pt idx="302">
                  <c:v>0.82175925925925897</c:v>
                </c:pt>
                <c:pt idx="303">
                  <c:v>0.82175925925925897</c:v>
                </c:pt>
                <c:pt idx="304">
                  <c:v>0.82175925925925897</c:v>
                </c:pt>
                <c:pt idx="305">
                  <c:v>0.81944444444444398</c:v>
                </c:pt>
                <c:pt idx="306">
                  <c:v>0.717592592592593</c:v>
                </c:pt>
                <c:pt idx="307">
                  <c:v>0.80555555555555602</c:v>
                </c:pt>
                <c:pt idx="308">
                  <c:v>0.81944444444444398</c:v>
                </c:pt>
                <c:pt idx="309">
                  <c:v>0.81481481481481499</c:v>
                </c:pt>
                <c:pt idx="310">
                  <c:v>0.82175925925925897</c:v>
                </c:pt>
                <c:pt idx="311">
                  <c:v>0.81712962962962998</c:v>
                </c:pt>
                <c:pt idx="312">
                  <c:v>0.78703703703703698</c:v>
                </c:pt>
                <c:pt idx="313">
                  <c:v>0.71296296296296302</c:v>
                </c:pt>
                <c:pt idx="314">
                  <c:v>0.81481481481481499</c:v>
                </c:pt>
                <c:pt idx="315">
                  <c:v>0.74074074074074103</c:v>
                </c:pt>
                <c:pt idx="316">
                  <c:v>0.81944444444444398</c:v>
                </c:pt>
                <c:pt idx="317">
                  <c:v>0.81712962962962998</c:v>
                </c:pt>
                <c:pt idx="318">
                  <c:v>0.81712962962962998</c:v>
                </c:pt>
                <c:pt idx="319">
                  <c:v>0.82175925925925897</c:v>
                </c:pt>
                <c:pt idx="320">
                  <c:v>0.81944444444444398</c:v>
                </c:pt>
                <c:pt idx="321">
                  <c:v>0.79398148148148195</c:v>
                </c:pt>
                <c:pt idx="322">
                  <c:v>0.719907407407407</c:v>
                </c:pt>
                <c:pt idx="323">
                  <c:v>0.51620370370370405</c:v>
                </c:pt>
                <c:pt idx="324">
                  <c:v>0.71064814814814803</c:v>
                </c:pt>
                <c:pt idx="325">
                  <c:v>0.52314814814814803</c:v>
                </c:pt>
                <c:pt idx="326">
                  <c:v>0.81712962962962998</c:v>
                </c:pt>
                <c:pt idx="327">
                  <c:v>0.81481481481481499</c:v>
                </c:pt>
                <c:pt idx="328">
                  <c:v>0.82175925925925897</c:v>
                </c:pt>
                <c:pt idx="329">
                  <c:v>0.8125</c:v>
                </c:pt>
                <c:pt idx="330">
                  <c:v>0.80555555555555602</c:v>
                </c:pt>
                <c:pt idx="331">
                  <c:v>0.81944444444444398</c:v>
                </c:pt>
                <c:pt idx="332">
                  <c:v>0.82175925925925897</c:v>
                </c:pt>
                <c:pt idx="333">
                  <c:v>0.79861111111111105</c:v>
                </c:pt>
                <c:pt idx="334">
                  <c:v>0.81712962962962998</c:v>
                </c:pt>
                <c:pt idx="335">
                  <c:v>0.81944444444444398</c:v>
                </c:pt>
                <c:pt idx="336">
                  <c:v>0.82175925925925897</c:v>
                </c:pt>
                <c:pt idx="337">
                  <c:v>0.80324074074074103</c:v>
                </c:pt>
                <c:pt idx="338">
                  <c:v>0.80324074074074103</c:v>
                </c:pt>
                <c:pt idx="339">
                  <c:v>0.76620370370370405</c:v>
                </c:pt>
                <c:pt idx="340">
                  <c:v>0.81944444444444398</c:v>
                </c:pt>
                <c:pt idx="341">
                  <c:v>0.82175925925925897</c:v>
                </c:pt>
                <c:pt idx="342">
                  <c:v>0.81018518518518501</c:v>
                </c:pt>
                <c:pt idx="343">
                  <c:v>0.82175925925925897</c:v>
                </c:pt>
                <c:pt idx="344">
                  <c:v>0.78703703703703698</c:v>
                </c:pt>
                <c:pt idx="345">
                  <c:v>0.77546296296296302</c:v>
                </c:pt>
                <c:pt idx="346">
                  <c:v>0.79166666666666696</c:v>
                </c:pt>
                <c:pt idx="347">
                  <c:v>0.81481481481481499</c:v>
                </c:pt>
                <c:pt idx="348">
                  <c:v>0.75</c:v>
                </c:pt>
                <c:pt idx="349">
                  <c:v>0.8125</c:v>
                </c:pt>
                <c:pt idx="350">
                  <c:v>0.75925925925925897</c:v>
                </c:pt>
                <c:pt idx="351">
                  <c:v>0.79861111111111105</c:v>
                </c:pt>
                <c:pt idx="352">
                  <c:v>0.81712962962962998</c:v>
                </c:pt>
                <c:pt idx="353">
                  <c:v>0.81481481481481499</c:v>
                </c:pt>
                <c:pt idx="354">
                  <c:v>0.81944444444444398</c:v>
                </c:pt>
                <c:pt idx="355">
                  <c:v>0.76620370370370405</c:v>
                </c:pt>
                <c:pt idx="356">
                  <c:v>0.75231481481481499</c:v>
                </c:pt>
                <c:pt idx="357">
                  <c:v>0.719907407407407</c:v>
                </c:pt>
                <c:pt idx="358">
                  <c:v>0.80555555555555602</c:v>
                </c:pt>
                <c:pt idx="359">
                  <c:v>0.81944444444444398</c:v>
                </c:pt>
                <c:pt idx="360">
                  <c:v>0.62962962962962998</c:v>
                </c:pt>
                <c:pt idx="361">
                  <c:v>0.82175925925925897</c:v>
                </c:pt>
                <c:pt idx="362">
                  <c:v>0.81944444444444398</c:v>
                </c:pt>
                <c:pt idx="363">
                  <c:v>0.82175925925925897</c:v>
                </c:pt>
                <c:pt idx="364">
                  <c:v>0.81944444444444398</c:v>
                </c:pt>
                <c:pt idx="365">
                  <c:v>0.81481481481481499</c:v>
                </c:pt>
                <c:pt idx="366">
                  <c:v>0.75</c:v>
                </c:pt>
                <c:pt idx="367">
                  <c:v>0.76388888888888895</c:v>
                </c:pt>
                <c:pt idx="368">
                  <c:v>0.78935185185185197</c:v>
                </c:pt>
                <c:pt idx="369">
                  <c:v>0.61111111111111105</c:v>
                </c:pt>
                <c:pt idx="370">
                  <c:v>0.81944444444444398</c:v>
                </c:pt>
                <c:pt idx="371">
                  <c:v>0.81944444444444398</c:v>
                </c:pt>
                <c:pt idx="372">
                  <c:v>0.81944444444444398</c:v>
                </c:pt>
                <c:pt idx="373">
                  <c:v>0.82175925925925897</c:v>
                </c:pt>
                <c:pt idx="374">
                  <c:v>0.719907407407407</c:v>
                </c:pt>
                <c:pt idx="375">
                  <c:v>0.74537037037037002</c:v>
                </c:pt>
                <c:pt idx="376">
                  <c:v>0.75925925925925897</c:v>
                </c:pt>
                <c:pt idx="377">
                  <c:v>0.81712962962962998</c:v>
                </c:pt>
                <c:pt idx="378">
                  <c:v>0.81944444444444398</c:v>
                </c:pt>
                <c:pt idx="379">
                  <c:v>0.81944444444444398</c:v>
                </c:pt>
                <c:pt idx="380">
                  <c:v>0.76157407407407396</c:v>
                </c:pt>
                <c:pt idx="381">
                  <c:v>0.82175925925925897</c:v>
                </c:pt>
                <c:pt idx="382">
                  <c:v>0.82175925925925897</c:v>
                </c:pt>
                <c:pt idx="383">
                  <c:v>0.82175925925925897</c:v>
                </c:pt>
                <c:pt idx="384">
                  <c:v>0.780092592592593</c:v>
                </c:pt>
                <c:pt idx="385">
                  <c:v>0.76851851851851805</c:v>
                </c:pt>
                <c:pt idx="386">
                  <c:v>0.81481481481481499</c:v>
                </c:pt>
                <c:pt idx="387">
                  <c:v>0.76157407407407396</c:v>
                </c:pt>
                <c:pt idx="388">
                  <c:v>0.81944444444444398</c:v>
                </c:pt>
                <c:pt idx="389">
                  <c:v>0.59027777777777801</c:v>
                </c:pt>
                <c:pt idx="390">
                  <c:v>0.81944444444444398</c:v>
                </c:pt>
                <c:pt idx="391">
                  <c:v>0.81944444444444398</c:v>
                </c:pt>
                <c:pt idx="392">
                  <c:v>0.81944444444444398</c:v>
                </c:pt>
                <c:pt idx="393">
                  <c:v>0.76388888888888895</c:v>
                </c:pt>
                <c:pt idx="394">
                  <c:v>0.81712962962962998</c:v>
                </c:pt>
                <c:pt idx="395">
                  <c:v>0.81944444444444398</c:v>
                </c:pt>
                <c:pt idx="396">
                  <c:v>0.80787037037037002</c:v>
                </c:pt>
                <c:pt idx="397">
                  <c:v>0.81481481481481499</c:v>
                </c:pt>
                <c:pt idx="398">
                  <c:v>0.80324074074074103</c:v>
                </c:pt>
                <c:pt idx="399">
                  <c:v>0.48611111111111099</c:v>
                </c:pt>
                <c:pt idx="400">
                  <c:v>0.48611111111111099</c:v>
                </c:pt>
                <c:pt idx="401">
                  <c:v>0.48611111111111099</c:v>
                </c:pt>
                <c:pt idx="402">
                  <c:v>0.48842592592592599</c:v>
                </c:pt>
                <c:pt idx="403">
                  <c:v>0.48842592592592599</c:v>
                </c:pt>
                <c:pt idx="404">
                  <c:v>0.48842592592592599</c:v>
                </c:pt>
                <c:pt idx="405">
                  <c:v>0.68518518518518501</c:v>
                </c:pt>
                <c:pt idx="406">
                  <c:v>0.68518518518518501</c:v>
                </c:pt>
                <c:pt idx="407">
                  <c:v>0.68518518518518501</c:v>
                </c:pt>
                <c:pt idx="408">
                  <c:v>0.68518518518518501</c:v>
                </c:pt>
                <c:pt idx="409">
                  <c:v>0.68518518518518501</c:v>
                </c:pt>
                <c:pt idx="410">
                  <c:v>0.68518518518518501</c:v>
                </c:pt>
                <c:pt idx="411">
                  <c:v>0.68518518518518501</c:v>
                </c:pt>
                <c:pt idx="412">
                  <c:v>0.68518518518518501</c:v>
                </c:pt>
                <c:pt idx="413">
                  <c:v>0.68518518518518501</c:v>
                </c:pt>
                <c:pt idx="414">
                  <c:v>0.68518518518518501</c:v>
                </c:pt>
                <c:pt idx="415">
                  <c:v>0.68518518518518501</c:v>
                </c:pt>
                <c:pt idx="416">
                  <c:v>0.68518518518518501</c:v>
                </c:pt>
                <c:pt idx="417">
                  <c:v>0.75925925925925897</c:v>
                </c:pt>
                <c:pt idx="418">
                  <c:v>0.75925925925925897</c:v>
                </c:pt>
                <c:pt idx="419">
                  <c:v>0.759259259259258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633-4B7B-A829-5F73D6911D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81828255"/>
        <c:axId val="214256879"/>
      </c:lineChart>
      <c:catAx>
        <c:axId val="581828255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14256879"/>
        <c:crosses val="autoZero"/>
        <c:auto val="1"/>
        <c:lblAlgn val="ctr"/>
        <c:lblOffset val="100"/>
        <c:noMultiLvlLbl val="0"/>
      </c:catAx>
      <c:valAx>
        <c:axId val="21425687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81828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800" dirty="0"/>
              <a:t>C3 </a:t>
            </a:r>
            <a:r>
              <a:rPr lang="en-US" sz="1800" dirty="0"/>
              <a:t>identity</a:t>
            </a:r>
          </a:p>
        </c:rich>
      </c:tx>
      <c:layout>
        <c:manualLayout>
          <c:xMode val="edge"/>
          <c:yMode val="edge"/>
          <c:x val="0.40574324324324323"/>
          <c:y val="3.7037037037037035E-2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[工作簿13]Sheet1!$G$1</c:f>
              <c:strCache>
                <c:ptCount val="1"/>
                <c:pt idx="0">
                  <c:v>identity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[工作簿13]Sheet1!$G$2:$G$322</c:f>
              <c:numCache>
                <c:formatCode>General</c:formatCode>
                <c:ptCount val="321"/>
                <c:pt idx="0">
                  <c:v>0.98691099476439803</c:v>
                </c:pt>
                <c:pt idx="1">
                  <c:v>0.98691099476439803</c:v>
                </c:pt>
                <c:pt idx="2">
                  <c:v>0.98691099476439803</c:v>
                </c:pt>
                <c:pt idx="3">
                  <c:v>0.98691099476439803</c:v>
                </c:pt>
                <c:pt idx="4">
                  <c:v>0.98691099476439803</c:v>
                </c:pt>
                <c:pt idx="5">
                  <c:v>0.98429319371727797</c:v>
                </c:pt>
                <c:pt idx="6">
                  <c:v>0.98429319371727797</c:v>
                </c:pt>
                <c:pt idx="7">
                  <c:v>0.84293193717277504</c:v>
                </c:pt>
                <c:pt idx="8">
                  <c:v>0.95811518324607303</c:v>
                </c:pt>
                <c:pt idx="9">
                  <c:v>0.98429319371727797</c:v>
                </c:pt>
                <c:pt idx="10">
                  <c:v>0.96596858638743499</c:v>
                </c:pt>
                <c:pt idx="11">
                  <c:v>0.98691099476439803</c:v>
                </c:pt>
                <c:pt idx="12">
                  <c:v>0.98691099476439803</c:v>
                </c:pt>
                <c:pt idx="13">
                  <c:v>0.98167539267015702</c:v>
                </c:pt>
                <c:pt idx="14">
                  <c:v>0.81675392670157099</c:v>
                </c:pt>
                <c:pt idx="15">
                  <c:v>0.98952879581151798</c:v>
                </c:pt>
                <c:pt idx="16">
                  <c:v>0.98691099476439803</c:v>
                </c:pt>
                <c:pt idx="17">
                  <c:v>0.98952879581151798</c:v>
                </c:pt>
                <c:pt idx="18">
                  <c:v>0.98429319371727797</c:v>
                </c:pt>
                <c:pt idx="19">
                  <c:v>0.98691099476439803</c:v>
                </c:pt>
                <c:pt idx="20">
                  <c:v>0.93455497382198904</c:v>
                </c:pt>
                <c:pt idx="21">
                  <c:v>0.884816753926702</c:v>
                </c:pt>
                <c:pt idx="22">
                  <c:v>0.88219895287958106</c:v>
                </c:pt>
                <c:pt idx="23">
                  <c:v>0.81675392670157099</c:v>
                </c:pt>
                <c:pt idx="24">
                  <c:v>0.81413612565445004</c:v>
                </c:pt>
                <c:pt idx="25">
                  <c:v>0.98429319371727797</c:v>
                </c:pt>
                <c:pt idx="26">
                  <c:v>0.942408376963351</c:v>
                </c:pt>
                <c:pt idx="27">
                  <c:v>0.94764397905759201</c:v>
                </c:pt>
                <c:pt idx="28">
                  <c:v>0.97382198952879595</c:v>
                </c:pt>
                <c:pt idx="29">
                  <c:v>0.98167539267015702</c:v>
                </c:pt>
                <c:pt idx="30">
                  <c:v>0.98429319371727797</c:v>
                </c:pt>
                <c:pt idx="31">
                  <c:v>0.97905759162303696</c:v>
                </c:pt>
                <c:pt idx="32">
                  <c:v>0.69371727748691103</c:v>
                </c:pt>
                <c:pt idx="33">
                  <c:v>0.74607329842931902</c:v>
                </c:pt>
                <c:pt idx="34">
                  <c:v>0.85602094240837701</c:v>
                </c:pt>
                <c:pt idx="35">
                  <c:v>0.98691099476439803</c:v>
                </c:pt>
                <c:pt idx="36">
                  <c:v>0.98691099476439803</c:v>
                </c:pt>
                <c:pt idx="37">
                  <c:v>0.98691099476439803</c:v>
                </c:pt>
                <c:pt idx="38">
                  <c:v>0.77225130890052396</c:v>
                </c:pt>
                <c:pt idx="39">
                  <c:v>0.86125654450261802</c:v>
                </c:pt>
                <c:pt idx="40">
                  <c:v>0.95287958115183202</c:v>
                </c:pt>
                <c:pt idx="41">
                  <c:v>0.87434554973821998</c:v>
                </c:pt>
                <c:pt idx="42">
                  <c:v>0.80366492146596902</c:v>
                </c:pt>
                <c:pt idx="43">
                  <c:v>0.91623036649214695</c:v>
                </c:pt>
                <c:pt idx="44">
                  <c:v>0.98691099476439803</c:v>
                </c:pt>
                <c:pt idx="45">
                  <c:v>0.98952879581151798</c:v>
                </c:pt>
                <c:pt idx="46">
                  <c:v>0.87696335078534005</c:v>
                </c:pt>
                <c:pt idx="47">
                  <c:v>0.98429319371727797</c:v>
                </c:pt>
                <c:pt idx="48">
                  <c:v>0.98429319371727797</c:v>
                </c:pt>
                <c:pt idx="49">
                  <c:v>0.98691099476439803</c:v>
                </c:pt>
                <c:pt idx="50">
                  <c:v>0.98167539267015702</c:v>
                </c:pt>
                <c:pt idx="51">
                  <c:v>0.98429319371727797</c:v>
                </c:pt>
                <c:pt idx="52">
                  <c:v>0.98167539267015702</c:v>
                </c:pt>
                <c:pt idx="53">
                  <c:v>0.79842931937172801</c:v>
                </c:pt>
                <c:pt idx="54">
                  <c:v>0.98691099476439803</c:v>
                </c:pt>
                <c:pt idx="55">
                  <c:v>0.71204188481675401</c:v>
                </c:pt>
                <c:pt idx="56">
                  <c:v>0.98691099476439803</c:v>
                </c:pt>
                <c:pt idx="57">
                  <c:v>0.98952879581151798</c:v>
                </c:pt>
                <c:pt idx="58">
                  <c:v>0.92670157068062797</c:v>
                </c:pt>
                <c:pt idx="59">
                  <c:v>0.74607329842931902</c:v>
                </c:pt>
                <c:pt idx="60">
                  <c:v>0.98429319371727797</c:v>
                </c:pt>
                <c:pt idx="61">
                  <c:v>0.942408376963351</c:v>
                </c:pt>
                <c:pt idx="62">
                  <c:v>0.93717277486910999</c:v>
                </c:pt>
                <c:pt idx="63">
                  <c:v>0.78534031413612604</c:v>
                </c:pt>
                <c:pt idx="64">
                  <c:v>0.78795811518324599</c:v>
                </c:pt>
                <c:pt idx="65">
                  <c:v>0.95287958115183202</c:v>
                </c:pt>
                <c:pt idx="66">
                  <c:v>0.77225130890052396</c:v>
                </c:pt>
                <c:pt idx="67">
                  <c:v>0.98429319371727797</c:v>
                </c:pt>
                <c:pt idx="68">
                  <c:v>0.735602094240838</c:v>
                </c:pt>
                <c:pt idx="69">
                  <c:v>0.85863874345549696</c:v>
                </c:pt>
                <c:pt idx="70">
                  <c:v>0.88219895287958106</c:v>
                </c:pt>
                <c:pt idx="71">
                  <c:v>0.65445026178010501</c:v>
                </c:pt>
                <c:pt idx="72">
                  <c:v>0.97905759162303696</c:v>
                </c:pt>
                <c:pt idx="73">
                  <c:v>0.98429319371727797</c:v>
                </c:pt>
                <c:pt idx="74">
                  <c:v>0.98952879581151798</c:v>
                </c:pt>
                <c:pt idx="75">
                  <c:v>0.98952879581151798</c:v>
                </c:pt>
                <c:pt idx="76">
                  <c:v>0.98167539267015702</c:v>
                </c:pt>
                <c:pt idx="77">
                  <c:v>0.98429319371727797</c:v>
                </c:pt>
                <c:pt idx="78">
                  <c:v>0.97382198952879595</c:v>
                </c:pt>
                <c:pt idx="79">
                  <c:v>0.98691099476439803</c:v>
                </c:pt>
                <c:pt idx="80">
                  <c:v>0.62565445026178002</c:v>
                </c:pt>
                <c:pt idx="81">
                  <c:v>0.98429319371727797</c:v>
                </c:pt>
                <c:pt idx="82">
                  <c:v>0.98429319371727797</c:v>
                </c:pt>
                <c:pt idx="83">
                  <c:v>0.98429319371727797</c:v>
                </c:pt>
                <c:pt idx="84">
                  <c:v>0.98952879581151798</c:v>
                </c:pt>
                <c:pt idx="85">
                  <c:v>0.98952879581151798</c:v>
                </c:pt>
                <c:pt idx="86">
                  <c:v>0.98429319371727797</c:v>
                </c:pt>
                <c:pt idx="87">
                  <c:v>0.97382198952879595</c:v>
                </c:pt>
                <c:pt idx="88">
                  <c:v>0.93717277486910999</c:v>
                </c:pt>
                <c:pt idx="89">
                  <c:v>0.95549738219895297</c:v>
                </c:pt>
                <c:pt idx="90">
                  <c:v>0.942408376963351</c:v>
                </c:pt>
                <c:pt idx="91">
                  <c:v>0.98167539267015702</c:v>
                </c:pt>
                <c:pt idx="92">
                  <c:v>0.87172774869109904</c:v>
                </c:pt>
                <c:pt idx="93">
                  <c:v>0.92931937172774903</c:v>
                </c:pt>
                <c:pt idx="94">
                  <c:v>0.913612565445026</c:v>
                </c:pt>
                <c:pt idx="95">
                  <c:v>0.63350785340314097</c:v>
                </c:pt>
                <c:pt idx="96">
                  <c:v>0.62565445026178002</c:v>
                </c:pt>
                <c:pt idx="97">
                  <c:v>0.90314136125654498</c:v>
                </c:pt>
                <c:pt idx="98">
                  <c:v>0.74607329842931902</c:v>
                </c:pt>
                <c:pt idx="99">
                  <c:v>0.97643979057591601</c:v>
                </c:pt>
                <c:pt idx="100">
                  <c:v>0.98429319371727797</c:v>
                </c:pt>
                <c:pt idx="101">
                  <c:v>0.98691099476439803</c:v>
                </c:pt>
                <c:pt idx="102">
                  <c:v>0.71465968586387396</c:v>
                </c:pt>
                <c:pt idx="103">
                  <c:v>0.60994764397905799</c:v>
                </c:pt>
                <c:pt idx="104">
                  <c:v>0.84816753926701605</c:v>
                </c:pt>
                <c:pt idx="105">
                  <c:v>0.67277486910994799</c:v>
                </c:pt>
                <c:pt idx="106">
                  <c:v>0.91884816753926701</c:v>
                </c:pt>
                <c:pt idx="107">
                  <c:v>0.84554973821989499</c:v>
                </c:pt>
                <c:pt idx="108">
                  <c:v>0.793193717277487</c:v>
                </c:pt>
                <c:pt idx="109">
                  <c:v>0.90837696335078499</c:v>
                </c:pt>
                <c:pt idx="110">
                  <c:v>0.69633507853403098</c:v>
                </c:pt>
                <c:pt idx="111">
                  <c:v>0.98167539267015702</c:v>
                </c:pt>
                <c:pt idx="112">
                  <c:v>0.97905759162303696</c:v>
                </c:pt>
                <c:pt idx="113">
                  <c:v>0.93193717277486898</c:v>
                </c:pt>
                <c:pt idx="114">
                  <c:v>0.97905759162303696</c:v>
                </c:pt>
                <c:pt idx="115">
                  <c:v>0.98952879581151798</c:v>
                </c:pt>
                <c:pt idx="116">
                  <c:v>0.764397905759162</c:v>
                </c:pt>
                <c:pt idx="117">
                  <c:v>0.82984293193717296</c:v>
                </c:pt>
                <c:pt idx="118">
                  <c:v>0.80366492146596902</c:v>
                </c:pt>
                <c:pt idx="119">
                  <c:v>0.678010471204188</c:v>
                </c:pt>
                <c:pt idx="120">
                  <c:v>0.93979057591623005</c:v>
                </c:pt>
                <c:pt idx="121">
                  <c:v>0.706806282722513</c:v>
                </c:pt>
                <c:pt idx="122">
                  <c:v>0.87696335078534005</c:v>
                </c:pt>
                <c:pt idx="123">
                  <c:v>0.971204188481675</c:v>
                </c:pt>
                <c:pt idx="124">
                  <c:v>0.92408376963350802</c:v>
                </c:pt>
                <c:pt idx="125">
                  <c:v>0.92408376963350802</c:v>
                </c:pt>
                <c:pt idx="126">
                  <c:v>0.678010471204188</c:v>
                </c:pt>
                <c:pt idx="127">
                  <c:v>0.97905759162303696</c:v>
                </c:pt>
                <c:pt idx="128">
                  <c:v>0.96858638743455505</c:v>
                </c:pt>
                <c:pt idx="129">
                  <c:v>0.93455497382198904</c:v>
                </c:pt>
                <c:pt idx="130">
                  <c:v>0.98167539267015702</c:v>
                </c:pt>
                <c:pt idx="131">
                  <c:v>0.93979057591623005</c:v>
                </c:pt>
                <c:pt idx="132">
                  <c:v>0.884816753926702</c:v>
                </c:pt>
                <c:pt idx="133">
                  <c:v>0.92931937172774903</c:v>
                </c:pt>
                <c:pt idx="134">
                  <c:v>0.75654450261780104</c:v>
                </c:pt>
                <c:pt idx="135">
                  <c:v>0.88743455497382195</c:v>
                </c:pt>
                <c:pt idx="136">
                  <c:v>0.98952879581151798</c:v>
                </c:pt>
                <c:pt idx="137">
                  <c:v>0.70157068062827199</c:v>
                </c:pt>
                <c:pt idx="138">
                  <c:v>0.70157068062827199</c:v>
                </c:pt>
                <c:pt idx="139">
                  <c:v>0.913612565445026</c:v>
                </c:pt>
                <c:pt idx="140">
                  <c:v>0.62303664921465995</c:v>
                </c:pt>
                <c:pt idx="141">
                  <c:v>0.78534031413612604</c:v>
                </c:pt>
                <c:pt idx="142">
                  <c:v>0.98952879581151798</c:v>
                </c:pt>
                <c:pt idx="143">
                  <c:v>0.649214659685864</c:v>
                </c:pt>
                <c:pt idx="144">
                  <c:v>0.98952879581151798</c:v>
                </c:pt>
                <c:pt idx="145">
                  <c:v>0.98167539267015702</c:v>
                </c:pt>
                <c:pt idx="146">
                  <c:v>0.73821989528795795</c:v>
                </c:pt>
                <c:pt idx="147">
                  <c:v>0.86910994764397898</c:v>
                </c:pt>
                <c:pt idx="148">
                  <c:v>0.98691099476439803</c:v>
                </c:pt>
                <c:pt idx="149">
                  <c:v>0.70157068062827199</c:v>
                </c:pt>
                <c:pt idx="150">
                  <c:v>0.72251308900523603</c:v>
                </c:pt>
                <c:pt idx="151">
                  <c:v>0.74869109947643997</c:v>
                </c:pt>
                <c:pt idx="152">
                  <c:v>0.88219895287958106</c:v>
                </c:pt>
                <c:pt idx="153">
                  <c:v>0.98691099476439803</c:v>
                </c:pt>
                <c:pt idx="154">
                  <c:v>0.98952879581151798</c:v>
                </c:pt>
                <c:pt idx="155">
                  <c:v>0.98952879581151798</c:v>
                </c:pt>
                <c:pt idx="156">
                  <c:v>0.98952879581151798</c:v>
                </c:pt>
                <c:pt idx="157">
                  <c:v>0.98429319371727797</c:v>
                </c:pt>
                <c:pt idx="158">
                  <c:v>0.87696335078534005</c:v>
                </c:pt>
                <c:pt idx="159">
                  <c:v>0.84293193717277504</c:v>
                </c:pt>
                <c:pt idx="160">
                  <c:v>0.98691099476439803</c:v>
                </c:pt>
                <c:pt idx="161">
                  <c:v>0.98167539267015702</c:v>
                </c:pt>
                <c:pt idx="162">
                  <c:v>0.98952879581151798</c:v>
                </c:pt>
                <c:pt idx="163">
                  <c:v>0.98429319371727797</c:v>
                </c:pt>
                <c:pt idx="164">
                  <c:v>0.94502617801047095</c:v>
                </c:pt>
                <c:pt idx="165">
                  <c:v>0.69633507853403098</c:v>
                </c:pt>
                <c:pt idx="166">
                  <c:v>0.98167539267015702</c:v>
                </c:pt>
                <c:pt idx="167">
                  <c:v>0.735602094240838</c:v>
                </c:pt>
                <c:pt idx="168">
                  <c:v>0.98691099476439803</c:v>
                </c:pt>
                <c:pt idx="169">
                  <c:v>0.98429319371727797</c:v>
                </c:pt>
                <c:pt idx="170">
                  <c:v>0.98429319371727797</c:v>
                </c:pt>
                <c:pt idx="171">
                  <c:v>0.98952879581151798</c:v>
                </c:pt>
                <c:pt idx="172">
                  <c:v>0.98691099476439803</c:v>
                </c:pt>
                <c:pt idx="173">
                  <c:v>0.79057591623036605</c:v>
                </c:pt>
                <c:pt idx="174">
                  <c:v>0.88743455497382195</c:v>
                </c:pt>
                <c:pt idx="175">
                  <c:v>0.50523560209424101</c:v>
                </c:pt>
                <c:pt idx="176">
                  <c:v>0.70418848167539305</c:v>
                </c:pt>
                <c:pt idx="177">
                  <c:v>0.68324607329842901</c:v>
                </c:pt>
                <c:pt idx="178">
                  <c:v>0.98691099476439803</c:v>
                </c:pt>
                <c:pt idx="179">
                  <c:v>0.98167539267015702</c:v>
                </c:pt>
                <c:pt idx="180">
                  <c:v>0.98952879581151798</c:v>
                </c:pt>
                <c:pt idx="181">
                  <c:v>0.98429319371727797</c:v>
                </c:pt>
                <c:pt idx="182">
                  <c:v>0.96335078534031404</c:v>
                </c:pt>
                <c:pt idx="183">
                  <c:v>0.97905759162303696</c:v>
                </c:pt>
                <c:pt idx="184">
                  <c:v>0.98952879581151798</c:v>
                </c:pt>
                <c:pt idx="185">
                  <c:v>0.79581151832460695</c:v>
                </c:pt>
                <c:pt idx="186">
                  <c:v>0.98429319371727797</c:v>
                </c:pt>
                <c:pt idx="187">
                  <c:v>0.98691099476439803</c:v>
                </c:pt>
                <c:pt idx="188">
                  <c:v>0.98952879581151798</c:v>
                </c:pt>
                <c:pt idx="189">
                  <c:v>0.96073298429319398</c:v>
                </c:pt>
                <c:pt idx="190">
                  <c:v>0.971204188481675</c:v>
                </c:pt>
                <c:pt idx="191">
                  <c:v>0.92408376963350802</c:v>
                </c:pt>
                <c:pt idx="192">
                  <c:v>0.98691099476439803</c:v>
                </c:pt>
                <c:pt idx="193">
                  <c:v>0.98952879581151798</c:v>
                </c:pt>
                <c:pt idx="194">
                  <c:v>0.97643979057591601</c:v>
                </c:pt>
                <c:pt idx="195">
                  <c:v>0.98952879581151798</c:v>
                </c:pt>
                <c:pt idx="196">
                  <c:v>0.95287958115183202</c:v>
                </c:pt>
                <c:pt idx="197">
                  <c:v>0.93193717277486898</c:v>
                </c:pt>
                <c:pt idx="198">
                  <c:v>0.95287958115183202</c:v>
                </c:pt>
                <c:pt idx="199">
                  <c:v>0.98167539267015702</c:v>
                </c:pt>
                <c:pt idx="200">
                  <c:v>0.74083769633507901</c:v>
                </c:pt>
                <c:pt idx="201">
                  <c:v>0.92146596858638696</c:v>
                </c:pt>
                <c:pt idx="202">
                  <c:v>0.74869109947643997</c:v>
                </c:pt>
                <c:pt idx="203">
                  <c:v>0.96073298429319398</c:v>
                </c:pt>
                <c:pt idx="204">
                  <c:v>0.98429319371727797</c:v>
                </c:pt>
                <c:pt idx="205">
                  <c:v>0.82460732984293195</c:v>
                </c:pt>
                <c:pt idx="206">
                  <c:v>0.98691099476439803</c:v>
                </c:pt>
                <c:pt idx="207">
                  <c:v>0.82984293193717296</c:v>
                </c:pt>
                <c:pt idx="208">
                  <c:v>0.74607329842931902</c:v>
                </c:pt>
                <c:pt idx="209">
                  <c:v>0.86649214659685903</c:v>
                </c:pt>
                <c:pt idx="210">
                  <c:v>0.96858638743455505</c:v>
                </c:pt>
                <c:pt idx="211">
                  <c:v>0.98429319371727797</c:v>
                </c:pt>
                <c:pt idx="212">
                  <c:v>0.63350785340314097</c:v>
                </c:pt>
                <c:pt idx="213">
                  <c:v>0.98952879581151798</c:v>
                </c:pt>
                <c:pt idx="214">
                  <c:v>0.98691099476439803</c:v>
                </c:pt>
                <c:pt idx="215">
                  <c:v>0.98952879581151798</c:v>
                </c:pt>
                <c:pt idx="216">
                  <c:v>0.98691099476439803</c:v>
                </c:pt>
                <c:pt idx="217">
                  <c:v>0.98167539267015702</c:v>
                </c:pt>
                <c:pt idx="218">
                  <c:v>0.73821989528795795</c:v>
                </c:pt>
                <c:pt idx="219">
                  <c:v>0.75392670157068098</c:v>
                </c:pt>
                <c:pt idx="220">
                  <c:v>0.78795811518324599</c:v>
                </c:pt>
                <c:pt idx="221">
                  <c:v>0.60732984293193704</c:v>
                </c:pt>
                <c:pt idx="222">
                  <c:v>0.98691099476439803</c:v>
                </c:pt>
                <c:pt idx="223">
                  <c:v>0.98691099476439803</c:v>
                </c:pt>
                <c:pt idx="224">
                  <c:v>0.98691099476439803</c:v>
                </c:pt>
                <c:pt idx="225">
                  <c:v>0.98952879581151798</c:v>
                </c:pt>
                <c:pt idx="226">
                  <c:v>0.89005235602094201</c:v>
                </c:pt>
                <c:pt idx="227">
                  <c:v>0.74083769633507901</c:v>
                </c:pt>
                <c:pt idx="228">
                  <c:v>0.91884816753926701</c:v>
                </c:pt>
                <c:pt idx="229">
                  <c:v>0.98429319371727797</c:v>
                </c:pt>
                <c:pt idx="230">
                  <c:v>0.98691099476439803</c:v>
                </c:pt>
                <c:pt idx="231">
                  <c:v>0.98691099476439803</c:v>
                </c:pt>
                <c:pt idx="232">
                  <c:v>0.92408376963350802</c:v>
                </c:pt>
                <c:pt idx="233">
                  <c:v>0.98952879581151798</c:v>
                </c:pt>
                <c:pt idx="234">
                  <c:v>0.98691099476439803</c:v>
                </c:pt>
                <c:pt idx="235">
                  <c:v>0.98952879581151798</c:v>
                </c:pt>
                <c:pt idx="236">
                  <c:v>0.77748691099476397</c:v>
                </c:pt>
                <c:pt idx="237">
                  <c:v>0.75916230366492099</c:v>
                </c:pt>
                <c:pt idx="238">
                  <c:v>0.821989528795812</c:v>
                </c:pt>
                <c:pt idx="239">
                  <c:v>0.75392670157068098</c:v>
                </c:pt>
                <c:pt idx="240">
                  <c:v>0.98691099476439803</c:v>
                </c:pt>
                <c:pt idx="241">
                  <c:v>0.69895287958115204</c:v>
                </c:pt>
                <c:pt idx="242">
                  <c:v>0.98952879581151798</c:v>
                </c:pt>
                <c:pt idx="243">
                  <c:v>0.98952879581151798</c:v>
                </c:pt>
                <c:pt idx="244">
                  <c:v>0.98691099476439803</c:v>
                </c:pt>
                <c:pt idx="245">
                  <c:v>0.92931937172774903</c:v>
                </c:pt>
                <c:pt idx="246">
                  <c:v>0.98429319371727797</c:v>
                </c:pt>
                <c:pt idx="247">
                  <c:v>0.98952879581151798</c:v>
                </c:pt>
                <c:pt idx="248">
                  <c:v>0.98429319371727797</c:v>
                </c:pt>
                <c:pt idx="249">
                  <c:v>0.98691099476439803</c:v>
                </c:pt>
                <c:pt idx="250">
                  <c:v>0.95549738219895297</c:v>
                </c:pt>
                <c:pt idx="251">
                  <c:v>0.98952879581151798</c:v>
                </c:pt>
                <c:pt idx="252">
                  <c:v>0.98167539267015702</c:v>
                </c:pt>
                <c:pt idx="253">
                  <c:v>0.98952879581151798</c:v>
                </c:pt>
                <c:pt idx="254">
                  <c:v>0.91099476439790605</c:v>
                </c:pt>
                <c:pt idx="255">
                  <c:v>0.98691099476439803</c:v>
                </c:pt>
                <c:pt idx="256">
                  <c:v>0.98167539267015702</c:v>
                </c:pt>
                <c:pt idx="257">
                  <c:v>0.98952879581151798</c:v>
                </c:pt>
                <c:pt idx="258">
                  <c:v>0.98952879581151798</c:v>
                </c:pt>
                <c:pt idx="259">
                  <c:v>0.735602094240838</c:v>
                </c:pt>
                <c:pt idx="260">
                  <c:v>0.83769633507853403</c:v>
                </c:pt>
                <c:pt idx="261">
                  <c:v>0.86910994764397898</c:v>
                </c:pt>
                <c:pt idx="262">
                  <c:v>0.93193717277486898</c:v>
                </c:pt>
                <c:pt idx="263">
                  <c:v>0.93979057591623005</c:v>
                </c:pt>
                <c:pt idx="264">
                  <c:v>0.85602094240837701</c:v>
                </c:pt>
                <c:pt idx="265">
                  <c:v>0.98167539267015702</c:v>
                </c:pt>
                <c:pt idx="266">
                  <c:v>0.98429319371727797</c:v>
                </c:pt>
                <c:pt idx="267">
                  <c:v>0.735602094240838</c:v>
                </c:pt>
                <c:pt idx="268">
                  <c:v>0.80628272251308897</c:v>
                </c:pt>
                <c:pt idx="269">
                  <c:v>0.93455497382198904</c:v>
                </c:pt>
                <c:pt idx="270">
                  <c:v>0.68324607329842901</c:v>
                </c:pt>
                <c:pt idx="271">
                  <c:v>0.92670157068062797</c:v>
                </c:pt>
                <c:pt idx="272">
                  <c:v>0.90837696335078499</c:v>
                </c:pt>
                <c:pt idx="273">
                  <c:v>0.97643979057591601</c:v>
                </c:pt>
                <c:pt idx="274">
                  <c:v>0.93455497382198904</c:v>
                </c:pt>
                <c:pt idx="275">
                  <c:v>0.66230366492146597</c:v>
                </c:pt>
                <c:pt idx="276">
                  <c:v>0.98691099476439803</c:v>
                </c:pt>
                <c:pt idx="277">
                  <c:v>0.98952879581151798</c:v>
                </c:pt>
                <c:pt idx="278">
                  <c:v>0.97382198952879595</c:v>
                </c:pt>
                <c:pt idx="279">
                  <c:v>0.98691099476439803</c:v>
                </c:pt>
                <c:pt idx="280">
                  <c:v>0.98952879581151798</c:v>
                </c:pt>
                <c:pt idx="281">
                  <c:v>0.87172774869109904</c:v>
                </c:pt>
                <c:pt idx="282">
                  <c:v>0.74869109947643997</c:v>
                </c:pt>
                <c:pt idx="283">
                  <c:v>0.98429319371727797</c:v>
                </c:pt>
                <c:pt idx="284">
                  <c:v>0.98167539267015702</c:v>
                </c:pt>
                <c:pt idx="285">
                  <c:v>0.98429319371727797</c:v>
                </c:pt>
                <c:pt idx="286">
                  <c:v>0.74083769633507901</c:v>
                </c:pt>
                <c:pt idx="287">
                  <c:v>0.78272251308900498</c:v>
                </c:pt>
                <c:pt idx="288">
                  <c:v>0.59162303664921501</c:v>
                </c:pt>
                <c:pt idx="289">
                  <c:v>0.98952879581151798</c:v>
                </c:pt>
                <c:pt idx="290">
                  <c:v>0.63874345549738198</c:v>
                </c:pt>
                <c:pt idx="291">
                  <c:v>0.98429319371727797</c:v>
                </c:pt>
                <c:pt idx="292">
                  <c:v>0.97905759162303696</c:v>
                </c:pt>
                <c:pt idx="293">
                  <c:v>0.78795811518324599</c:v>
                </c:pt>
                <c:pt idx="294">
                  <c:v>0.95287958115183202</c:v>
                </c:pt>
                <c:pt idx="295">
                  <c:v>0.98691099476439803</c:v>
                </c:pt>
                <c:pt idx="296">
                  <c:v>0.81413612565445004</c:v>
                </c:pt>
                <c:pt idx="297">
                  <c:v>0.94764397905759201</c:v>
                </c:pt>
                <c:pt idx="298">
                  <c:v>0.98691099476439803</c:v>
                </c:pt>
                <c:pt idx="299">
                  <c:v>0.98167539267015702</c:v>
                </c:pt>
                <c:pt idx="300">
                  <c:v>0.80628272251308897</c:v>
                </c:pt>
                <c:pt idx="301">
                  <c:v>0.81413612565445004</c:v>
                </c:pt>
                <c:pt idx="302">
                  <c:v>0.51308900523560197</c:v>
                </c:pt>
                <c:pt idx="303">
                  <c:v>0.92931937172774903</c:v>
                </c:pt>
                <c:pt idx="304">
                  <c:v>0.98691099476439803</c:v>
                </c:pt>
                <c:pt idx="305">
                  <c:v>0.79057591623036605</c:v>
                </c:pt>
                <c:pt idx="306">
                  <c:v>0.98952879581151798</c:v>
                </c:pt>
                <c:pt idx="307">
                  <c:v>0.98952879581151798</c:v>
                </c:pt>
                <c:pt idx="308">
                  <c:v>0.86910994764397898</c:v>
                </c:pt>
                <c:pt idx="309">
                  <c:v>0.97905759162303696</c:v>
                </c:pt>
                <c:pt idx="310">
                  <c:v>0.97643979057591601</c:v>
                </c:pt>
                <c:pt idx="311">
                  <c:v>0.98691099476439803</c:v>
                </c:pt>
                <c:pt idx="312">
                  <c:v>0.92670157068062797</c:v>
                </c:pt>
                <c:pt idx="313">
                  <c:v>0.93455497382198904</c:v>
                </c:pt>
                <c:pt idx="314">
                  <c:v>0.87696335078534005</c:v>
                </c:pt>
                <c:pt idx="315">
                  <c:v>0.97905759162303696</c:v>
                </c:pt>
                <c:pt idx="316">
                  <c:v>0.98691099476439803</c:v>
                </c:pt>
                <c:pt idx="317">
                  <c:v>0.61780104712041894</c:v>
                </c:pt>
                <c:pt idx="318">
                  <c:v>0.92408376963350802</c:v>
                </c:pt>
                <c:pt idx="319">
                  <c:v>0.96596858638743499</c:v>
                </c:pt>
                <c:pt idx="320">
                  <c:v>0.816753926701570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7A4-4273-B141-55F5EEB3FE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815553937"/>
        <c:axId val="916635945"/>
      </c:lineChart>
      <c:catAx>
        <c:axId val="815553937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16635945"/>
        <c:crosses val="autoZero"/>
        <c:auto val="1"/>
        <c:lblAlgn val="ctr"/>
        <c:lblOffset val="100"/>
        <c:noMultiLvlLbl val="0"/>
      </c:catAx>
      <c:valAx>
        <c:axId val="916635945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81555393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800"/>
              <a:t>C4 </a:t>
            </a:r>
            <a:r>
              <a:rPr lang="en-US" sz="1800"/>
              <a:t>identity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 defTabSz="914400">
            <a:defRPr lang="zh-CN" sz="1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[工作簿14]Sheet1!$G$1</c:f>
              <c:strCache>
                <c:ptCount val="1"/>
                <c:pt idx="0">
                  <c:v>identity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[工作簿14]Sheet1!$G$2:$G$421</c:f>
              <c:numCache>
                <c:formatCode>General</c:formatCode>
                <c:ptCount val="420"/>
                <c:pt idx="0">
                  <c:v>0.92134831460674205</c:v>
                </c:pt>
                <c:pt idx="1">
                  <c:v>0.92134831460674205</c:v>
                </c:pt>
                <c:pt idx="2">
                  <c:v>0.81741573033707904</c:v>
                </c:pt>
                <c:pt idx="3">
                  <c:v>0.848314606741573</c:v>
                </c:pt>
                <c:pt idx="4">
                  <c:v>0.89325842696629199</c:v>
                </c:pt>
                <c:pt idx="5">
                  <c:v>0.94662921348314599</c:v>
                </c:pt>
                <c:pt idx="6">
                  <c:v>0.96348314606741603</c:v>
                </c:pt>
                <c:pt idx="7">
                  <c:v>0.85393258426966301</c:v>
                </c:pt>
                <c:pt idx="8">
                  <c:v>0.92134831460674205</c:v>
                </c:pt>
                <c:pt idx="9">
                  <c:v>0.95786516853932602</c:v>
                </c:pt>
                <c:pt idx="10">
                  <c:v>0.82584269662921395</c:v>
                </c:pt>
                <c:pt idx="11">
                  <c:v>0.94382022471910099</c:v>
                </c:pt>
                <c:pt idx="12">
                  <c:v>0.94382022471910099</c:v>
                </c:pt>
                <c:pt idx="13">
                  <c:v>0.952247191011236</c:v>
                </c:pt>
                <c:pt idx="14">
                  <c:v>0.96629213483146104</c:v>
                </c:pt>
                <c:pt idx="15">
                  <c:v>0.95786516853932602</c:v>
                </c:pt>
                <c:pt idx="16">
                  <c:v>0.78932584269662898</c:v>
                </c:pt>
                <c:pt idx="17">
                  <c:v>0.93539325842696597</c:v>
                </c:pt>
                <c:pt idx="18">
                  <c:v>0.96067415730337102</c:v>
                </c:pt>
                <c:pt idx="19">
                  <c:v>0.51685393258427004</c:v>
                </c:pt>
                <c:pt idx="20">
                  <c:v>0.96067415730337102</c:v>
                </c:pt>
                <c:pt idx="21">
                  <c:v>0.95505617977528101</c:v>
                </c:pt>
                <c:pt idx="22">
                  <c:v>0.76404494382022503</c:v>
                </c:pt>
                <c:pt idx="23">
                  <c:v>0.96067415730337102</c:v>
                </c:pt>
                <c:pt idx="24">
                  <c:v>0.92696629213483195</c:v>
                </c:pt>
                <c:pt idx="25">
                  <c:v>0.81460674157303403</c:v>
                </c:pt>
                <c:pt idx="26">
                  <c:v>0.96348314606741603</c:v>
                </c:pt>
                <c:pt idx="27">
                  <c:v>0.96348314606741603</c:v>
                </c:pt>
                <c:pt idx="28">
                  <c:v>0.56741573033707904</c:v>
                </c:pt>
                <c:pt idx="29">
                  <c:v>0.67415730337078705</c:v>
                </c:pt>
                <c:pt idx="30">
                  <c:v>0.95786516853932602</c:v>
                </c:pt>
                <c:pt idx="31">
                  <c:v>0.57584269662921395</c:v>
                </c:pt>
                <c:pt idx="32">
                  <c:v>0.96629213483146104</c:v>
                </c:pt>
                <c:pt idx="33">
                  <c:v>0.96629213483146104</c:v>
                </c:pt>
                <c:pt idx="34">
                  <c:v>0.66011235955056202</c:v>
                </c:pt>
                <c:pt idx="35">
                  <c:v>0.94382022471910099</c:v>
                </c:pt>
                <c:pt idx="36">
                  <c:v>0.94101123595505598</c:v>
                </c:pt>
                <c:pt idx="37">
                  <c:v>0.82303370786516905</c:v>
                </c:pt>
                <c:pt idx="38">
                  <c:v>0.84550561797752799</c:v>
                </c:pt>
                <c:pt idx="39">
                  <c:v>0.96629213483146104</c:v>
                </c:pt>
                <c:pt idx="40">
                  <c:v>0.651685393258427</c:v>
                </c:pt>
                <c:pt idx="41">
                  <c:v>0.55898876404494402</c:v>
                </c:pt>
                <c:pt idx="42">
                  <c:v>0.91292134831460703</c:v>
                </c:pt>
                <c:pt idx="43">
                  <c:v>0.67696629213483195</c:v>
                </c:pt>
                <c:pt idx="44">
                  <c:v>0.92977528089887596</c:v>
                </c:pt>
                <c:pt idx="45">
                  <c:v>0.92696629213483195</c:v>
                </c:pt>
                <c:pt idx="46">
                  <c:v>0.92977528089887596</c:v>
                </c:pt>
                <c:pt idx="47">
                  <c:v>0.91853932584269704</c:v>
                </c:pt>
                <c:pt idx="48">
                  <c:v>0.92696629213483195</c:v>
                </c:pt>
                <c:pt idx="49">
                  <c:v>0.598314606741573</c:v>
                </c:pt>
                <c:pt idx="50">
                  <c:v>0.94382022471910099</c:v>
                </c:pt>
                <c:pt idx="51">
                  <c:v>0.95786516853932602</c:v>
                </c:pt>
                <c:pt idx="52">
                  <c:v>0.86235955056179803</c:v>
                </c:pt>
                <c:pt idx="53">
                  <c:v>0.90449438202247201</c:v>
                </c:pt>
                <c:pt idx="54">
                  <c:v>0.96067415730337102</c:v>
                </c:pt>
                <c:pt idx="55">
                  <c:v>0.82584269662921395</c:v>
                </c:pt>
                <c:pt idx="56">
                  <c:v>0.96629213483146104</c:v>
                </c:pt>
                <c:pt idx="57">
                  <c:v>0.96910112359550604</c:v>
                </c:pt>
                <c:pt idx="58">
                  <c:v>0.88202247191011196</c:v>
                </c:pt>
                <c:pt idx="59">
                  <c:v>0.92134831460674205</c:v>
                </c:pt>
                <c:pt idx="60">
                  <c:v>0.91292134831460703</c:v>
                </c:pt>
                <c:pt idx="61">
                  <c:v>0.86797752808988804</c:v>
                </c:pt>
                <c:pt idx="62">
                  <c:v>0.95505617977528101</c:v>
                </c:pt>
                <c:pt idx="63">
                  <c:v>0.949438202247191</c:v>
                </c:pt>
                <c:pt idx="64">
                  <c:v>0.93539325842696597</c:v>
                </c:pt>
                <c:pt idx="65">
                  <c:v>0.72752808988763995</c:v>
                </c:pt>
                <c:pt idx="66">
                  <c:v>0.96910112359550604</c:v>
                </c:pt>
                <c:pt idx="67">
                  <c:v>0.79213483146067398</c:v>
                </c:pt>
                <c:pt idx="68">
                  <c:v>0.651685393258427</c:v>
                </c:pt>
                <c:pt idx="69">
                  <c:v>0.79494382022471899</c:v>
                </c:pt>
                <c:pt idx="70">
                  <c:v>0.88202247191011196</c:v>
                </c:pt>
                <c:pt idx="71">
                  <c:v>0.76966292134831504</c:v>
                </c:pt>
                <c:pt idx="72">
                  <c:v>0.78651685393258397</c:v>
                </c:pt>
                <c:pt idx="73">
                  <c:v>0.75280898876404501</c:v>
                </c:pt>
                <c:pt idx="74">
                  <c:v>0.89044943820224698</c:v>
                </c:pt>
                <c:pt idx="75">
                  <c:v>0.96629213483146104</c:v>
                </c:pt>
                <c:pt idx="76">
                  <c:v>0.848314606741573</c:v>
                </c:pt>
                <c:pt idx="77">
                  <c:v>0.70786516853932602</c:v>
                </c:pt>
                <c:pt idx="78">
                  <c:v>0.91573033707865203</c:v>
                </c:pt>
                <c:pt idx="79">
                  <c:v>0.89044943820224698</c:v>
                </c:pt>
                <c:pt idx="80">
                  <c:v>0.94101123595505598</c:v>
                </c:pt>
                <c:pt idx="81">
                  <c:v>0.94101123595505598</c:v>
                </c:pt>
                <c:pt idx="82">
                  <c:v>0.699438202247191</c:v>
                </c:pt>
                <c:pt idx="83">
                  <c:v>0.97191011235955105</c:v>
                </c:pt>
                <c:pt idx="84">
                  <c:v>0.97191011235955105</c:v>
                </c:pt>
                <c:pt idx="85">
                  <c:v>0.83426966292134797</c:v>
                </c:pt>
                <c:pt idx="86">
                  <c:v>0.86516853932584303</c:v>
                </c:pt>
                <c:pt idx="87">
                  <c:v>0.85955056179775302</c:v>
                </c:pt>
                <c:pt idx="88">
                  <c:v>0.70505617977528101</c:v>
                </c:pt>
                <c:pt idx="89">
                  <c:v>0.85393258426966301</c:v>
                </c:pt>
                <c:pt idx="90">
                  <c:v>0.851123595505618</c:v>
                </c:pt>
                <c:pt idx="91">
                  <c:v>0.80337078651685401</c:v>
                </c:pt>
                <c:pt idx="92">
                  <c:v>0.96348314606741603</c:v>
                </c:pt>
                <c:pt idx="93">
                  <c:v>0.95786516853932602</c:v>
                </c:pt>
                <c:pt idx="94">
                  <c:v>0.92415730337078705</c:v>
                </c:pt>
                <c:pt idx="95">
                  <c:v>0.76966292134831504</c:v>
                </c:pt>
                <c:pt idx="96">
                  <c:v>0.77247191011236005</c:v>
                </c:pt>
                <c:pt idx="97">
                  <c:v>0.96910112359550604</c:v>
                </c:pt>
                <c:pt idx="98">
                  <c:v>0.96629213483146104</c:v>
                </c:pt>
                <c:pt idx="99">
                  <c:v>0.70505617977528101</c:v>
                </c:pt>
                <c:pt idx="100">
                  <c:v>0.83426966292134797</c:v>
                </c:pt>
                <c:pt idx="101">
                  <c:v>0.96348314606741603</c:v>
                </c:pt>
                <c:pt idx="102">
                  <c:v>0.96629213483146104</c:v>
                </c:pt>
                <c:pt idx="103">
                  <c:v>0.76685393258427004</c:v>
                </c:pt>
                <c:pt idx="104">
                  <c:v>0.87921348314606695</c:v>
                </c:pt>
                <c:pt idx="105">
                  <c:v>0.71629213483146104</c:v>
                </c:pt>
                <c:pt idx="106">
                  <c:v>0.91853932584269704</c:v>
                </c:pt>
                <c:pt idx="107">
                  <c:v>0.598314606741573</c:v>
                </c:pt>
                <c:pt idx="108">
                  <c:v>0.96910112359550604</c:v>
                </c:pt>
                <c:pt idx="109">
                  <c:v>0.67696629213483195</c:v>
                </c:pt>
                <c:pt idx="110">
                  <c:v>0.93820224719101097</c:v>
                </c:pt>
                <c:pt idx="111">
                  <c:v>0.92977528089887596</c:v>
                </c:pt>
                <c:pt idx="112">
                  <c:v>0.87640449438202295</c:v>
                </c:pt>
                <c:pt idx="113">
                  <c:v>0.91853932584269704</c:v>
                </c:pt>
                <c:pt idx="114">
                  <c:v>0.88202247191011196</c:v>
                </c:pt>
                <c:pt idx="115">
                  <c:v>0.82022471910112404</c:v>
                </c:pt>
                <c:pt idx="116">
                  <c:v>0.96629213483146104</c:v>
                </c:pt>
                <c:pt idx="117">
                  <c:v>0.96348314606741603</c:v>
                </c:pt>
                <c:pt idx="118">
                  <c:v>0.82584269662921395</c:v>
                </c:pt>
                <c:pt idx="119">
                  <c:v>0.78651685393258397</c:v>
                </c:pt>
                <c:pt idx="120">
                  <c:v>0.93820224719101097</c:v>
                </c:pt>
                <c:pt idx="121">
                  <c:v>0.61797752808988804</c:v>
                </c:pt>
                <c:pt idx="122">
                  <c:v>0.96910112359550604</c:v>
                </c:pt>
                <c:pt idx="123">
                  <c:v>0.96910112359550604</c:v>
                </c:pt>
                <c:pt idx="124">
                  <c:v>0.86516853932584303</c:v>
                </c:pt>
                <c:pt idx="125">
                  <c:v>0.952247191011236</c:v>
                </c:pt>
                <c:pt idx="126">
                  <c:v>0.95505617977528101</c:v>
                </c:pt>
                <c:pt idx="127">
                  <c:v>0.59269662921348298</c:v>
                </c:pt>
                <c:pt idx="128">
                  <c:v>0.64606741573033699</c:v>
                </c:pt>
                <c:pt idx="129">
                  <c:v>0.97191011235955105</c:v>
                </c:pt>
                <c:pt idx="130">
                  <c:v>0.96629213483146104</c:v>
                </c:pt>
                <c:pt idx="131">
                  <c:v>0.96629213483146104</c:v>
                </c:pt>
                <c:pt idx="132">
                  <c:v>0.97191011235955105</c:v>
                </c:pt>
                <c:pt idx="133">
                  <c:v>0.96910112359550604</c:v>
                </c:pt>
                <c:pt idx="134">
                  <c:v>0.63202247191011196</c:v>
                </c:pt>
                <c:pt idx="135">
                  <c:v>0.66011235955056202</c:v>
                </c:pt>
                <c:pt idx="136">
                  <c:v>0.66011235955056202</c:v>
                </c:pt>
                <c:pt idx="137">
                  <c:v>0.96629213483146104</c:v>
                </c:pt>
                <c:pt idx="138">
                  <c:v>0.95786516853932602</c:v>
                </c:pt>
                <c:pt idx="139">
                  <c:v>0.58988764044943798</c:v>
                </c:pt>
                <c:pt idx="140">
                  <c:v>0.97191011235955105</c:v>
                </c:pt>
                <c:pt idx="141">
                  <c:v>0.96910112359550604</c:v>
                </c:pt>
                <c:pt idx="142">
                  <c:v>0.75561797752809001</c:v>
                </c:pt>
                <c:pt idx="143">
                  <c:v>0.86516853932584303</c:v>
                </c:pt>
                <c:pt idx="144">
                  <c:v>0.97191011235955105</c:v>
                </c:pt>
                <c:pt idx="145">
                  <c:v>0.71348314606741603</c:v>
                </c:pt>
                <c:pt idx="146">
                  <c:v>0.97191011235955105</c:v>
                </c:pt>
                <c:pt idx="147">
                  <c:v>0.96629213483146104</c:v>
                </c:pt>
                <c:pt idx="148">
                  <c:v>0.90730337078651702</c:v>
                </c:pt>
                <c:pt idx="149">
                  <c:v>0.901685393258427</c:v>
                </c:pt>
                <c:pt idx="150">
                  <c:v>0.94101123595505598</c:v>
                </c:pt>
                <c:pt idx="151">
                  <c:v>0.68539325842696597</c:v>
                </c:pt>
                <c:pt idx="152">
                  <c:v>0.97191011235955105</c:v>
                </c:pt>
                <c:pt idx="153">
                  <c:v>0.97191011235955105</c:v>
                </c:pt>
                <c:pt idx="154">
                  <c:v>0.64325842696629199</c:v>
                </c:pt>
                <c:pt idx="155">
                  <c:v>0.952247191011236</c:v>
                </c:pt>
                <c:pt idx="156">
                  <c:v>0.97191011235955105</c:v>
                </c:pt>
                <c:pt idx="157">
                  <c:v>0.83426966292134797</c:v>
                </c:pt>
                <c:pt idx="158">
                  <c:v>0.97191011235955105</c:v>
                </c:pt>
                <c:pt idx="159">
                  <c:v>0.96348314606741603</c:v>
                </c:pt>
                <c:pt idx="160">
                  <c:v>0.79494382022471899</c:v>
                </c:pt>
                <c:pt idx="161">
                  <c:v>0.97191011235955105</c:v>
                </c:pt>
                <c:pt idx="162">
                  <c:v>0.96629213483146104</c:v>
                </c:pt>
                <c:pt idx="163">
                  <c:v>0.91011235955056202</c:v>
                </c:pt>
                <c:pt idx="164">
                  <c:v>0.952247191011236</c:v>
                </c:pt>
                <c:pt idx="165">
                  <c:v>0.97191011235955105</c:v>
                </c:pt>
                <c:pt idx="166">
                  <c:v>0.901685393258427</c:v>
                </c:pt>
                <c:pt idx="167">
                  <c:v>0.96910112359550604</c:v>
                </c:pt>
                <c:pt idx="168">
                  <c:v>0.96910112359550604</c:v>
                </c:pt>
                <c:pt idx="169">
                  <c:v>0.51404494382022503</c:v>
                </c:pt>
                <c:pt idx="170">
                  <c:v>0.97191011235955105</c:v>
                </c:pt>
                <c:pt idx="171">
                  <c:v>0.96910112359550604</c:v>
                </c:pt>
                <c:pt idx="172">
                  <c:v>0.72471910112359605</c:v>
                </c:pt>
                <c:pt idx="173">
                  <c:v>0.949438202247191</c:v>
                </c:pt>
                <c:pt idx="174">
                  <c:v>0.56741573033707904</c:v>
                </c:pt>
                <c:pt idx="175">
                  <c:v>0.95786516853932602</c:v>
                </c:pt>
                <c:pt idx="176">
                  <c:v>0.76685393258427004</c:v>
                </c:pt>
                <c:pt idx="177">
                  <c:v>0.96067415730337102</c:v>
                </c:pt>
                <c:pt idx="178">
                  <c:v>0.62640449438202295</c:v>
                </c:pt>
                <c:pt idx="179">
                  <c:v>0.96910112359550604</c:v>
                </c:pt>
                <c:pt idx="180">
                  <c:v>0.95505617977528101</c:v>
                </c:pt>
                <c:pt idx="181">
                  <c:v>0.62359550561797805</c:v>
                </c:pt>
                <c:pt idx="182">
                  <c:v>0.83426966292134797</c:v>
                </c:pt>
                <c:pt idx="183">
                  <c:v>0.89325842696629199</c:v>
                </c:pt>
                <c:pt idx="184">
                  <c:v>0.56460674157303403</c:v>
                </c:pt>
                <c:pt idx="185">
                  <c:v>0.97191011235955105</c:v>
                </c:pt>
                <c:pt idx="186">
                  <c:v>0.96067415730337102</c:v>
                </c:pt>
                <c:pt idx="187">
                  <c:v>0.62640449438202295</c:v>
                </c:pt>
                <c:pt idx="188">
                  <c:v>0.72471910112359605</c:v>
                </c:pt>
                <c:pt idx="189">
                  <c:v>0.952247191011236</c:v>
                </c:pt>
                <c:pt idx="190">
                  <c:v>0.65730337078651702</c:v>
                </c:pt>
                <c:pt idx="191">
                  <c:v>0.62640449438202295</c:v>
                </c:pt>
                <c:pt idx="192">
                  <c:v>0.97191011235955105</c:v>
                </c:pt>
                <c:pt idx="193">
                  <c:v>0.49438202247190999</c:v>
                </c:pt>
                <c:pt idx="194">
                  <c:v>0.95505617977528101</c:v>
                </c:pt>
                <c:pt idx="195">
                  <c:v>0.95505617977528101</c:v>
                </c:pt>
                <c:pt idx="196">
                  <c:v>0.95505617977528101</c:v>
                </c:pt>
                <c:pt idx="197">
                  <c:v>0.96910112359550604</c:v>
                </c:pt>
                <c:pt idx="198">
                  <c:v>0.96910112359550604</c:v>
                </c:pt>
                <c:pt idx="199">
                  <c:v>0.96629213483146104</c:v>
                </c:pt>
                <c:pt idx="200">
                  <c:v>0.97191011235955105</c:v>
                </c:pt>
                <c:pt idx="201">
                  <c:v>0.97191011235955105</c:v>
                </c:pt>
                <c:pt idx="202">
                  <c:v>0.74438202247190999</c:v>
                </c:pt>
                <c:pt idx="203">
                  <c:v>0.88202247191011196</c:v>
                </c:pt>
                <c:pt idx="204">
                  <c:v>0.96348314606741603</c:v>
                </c:pt>
                <c:pt idx="205">
                  <c:v>0.69101123595505598</c:v>
                </c:pt>
                <c:pt idx="206">
                  <c:v>0.70505617977528101</c:v>
                </c:pt>
                <c:pt idx="207">
                  <c:v>0.73033707865168496</c:v>
                </c:pt>
                <c:pt idx="208">
                  <c:v>0.77808988764044895</c:v>
                </c:pt>
                <c:pt idx="209">
                  <c:v>0.95505617977528101</c:v>
                </c:pt>
                <c:pt idx="210">
                  <c:v>0.95505617977528101</c:v>
                </c:pt>
                <c:pt idx="211">
                  <c:v>0.92415730337078705</c:v>
                </c:pt>
                <c:pt idx="212">
                  <c:v>0.949438202247191</c:v>
                </c:pt>
                <c:pt idx="213">
                  <c:v>0.97191011235955105</c:v>
                </c:pt>
                <c:pt idx="214">
                  <c:v>0.952247191011236</c:v>
                </c:pt>
                <c:pt idx="215">
                  <c:v>0.92134831460674205</c:v>
                </c:pt>
                <c:pt idx="216">
                  <c:v>0.54494382022471899</c:v>
                </c:pt>
                <c:pt idx="217">
                  <c:v>0.89044943820224698</c:v>
                </c:pt>
                <c:pt idx="218">
                  <c:v>0.96629213483146104</c:v>
                </c:pt>
                <c:pt idx="219">
                  <c:v>0.96067415730337102</c:v>
                </c:pt>
                <c:pt idx="220">
                  <c:v>0.800561797752809</c:v>
                </c:pt>
                <c:pt idx="221">
                  <c:v>0.86797752808988804</c:v>
                </c:pt>
                <c:pt idx="222">
                  <c:v>0.96629213483146104</c:v>
                </c:pt>
                <c:pt idx="223">
                  <c:v>0.95505617977528101</c:v>
                </c:pt>
                <c:pt idx="224">
                  <c:v>0.89044943820224698</c:v>
                </c:pt>
                <c:pt idx="225">
                  <c:v>0.96910112359550604</c:v>
                </c:pt>
                <c:pt idx="226">
                  <c:v>0.94382022471910099</c:v>
                </c:pt>
                <c:pt idx="227">
                  <c:v>0.952247191011236</c:v>
                </c:pt>
                <c:pt idx="228">
                  <c:v>0.96629213483146104</c:v>
                </c:pt>
                <c:pt idx="229">
                  <c:v>0.95786516853932602</c:v>
                </c:pt>
                <c:pt idx="230">
                  <c:v>0.97191011235955105</c:v>
                </c:pt>
                <c:pt idx="231">
                  <c:v>0.96067415730337102</c:v>
                </c:pt>
                <c:pt idx="232">
                  <c:v>0.97191011235955105</c:v>
                </c:pt>
                <c:pt idx="233">
                  <c:v>0.97191011235955105</c:v>
                </c:pt>
                <c:pt idx="234">
                  <c:v>0.97191011235955105</c:v>
                </c:pt>
                <c:pt idx="235">
                  <c:v>0.94662921348314599</c:v>
                </c:pt>
                <c:pt idx="236">
                  <c:v>0.97191011235955105</c:v>
                </c:pt>
                <c:pt idx="237">
                  <c:v>0.96910112359550604</c:v>
                </c:pt>
                <c:pt idx="238">
                  <c:v>0.75561797752809001</c:v>
                </c:pt>
                <c:pt idx="239">
                  <c:v>0.97191011235955105</c:v>
                </c:pt>
                <c:pt idx="240">
                  <c:v>0.96629213483146104</c:v>
                </c:pt>
                <c:pt idx="241">
                  <c:v>0.93258426966292096</c:v>
                </c:pt>
                <c:pt idx="242">
                  <c:v>0.92134831460674205</c:v>
                </c:pt>
                <c:pt idx="243">
                  <c:v>0.97191011235955105</c:v>
                </c:pt>
                <c:pt idx="244">
                  <c:v>0.949438202247191</c:v>
                </c:pt>
                <c:pt idx="245">
                  <c:v>0.97191011235955105</c:v>
                </c:pt>
                <c:pt idx="246">
                  <c:v>0.97191011235955105</c:v>
                </c:pt>
                <c:pt idx="247">
                  <c:v>0.96629213483146104</c:v>
                </c:pt>
                <c:pt idx="248">
                  <c:v>0.95505617977528101</c:v>
                </c:pt>
                <c:pt idx="249">
                  <c:v>0.50280898876404501</c:v>
                </c:pt>
                <c:pt idx="250">
                  <c:v>0.96067415730337102</c:v>
                </c:pt>
                <c:pt idx="251">
                  <c:v>0.96629213483146104</c:v>
                </c:pt>
                <c:pt idx="252">
                  <c:v>0.96067415730337102</c:v>
                </c:pt>
                <c:pt idx="253">
                  <c:v>0.96629213483146104</c:v>
                </c:pt>
                <c:pt idx="254">
                  <c:v>0.97191011235955105</c:v>
                </c:pt>
                <c:pt idx="255">
                  <c:v>0.96910112359550604</c:v>
                </c:pt>
                <c:pt idx="256">
                  <c:v>0.53370786516853896</c:v>
                </c:pt>
                <c:pt idx="257">
                  <c:v>0.72191011235955105</c:v>
                </c:pt>
                <c:pt idx="258">
                  <c:v>0.72752808988763995</c:v>
                </c:pt>
                <c:pt idx="259">
                  <c:v>0.84269662921348298</c:v>
                </c:pt>
                <c:pt idx="260">
                  <c:v>0.75</c:v>
                </c:pt>
                <c:pt idx="261">
                  <c:v>0.76123595505618002</c:v>
                </c:pt>
                <c:pt idx="262">
                  <c:v>0.76123595505618002</c:v>
                </c:pt>
                <c:pt idx="263">
                  <c:v>0.71348314606741603</c:v>
                </c:pt>
                <c:pt idx="264">
                  <c:v>0.901685393258427</c:v>
                </c:pt>
                <c:pt idx="265">
                  <c:v>0.70786516853932602</c:v>
                </c:pt>
                <c:pt idx="266">
                  <c:v>0.97191011235955105</c:v>
                </c:pt>
                <c:pt idx="267">
                  <c:v>0.96629213483146104</c:v>
                </c:pt>
                <c:pt idx="268">
                  <c:v>0.76685393258427004</c:v>
                </c:pt>
                <c:pt idx="269">
                  <c:v>0.97191011235955105</c:v>
                </c:pt>
                <c:pt idx="270">
                  <c:v>0.96910112359550604</c:v>
                </c:pt>
                <c:pt idx="271">
                  <c:v>0.87078651685393305</c:v>
                </c:pt>
                <c:pt idx="272">
                  <c:v>0.96629213483146104</c:v>
                </c:pt>
                <c:pt idx="273">
                  <c:v>0.96629213483146104</c:v>
                </c:pt>
                <c:pt idx="274">
                  <c:v>0.75280898876404501</c:v>
                </c:pt>
                <c:pt idx="275">
                  <c:v>0.66011235955056202</c:v>
                </c:pt>
                <c:pt idx="276">
                  <c:v>0.97191011235955105</c:v>
                </c:pt>
                <c:pt idx="277">
                  <c:v>0.78370786516853896</c:v>
                </c:pt>
                <c:pt idx="278">
                  <c:v>0.97191011235955105</c:v>
                </c:pt>
                <c:pt idx="279">
                  <c:v>0.97191011235955105</c:v>
                </c:pt>
                <c:pt idx="280">
                  <c:v>0.81179775280898903</c:v>
                </c:pt>
                <c:pt idx="281">
                  <c:v>0.56741573033707904</c:v>
                </c:pt>
                <c:pt idx="282">
                  <c:v>0.97191011235955105</c:v>
                </c:pt>
                <c:pt idx="283">
                  <c:v>0.77808988764044895</c:v>
                </c:pt>
                <c:pt idx="284">
                  <c:v>0.96348314606741603</c:v>
                </c:pt>
                <c:pt idx="285">
                  <c:v>0.96629213483146104</c:v>
                </c:pt>
                <c:pt idx="286">
                  <c:v>0.61235955056179803</c:v>
                </c:pt>
                <c:pt idx="287">
                  <c:v>0.96629213483146104</c:v>
                </c:pt>
                <c:pt idx="288">
                  <c:v>0.96910112359550604</c:v>
                </c:pt>
                <c:pt idx="289">
                  <c:v>0.72471910112359605</c:v>
                </c:pt>
                <c:pt idx="290">
                  <c:v>0.96629213483146104</c:v>
                </c:pt>
                <c:pt idx="291">
                  <c:v>0.96348314606741603</c:v>
                </c:pt>
                <c:pt idx="292">
                  <c:v>0.92696629213483195</c:v>
                </c:pt>
                <c:pt idx="293">
                  <c:v>0.96629213483146104</c:v>
                </c:pt>
                <c:pt idx="294">
                  <c:v>0.97191011235955105</c:v>
                </c:pt>
                <c:pt idx="295">
                  <c:v>0.952247191011236</c:v>
                </c:pt>
                <c:pt idx="296">
                  <c:v>0.95505617977528101</c:v>
                </c:pt>
                <c:pt idx="297">
                  <c:v>0.96910112359550604</c:v>
                </c:pt>
                <c:pt idx="298">
                  <c:v>0.85955056179775302</c:v>
                </c:pt>
                <c:pt idx="299">
                  <c:v>0.52247191011236005</c:v>
                </c:pt>
                <c:pt idx="300">
                  <c:v>0.76404494382022503</c:v>
                </c:pt>
                <c:pt idx="301">
                  <c:v>0.73033707865168496</c:v>
                </c:pt>
                <c:pt idx="302">
                  <c:v>0.61516853932584303</c:v>
                </c:pt>
                <c:pt idx="303">
                  <c:v>0.96910112359550604</c:v>
                </c:pt>
                <c:pt idx="304">
                  <c:v>0.797752808988764</c:v>
                </c:pt>
                <c:pt idx="305">
                  <c:v>0.96629213483146104</c:v>
                </c:pt>
                <c:pt idx="306">
                  <c:v>0.96910112359550604</c:v>
                </c:pt>
                <c:pt idx="307">
                  <c:v>0.75842696629213502</c:v>
                </c:pt>
                <c:pt idx="308">
                  <c:v>0.75280898876404501</c:v>
                </c:pt>
                <c:pt idx="309">
                  <c:v>0.50842696629213502</c:v>
                </c:pt>
                <c:pt idx="310">
                  <c:v>0.72191011235955105</c:v>
                </c:pt>
                <c:pt idx="311">
                  <c:v>0.96348314606741603</c:v>
                </c:pt>
                <c:pt idx="312">
                  <c:v>0.96910112359550604</c:v>
                </c:pt>
                <c:pt idx="313">
                  <c:v>0.81741573033707904</c:v>
                </c:pt>
                <c:pt idx="314">
                  <c:v>0.80898876404494402</c:v>
                </c:pt>
                <c:pt idx="315">
                  <c:v>0.72752808988763995</c:v>
                </c:pt>
                <c:pt idx="316">
                  <c:v>0.77247191011236005</c:v>
                </c:pt>
                <c:pt idx="317">
                  <c:v>0.96910112359550604</c:v>
                </c:pt>
                <c:pt idx="318">
                  <c:v>0.96067415730337102</c:v>
                </c:pt>
                <c:pt idx="319">
                  <c:v>0.800561797752809</c:v>
                </c:pt>
                <c:pt idx="320">
                  <c:v>0.96348314606741603</c:v>
                </c:pt>
                <c:pt idx="321">
                  <c:v>0.96629213483146104</c:v>
                </c:pt>
                <c:pt idx="322">
                  <c:v>0.53370786516853896</c:v>
                </c:pt>
                <c:pt idx="323">
                  <c:v>0.89325842696629199</c:v>
                </c:pt>
                <c:pt idx="324">
                  <c:v>0.96910112359550604</c:v>
                </c:pt>
                <c:pt idx="325">
                  <c:v>0.92977528089887596</c:v>
                </c:pt>
                <c:pt idx="326">
                  <c:v>0.95786516853932602</c:v>
                </c:pt>
                <c:pt idx="327">
                  <c:v>0.96629213483146104</c:v>
                </c:pt>
                <c:pt idx="328">
                  <c:v>0.84269662921348298</c:v>
                </c:pt>
                <c:pt idx="329">
                  <c:v>0.848314606741573</c:v>
                </c:pt>
                <c:pt idx="330">
                  <c:v>0.95786516853932602</c:v>
                </c:pt>
                <c:pt idx="331">
                  <c:v>0.5</c:v>
                </c:pt>
                <c:pt idx="332">
                  <c:v>0.82584269662921395</c:v>
                </c:pt>
                <c:pt idx="333">
                  <c:v>0.96348314606741603</c:v>
                </c:pt>
                <c:pt idx="334">
                  <c:v>0.92134831460674205</c:v>
                </c:pt>
                <c:pt idx="335">
                  <c:v>0.96067415730337102</c:v>
                </c:pt>
                <c:pt idx="336">
                  <c:v>0.96348314606741603</c:v>
                </c:pt>
                <c:pt idx="337">
                  <c:v>0.59550561797752799</c:v>
                </c:pt>
                <c:pt idx="338">
                  <c:v>0.89044943820224698</c:v>
                </c:pt>
                <c:pt idx="339">
                  <c:v>0.952247191011236</c:v>
                </c:pt>
                <c:pt idx="340">
                  <c:v>0.78089887640449396</c:v>
                </c:pt>
                <c:pt idx="341">
                  <c:v>0.87921348314606695</c:v>
                </c:pt>
                <c:pt idx="342">
                  <c:v>0.96348314606741603</c:v>
                </c:pt>
                <c:pt idx="343">
                  <c:v>0.83146067415730296</c:v>
                </c:pt>
                <c:pt idx="344">
                  <c:v>0.96348314606741603</c:v>
                </c:pt>
                <c:pt idx="345">
                  <c:v>0.95786516853932602</c:v>
                </c:pt>
                <c:pt idx="346">
                  <c:v>0.78932584269662898</c:v>
                </c:pt>
                <c:pt idx="347">
                  <c:v>0.96067415730337102</c:v>
                </c:pt>
                <c:pt idx="348">
                  <c:v>0.96348314606741603</c:v>
                </c:pt>
                <c:pt idx="349">
                  <c:v>0.81741573033707904</c:v>
                </c:pt>
                <c:pt idx="350">
                  <c:v>0.74719101123595499</c:v>
                </c:pt>
                <c:pt idx="351">
                  <c:v>0.73314606741572996</c:v>
                </c:pt>
                <c:pt idx="352">
                  <c:v>0.53932584269662898</c:v>
                </c:pt>
                <c:pt idx="353">
                  <c:v>0.94662921348314599</c:v>
                </c:pt>
                <c:pt idx="354">
                  <c:v>0.949438202247191</c:v>
                </c:pt>
                <c:pt idx="355">
                  <c:v>0.851123595505618</c:v>
                </c:pt>
                <c:pt idx="356">
                  <c:v>0.90730337078651702</c:v>
                </c:pt>
                <c:pt idx="357">
                  <c:v>0.949438202247191</c:v>
                </c:pt>
                <c:pt idx="358">
                  <c:v>0.75280898876404501</c:v>
                </c:pt>
                <c:pt idx="359">
                  <c:v>0.93539325842696597</c:v>
                </c:pt>
                <c:pt idx="360">
                  <c:v>0.94382022471910099</c:v>
                </c:pt>
                <c:pt idx="361">
                  <c:v>0.88483146067415697</c:v>
                </c:pt>
                <c:pt idx="362">
                  <c:v>0.949438202247191</c:v>
                </c:pt>
                <c:pt idx="363">
                  <c:v>0.949438202247191</c:v>
                </c:pt>
                <c:pt idx="364">
                  <c:v>0.78089887640449396</c:v>
                </c:pt>
                <c:pt idx="365">
                  <c:v>0.94382022471910099</c:v>
                </c:pt>
                <c:pt idx="366">
                  <c:v>0.92696629213483195</c:v>
                </c:pt>
                <c:pt idx="367">
                  <c:v>0.91292134831460703</c:v>
                </c:pt>
                <c:pt idx="368">
                  <c:v>0.92134831460674205</c:v>
                </c:pt>
                <c:pt idx="369">
                  <c:v>0.92696629213483195</c:v>
                </c:pt>
                <c:pt idx="370">
                  <c:v>0.76123595505618002</c:v>
                </c:pt>
                <c:pt idx="371">
                  <c:v>0.92977528089887596</c:v>
                </c:pt>
                <c:pt idx="372">
                  <c:v>0.92977528089887596</c:v>
                </c:pt>
                <c:pt idx="373">
                  <c:v>0.72471910112359605</c:v>
                </c:pt>
                <c:pt idx="374">
                  <c:v>0.92977528089887596</c:v>
                </c:pt>
                <c:pt idx="375">
                  <c:v>0.92977528089887596</c:v>
                </c:pt>
                <c:pt idx="376">
                  <c:v>0.87921348314606695</c:v>
                </c:pt>
                <c:pt idx="377">
                  <c:v>0.80898876404494402</c:v>
                </c:pt>
                <c:pt idx="378">
                  <c:v>0.83988764044943798</c:v>
                </c:pt>
                <c:pt idx="379">
                  <c:v>0.62359550561797805</c:v>
                </c:pt>
                <c:pt idx="380">
                  <c:v>0.92977528089887596</c:v>
                </c:pt>
                <c:pt idx="381">
                  <c:v>0.92977528089887596</c:v>
                </c:pt>
                <c:pt idx="382">
                  <c:v>0.83146067415730296</c:v>
                </c:pt>
                <c:pt idx="383">
                  <c:v>0.63483146067415697</c:v>
                </c:pt>
                <c:pt idx="384">
                  <c:v>0.91853932584269704</c:v>
                </c:pt>
                <c:pt idx="385">
                  <c:v>0.72752808988763995</c:v>
                </c:pt>
                <c:pt idx="386">
                  <c:v>0.92134831460674205</c:v>
                </c:pt>
                <c:pt idx="387">
                  <c:v>0.92134831460674205</c:v>
                </c:pt>
                <c:pt idx="388">
                  <c:v>0.66573033707865203</c:v>
                </c:pt>
                <c:pt idx="389">
                  <c:v>0.78089887640449396</c:v>
                </c:pt>
                <c:pt idx="390">
                  <c:v>0.848314606741573</c:v>
                </c:pt>
                <c:pt idx="391">
                  <c:v>0.83988764044943798</c:v>
                </c:pt>
                <c:pt idx="392">
                  <c:v>0.84269662921348298</c:v>
                </c:pt>
                <c:pt idx="393">
                  <c:v>0.82584269662921395</c:v>
                </c:pt>
                <c:pt idx="394">
                  <c:v>0.59550561797752799</c:v>
                </c:pt>
                <c:pt idx="395">
                  <c:v>0.60393258426966301</c:v>
                </c:pt>
                <c:pt idx="396">
                  <c:v>0.51966292134831504</c:v>
                </c:pt>
                <c:pt idx="397">
                  <c:v>0.57865168539325795</c:v>
                </c:pt>
                <c:pt idx="398">
                  <c:v>0.82022471910112404</c:v>
                </c:pt>
                <c:pt idx="399">
                  <c:v>0.81460674157303403</c:v>
                </c:pt>
                <c:pt idx="400">
                  <c:v>0.73033707865168496</c:v>
                </c:pt>
                <c:pt idx="401">
                  <c:v>0.601123595505618</c:v>
                </c:pt>
                <c:pt idx="402">
                  <c:v>0.81460674157303403</c:v>
                </c:pt>
                <c:pt idx="403">
                  <c:v>0.50842696629213502</c:v>
                </c:pt>
                <c:pt idx="404">
                  <c:v>0.61516853932584303</c:v>
                </c:pt>
                <c:pt idx="405">
                  <c:v>0.66853932584269704</c:v>
                </c:pt>
                <c:pt idx="406">
                  <c:v>0.82022471910112404</c:v>
                </c:pt>
                <c:pt idx="407">
                  <c:v>0.81460674157303403</c:v>
                </c:pt>
                <c:pt idx="408">
                  <c:v>0.73033707865168496</c:v>
                </c:pt>
                <c:pt idx="409">
                  <c:v>0.72471910112359605</c:v>
                </c:pt>
                <c:pt idx="410">
                  <c:v>0.73033707865168496</c:v>
                </c:pt>
                <c:pt idx="411">
                  <c:v>0.73314606741572996</c:v>
                </c:pt>
                <c:pt idx="412">
                  <c:v>0.72752808988763995</c:v>
                </c:pt>
                <c:pt idx="413">
                  <c:v>0.73314606741572996</c:v>
                </c:pt>
                <c:pt idx="414">
                  <c:v>0.69101123595505598</c:v>
                </c:pt>
                <c:pt idx="415">
                  <c:v>0.72471910112359605</c:v>
                </c:pt>
                <c:pt idx="416">
                  <c:v>0.72752808988763995</c:v>
                </c:pt>
                <c:pt idx="417">
                  <c:v>0.73314606741572996</c:v>
                </c:pt>
                <c:pt idx="418">
                  <c:v>0.73314606741572996</c:v>
                </c:pt>
                <c:pt idx="419">
                  <c:v>0.539325842696628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AD6-4B72-9628-4938B9A2C0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58413836"/>
        <c:axId val="106945087"/>
      </c:lineChart>
      <c:catAx>
        <c:axId val="35841383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06945087"/>
        <c:crosses val="autoZero"/>
        <c:auto val="1"/>
        <c:lblAlgn val="ctr"/>
        <c:lblOffset val="100"/>
        <c:noMultiLvlLbl val="0"/>
      </c:catAx>
      <c:valAx>
        <c:axId val="10694508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3584138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3A0524-238E-4927-85CB-8DB844F92B47}" type="datetimeFigureOut">
              <a:rPr lang="zh-CN" altLang="en-US" smtClean="0"/>
              <a:t>2023/5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60BC2B-90B4-48D4-AA1C-E022EF2E29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13324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 S1 identification of conserved target sites in TYLCLV encoded genes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60BC2B-90B4-48D4-AA1C-E022EF2E2956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40495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 S2 Mechanism for restoration of restriction sites in vector after ligation between vector and insert. The 5’ </a:t>
            </a:r>
            <a:r>
              <a:rPr lang="en-US" altLang="zh-CN" dirty="0" err="1"/>
              <a:t>SpeI</a:t>
            </a:r>
            <a:r>
              <a:rPr lang="en-US" altLang="zh-CN" dirty="0"/>
              <a:t>-generated sticky end of insert is ligated with the compatible </a:t>
            </a:r>
            <a:r>
              <a:rPr lang="en-US" altLang="zh-CN" dirty="0" err="1"/>
              <a:t>XbaI</a:t>
            </a:r>
            <a:r>
              <a:rPr lang="en-US" altLang="zh-CN" dirty="0"/>
              <a:t>-generated </a:t>
            </a:r>
            <a:r>
              <a:rPr lang="en-US" altLang="zh-CN" dirty="0" err="1"/>
              <a:t>stiky</a:t>
            </a:r>
            <a:r>
              <a:rPr lang="en-US" altLang="zh-CN" dirty="0"/>
              <a:t> 3’ end of vector and after ligation both sites were destroyed (bottom left, marked by red cross).  The </a:t>
            </a:r>
            <a:r>
              <a:rPr lang="en-US" altLang="zh-CN" dirty="0" err="1"/>
              <a:t>XbaI</a:t>
            </a:r>
            <a:r>
              <a:rPr lang="en-US" altLang="zh-CN" dirty="0"/>
              <a:t> and </a:t>
            </a:r>
            <a:r>
              <a:rPr lang="en-US" altLang="zh-CN" dirty="0" err="1"/>
              <a:t>XhoI</a:t>
            </a:r>
            <a:r>
              <a:rPr lang="en-US" altLang="zh-CN" dirty="0"/>
              <a:t> sites from insert were moved to the vector after ligation (bottom right)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793134-F9C5-42FD-BAC7-C8DD2E2BA47C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40036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 S3 Validation of amiRNA expression. (A) Mechanism for testing miRNA function using GFP sensor. (B)</a:t>
            </a:r>
            <a:r>
              <a:rPr lang="zh-CN" altLang="en-US" dirty="0"/>
              <a:t> </a:t>
            </a:r>
            <a:r>
              <a:rPr lang="en-US" altLang="zh-CN" dirty="0"/>
              <a:t>Transient expression of pMS4 miRNA sensor and dual amiRNA cluster. In the left column, pMS4 sensor is co-expressed with empty vector (white solid circle) and </a:t>
            </a:r>
            <a:r>
              <a:rPr lang="en-US" altLang="zh-CN" dirty="0" err="1"/>
              <a:t>pAMIN</a:t>
            </a:r>
            <a:r>
              <a:rPr lang="en-US" altLang="zh-CN" dirty="0"/>
              <a:t> vectors (white dashed circle) as indicated to the left. In the right column, pMS4 sensor is co-expressed with empty vector (white solid circle) and </a:t>
            </a:r>
            <a:r>
              <a:rPr lang="en-US" altLang="zh-CN" dirty="0" err="1"/>
              <a:t>pAMIE</a:t>
            </a:r>
            <a:r>
              <a:rPr lang="en-US" altLang="zh-CN" dirty="0"/>
              <a:t> vectors (white dashed circle) as indicated to the left. (C) Expression of non-targeted pMS4 vector (solid white circle) and pMS4 sensor (dashed white circle) targeted by cognate amiRNA in transgenic tobacco plants. Left column showed transgenic plants transformed with </a:t>
            </a:r>
            <a:r>
              <a:rPr lang="en-US" altLang="zh-CN" dirty="0" err="1"/>
              <a:t>pAMIN</a:t>
            </a:r>
            <a:r>
              <a:rPr lang="en-US" altLang="zh-CN" dirty="0"/>
              <a:t> vectors encoding dual amiRNA targeting viral genes indicated to the left. Right column showed transgenic plants transformed with </a:t>
            </a:r>
            <a:r>
              <a:rPr lang="en-US" altLang="zh-CN" dirty="0" err="1"/>
              <a:t>pAMIE</a:t>
            </a:r>
            <a:r>
              <a:rPr lang="en-US" altLang="zh-CN" dirty="0"/>
              <a:t> vectors encoding dual amiRNAs targeting viral genes indicated to the left. (D) Expression of non-targeted (#1 and #5) and targeted pMS4 sensors (#2,3,4) in transgenic tobacco transformed with pAMIN6 (left) and pAMIE6 (right) vectors. (E) ) Expression of non-targeted (#1 and #6) and targeted pMS4 sensors (#2,3,4,5) in transgenic tobacco transformed with pAMIN8 (left) and pAMIE8 (right) vectors. 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F793A6-8E6D-4126-B5B7-A4CA03E5B9AD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165310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 S4 Detection of TYLCLV DNA in systemic leaves of infected transgenic and wild type plants. 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68FBA2F-E866-49BD-94EF-AB6B3FA5ADB6}" type="slidenum">
              <a:rPr lang="en-US" smtClean="0"/>
              <a:t>9</a:t>
            </a:fld>
            <a:endParaRPr 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/>
              <a:t>Figure S5 </a:t>
            </a:r>
            <a:r>
              <a:rPr lang="zh-CN" altLang="en-US" dirty="0"/>
              <a:t>（</a:t>
            </a:r>
            <a:r>
              <a:rPr lang="en-US" altLang="zh-CN" dirty="0"/>
              <a:t>A</a:t>
            </a:r>
            <a:r>
              <a:rPr lang="zh-CN" altLang="en-US" dirty="0"/>
              <a:t>）</a:t>
            </a:r>
            <a:r>
              <a:rPr lang="en-US" altLang="zh-CN" dirty="0"/>
              <a:t>Plant picture of different disease level. (B) Progression of infection in tomato infected by agrobacterium-mediated infiltration. X ax shows days after inoculation. Y ax shows the rate of infected plants showing visible phenotype. Yellow line, A57; green line, TY1; light blue, AE-6; dark blue AN-12. (C) Disease index standard for classification of resistance level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A9DC35-4E8C-4554-A15F-350F61CEB53E}" type="slidenum">
              <a:rPr lang="zh-CN" altLang="en-US" smtClean="0"/>
              <a:t>1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99213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 b="1" i="0" spc="30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 eaLnBrk="1" fontAlgn="auto" latinLnBrk="0" hangingPunct="1">
              <a:lnSpc>
                <a:spcPct val="110000"/>
              </a:lnSpc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28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>
            <a:lvl1pPr marL="228600" indent="-228600" eaLnBrk="1" fontAlgn="auto" latinLnBrk="0" hangingPunct="1">
              <a:lnSpc>
                <a:spcPct val="13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60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●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  <a:lvl6pPr marL="2286000" indent="0">
              <a:buNone/>
              <a:defRPr/>
            </a:lvl6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 b="1" i="0" u="none" strike="noStrike" kern="1200" cap="none" spc="300" normalizeH="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 eaLnBrk="1" fontAlgn="auto" latinLnBrk="0" hangingPunct="1">
              <a:lnSpc>
                <a:spcPct val="130000"/>
              </a:lnSpc>
              <a:buNone/>
              <a:defRPr kumimoji="0" lang="zh-CN" altLang="en-US" sz="1800" b="0" i="0" u="none" strike="noStrike" kern="1200" cap="none" spc="150" normalizeH="0" baseline="0" noProof="1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sz="14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lnSpc>
                <a:spcPct val="120000"/>
              </a:lnSpc>
              <a:defRPr sz="1400"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 defTabSz="914400" eaLnBrk="1" fontAlgn="auto" latinLnBrk="0" hangingPunct="1">
              <a:buFont typeface="Arial" panose="020B060402020202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eaLnBrk="1" fontAlgn="auto" latinLnBrk="0" hangingPunct="1">
              <a:buFont typeface="Arial" panose="020B0604020202020204" pitchFamily="34" charset="0"/>
              <a:buChar char="●"/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3/5/28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>
            <a:lvl1pPr>
              <a:defRPr baseline="0"/>
            </a:lvl1pPr>
          </a:lstStyle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8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spcAft>
                <a:spcPts val="300"/>
              </a:spcAft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spcAft>
                <a:spcPts val="300"/>
              </a:spcAft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  <a:t>2023/5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63.xml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jpeg"/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56.jpeg"/><Relationship Id="rId2" Type="http://schemas.openxmlformats.org/officeDocument/2006/relationships/tags" Target="../tags/tag70.xml"/><Relationship Id="rId1" Type="http://schemas.openxmlformats.org/officeDocument/2006/relationships/tags" Target="../tags/tag69.xml"/><Relationship Id="rId6" Type="http://schemas.openxmlformats.org/officeDocument/2006/relationships/image" Target="../media/image55.jpeg"/><Relationship Id="rId11" Type="http://schemas.openxmlformats.org/officeDocument/2006/relationships/image" Target="../media/image60.jpeg"/><Relationship Id="rId5" Type="http://schemas.openxmlformats.org/officeDocument/2006/relationships/image" Target="../media/image54.png"/><Relationship Id="rId10" Type="http://schemas.openxmlformats.org/officeDocument/2006/relationships/image" Target="../media/image59.png"/><Relationship Id="rId4" Type="http://schemas.openxmlformats.org/officeDocument/2006/relationships/notesSlide" Target="../notesSlides/notesSlide5.xml"/><Relationship Id="rId9" Type="http://schemas.openxmlformats.org/officeDocument/2006/relationships/image" Target="../media/image58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64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65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66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6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68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chart" Target="../charts/char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3" Type="http://schemas.microsoft.com/office/2007/relationships/hdphoto" Target="../media/hdphoto4.wdp"/><Relationship Id="rId18" Type="http://schemas.openxmlformats.org/officeDocument/2006/relationships/image" Target="../media/image22.png"/><Relationship Id="rId26" Type="http://schemas.openxmlformats.org/officeDocument/2006/relationships/image" Target="../media/image26.png"/><Relationship Id="rId39" Type="http://schemas.openxmlformats.org/officeDocument/2006/relationships/image" Target="../media/image34.png"/><Relationship Id="rId21" Type="http://schemas.microsoft.com/office/2007/relationships/hdphoto" Target="../media/hdphoto8.wdp"/><Relationship Id="rId34" Type="http://schemas.openxmlformats.org/officeDocument/2006/relationships/image" Target="../media/image30.jpeg"/><Relationship Id="rId42" Type="http://schemas.microsoft.com/office/2007/relationships/hdphoto" Target="../media/hdphoto17.wdp"/><Relationship Id="rId47" Type="http://schemas.microsoft.com/office/2007/relationships/hdphoto" Target="../media/hdphoto18.wdp"/><Relationship Id="rId50" Type="http://schemas.openxmlformats.org/officeDocument/2006/relationships/image" Target="../media/image41.jpeg"/><Relationship Id="rId55" Type="http://schemas.openxmlformats.org/officeDocument/2006/relationships/image" Target="../media/image44.jpeg"/><Relationship Id="rId7" Type="http://schemas.microsoft.com/office/2007/relationships/hdphoto" Target="../media/hdphoto1.wdp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21.png"/><Relationship Id="rId29" Type="http://schemas.microsoft.com/office/2007/relationships/hdphoto" Target="../media/hdphoto12.wdp"/><Relationship Id="rId11" Type="http://schemas.microsoft.com/office/2007/relationships/hdphoto" Target="../media/hdphoto3.wdp"/><Relationship Id="rId24" Type="http://schemas.openxmlformats.org/officeDocument/2006/relationships/image" Target="../media/image25.png"/><Relationship Id="rId32" Type="http://schemas.openxmlformats.org/officeDocument/2006/relationships/image" Target="../media/image29.png"/><Relationship Id="rId37" Type="http://schemas.openxmlformats.org/officeDocument/2006/relationships/image" Target="../media/image33.png"/><Relationship Id="rId40" Type="http://schemas.microsoft.com/office/2007/relationships/hdphoto" Target="../media/hdphoto16.wdp"/><Relationship Id="rId45" Type="http://schemas.openxmlformats.org/officeDocument/2006/relationships/image" Target="../media/image38.jpeg"/><Relationship Id="rId53" Type="http://schemas.openxmlformats.org/officeDocument/2006/relationships/image" Target="../media/image43.png"/><Relationship Id="rId5" Type="http://schemas.openxmlformats.org/officeDocument/2006/relationships/image" Target="../media/image15.jpeg"/><Relationship Id="rId10" Type="http://schemas.openxmlformats.org/officeDocument/2006/relationships/image" Target="../media/image18.png"/><Relationship Id="rId19" Type="http://schemas.microsoft.com/office/2007/relationships/hdphoto" Target="../media/hdphoto7.wdp"/><Relationship Id="rId31" Type="http://schemas.microsoft.com/office/2007/relationships/hdphoto" Target="../media/hdphoto13.wdp"/><Relationship Id="rId44" Type="http://schemas.openxmlformats.org/officeDocument/2006/relationships/image" Target="../media/image37.jpeg"/><Relationship Id="rId52" Type="http://schemas.microsoft.com/office/2007/relationships/hdphoto" Target="../media/hdphoto20.wdp"/><Relationship Id="rId4" Type="http://schemas.openxmlformats.org/officeDocument/2006/relationships/image" Target="../media/image14.jpeg"/><Relationship Id="rId9" Type="http://schemas.microsoft.com/office/2007/relationships/hdphoto" Target="../media/hdphoto2.wdp"/><Relationship Id="rId14" Type="http://schemas.openxmlformats.org/officeDocument/2006/relationships/image" Target="../media/image20.png"/><Relationship Id="rId22" Type="http://schemas.openxmlformats.org/officeDocument/2006/relationships/image" Target="../media/image24.png"/><Relationship Id="rId27" Type="http://schemas.microsoft.com/office/2007/relationships/hdphoto" Target="../media/hdphoto11.wdp"/><Relationship Id="rId30" Type="http://schemas.openxmlformats.org/officeDocument/2006/relationships/image" Target="../media/image28.png"/><Relationship Id="rId35" Type="http://schemas.openxmlformats.org/officeDocument/2006/relationships/image" Target="../media/image31.jpeg"/><Relationship Id="rId43" Type="http://schemas.openxmlformats.org/officeDocument/2006/relationships/image" Target="../media/image36.jpeg"/><Relationship Id="rId48" Type="http://schemas.openxmlformats.org/officeDocument/2006/relationships/image" Target="../media/image40.png"/><Relationship Id="rId8" Type="http://schemas.openxmlformats.org/officeDocument/2006/relationships/image" Target="../media/image17.png"/><Relationship Id="rId51" Type="http://schemas.openxmlformats.org/officeDocument/2006/relationships/image" Target="../media/image42.png"/><Relationship Id="rId3" Type="http://schemas.openxmlformats.org/officeDocument/2006/relationships/image" Target="../media/image13.jpeg"/><Relationship Id="rId12" Type="http://schemas.openxmlformats.org/officeDocument/2006/relationships/image" Target="../media/image19.png"/><Relationship Id="rId17" Type="http://schemas.microsoft.com/office/2007/relationships/hdphoto" Target="../media/hdphoto6.wdp"/><Relationship Id="rId25" Type="http://schemas.microsoft.com/office/2007/relationships/hdphoto" Target="../media/hdphoto10.wdp"/><Relationship Id="rId33" Type="http://schemas.microsoft.com/office/2007/relationships/hdphoto" Target="../media/hdphoto14.wdp"/><Relationship Id="rId38" Type="http://schemas.microsoft.com/office/2007/relationships/hdphoto" Target="../media/hdphoto15.wdp"/><Relationship Id="rId46" Type="http://schemas.openxmlformats.org/officeDocument/2006/relationships/image" Target="../media/image39.png"/><Relationship Id="rId20" Type="http://schemas.openxmlformats.org/officeDocument/2006/relationships/image" Target="../media/image23.png"/><Relationship Id="rId41" Type="http://schemas.openxmlformats.org/officeDocument/2006/relationships/image" Target="../media/image35.png"/><Relationship Id="rId54" Type="http://schemas.microsoft.com/office/2007/relationships/hdphoto" Target="../media/hdphoto21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5" Type="http://schemas.microsoft.com/office/2007/relationships/hdphoto" Target="../media/hdphoto5.wdp"/><Relationship Id="rId23" Type="http://schemas.microsoft.com/office/2007/relationships/hdphoto" Target="../media/hdphoto9.wdp"/><Relationship Id="rId28" Type="http://schemas.openxmlformats.org/officeDocument/2006/relationships/image" Target="../media/image27.png"/><Relationship Id="rId36" Type="http://schemas.openxmlformats.org/officeDocument/2006/relationships/image" Target="../media/image32.jpeg"/><Relationship Id="rId49" Type="http://schemas.microsoft.com/office/2007/relationships/hdphoto" Target="../media/hdphoto19.wdp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w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53.png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49.wmf"/><Relationship Id="rId17" Type="http://schemas.openxmlformats.org/officeDocument/2006/relationships/image" Target="../media/image52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51.w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8.wmf"/><Relationship Id="rId4" Type="http://schemas.openxmlformats.org/officeDocument/2006/relationships/image" Target="../media/image45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50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组合 15">
            <a:extLst>
              <a:ext uri="{FF2B5EF4-FFF2-40B4-BE49-F238E27FC236}">
                <a16:creationId xmlns:a16="http://schemas.microsoft.com/office/drawing/2014/main" id="{E614F979-907C-4783-9E2B-16EB587333B1}"/>
              </a:ext>
            </a:extLst>
          </p:cNvPr>
          <p:cNvGrpSpPr/>
          <p:nvPr/>
        </p:nvGrpSpPr>
        <p:grpSpPr>
          <a:xfrm>
            <a:off x="1191703" y="1168691"/>
            <a:ext cx="9808593" cy="2160468"/>
            <a:chOff x="321760" y="450421"/>
            <a:chExt cx="11689715" cy="2743200"/>
          </a:xfrm>
        </p:grpSpPr>
        <p:graphicFrame>
          <p:nvGraphicFramePr>
            <p:cNvPr id="2" name="图表 1"/>
            <p:cNvGraphicFramePr/>
            <p:nvPr>
              <p:extLst>
                <p:ext uri="{D42A27DB-BD31-4B8C-83A1-F6EECF244321}">
                  <p14:modId xmlns:p14="http://schemas.microsoft.com/office/powerpoint/2010/main" val="400342466"/>
                </p:ext>
              </p:extLst>
            </p:nvPr>
          </p:nvGraphicFramePr>
          <p:xfrm>
            <a:off x="321760" y="450421"/>
            <a:ext cx="1168971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9" name="直接连接符 8"/>
            <p:cNvCxnSpPr/>
            <p:nvPr/>
          </p:nvCxnSpPr>
          <p:spPr>
            <a:xfrm>
              <a:off x="2507112" y="1057481"/>
              <a:ext cx="0" cy="91884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/>
            <p:cNvCxnSpPr/>
            <p:nvPr/>
          </p:nvCxnSpPr>
          <p:spPr>
            <a:xfrm>
              <a:off x="2803657" y="1057481"/>
              <a:ext cx="0" cy="91884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>
              <a:off x="3029717" y="1057481"/>
              <a:ext cx="0" cy="91884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/>
            <p:cNvCxnSpPr/>
            <p:nvPr/>
          </p:nvCxnSpPr>
          <p:spPr>
            <a:xfrm>
              <a:off x="3337692" y="1057481"/>
              <a:ext cx="0" cy="91884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88426AF5-1185-4E42-9E60-F3DAD0C9DB82}"/>
              </a:ext>
            </a:extLst>
          </p:cNvPr>
          <p:cNvGrpSpPr/>
          <p:nvPr/>
        </p:nvGrpSpPr>
        <p:grpSpPr>
          <a:xfrm>
            <a:off x="1180611" y="3947355"/>
            <a:ext cx="5009507" cy="2151400"/>
            <a:chOff x="402467" y="4132021"/>
            <a:chExt cx="5009507" cy="2151400"/>
          </a:xfrm>
        </p:grpSpPr>
        <p:sp>
          <p:nvSpPr>
            <p:cNvPr id="4" name="文本框 3"/>
            <p:cNvSpPr txBox="1"/>
            <p:nvPr/>
          </p:nvSpPr>
          <p:spPr>
            <a:xfrm>
              <a:off x="1578597" y="5914089"/>
              <a:ext cx="290223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P,135-156::</a:t>
              </a:r>
              <a:r>
                <a:rPr lang="en-US" altLang="zh-CN" dirty="0" err="1"/>
                <a:t>amiRCPa</a:t>
              </a:r>
              <a:endParaRPr lang="en-US" altLang="zh-CN" dirty="0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644022" y="5136721"/>
              <a:ext cx="476795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|||O|||||||||||||||||O</a:t>
              </a:r>
              <a:endParaRPr lang="zh-CN" altLang="en-US" sz="2400" dirty="0">
                <a:latin typeface="Courier New" panose="02070309020205020404" charset="0"/>
                <a:cs typeface="Courier New" panose="02070309020205020404" charset="0"/>
              </a:endParaRPr>
            </a:p>
            <a:p>
              <a:r>
                <a:rPr lang="zh-CN" altLang="en-US" sz="2400" dirty="0">
                  <a:latin typeface="Courier New" panose="02070309020205020404" charset="0"/>
                  <a:cs typeface="Courier New" panose="02070309020205020404" charset="0"/>
                </a:rPr>
                <a:t>CTGTATGTCCGGGTACATGGCT</a:t>
              </a:r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-5'</a:t>
              </a:r>
            </a:p>
          </p:txBody>
        </p:sp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02467" y="4132021"/>
              <a:ext cx="4395165" cy="1040260"/>
            </a:xfrm>
            <a:prstGeom prst="rect">
              <a:avLst/>
            </a:prstGeom>
          </p:spPr>
        </p:pic>
      </p:grp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83B8C8A1-D7D7-4BAD-BACB-CDA353456174}"/>
              </a:ext>
            </a:extLst>
          </p:cNvPr>
          <p:cNvGrpSpPr/>
          <p:nvPr/>
        </p:nvGrpSpPr>
        <p:grpSpPr>
          <a:xfrm>
            <a:off x="6095999" y="3947355"/>
            <a:ext cx="5017632" cy="2158825"/>
            <a:chOff x="6530348" y="4124596"/>
            <a:chExt cx="5017632" cy="2158825"/>
          </a:xfrm>
        </p:grpSpPr>
        <p:sp>
          <p:nvSpPr>
            <p:cNvPr id="7" name="文本框 6"/>
            <p:cNvSpPr txBox="1"/>
            <p:nvPr/>
          </p:nvSpPr>
          <p:spPr>
            <a:xfrm>
              <a:off x="7493329" y="5914089"/>
              <a:ext cx="26370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P, 170-191:: </a:t>
              </a:r>
              <a:r>
                <a:rPr lang="en-US" altLang="zh-CN" dirty="0" err="1"/>
                <a:t>amiRCPb</a:t>
              </a:r>
              <a:endParaRPr lang="en-US" altLang="zh-CN" dirty="0"/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6780027" y="5172281"/>
              <a:ext cx="4463415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6780027" y="5095446"/>
              <a:ext cx="4767953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||||||||||O|O|||||||||</a:t>
              </a:r>
              <a:br>
                <a:rPr lang="zh-CN" altLang="en-US" sz="2400" dirty="0">
                  <a:latin typeface="Courier New" panose="02070309020205020404" charset="0"/>
                  <a:cs typeface="Courier New" panose="02070309020205020404" charset="0"/>
                </a:rPr>
              </a:br>
              <a:r>
                <a:rPr lang="zh-CN" altLang="en-US" sz="2400" dirty="0">
                  <a:latin typeface="Courier New" panose="02070309020205020404" charset="0"/>
                  <a:cs typeface="Courier New" panose="02070309020205020404" charset="0"/>
                </a:rPr>
                <a:t>TGTCTTACATGGTTTCGGGACT</a:t>
              </a:r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-5'</a:t>
              </a:r>
            </a:p>
          </p:txBody>
        </p:sp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530348" y="4124596"/>
              <a:ext cx="4395166" cy="1047820"/>
            </a:xfrm>
            <a:prstGeom prst="rect">
              <a:avLst/>
            </a:prstGeom>
          </p:spPr>
        </p:pic>
      </p:grpSp>
      <p:sp>
        <p:nvSpPr>
          <p:cNvPr id="6" name="文本框 5">
            <a:extLst>
              <a:ext uri="{FF2B5EF4-FFF2-40B4-BE49-F238E27FC236}">
                <a16:creationId xmlns:a16="http://schemas.microsoft.com/office/drawing/2014/main" id="{886FA161-78B3-498D-BF33-9FDB179E4916}"/>
              </a:ext>
            </a:extLst>
          </p:cNvPr>
          <p:cNvSpPr txBox="1"/>
          <p:nvPr/>
        </p:nvSpPr>
        <p:spPr>
          <a:xfrm>
            <a:off x="840453" y="799359"/>
            <a:ext cx="34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</p:spTree>
    <p:custDataLst>
      <p:tags r:id="rId1"/>
    </p:custData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图片 30">
            <a:extLst>
              <a:ext uri="{FF2B5EF4-FFF2-40B4-BE49-F238E27FC236}">
                <a16:creationId xmlns:a16="http://schemas.microsoft.com/office/drawing/2014/main" id="{ADC2137A-BFB6-A73C-C120-4EBA6E5AFAF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19828" y="447716"/>
            <a:ext cx="1572904" cy="6127011"/>
          </a:xfrm>
          <a:prstGeom prst="rect">
            <a:avLst/>
          </a:prstGeom>
        </p:spPr>
      </p:pic>
      <p:pic>
        <p:nvPicPr>
          <p:cNvPr id="2" name="图片 1" descr="DSC_4894">
            <a:extLst>
              <a:ext uri="{FF2B5EF4-FFF2-40B4-BE49-F238E27FC236}">
                <a16:creationId xmlns:a16="http://schemas.microsoft.com/office/drawing/2014/main" id="{708E746F-BEC9-A3FB-3CA4-E77C78392E1F}"/>
              </a:ext>
            </a:extLst>
          </p:cNvPr>
          <p:cNvPicPr>
            <a:picLocks/>
          </p:cNvPicPr>
          <p:nvPr>
            <p:custDataLst>
              <p:tags r:id="rId1"/>
            </p:custDataLst>
          </p:nvPr>
        </p:nvPicPr>
        <p:blipFill>
          <a:blip r:embed="rId6" cstate="print">
            <a:lum bright="-18000" contrast="6000"/>
          </a:blip>
          <a:srcRect l="33136" t="38693" r="31763" b="10278"/>
          <a:stretch>
            <a:fillRect/>
          </a:stretch>
        </p:blipFill>
        <p:spPr>
          <a:xfrm>
            <a:off x="2450366" y="5583576"/>
            <a:ext cx="1008000" cy="1008000"/>
          </a:xfrm>
          <a:prstGeom prst="rect">
            <a:avLst/>
          </a:prstGeom>
        </p:spPr>
      </p:pic>
      <p:pic>
        <p:nvPicPr>
          <p:cNvPr id="3" name="图片 2" descr="DSC_4893">
            <a:extLst>
              <a:ext uri="{FF2B5EF4-FFF2-40B4-BE49-F238E27FC236}">
                <a16:creationId xmlns:a16="http://schemas.microsoft.com/office/drawing/2014/main" id="{32C71C4D-25CC-81B8-F7FD-64CC7D9BE56A}"/>
              </a:ext>
            </a:extLst>
          </p:cNvPr>
          <p:cNvPicPr>
            <a:picLocks/>
          </p:cNvPicPr>
          <p:nvPr/>
        </p:nvPicPr>
        <p:blipFill>
          <a:blip r:embed="rId7" cstate="print">
            <a:lum bright="-12000" contrast="6000"/>
          </a:blip>
          <a:srcRect l="38862" t="36000" r="30277"/>
          <a:stretch>
            <a:fillRect/>
          </a:stretch>
        </p:blipFill>
        <p:spPr>
          <a:xfrm>
            <a:off x="2450366" y="4561144"/>
            <a:ext cx="1008000" cy="1008000"/>
          </a:xfrm>
          <a:prstGeom prst="rect">
            <a:avLst/>
          </a:prstGeom>
        </p:spPr>
      </p:pic>
      <p:pic>
        <p:nvPicPr>
          <p:cNvPr id="4" name="图片 3" descr="DSC_4895">
            <a:extLst>
              <a:ext uri="{FF2B5EF4-FFF2-40B4-BE49-F238E27FC236}">
                <a16:creationId xmlns:a16="http://schemas.microsoft.com/office/drawing/2014/main" id="{1C1A8BEE-2A66-AEB0-0F2F-BA3EAB37462A}"/>
              </a:ext>
            </a:extLst>
          </p:cNvPr>
          <p:cNvPicPr>
            <a:picLocks/>
          </p:cNvPicPr>
          <p:nvPr/>
        </p:nvPicPr>
        <p:blipFill>
          <a:blip r:embed="rId8" cstate="print">
            <a:clrChange>
              <a:clrFrom>
                <a:srgbClr val="373F42">
                  <a:alpha val="100000"/>
                </a:srgbClr>
              </a:clrFrom>
              <a:clrTo>
                <a:srgbClr val="373F42">
                  <a:alpha val="100000"/>
                  <a:alpha val="0"/>
                </a:srgbClr>
              </a:clrTo>
            </a:clrChange>
            <a:lum bright="-18000" contrast="6000"/>
          </a:blip>
          <a:srcRect l="33563" t="15901" r="28415" b="18878"/>
          <a:stretch>
            <a:fillRect/>
          </a:stretch>
        </p:blipFill>
        <p:spPr>
          <a:xfrm>
            <a:off x="2450366" y="2516284"/>
            <a:ext cx="1008000" cy="1008000"/>
          </a:xfrm>
          <a:prstGeom prst="rect">
            <a:avLst/>
          </a:prstGeom>
          <a:solidFill>
            <a:schemeClr val="tx1"/>
          </a:solidFill>
        </p:spPr>
      </p:pic>
      <p:pic>
        <p:nvPicPr>
          <p:cNvPr id="5" name="图片 4" descr="DSC_4901">
            <a:extLst>
              <a:ext uri="{FF2B5EF4-FFF2-40B4-BE49-F238E27FC236}">
                <a16:creationId xmlns:a16="http://schemas.microsoft.com/office/drawing/2014/main" id="{684CE87C-93B3-31E5-524D-5FB33F49AD14}"/>
              </a:ext>
            </a:extLst>
          </p:cNvPr>
          <p:cNvPicPr>
            <a:picLocks/>
          </p:cNvPicPr>
          <p:nvPr/>
        </p:nvPicPr>
        <p:blipFill>
          <a:blip r:embed="rId9" cstate="print">
            <a:clrChange>
              <a:clrFrom>
                <a:srgbClr val="3B423B">
                  <a:alpha val="100000"/>
                </a:srgbClr>
              </a:clrFrom>
              <a:clrTo>
                <a:srgbClr val="3B423B">
                  <a:alpha val="100000"/>
                  <a:alpha val="0"/>
                </a:srgbClr>
              </a:clrTo>
            </a:clrChange>
            <a:lum bright="-24000" contrast="6000"/>
          </a:blip>
          <a:srcRect l="40702" t="28260" r="33470" b="27155"/>
          <a:stretch>
            <a:fillRect/>
          </a:stretch>
        </p:blipFill>
        <p:spPr>
          <a:xfrm>
            <a:off x="2450366" y="3538714"/>
            <a:ext cx="1008000" cy="1008000"/>
          </a:xfrm>
          <a:prstGeom prst="rect">
            <a:avLst/>
          </a:prstGeom>
          <a:solidFill>
            <a:schemeClr val="tx1"/>
          </a:solidFill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6249B17-83FC-8A5F-F60F-3D946D6866CA}"/>
              </a:ext>
            </a:extLst>
          </p:cNvPr>
          <p:cNvPicPr>
            <a:picLocks/>
          </p:cNvPicPr>
          <p:nvPr/>
        </p:nvPicPr>
        <p:blipFill>
          <a:blip r:embed="rId10" cstate="print">
            <a:lum bright="-12000" contrast="6000"/>
          </a:blip>
          <a:srcRect l="40208" t="36833" r="30865" b="7805"/>
          <a:stretch>
            <a:fillRect/>
          </a:stretch>
        </p:blipFill>
        <p:spPr>
          <a:xfrm>
            <a:off x="2450366" y="1493854"/>
            <a:ext cx="1008000" cy="1008000"/>
          </a:xfrm>
          <a:prstGeom prst="rect">
            <a:avLst/>
          </a:prstGeom>
        </p:spPr>
      </p:pic>
      <p:pic>
        <p:nvPicPr>
          <p:cNvPr id="7" name="图片 6" descr="DSC_4896">
            <a:extLst>
              <a:ext uri="{FF2B5EF4-FFF2-40B4-BE49-F238E27FC236}">
                <a16:creationId xmlns:a16="http://schemas.microsoft.com/office/drawing/2014/main" id="{EDD6961E-4AD6-750D-B2F8-984F910EAC12}"/>
              </a:ext>
            </a:extLst>
          </p:cNvPr>
          <p:cNvPicPr>
            <a:picLocks/>
          </p:cNvPicPr>
          <p:nvPr>
            <p:custDataLst>
              <p:tags r:id="rId2"/>
            </p:custDataLst>
          </p:nvPr>
        </p:nvPicPr>
        <p:blipFill>
          <a:blip r:embed="rId11" cstate="print">
            <a:clrChange>
              <a:clrFrom>
                <a:srgbClr val="2C302F">
                  <a:alpha val="100000"/>
                </a:srgbClr>
              </a:clrFrom>
              <a:clrTo>
                <a:srgbClr val="2C302F">
                  <a:alpha val="100000"/>
                  <a:alpha val="0"/>
                </a:srgbClr>
              </a:clrTo>
            </a:clrChange>
            <a:lum bright="-24000" contrast="12000"/>
          </a:blip>
          <a:srcRect l="40356" t="35237" r="37572" b="32106"/>
          <a:stretch>
            <a:fillRect/>
          </a:stretch>
        </p:blipFill>
        <p:spPr>
          <a:xfrm>
            <a:off x="2450366" y="471424"/>
            <a:ext cx="1008000" cy="1008000"/>
          </a:xfrm>
          <a:prstGeom prst="rect">
            <a:avLst/>
          </a:prstGeom>
          <a:solidFill>
            <a:schemeClr val="tx1"/>
          </a:solidFill>
        </p:spPr>
      </p:pic>
      <p:sp>
        <p:nvSpPr>
          <p:cNvPr id="8" name="TextBox 12">
            <a:extLst>
              <a:ext uri="{FF2B5EF4-FFF2-40B4-BE49-F238E27FC236}">
                <a16:creationId xmlns:a16="http://schemas.microsoft.com/office/drawing/2014/main" id="{6A45EB64-4A3F-EC3F-AE91-C398BEC42C60}"/>
              </a:ext>
            </a:extLst>
          </p:cNvPr>
          <p:cNvSpPr txBox="1"/>
          <p:nvPr/>
        </p:nvSpPr>
        <p:spPr>
          <a:xfrm>
            <a:off x="1565921" y="838895"/>
            <a:ext cx="382703" cy="162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 Level</a:t>
            </a:r>
          </a:p>
        </p:txBody>
      </p:sp>
      <p:sp>
        <p:nvSpPr>
          <p:cNvPr id="9" name="TextBox 14">
            <a:extLst>
              <a:ext uri="{FF2B5EF4-FFF2-40B4-BE49-F238E27FC236}">
                <a16:creationId xmlns:a16="http://schemas.microsoft.com/office/drawing/2014/main" id="{B2141830-A08B-D932-7703-0367A178DB69}"/>
              </a:ext>
            </a:extLst>
          </p:cNvPr>
          <p:cNvSpPr txBox="1"/>
          <p:nvPr/>
        </p:nvSpPr>
        <p:spPr>
          <a:xfrm>
            <a:off x="1565921" y="1966356"/>
            <a:ext cx="382703" cy="162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 Level</a:t>
            </a:r>
          </a:p>
        </p:txBody>
      </p:sp>
      <p:sp>
        <p:nvSpPr>
          <p:cNvPr id="10" name="TextBox 15">
            <a:extLst>
              <a:ext uri="{FF2B5EF4-FFF2-40B4-BE49-F238E27FC236}">
                <a16:creationId xmlns:a16="http://schemas.microsoft.com/office/drawing/2014/main" id="{D615D058-88F2-7F0B-D4F1-3510E9FBB1DE}"/>
              </a:ext>
            </a:extLst>
          </p:cNvPr>
          <p:cNvSpPr txBox="1"/>
          <p:nvPr/>
        </p:nvSpPr>
        <p:spPr>
          <a:xfrm>
            <a:off x="1565921" y="2929132"/>
            <a:ext cx="382703" cy="162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 Level</a:t>
            </a:r>
          </a:p>
        </p:txBody>
      </p:sp>
      <p:sp>
        <p:nvSpPr>
          <p:cNvPr id="11" name="TextBox 16">
            <a:extLst>
              <a:ext uri="{FF2B5EF4-FFF2-40B4-BE49-F238E27FC236}">
                <a16:creationId xmlns:a16="http://schemas.microsoft.com/office/drawing/2014/main" id="{FDE9FC1A-D1F6-A8B7-A4EF-E92F07EC3F0C}"/>
              </a:ext>
            </a:extLst>
          </p:cNvPr>
          <p:cNvSpPr txBox="1"/>
          <p:nvPr/>
        </p:nvSpPr>
        <p:spPr>
          <a:xfrm>
            <a:off x="1565921" y="3867870"/>
            <a:ext cx="382703" cy="162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 Level</a:t>
            </a:r>
          </a:p>
        </p:txBody>
      </p:sp>
      <p:sp>
        <p:nvSpPr>
          <p:cNvPr id="12" name="TextBox 17">
            <a:extLst>
              <a:ext uri="{FF2B5EF4-FFF2-40B4-BE49-F238E27FC236}">
                <a16:creationId xmlns:a16="http://schemas.microsoft.com/office/drawing/2014/main" id="{0DFF662E-1D29-8F22-8BBF-9C29D3A13476}"/>
              </a:ext>
            </a:extLst>
          </p:cNvPr>
          <p:cNvSpPr txBox="1"/>
          <p:nvPr/>
        </p:nvSpPr>
        <p:spPr>
          <a:xfrm>
            <a:off x="1565921" y="5047780"/>
            <a:ext cx="382703" cy="162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7 Level</a:t>
            </a:r>
          </a:p>
        </p:txBody>
      </p:sp>
      <p:sp>
        <p:nvSpPr>
          <p:cNvPr id="13" name="TextBox 18">
            <a:extLst>
              <a:ext uri="{FF2B5EF4-FFF2-40B4-BE49-F238E27FC236}">
                <a16:creationId xmlns:a16="http://schemas.microsoft.com/office/drawing/2014/main" id="{16360B7D-F627-AB81-E166-1E9096120788}"/>
              </a:ext>
            </a:extLst>
          </p:cNvPr>
          <p:cNvSpPr txBox="1"/>
          <p:nvPr/>
        </p:nvSpPr>
        <p:spPr>
          <a:xfrm>
            <a:off x="1565921" y="6010556"/>
            <a:ext cx="382703" cy="162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9 Level</a:t>
            </a:r>
          </a:p>
        </p:txBody>
      </p:sp>
      <p:sp>
        <p:nvSpPr>
          <p:cNvPr id="18" name="文本框 1">
            <a:extLst>
              <a:ext uri="{FF2B5EF4-FFF2-40B4-BE49-F238E27FC236}">
                <a16:creationId xmlns:a16="http://schemas.microsoft.com/office/drawing/2014/main" id="{816C24AE-4398-3797-C042-AB5B2E128FDE}"/>
              </a:ext>
            </a:extLst>
          </p:cNvPr>
          <p:cNvSpPr txBox="1"/>
          <p:nvPr/>
        </p:nvSpPr>
        <p:spPr>
          <a:xfrm>
            <a:off x="1408082" y="219679"/>
            <a:ext cx="466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文本框 1">
            <a:extLst>
              <a:ext uri="{FF2B5EF4-FFF2-40B4-BE49-F238E27FC236}">
                <a16:creationId xmlns:a16="http://schemas.microsoft.com/office/drawing/2014/main" id="{107FAC9D-A89C-C9D5-CE42-4D02332AB3E4}"/>
              </a:ext>
            </a:extLst>
          </p:cNvPr>
          <p:cNvSpPr txBox="1"/>
          <p:nvPr/>
        </p:nvSpPr>
        <p:spPr>
          <a:xfrm>
            <a:off x="3786409" y="233903"/>
            <a:ext cx="347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文本框 1">
            <a:extLst>
              <a:ext uri="{FF2B5EF4-FFF2-40B4-BE49-F238E27FC236}">
                <a16:creationId xmlns:a16="http://schemas.microsoft.com/office/drawing/2014/main" id="{6CBEDC82-2D3D-3D59-D4F3-03B151C07020}"/>
              </a:ext>
            </a:extLst>
          </p:cNvPr>
          <p:cNvSpPr txBox="1"/>
          <p:nvPr/>
        </p:nvSpPr>
        <p:spPr>
          <a:xfrm>
            <a:off x="3688148" y="1091481"/>
            <a:ext cx="466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5 w</a:t>
            </a:r>
          </a:p>
        </p:txBody>
      </p:sp>
      <p:sp>
        <p:nvSpPr>
          <p:cNvPr id="21" name="文本框 1">
            <a:extLst>
              <a:ext uri="{FF2B5EF4-FFF2-40B4-BE49-F238E27FC236}">
                <a16:creationId xmlns:a16="http://schemas.microsoft.com/office/drawing/2014/main" id="{6F7FECB3-15CC-D787-26D5-8A29DDA6565E}"/>
              </a:ext>
            </a:extLst>
          </p:cNvPr>
          <p:cNvSpPr txBox="1"/>
          <p:nvPr/>
        </p:nvSpPr>
        <p:spPr>
          <a:xfrm>
            <a:off x="3688148" y="2686253"/>
            <a:ext cx="466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8 w</a:t>
            </a:r>
          </a:p>
        </p:txBody>
      </p:sp>
      <p:sp>
        <p:nvSpPr>
          <p:cNvPr id="22" name="文本框 1">
            <a:extLst>
              <a:ext uri="{FF2B5EF4-FFF2-40B4-BE49-F238E27FC236}">
                <a16:creationId xmlns:a16="http://schemas.microsoft.com/office/drawing/2014/main" id="{1A9AA5A4-1592-D317-93B6-D5ED74C62147}"/>
              </a:ext>
            </a:extLst>
          </p:cNvPr>
          <p:cNvSpPr txBox="1"/>
          <p:nvPr/>
        </p:nvSpPr>
        <p:spPr>
          <a:xfrm>
            <a:off x="3655982" y="4187626"/>
            <a:ext cx="5311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1 w</a:t>
            </a:r>
          </a:p>
        </p:txBody>
      </p:sp>
      <p:sp>
        <p:nvSpPr>
          <p:cNvPr id="23" name="文本框 1">
            <a:extLst>
              <a:ext uri="{FF2B5EF4-FFF2-40B4-BE49-F238E27FC236}">
                <a16:creationId xmlns:a16="http://schemas.microsoft.com/office/drawing/2014/main" id="{3273FEFC-C064-546B-5708-698AF06EA58E}"/>
              </a:ext>
            </a:extLst>
          </p:cNvPr>
          <p:cNvSpPr txBox="1"/>
          <p:nvPr/>
        </p:nvSpPr>
        <p:spPr>
          <a:xfrm>
            <a:off x="3655982" y="5736608"/>
            <a:ext cx="5311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4 w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F0D92C1-23D2-817E-A75D-5ECCF8980E9A}"/>
              </a:ext>
            </a:extLst>
          </p:cNvPr>
          <p:cNvSpPr txBox="1"/>
          <p:nvPr/>
        </p:nvSpPr>
        <p:spPr>
          <a:xfrm>
            <a:off x="4543424" y="6358722"/>
            <a:ext cx="1298481" cy="223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dist"/>
            <a:r>
              <a:rPr lang="en-US" altLang="zh-CN" sz="800" dirty="0"/>
              <a:t> 10  20 30 40  50 60 </a:t>
            </a:r>
            <a:endParaRPr lang="zh-CN" altLang="en-US" sz="800" dirty="0"/>
          </a:p>
        </p:txBody>
      </p:sp>
      <p:graphicFrame>
        <p:nvGraphicFramePr>
          <p:cNvPr id="26" name="表格 26">
            <a:extLst>
              <a:ext uri="{FF2B5EF4-FFF2-40B4-BE49-F238E27FC236}">
                <a16:creationId xmlns:a16="http://schemas.microsoft.com/office/drawing/2014/main" id="{785767B3-C5D5-5DD7-3E33-73062CE6A1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2965634"/>
              </p:ext>
            </p:extLst>
          </p:nvPr>
        </p:nvGraphicFramePr>
        <p:xfrm>
          <a:off x="6578696" y="447716"/>
          <a:ext cx="1669954" cy="25044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36529">
                  <a:extLst>
                    <a:ext uri="{9D8B030D-6E8A-4147-A177-3AD203B41FA5}">
                      <a16:colId xmlns:a16="http://schemas.microsoft.com/office/drawing/2014/main" val="608109308"/>
                    </a:ext>
                  </a:extLst>
                </a:gridCol>
                <a:gridCol w="733425">
                  <a:extLst>
                    <a:ext uri="{9D8B030D-6E8A-4147-A177-3AD203B41FA5}">
                      <a16:colId xmlns:a16="http://schemas.microsoft.com/office/drawing/2014/main" val="258650560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Resistance level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Disease index Standard 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6568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Immune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47728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High resistance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&lt;5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84995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Medium resistance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&lt;25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82161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Medium susceptibility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&lt;50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94779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High susceptibility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&gt;50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9829444"/>
                  </a:ext>
                </a:extLst>
              </a:tr>
            </a:tbl>
          </a:graphicData>
        </a:graphic>
      </p:graphicFrame>
      <p:sp>
        <p:nvSpPr>
          <p:cNvPr id="27" name="文本框 1">
            <a:extLst>
              <a:ext uri="{FF2B5EF4-FFF2-40B4-BE49-F238E27FC236}">
                <a16:creationId xmlns:a16="http://schemas.microsoft.com/office/drawing/2014/main" id="{2D9A44F7-34D2-DA48-CC74-BC79E37AFDA7}"/>
              </a:ext>
            </a:extLst>
          </p:cNvPr>
          <p:cNvSpPr txBox="1"/>
          <p:nvPr/>
        </p:nvSpPr>
        <p:spPr>
          <a:xfrm>
            <a:off x="6096000" y="221623"/>
            <a:ext cx="347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5822692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>
            <a:extLst>
              <a:ext uri="{FF2B5EF4-FFF2-40B4-BE49-F238E27FC236}">
                <a16:creationId xmlns:a16="http://schemas.microsoft.com/office/drawing/2014/main" id="{E0F0CB6E-3DE0-40F7-8D40-7CE7D29DCA34}"/>
              </a:ext>
            </a:extLst>
          </p:cNvPr>
          <p:cNvGrpSpPr/>
          <p:nvPr/>
        </p:nvGrpSpPr>
        <p:grpSpPr>
          <a:xfrm>
            <a:off x="1326519" y="1212433"/>
            <a:ext cx="9294267" cy="2353955"/>
            <a:chOff x="665480" y="306705"/>
            <a:chExt cx="10581640" cy="2743200"/>
          </a:xfrm>
        </p:grpSpPr>
        <p:graphicFrame>
          <p:nvGraphicFramePr>
            <p:cNvPr id="9" name="图表 8"/>
            <p:cNvGraphicFramePr/>
            <p:nvPr>
              <p:extLst>
                <p:ext uri="{D42A27DB-BD31-4B8C-83A1-F6EECF244321}">
                  <p14:modId xmlns:p14="http://schemas.microsoft.com/office/powerpoint/2010/main" val="403834850"/>
                </p:ext>
              </p:extLst>
            </p:nvPr>
          </p:nvGraphicFramePr>
          <p:xfrm>
            <a:off x="665480" y="306705"/>
            <a:ext cx="1058164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10" name="直接连接符 9"/>
            <p:cNvCxnSpPr/>
            <p:nvPr/>
          </p:nvCxnSpPr>
          <p:spPr>
            <a:xfrm>
              <a:off x="7099300" y="995045"/>
              <a:ext cx="0" cy="76898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>
              <a:off x="7715885" y="995045"/>
              <a:ext cx="0" cy="76898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/>
            <p:cNvCxnSpPr/>
            <p:nvPr/>
          </p:nvCxnSpPr>
          <p:spPr>
            <a:xfrm>
              <a:off x="2503170" y="995045"/>
              <a:ext cx="0" cy="76898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/>
            <p:cNvCxnSpPr/>
            <p:nvPr/>
          </p:nvCxnSpPr>
          <p:spPr>
            <a:xfrm>
              <a:off x="3099435" y="995045"/>
              <a:ext cx="0" cy="76898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组合 5">
            <a:extLst>
              <a:ext uri="{FF2B5EF4-FFF2-40B4-BE49-F238E27FC236}">
                <a16:creationId xmlns:a16="http://schemas.microsoft.com/office/drawing/2014/main" id="{6B0417BE-0A19-4026-9F6B-C22DB9E01C88}"/>
              </a:ext>
            </a:extLst>
          </p:cNvPr>
          <p:cNvGrpSpPr/>
          <p:nvPr/>
        </p:nvGrpSpPr>
        <p:grpSpPr>
          <a:xfrm>
            <a:off x="1326519" y="3866203"/>
            <a:ext cx="5025703" cy="2065035"/>
            <a:chOff x="684218" y="3871969"/>
            <a:chExt cx="5025703" cy="2065035"/>
          </a:xfrm>
        </p:grpSpPr>
        <p:sp>
          <p:nvSpPr>
            <p:cNvPr id="3" name="文本框 2"/>
            <p:cNvSpPr txBox="1"/>
            <p:nvPr/>
          </p:nvSpPr>
          <p:spPr>
            <a:xfrm>
              <a:off x="1787071" y="5567672"/>
              <a:ext cx="30517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V2,</a:t>
              </a:r>
              <a:r>
                <a:rPr lang="zh-CN" altLang="en-US" dirty="0"/>
                <a:t> </a:t>
              </a:r>
              <a:r>
                <a:rPr lang="en-US" altLang="zh-CN" dirty="0"/>
                <a:t>212-233::amiRV2a</a:t>
              </a: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915993" y="4814570"/>
              <a:ext cx="4793928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||||||||||||||||||||||</a:t>
              </a:r>
              <a:endParaRPr lang="zh-CN" altLang="en-US" sz="2400" dirty="0">
                <a:latin typeface="Courier New" panose="02070309020205020404" charset="0"/>
                <a:cs typeface="Courier New" panose="02070309020205020404" charset="0"/>
              </a:endParaRPr>
            </a:p>
            <a:p>
              <a:r>
                <a:rPr lang="zh-CN" altLang="en-US" sz="2400" dirty="0">
                  <a:latin typeface="Courier New" panose="02070309020205020404" charset="0"/>
                  <a:cs typeface="Courier New" panose="02070309020205020404" charset="0"/>
                </a:rPr>
                <a:t>GCGGCTTCCGACTTGAAGCTGT</a:t>
              </a:r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-5'</a:t>
              </a:r>
            </a:p>
          </p:txBody>
        </p:sp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84218" y="3871969"/>
              <a:ext cx="4398421" cy="1058305"/>
            </a:xfrm>
            <a:prstGeom prst="rect">
              <a:avLst/>
            </a:prstGeom>
          </p:spPr>
        </p:pic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B9410BA4-3157-4C3B-BFFE-F98B31B37629}"/>
              </a:ext>
            </a:extLst>
          </p:cNvPr>
          <p:cNvGrpSpPr/>
          <p:nvPr/>
        </p:nvGrpSpPr>
        <p:grpSpPr>
          <a:xfrm>
            <a:off x="6222365" y="3874653"/>
            <a:ext cx="5142321" cy="2056585"/>
            <a:chOff x="6222365" y="3874653"/>
            <a:chExt cx="5142321" cy="2056585"/>
          </a:xfrm>
        </p:grpSpPr>
        <p:sp>
          <p:nvSpPr>
            <p:cNvPr id="4" name="文本框 3"/>
            <p:cNvSpPr txBox="1"/>
            <p:nvPr/>
          </p:nvSpPr>
          <p:spPr>
            <a:xfrm>
              <a:off x="7633063" y="5562938"/>
              <a:ext cx="258064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V2, 54-75::amiRV2b</a:t>
              </a: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6482080" y="4814570"/>
              <a:ext cx="4882606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|||||||||O||||||||OO|O</a:t>
              </a:r>
              <a:endParaRPr lang="zh-CN" altLang="en-US" sz="2400" dirty="0">
                <a:latin typeface="Courier New" panose="02070309020205020404" charset="0"/>
                <a:cs typeface="Courier New" panose="02070309020205020404" charset="0"/>
              </a:endParaRPr>
            </a:p>
            <a:p>
              <a:r>
                <a:rPr lang="zh-CN" altLang="en-US" sz="2400" dirty="0">
                  <a:latin typeface="Courier New" panose="02070309020205020404" charset="0"/>
                  <a:cs typeface="Courier New" panose="02070309020205020404" charset="0"/>
                </a:rPr>
                <a:t>ATACAATCGGTAATTTATGGAT</a:t>
              </a:r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-5'</a:t>
              </a:r>
            </a:p>
          </p:txBody>
        </p:sp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222365" y="3874653"/>
              <a:ext cx="4398421" cy="1055621"/>
            </a:xfrm>
            <a:prstGeom prst="rect">
              <a:avLst/>
            </a:prstGeom>
          </p:spPr>
        </p:pic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84D2CC4A-AE77-48E4-A57D-25FDBA69BB93}"/>
              </a:ext>
            </a:extLst>
          </p:cNvPr>
          <p:cNvSpPr txBox="1"/>
          <p:nvPr/>
        </p:nvSpPr>
        <p:spPr>
          <a:xfrm>
            <a:off x="857419" y="73506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>
            <a:extLst>
              <a:ext uri="{FF2B5EF4-FFF2-40B4-BE49-F238E27FC236}">
                <a16:creationId xmlns:a16="http://schemas.microsoft.com/office/drawing/2014/main" id="{7641945E-D2B8-4F1E-A5C6-82AEFD7C98BC}"/>
              </a:ext>
            </a:extLst>
          </p:cNvPr>
          <p:cNvGrpSpPr/>
          <p:nvPr/>
        </p:nvGrpSpPr>
        <p:grpSpPr>
          <a:xfrm>
            <a:off x="1209295" y="1151906"/>
            <a:ext cx="9366755" cy="2073902"/>
            <a:chOff x="248285" y="363855"/>
            <a:chExt cx="11695430" cy="2743200"/>
          </a:xfrm>
        </p:grpSpPr>
        <p:graphicFrame>
          <p:nvGraphicFramePr>
            <p:cNvPr id="2" name="图表 1"/>
            <p:cNvGraphicFramePr/>
            <p:nvPr>
              <p:extLst>
                <p:ext uri="{D42A27DB-BD31-4B8C-83A1-F6EECF244321}">
                  <p14:modId xmlns:p14="http://schemas.microsoft.com/office/powerpoint/2010/main" val="689567241"/>
                </p:ext>
              </p:extLst>
            </p:nvPr>
          </p:nvGraphicFramePr>
          <p:xfrm>
            <a:off x="248285" y="363855"/>
            <a:ext cx="1169543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9" name="直接连接符 8"/>
            <p:cNvCxnSpPr/>
            <p:nvPr/>
          </p:nvCxnSpPr>
          <p:spPr>
            <a:xfrm>
              <a:off x="7667625" y="502285"/>
              <a:ext cx="0" cy="141795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/>
            <p:cNvCxnSpPr/>
            <p:nvPr/>
          </p:nvCxnSpPr>
          <p:spPr>
            <a:xfrm>
              <a:off x="7912735" y="502285"/>
              <a:ext cx="0" cy="141795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>
              <a:off x="9144000" y="502285"/>
              <a:ext cx="0" cy="141795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/>
            <p:cNvCxnSpPr/>
            <p:nvPr/>
          </p:nvCxnSpPr>
          <p:spPr>
            <a:xfrm>
              <a:off x="9360535" y="502285"/>
              <a:ext cx="0" cy="141795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0BD5EF92-17B0-40B8-B4BA-ED0AE32C30B3}"/>
              </a:ext>
            </a:extLst>
          </p:cNvPr>
          <p:cNvGrpSpPr/>
          <p:nvPr/>
        </p:nvGrpSpPr>
        <p:grpSpPr>
          <a:xfrm>
            <a:off x="1209295" y="3782715"/>
            <a:ext cx="5223853" cy="2062522"/>
            <a:chOff x="271145" y="3913344"/>
            <a:chExt cx="5223853" cy="2062522"/>
          </a:xfrm>
        </p:grpSpPr>
        <p:sp>
          <p:nvSpPr>
            <p:cNvPr id="3" name="文本框 2"/>
            <p:cNvSpPr txBox="1"/>
            <p:nvPr/>
          </p:nvSpPr>
          <p:spPr>
            <a:xfrm>
              <a:off x="1130795" y="5606534"/>
              <a:ext cx="26409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1, 829-850::amiRC1a</a:t>
              </a:r>
            </a:p>
          </p:txBody>
        </p:sp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1145" y="3913344"/>
              <a:ext cx="4360232" cy="1051855"/>
            </a:xfrm>
            <a:prstGeom prst="rect">
              <a:avLst/>
            </a:prstGeom>
          </p:spPr>
        </p:pic>
        <p:sp>
          <p:nvSpPr>
            <p:cNvPr id="15" name="文本框 14"/>
            <p:cNvSpPr txBox="1"/>
            <p:nvPr/>
          </p:nvSpPr>
          <p:spPr>
            <a:xfrm>
              <a:off x="484505" y="4838065"/>
              <a:ext cx="5010493" cy="83099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|||||O||||||||||||||||</a:t>
              </a:r>
              <a:endParaRPr lang="zh-CN" altLang="en-US" sz="2400" dirty="0">
                <a:latin typeface="Courier New" panose="02070309020205020404" charset="0"/>
                <a:cs typeface="Courier New" panose="02070309020205020404" charset="0"/>
              </a:endParaRPr>
            </a:p>
            <a:p>
              <a:r>
                <a:rPr lang="zh-CN" altLang="en-US" sz="2400" dirty="0">
                  <a:latin typeface="Courier New" panose="02070309020205020404" charset="0"/>
                  <a:cs typeface="Courier New" panose="02070309020205020404" charset="0"/>
                </a:rPr>
                <a:t>CGGGTTTCCCTGACCGTTTCGT</a:t>
              </a:r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-5'</a:t>
              </a:r>
            </a:p>
          </p:txBody>
        </p:sp>
      </p:grp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9EBE4668-8118-4463-AF03-604116A98FAF}"/>
              </a:ext>
            </a:extLst>
          </p:cNvPr>
          <p:cNvGrpSpPr/>
          <p:nvPr/>
        </p:nvGrpSpPr>
        <p:grpSpPr>
          <a:xfrm>
            <a:off x="6215817" y="3782715"/>
            <a:ext cx="5144994" cy="2044430"/>
            <a:chOff x="6326570" y="3931436"/>
            <a:chExt cx="5144994" cy="2044430"/>
          </a:xfrm>
        </p:grpSpPr>
        <p:sp>
          <p:nvSpPr>
            <p:cNvPr id="4" name="文本框 3"/>
            <p:cNvSpPr txBox="1"/>
            <p:nvPr/>
          </p:nvSpPr>
          <p:spPr>
            <a:xfrm>
              <a:off x="7481455" y="5607566"/>
              <a:ext cx="2834475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1, 682-703::amiRC1b</a:t>
              </a:r>
            </a:p>
          </p:txBody>
        </p:sp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326570" y="3931436"/>
              <a:ext cx="4360233" cy="1033764"/>
            </a:xfrm>
            <a:prstGeom prst="rect">
              <a:avLst/>
            </a:prstGeom>
          </p:spPr>
        </p:pic>
        <p:sp>
          <p:nvSpPr>
            <p:cNvPr id="16" name="文本框 15"/>
            <p:cNvSpPr txBox="1"/>
            <p:nvPr/>
          </p:nvSpPr>
          <p:spPr>
            <a:xfrm>
              <a:off x="6547485" y="4838065"/>
              <a:ext cx="4924079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|||||||||||||||||||||O</a:t>
              </a:r>
              <a:endParaRPr lang="zh-CN" altLang="en-US" sz="2400" dirty="0">
                <a:latin typeface="Courier New" panose="02070309020205020404" charset="0"/>
                <a:cs typeface="Courier New" panose="02070309020205020404" charset="0"/>
              </a:endParaRPr>
            </a:p>
            <a:p>
              <a:r>
                <a:rPr lang="zh-CN" altLang="en-US" sz="2400" dirty="0">
                  <a:latin typeface="Courier New" panose="02070309020205020404" charset="0"/>
                  <a:cs typeface="Courier New" panose="02070309020205020404" charset="0"/>
                </a:rPr>
                <a:t>TGTTACACCCGGTCCAGAGATT</a:t>
              </a:r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-5'</a:t>
              </a:r>
            </a:p>
          </p:txBody>
        </p:sp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28EFE989-1C1F-45AD-B446-5FA9044E64D2}"/>
              </a:ext>
            </a:extLst>
          </p:cNvPr>
          <p:cNvSpPr txBox="1"/>
          <p:nvPr/>
        </p:nvSpPr>
        <p:spPr>
          <a:xfrm>
            <a:off x="857917" y="59499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C</a:t>
            </a:r>
            <a:endParaRPr lang="zh-CN" altLang="en-US" b="1" dirty="0"/>
          </a:p>
        </p:txBody>
      </p:sp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>
            <a:extLst>
              <a:ext uri="{FF2B5EF4-FFF2-40B4-BE49-F238E27FC236}">
                <a16:creationId xmlns:a16="http://schemas.microsoft.com/office/drawing/2014/main" id="{482101C3-9AC3-4A64-964F-EEF8104B9301}"/>
              </a:ext>
            </a:extLst>
          </p:cNvPr>
          <p:cNvGrpSpPr/>
          <p:nvPr/>
        </p:nvGrpSpPr>
        <p:grpSpPr>
          <a:xfrm>
            <a:off x="1452640" y="1031639"/>
            <a:ext cx="9254524" cy="1980484"/>
            <a:chOff x="516890" y="221298"/>
            <a:chExt cx="11515090" cy="2790825"/>
          </a:xfrm>
        </p:grpSpPr>
        <p:graphicFrame>
          <p:nvGraphicFramePr>
            <p:cNvPr id="2" name="图表 1"/>
            <p:cNvGraphicFramePr/>
            <p:nvPr>
              <p:extLst>
                <p:ext uri="{D42A27DB-BD31-4B8C-83A1-F6EECF244321}">
                  <p14:modId xmlns:p14="http://schemas.microsoft.com/office/powerpoint/2010/main" val="1792267440"/>
                </p:ext>
              </p:extLst>
            </p:nvPr>
          </p:nvGraphicFramePr>
          <p:xfrm>
            <a:off x="516890" y="221298"/>
            <a:ext cx="11515090" cy="27908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9" name="直接连接符 8"/>
            <p:cNvCxnSpPr/>
            <p:nvPr/>
          </p:nvCxnSpPr>
          <p:spPr>
            <a:xfrm>
              <a:off x="4671695" y="980255"/>
              <a:ext cx="0" cy="1108076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/>
            <p:cNvCxnSpPr/>
            <p:nvPr/>
          </p:nvCxnSpPr>
          <p:spPr>
            <a:xfrm>
              <a:off x="5227955" y="980255"/>
              <a:ext cx="0" cy="1108076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>
              <a:off x="5894070" y="980255"/>
              <a:ext cx="0" cy="1108076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/>
            <p:cNvCxnSpPr/>
            <p:nvPr/>
          </p:nvCxnSpPr>
          <p:spPr>
            <a:xfrm>
              <a:off x="6479540" y="980255"/>
              <a:ext cx="0" cy="1108076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E4AC13B3-CC21-4B53-8BAD-C731875EBCDC}"/>
              </a:ext>
            </a:extLst>
          </p:cNvPr>
          <p:cNvGrpSpPr/>
          <p:nvPr/>
        </p:nvGrpSpPr>
        <p:grpSpPr>
          <a:xfrm>
            <a:off x="1452640" y="3779424"/>
            <a:ext cx="5062525" cy="2046937"/>
            <a:chOff x="257620" y="3824271"/>
            <a:chExt cx="5062525" cy="2046937"/>
          </a:xfrm>
        </p:grpSpPr>
        <p:sp>
          <p:nvSpPr>
            <p:cNvPr id="3" name="文本框 2"/>
            <p:cNvSpPr txBox="1"/>
            <p:nvPr/>
          </p:nvSpPr>
          <p:spPr>
            <a:xfrm>
              <a:off x="1284011" y="5501876"/>
              <a:ext cx="32182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2, 148-169::amiRC2a</a:t>
              </a:r>
            </a:p>
          </p:txBody>
        </p:sp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57620" y="3824271"/>
              <a:ext cx="4338130" cy="1050123"/>
            </a:xfrm>
            <a:prstGeom prst="rect">
              <a:avLst/>
            </a:prstGeom>
          </p:spPr>
        </p:pic>
        <p:sp>
          <p:nvSpPr>
            <p:cNvPr id="15" name="文本框 14"/>
            <p:cNvSpPr txBox="1"/>
            <p:nvPr/>
          </p:nvSpPr>
          <p:spPr>
            <a:xfrm>
              <a:off x="466090" y="4759960"/>
              <a:ext cx="4854055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|||||||||||O||||||||||</a:t>
              </a:r>
              <a:endParaRPr lang="zh-CN" altLang="en-US" sz="2400" dirty="0">
                <a:latin typeface="Courier New" panose="02070309020205020404" charset="0"/>
                <a:cs typeface="Courier New" panose="02070309020205020404" charset="0"/>
              </a:endParaRPr>
            </a:p>
            <a:p>
              <a:r>
                <a:rPr lang="zh-CN" altLang="en-US" sz="2400" dirty="0">
                  <a:latin typeface="Courier New" panose="02070309020205020404" charset="0"/>
                  <a:cs typeface="Courier New" panose="02070309020205020404" charset="0"/>
                </a:rPr>
                <a:t>GTACCTAAGTGTGTGTCCCCTT</a:t>
              </a:r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-5'</a:t>
              </a:r>
            </a:p>
          </p:txBody>
        </p:sp>
      </p:grp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C370C91D-3EAD-4332-A8AD-CAB281B41440}"/>
              </a:ext>
            </a:extLst>
          </p:cNvPr>
          <p:cNvGrpSpPr/>
          <p:nvPr/>
        </p:nvGrpSpPr>
        <p:grpSpPr>
          <a:xfrm>
            <a:off x="6274435" y="3729681"/>
            <a:ext cx="5228377" cy="2060557"/>
            <a:chOff x="6314440" y="3811683"/>
            <a:chExt cx="5228377" cy="2060557"/>
          </a:xfrm>
        </p:grpSpPr>
        <p:sp>
          <p:nvSpPr>
            <p:cNvPr id="4" name="文本框 3"/>
            <p:cNvSpPr txBox="1"/>
            <p:nvPr/>
          </p:nvSpPr>
          <p:spPr>
            <a:xfrm>
              <a:off x="7627157" y="5502908"/>
              <a:ext cx="28706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2, 196-217::amiRC2b</a:t>
              </a:r>
            </a:p>
          </p:txBody>
        </p:sp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314440" y="3811683"/>
              <a:ext cx="4432729" cy="1062712"/>
            </a:xfrm>
            <a:prstGeom prst="rect">
              <a:avLst/>
            </a:prstGeom>
          </p:spPr>
        </p:pic>
        <p:sp>
          <p:nvSpPr>
            <p:cNvPr id="16" name="文本框 15"/>
            <p:cNvSpPr txBox="1"/>
            <p:nvPr/>
          </p:nvSpPr>
          <p:spPr>
            <a:xfrm>
              <a:off x="6597651" y="4759960"/>
              <a:ext cx="4945166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||||||O|||||||||O|||||</a:t>
              </a:r>
              <a:endParaRPr lang="zh-CN" altLang="en-US" sz="2400" dirty="0">
                <a:latin typeface="Courier New" panose="02070309020205020404" charset="0"/>
                <a:cs typeface="Courier New" panose="02070309020205020404" charset="0"/>
              </a:endParaRPr>
            </a:p>
            <a:p>
              <a:r>
                <a:rPr lang="zh-CN" altLang="en-US" sz="2400" dirty="0">
                  <a:latin typeface="Courier New" panose="02070309020205020404" charset="0"/>
                  <a:cs typeface="Courier New" panose="02070309020205020404" charset="0"/>
                </a:rPr>
                <a:t>ACCGCAGAAATAGACCTTCTAT</a:t>
              </a:r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-5'</a:t>
              </a:r>
            </a:p>
          </p:txBody>
        </p:sp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D28B6A43-6A1C-491F-AD17-D77B98172795}"/>
              </a:ext>
            </a:extLst>
          </p:cNvPr>
          <p:cNvSpPr txBox="1"/>
          <p:nvPr/>
        </p:nvSpPr>
        <p:spPr>
          <a:xfrm>
            <a:off x="857419" y="54506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D</a:t>
            </a:r>
            <a:endParaRPr lang="zh-CN" altLang="en-US" b="1" dirty="0"/>
          </a:p>
        </p:txBody>
      </p:sp>
    </p:spTree>
    <p:custDataLst>
      <p:tags r:id="rId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>
            <a:extLst>
              <a:ext uri="{FF2B5EF4-FFF2-40B4-BE49-F238E27FC236}">
                <a16:creationId xmlns:a16="http://schemas.microsoft.com/office/drawing/2014/main" id="{B9F2FE26-E9B7-46F4-B44C-74A407EF3105}"/>
              </a:ext>
            </a:extLst>
          </p:cNvPr>
          <p:cNvGrpSpPr/>
          <p:nvPr/>
        </p:nvGrpSpPr>
        <p:grpSpPr>
          <a:xfrm>
            <a:off x="1511929" y="929930"/>
            <a:ext cx="9152113" cy="2172680"/>
            <a:chOff x="357505" y="359410"/>
            <a:chExt cx="11277600" cy="2743200"/>
          </a:xfrm>
        </p:grpSpPr>
        <p:graphicFrame>
          <p:nvGraphicFramePr>
            <p:cNvPr id="2" name="图表 1"/>
            <p:cNvGraphicFramePr/>
            <p:nvPr>
              <p:extLst>
                <p:ext uri="{D42A27DB-BD31-4B8C-83A1-F6EECF244321}">
                  <p14:modId xmlns:p14="http://schemas.microsoft.com/office/powerpoint/2010/main" val="1042518037"/>
                </p:ext>
              </p:extLst>
            </p:nvPr>
          </p:nvGraphicFramePr>
          <p:xfrm>
            <a:off x="357505" y="359410"/>
            <a:ext cx="112776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11" name="直接连接符 10"/>
            <p:cNvCxnSpPr/>
            <p:nvPr/>
          </p:nvCxnSpPr>
          <p:spPr>
            <a:xfrm>
              <a:off x="1886585" y="763229"/>
              <a:ext cx="0" cy="113855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/>
            <p:cNvCxnSpPr/>
            <p:nvPr/>
          </p:nvCxnSpPr>
          <p:spPr>
            <a:xfrm>
              <a:off x="2592705" y="763229"/>
              <a:ext cx="0" cy="113855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/>
            <p:cNvCxnSpPr/>
            <p:nvPr/>
          </p:nvCxnSpPr>
          <p:spPr>
            <a:xfrm>
              <a:off x="6693535" y="763229"/>
              <a:ext cx="0" cy="113855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/>
            <p:cNvCxnSpPr/>
            <p:nvPr/>
          </p:nvCxnSpPr>
          <p:spPr>
            <a:xfrm>
              <a:off x="7470140" y="763229"/>
              <a:ext cx="0" cy="113855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F054DE3A-6F69-44D2-AAF0-6C330C0C21FB}"/>
              </a:ext>
            </a:extLst>
          </p:cNvPr>
          <p:cNvGrpSpPr/>
          <p:nvPr/>
        </p:nvGrpSpPr>
        <p:grpSpPr>
          <a:xfrm>
            <a:off x="1511929" y="3799236"/>
            <a:ext cx="5905500" cy="2128834"/>
            <a:chOff x="357505" y="3807709"/>
            <a:chExt cx="5905500" cy="2128834"/>
          </a:xfrm>
        </p:grpSpPr>
        <p:sp>
          <p:nvSpPr>
            <p:cNvPr id="3" name="文本框 2"/>
            <p:cNvSpPr txBox="1"/>
            <p:nvPr/>
          </p:nvSpPr>
          <p:spPr>
            <a:xfrm>
              <a:off x="1556911" y="5567211"/>
              <a:ext cx="23565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3, 37-58::amiRC3a</a:t>
              </a:r>
            </a:p>
          </p:txBody>
        </p:sp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7505" y="3807709"/>
              <a:ext cx="4356999" cy="1062876"/>
            </a:xfrm>
            <a:prstGeom prst="rect">
              <a:avLst/>
            </a:prstGeom>
          </p:spPr>
        </p:pic>
        <p:sp>
          <p:nvSpPr>
            <p:cNvPr id="17" name="文本框 16"/>
            <p:cNvSpPr txBox="1"/>
            <p:nvPr/>
          </p:nvSpPr>
          <p:spPr>
            <a:xfrm>
              <a:off x="586105" y="4768850"/>
              <a:ext cx="56769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||O|||O||||||||||O||||</a:t>
              </a:r>
              <a:endParaRPr lang="zh-CN" altLang="en-US" sz="2400" dirty="0">
                <a:latin typeface="Courier New" panose="02070309020205020404" charset="0"/>
                <a:cs typeface="Courier New" panose="02070309020205020404" charset="0"/>
              </a:endParaRPr>
            </a:p>
            <a:p>
              <a:r>
                <a:rPr lang="zh-CN" altLang="en-US" sz="2400" dirty="0">
                  <a:latin typeface="Courier New" panose="02070309020205020404" charset="0"/>
                  <a:cs typeface="Courier New" panose="02070309020205020404" charset="0"/>
                </a:rPr>
                <a:t>GTCCGTTTCTTACCGCAGAAAT</a:t>
              </a:r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-5'</a:t>
              </a:r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18A50DBB-B38D-4B87-A569-92120D12AAAA}"/>
              </a:ext>
            </a:extLst>
          </p:cNvPr>
          <p:cNvGrpSpPr/>
          <p:nvPr/>
        </p:nvGrpSpPr>
        <p:grpSpPr>
          <a:xfrm>
            <a:off x="6307043" y="3815121"/>
            <a:ext cx="5298853" cy="2094184"/>
            <a:chOff x="6307043" y="3815121"/>
            <a:chExt cx="5298853" cy="2094184"/>
          </a:xfrm>
        </p:grpSpPr>
        <p:sp>
          <p:nvSpPr>
            <p:cNvPr id="4" name="文本框 3"/>
            <p:cNvSpPr txBox="1"/>
            <p:nvPr/>
          </p:nvSpPr>
          <p:spPr>
            <a:xfrm>
              <a:off x="7168053" y="5539973"/>
              <a:ext cx="25288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3, 181-202::amiRC3b</a:t>
              </a:r>
            </a:p>
          </p:txBody>
        </p:sp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307043" y="3815121"/>
              <a:ext cx="4356999" cy="1055464"/>
            </a:xfrm>
            <a:prstGeom prst="rect">
              <a:avLst/>
            </a:prstGeom>
          </p:spPr>
        </p:pic>
        <p:sp>
          <p:nvSpPr>
            <p:cNvPr id="18" name="文本框 17"/>
            <p:cNvSpPr txBox="1"/>
            <p:nvPr/>
          </p:nvSpPr>
          <p:spPr>
            <a:xfrm>
              <a:off x="6553836" y="4768850"/>
              <a:ext cx="505206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||||||||||||||||||||||</a:t>
              </a:r>
              <a:endParaRPr lang="zh-CN" altLang="en-US" sz="2400" dirty="0">
                <a:latin typeface="Courier New" panose="02070309020205020404" charset="0"/>
                <a:cs typeface="Courier New" panose="02070309020205020404" charset="0"/>
              </a:endParaRPr>
            </a:p>
            <a:p>
              <a:r>
                <a:rPr lang="zh-CN" altLang="en-US" sz="2400" dirty="0">
                  <a:latin typeface="Courier New" panose="02070309020205020404" charset="0"/>
                  <a:cs typeface="Courier New" panose="02070309020205020404" charset="0"/>
                </a:rPr>
                <a:t>CCCTAAGTGTTTACAAAAGAGT-5'</a:t>
              </a:r>
            </a:p>
          </p:txBody>
        </p:sp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2A9625B7-B385-4FC4-900B-5AB6133AA580}"/>
              </a:ext>
            </a:extLst>
          </p:cNvPr>
          <p:cNvSpPr txBox="1"/>
          <p:nvPr/>
        </p:nvSpPr>
        <p:spPr>
          <a:xfrm>
            <a:off x="979249" y="560598"/>
            <a:ext cx="34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E</a:t>
            </a:r>
            <a:endParaRPr lang="zh-CN" altLang="en-US" b="1" dirty="0"/>
          </a:p>
        </p:txBody>
      </p:sp>
    </p:spTree>
    <p:custDataLst>
      <p:tags r:id="rId1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>
            <a:extLst>
              <a:ext uri="{FF2B5EF4-FFF2-40B4-BE49-F238E27FC236}">
                <a16:creationId xmlns:a16="http://schemas.microsoft.com/office/drawing/2014/main" id="{27A71391-5D34-4703-BE3E-2AFCE069BBD4}"/>
              </a:ext>
            </a:extLst>
          </p:cNvPr>
          <p:cNvGrpSpPr/>
          <p:nvPr/>
        </p:nvGrpSpPr>
        <p:grpSpPr>
          <a:xfrm>
            <a:off x="1564432" y="1138138"/>
            <a:ext cx="9211344" cy="1914942"/>
            <a:chOff x="536893" y="309880"/>
            <a:chExt cx="11257915" cy="2743200"/>
          </a:xfrm>
        </p:grpSpPr>
        <p:graphicFrame>
          <p:nvGraphicFramePr>
            <p:cNvPr id="2" name="图表 1"/>
            <p:cNvGraphicFramePr/>
            <p:nvPr>
              <p:extLst>
                <p:ext uri="{D42A27DB-BD31-4B8C-83A1-F6EECF244321}">
                  <p14:modId xmlns:p14="http://schemas.microsoft.com/office/powerpoint/2010/main" val="2728246041"/>
                </p:ext>
              </p:extLst>
            </p:nvPr>
          </p:nvGraphicFramePr>
          <p:xfrm>
            <a:off x="536893" y="309880"/>
            <a:ext cx="1125791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10" name="直接连接符 9"/>
            <p:cNvCxnSpPr/>
            <p:nvPr/>
          </p:nvCxnSpPr>
          <p:spPr>
            <a:xfrm flipH="1">
              <a:off x="6618605" y="989034"/>
              <a:ext cx="19685" cy="116840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 flipH="1">
              <a:off x="7145020" y="989034"/>
              <a:ext cx="19685" cy="116840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/>
            <p:cNvCxnSpPr/>
            <p:nvPr/>
          </p:nvCxnSpPr>
          <p:spPr>
            <a:xfrm flipH="1">
              <a:off x="10017760" y="989034"/>
              <a:ext cx="19685" cy="116840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/>
            <p:cNvCxnSpPr/>
            <p:nvPr/>
          </p:nvCxnSpPr>
          <p:spPr>
            <a:xfrm flipH="1">
              <a:off x="10633710" y="989034"/>
              <a:ext cx="19685" cy="116840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B697B23D-18C9-4D78-BCC8-B5852C21700D}"/>
              </a:ext>
            </a:extLst>
          </p:cNvPr>
          <p:cNvGrpSpPr/>
          <p:nvPr/>
        </p:nvGrpSpPr>
        <p:grpSpPr>
          <a:xfrm>
            <a:off x="1564432" y="3337171"/>
            <a:ext cx="5064015" cy="2079641"/>
            <a:chOff x="408305" y="3899905"/>
            <a:chExt cx="5064015" cy="2079641"/>
          </a:xfrm>
        </p:grpSpPr>
        <p:sp>
          <p:nvSpPr>
            <p:cNvPr id="3" name="文本框 2"/>
            <p:cNvSpPr txBox="1"/>
            <p:nvPr/>
          </p:nvSpPr>
          <p:spPr>
            <a:xfrm>
              <a:off x="1461591" y="5610214"/>
              <a:ext cx="27811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4, 226-247::amiRC4a</a:t>
              </a:r>
            </a:p>
          </p:txBody>
        </p:sp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8305" y="3899905"/>
              <a:ext cx="4401201" cy="1048150"/>
            </a:xfrm>
            <a:prstGeom prst="rect">
              <a:avLst/>
            </a:prstGeom>
          </p:spPr>
        </p:pic>
        <p:sp>
          <p:nvSpPr>
            <p:cNvPr id="16" name="文本框 15"/>
            <p:cNvSpPr txBox="1"/>
            <p:nvPr/>
          </p:nvSpPr>
          <p:spPr>
            <a:xfrm>
              <a:off x="660400" y="4888865"/>
              <a:ext cx="481192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|||||||||||||O||||||||</a:t>
              </a:r>
              <a:endParaRPr lang="zh-CN" altLang="en-US" sz="2400" dirty="0">
                <a:latin typeface="Courier New" panose="02070309020205020404" charset="0"/>
                <a:cs typeface="Courier New" panose="02070309020205020404" charset="0"/>
              </a:endParaRPr>
            </a:p>
            <a:p>
              <a:r>
                <a:rPr lang="zh-CN" altLang="en-US" sz="2400" dirty="0">
                  <a:latin typeface="Courier New" panose="02070309020205020404" charset="0"/>
                  <a:cs typeface="Courier New" panose="02070309020205020404" charset="0"/>
                </a:rPr>
                <a:t>GTGTAAAGGTAGGTTTGTAAGT-5'</a:t>
              </a:r>
            </a:p>
          </p:txBody>
        </p:sp>
      </p:grpSp>
      <p:grpSp>
        <p:nvGrpSpPr>
          <p:cNvPr id="7" name="组合 6">
            <a:extLst>
              <a:ext uri="{FF2B5EF4-FFF2-40B4-BE49-F238E27FC236}">
                <a16:creationId xmlns:a16="http://schemas.microsoft.com/office/drawing/2014/main" id="{CEAE38E5-1D1E-438B-BB19-06C8CE9F780D}"/>
              </a:ext>
            </a:extLst>
          </p:cNvPr>
          <p:cNvGrpSpPr/>
          <p:nvPr/>
        </p:nvGrpSpPr>
        <p:grpSpPr>
          <a:xfrm>
            <a:off x="6374575" y="3337171"/>
            <a:ext cx="5157025" cy="2079125"/>
            <a:chOff x="6374575" y="3886317"/>
            <a:chExt cx="5157025" cy="2079125"/>
          </a:xfrm>
        </p:grpSpPr>
        <p:sp>
          <p:nvSpPr>
            <p:cNvPr id="4" name="文本框 3"/>
            <p:cNvSpPr txBox="1"/>
            <p:nvPr/>
          </p:nvSpPr>
          <p:spPr>
            <a:xfrm>
              <a:off x="7620779" y="5597142"/>
              <a:ext cx="2908646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4, 360-381::amiRC4b</a:t>
              </a:r>
            </a:p>
          </p:txBody>
        </p:sp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374575" y="3886317"/>
              <a:ext cx="4401201" cy="1061738"/>
            </a:xfrm>
            <a:prstGeom prst="rect">
              <a:avLst/>
            </a:prstGeom>
          </p:spPr>
        </p:pic>
        <p:sp>
          <p:nvSpPr>
            <p:cNvPr id="17" name="文本框 16"/>
            <p:cNvSpPr txBox="1"/>
            <p:nvPr/>
          </p:nvSpPr>
          <p:spPr>
            <a:xfrm>
              <a:off x="6618605" y="4888865"/>
              <a:ext cx="4912995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Courier New" panose="02070309020205020404" charset="0"/>
                  <a:cs typeface="Courier New" panose="02070309020205020404" charset="0"/>
                </a:rPr>
                <a:t>||||||||||||||O|||||OO</a:t>
              </a:r>
              <a:endParaRPr lang="zh-CN" altLang="en-US" sz="2400" dirty="0">
                <a:latin typeface="Courier New" panose="02070309020205020404" charset="0"/>
                <a:cs typeface="Courier New" panose="02070309020205020404" charset="0"/>
              </a:endParaRPr>
            </a:p>
            <a:p>
              <a:r>
                <a:rPr lang="zh-CN" altLang="en-US" sz="2400" dirty="0">
                  <a:latin typeface="Courier New" panose="02070309020205020404" charset="0"/>
                  <a:cs typeface="Courier New" panose="02070309020205020404" charset="0"/>
                </a:rPr>
                <a:t>CGGTTGCTGCGTATGCGGCTTT-5'</a:t>
              </a:r>
            </a:p>
          </p:txBody>
        </p:sp>
      </p:grpSp>
      <p:sp>
        <p:nvSpPr>
          <p:cNvPr id="19" name="文本框 18">
            <a:extLst>
              <a:ext uri="{FF2B5EF4-FFF2-40B4-BE49-F238E27FC236}">
                <a16:creationId xmlns:a16="http://schemas.microsoft.com/office/drawing/2014/main" id="{066EF998-7DCE-40AA-ABD6-306802A2A5C1}"/>
              </a:ext>
            </a:extLst>
          </p:cNvPr>
          <p:cNvSpPr txBox="1"/>
          <p:nvPr/>
        </p:nvSpPr>
        <p:spPr>
          <a:xfrm>
            <a:off x="1076066" y="76880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</a:t>
            </a:r>
            <a:endParaRPr lang="zh-CN" altLang="en-US" b="1" dirty="0"/>
          </a:p>
        </p:txBody>
      </p:sp>
    </p:spTree>
    <p:custDataLst>
      <p:tags r:id="rId1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8DC52E43-A779-4AC5-A7AD-94483DE9C023}"/>
              </a:ext>
            </a:extLst>
          </p:cNvPr>
          <p:cNvGrpSpPr/>
          <p:nvPr/>
        </p:nvGrpSpPr>
        <p:grpSpPr>
          <a:xfrm>
            <a:off x="5996217" y="1072877"/>
            <a:ext cx="2601994" cy="719524"/>
            <a:chOff x="5631462" y="911538"/>
            <a:chExt cx="2601994" cy="719524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0C36E152-C703-454A-A086-083606A12B36}"/>
                </a:ext>
              </a:extLst>
            </p:cNvPr>
            <p:cNvSpPr txBox="1"/>
            <p:nvPr/>
          </p:nvSpPr>
          <p:spPr>
            <a:xfrm>
              <a:off x="5631462" y="1169397"/>
              <a:ext cx="26019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solidFill>
                    <a:schemeClr val="bg2">
                      <a:lumMod val="7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n-US" altLang="zh-CN" sz="1200" b="1" dirty="0">
                  <a:solidFill>
                    <a:schemeClr val="accent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TAGT----TCTAGAGCAC</a:t>
              </a:r>
              <a:r>
                <a:rPr lang="en-US" altLang="zh-CN" sz="1200" b="1" dirty="0">
                  <a:solidFill>
                    <a:schemeClr val="bg2">
                      <a:lumMod val="90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CGAG</a:t>
              </a:r>
            </a:p>
            <a:p>
              <a:r>
                <a:rPr lang="en-US" altLang="zh-CN" sz="1200" b="1" dirty="0">
                  <a:solidFill>
                    <a:schemeClr val="bg2">
                      <a:lumMod val="7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GATC</a:t>
              </a:r>
              <a:r>
                <a:rPr lang="en-US" altLang="zh-CN" sz="1200" b="1" dirty="0">
                  <a:solidFill>
                    <a:schemeClr val="accent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----AGATCTCGTGAGCT</a:t>
              </a:r>
              <a:r>
                <a:rPr lang="en-US" altLang="zh-CN" sz="1200" b="1" dirty="0">
                  <a:solidFill>
                    <a:schemeClr val="bg2">
                      <a:lumMod val="90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endParaRPr lang="zh-CN" altLang="en-US" sz="1200" b="1" dirty="0">
                <a:solidFill>
                  <a:schemeClr val="bg2">
                    <a:lumMod val="9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4C54017D-CFE0-49CB-8E78-9A95BA99E3AD}"/>
                </a:ext>
              </a:extLst>
            </p:cNvPr>
            <p:cNvSpPr txBox="1"/>
            <p:nvPr/>
          </p:nvSpPr>
          <p:spPr>
            <a:xfrm>
              <a:off x="6663124" y="914946"/>
              <a:ext cx="5201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/>
                <a:t>Xba</a:t>
              </a:r>
              <a:r>
                <a:rPr lang="en-US" altLang="zh-CN" sz="1000" dirty="0"/>
                <a:t> I</a:t>
              </a:r>
              <a:endParaRPr lang="zh-CN" altLang="en-US" sz="1000" dirty="0"/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ECC640D0-72F8-46C0-81B9-0B38B099F48A}"/>
                </a:ext>
              </a:extLst>
            </p:cNvPr>
            <p:cNvSpPr txBox="1"/>
            <p:nvPr/>
          </p:nvSpPr>
          <p:spPr>
            <a:xfrm>
              <a:off x="7458534" y="911538"/>
              <a:ext cx="5276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/>
                <a:t>Xho</a:t>
              </a:r>
              <a:r>
                <a:rPr lang="en-US" altLang="zh-CN" sz="1000" dirty="0"/>
                <a:t> I</a:t>
              </a:r>
              <a:endParaRPr lang="zh-CN" altLang="en-US" sz="1000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95245516-68BC-457B-B583-E3B9713065CC}"/>
                </a:ext>
              </a:extLst>
            </p:cNvPr>
            <p:cNvSpPr txBox="1"/>
            <p:nvPr/>
          </p:nvSpPr>
          <p:spPr>
            <a:xfrm>
              <a:off x="5753572" y="923837"/>
              <a:ext cx="5276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/>
                <a:t>Spe</a:t>
              </a:r>
              <a:r>
                <a:rPr lang="en-US" altLang="zh-CN" sz="1000" dirty="0"/>
                <a:t> I</a:t>
              </a:r>
              <a:endParaRPr lang="zh-CN" altLang="en-US" sz="1000" dirty="0"/>
            </a:p>
          </p:txBody>
        </p:sp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614EDCA3-4435-4D32-A45B-96B39F8E3A00}"/>
                </a:ext>
              </a:extLst>
            </p:cNvPr>
            <p:cNvCxnSpPr/>
            <p:nvPr/>
          </p:nvCxnSpPr>
          <p:spPr>
            <a:xfrm>
              <a:off x="5727445" y="1169397"/>
              <a:ext cx="5276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2DCD2DD8-5B7D-4444-B779-3C0923EAD745}"/>
                </a:ext>
              </a:extLst>
            </p:cNvPr>
            <p:cNvCxnSpPr/>
            <p:nvPr/>
          </p:nvCxnSpPr>
          <p:spPr>
            <a:xfrm>
              <a:off x="6645706" y="1169397"/>
              <a:ext cx="5276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FB5D9981-215C-4A08-A35B-028795320241}"/>
                </a:ext>
              </a:extLst>
            </p:cNvPr>
            <p:cNvCxnSpPr/>
            <p:nvPr/>
          </p:nvCxnSpPr>
          <p:spPr>
            <a:xfrm>
              <a:off x="7473923" y="1169397"/>
              <a:ext cx="5276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9292FC19-0723-4DDC-8A4D-A0F951702157}"/>
              </a:ext>
            </a:extLst>
          </p:cNvPr>
          <p:cNvGrpSpPr/>
          <p:nvPr/>
        </p:nvGrpSpPr>
        <p:grpSpPr>
          <a:xfrm>
            <a:off x="6507575" y="2066679"/>
            <a:ext cx="1579278" cy="723572"/>
            <a:chOff x="6104788" y="1937124"/>
            <a:chExt cx="1579278" cy="723572"/>
          </a:xfrm>
        </p:grpSpPr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5A7EED7A-321C-4CEB-BDCC-96B399A51EA9}"/>
                </a:ext>
              </a:extLst>
            </p:cNvPr>
            <p:cNvGrpSpPr/>
            <p:nvPr/>
          </p:nvGrpSpPr>
          <p:grpSpPr>
            <a:xfrm>
              <a:off x="6104788" y="2199031"/>
              <a:ext cx="1579278" cy="461665"/>
              <a:chOff x="6382761" y="1472278"/>
              <a:chExt cx="1579278" cy="461665"/>
            </a:xfrm>
          </p:grpSpPr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92B41AB0-5918-4973-BA4D-4C21302F9254}"/>
                  </a:ext>
                </a:extLst>
              </p:cNvPr>
              <p:cNvSpPr txBox="1"/>
              <p:nvPr/>
            </p:nvSpPr>
            <p:spPr>
              <a:xfrm>
                <a:off x="6382761" y="1472278"/>
                <a:ext cx="157927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r>
                  <a:rPr lang="en-US" altLang="zh-CN" sz="1200" b="1" dirty="0">
                    <a:solidFill>
                      <a:schemeClr val="bg2">
                        <a:lumMod val="75000"/>
                      </a:schemeClr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CTAGAGCA</a:t>
                </a:r>
                <a:r>
                  <a:rPr lang="en-US" altLang="zh-CN" sz="1200" b="1" dirty="0">
                    <a:solidFill>
                      <a:schemeClr val="bg2">
                        <a:lumMod val="90000"/>
                      </a:schemeClr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  <a:r>
                  <a:rPr lang="en-US" altLang="zh-CN" sz="12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CGAG</a:t>
                </a:r>
              </a:p>
              <a:p>
                <a:r>
                  <a:rPr lang="en-US" altLang="zh-CN" sz="12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AGATC</a:t>
                </a:r>
                <a:r>
                  <a:rPr lang="en-US" altLang="zh-CN" sz="1200" b="1" dirty="0">
                    <a:solidFill>
                      <a:schemeClr val="bg2">
                        <a:lumMod val="75000"/>
                      </a:schemeClr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CGT</a:t>
                </a:r>
                <a:r>
                  <a:rPr lang="en-US" altLang="zh-CN" sz="1200" b="1" dirty="0">
                    <a:solidFill>
                      <a:schemeClr val="bg2">
                        <a:lumMod val="90000"/>
                      </a:schemeClr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CT</a:t>
                </a:r>
                <a:r>
                  <a:rPr lang="en-US" altLang="zh-CN" sz="12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  <a:endParaRPr lang="zh-CN" altLang="en-US" sz="12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cxnSp>
            <p:nvCxnSpPr>
              <p:cNvPr id="17" name="连接符: 肘形 16">
                <a:extLst>
                  <a:ext uri="{FF2B5EF4-FFF2-40B4-BE49-F238E27FC236}">
                    <a16:creationId xmlns:a16="http://schemas.microsoft.com/office/drawing/2014/main" id="{93C46306-3B18-4C23-A993-0CB852E6855C}"/>
                  </a:ext>
                </a:extLst>
              </p:cNvPr>
              <p:cNvCxnSpPr>
                <a:cxnSpLocks/>
                <a:stCxn id="16" idx="1"/>
                <a:endCxn id="16" idx="3"/>
              </p:cNvCxnSpPr>
              <p:nvPr/>
            </p:nvCxnSpPr>
            <p:spPr>
              <a:xfrm rot="10800000" flipH="1">
                <a:off x="6382761" y="1703111"/>
                <a:ext cx="1579278" cy="12700"/>
              </a:xfrm>
              <a:prstGeom prst="bentConnector5">
                <a:avLst>
                  <a:gd name="adj1" fmla="val -14475"/>
                  <a:gd name="adj2" fmla="val -4336709"/>
                  <a:gd name="adj3" fmla="val 114475"/>
                </a:avLst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8C8050CF-6ED9-4056-89DD-97A807AAB928}"/>
                </a:ext>
              </a:extLst>
            </p:cNvPr>
            <p:cNvSpPr txBox="1"/>
            <p:nvPr/>
          </p:nvSpPr>
          <p:spPr>
            <a:xfrm>
              <a:off x="6219023" y="1940532"/>
              <a:ext cx="5201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/>
                <a:t>Xba</a:t>
              </a:r>
              <a:r>
                <a:rPr lang="en-US" altLang="zh-CN" sz="1000" dirty="0"/>
                <a:t> I</a:t>
              </a:r>
              <a:endParaRPr lang="zh-CN" altLang="en-US" sz="1000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93DAB7F0-10FF-4D3A-A7EF-62285FDFC5D4}"/>
                </a:ext>
              </a:extLst>
            </p:cNvPr>
            <p:cNvSpPr txBox="1"/>
            <p:nvPr/>
          </p:nvSpPr>
          <p:spPr>
            <a:xfrm>
              <a:off x="7014433" y="1937124"/>
              <a:ext cx="5276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/>
                <a:t>Xho</a:t>
              </a:r>
              <a:r>
                <a:rPr lang="en-US" altLang="zh-CN" sz="1000" dirty="0"/>
                <a:t> I</a:t>
              </a:r>
              <a:endParaRPr lang="zh-CN" altLang="en-US" sz="1000" dirty="0"/>
            </a:p>
          </p:txBody>
        </p: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94235748-77EA-41E9-9207-EE1F95D341D7}"/>
                </a:ext>
              </a:extLst>
            </p:cNvPr>
            <p:cNvCxnSpPr/>
            <p:nvPr/>
          </p:nvCxnSpPr>
          <p:spPr>
            <a:xfrm>
              <a:off x="6201605" y="2194983"/>
              <a:ext cx="5276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id="{61F0A198-C9C4-4E12-93F2-38BAC630408E}"/>
                </a:ext>
              </a:extLst>
            </p:cNvPr>
            <p:cNvCxnSpPr/>
            <p:nvPr/>
          </p:nvCxnSpPr>
          <p:spPr>
            <a:xfrm>
              <a:off x="7029822" y="2194983"/>
              <a:ext cx="5276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2E4C0671-E328-4802-82A3-16F5563A3D13}"/>
              </a:ext>
            </a:extLst>
          </p:cNvPr>
          <p:cNvGrpSpPr/>
          <p:nvPr/>
        </p:nvGrpSpPr>
        <p:grpSpPr>
          <a:xfrm>
            <a:off x="7196549" y="1858691"/>
            <a:ext cx="201330" cy="186564"/>
            <a:chOff x="6643607" y="4010741"/>
            <a:chExt cx="250820" cy="250820"/>
          </a:xfrm>
        </p:grpSpPr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4D76A13A-4449-4B8D-8282-1B31E8E60396}"/>
                </a:ext>
              </a:extLst>
            </p:cNvPr>
            <p:cNvCxnSpPr/>
            <p:nvPr/>
          </p:nvCxnSpPr>
          <p:spPr>
            <a:xfrm>
              <a:off x="6643607" y="4125505"/>
              <a:ext cx="25082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030692C2-5338-4006-BCB3-D314E34FDF5F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6652316" y="4136151"/>
              <a:ext cx="25082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4CC9B7B9-AA11-4973-9E53-DB579B720C2E}"/>
              </a:ext>
            </a:extLst>
          </p:cNvPr>
          <p:cNvGrpSpPr/>
          <p:nvPr/>
        </p:nvGrpSpPr>
        <p:grpSpPr>
          <a:xfrm>
            <a:off x="6042704" y="3630485"/>
            <a:ext cx="2509020" cy="1037039"/>
            <a:chOff x="6252986" y="3705983"/>
            <a:chExt cx="2509020" cy="1037039"/>
          </a:xfrm>
        </p:grpSpPr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id="{7291EF85-1BE0-48FF-8303-CCF6B11DC635}"/>
                </a:ext>
              </a:extLst>
            </p:cNvPr>
            <p:cNvGrpSpPr/>
            <p:nvPr/>
          </p:nvGrpSpPr>
          <p:grpSpPr>
            <a:xfrm>
              <a:off x="6252986" y="4281357"/>
              <a:ext cx="2509020" cy="461665"/>
              <a:chOff x="6382761" y="1472278"/>
              <a:chExt cx="2509020" cy="461665"/>
            </a:xfrm>
          </p:grpSpPr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2C759598-D8C2-43F2-93DD-4BE6742FFD1D}"/>
                  </a:ext>
                </a:extLst>
              </p:cNvPr>
              <p:cNvSpPr txBox="1"/>
              <p:nvPr/>
            </p:nvSpPr>
            <p:spPr>
              <a:xfrm>
                <a:off x="6382761" y="1472278"/>
                <a:ext cx="250902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r>
                  <a:rPr lang="en-US" altLang="zh-CN" sz="1200" b="1" dirty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CTAGT----TCTAGAGCAC</a:t>
                </a:r>
                <a:r>
                  <a:rPr lang="en-US" altLang="zh-CN" sz="12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CGAG</a:t>
                </a:r>
              </a:p>
              <a:p>
                <a:r>
                  <a:rPr lang="en-US" altLang="zh-CN" sz="12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AGATC</a:t>
                </a:r>
                <a:r>
                  <a:rPr lang="en-US" altLang="zh-CN" sz="1200" b="1" dirty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----AGATCTCGTGAGCT</a:t>
                </a:r>
                <a:r>
                  <a:rPr lang="en-US" altLang="zh-CN" sz="12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  <a:endParaRPr lang="zh-CN" altLang="en-US" sz="12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cxnSp>
            <p:nvCxnSpPr>
              <p:cNvPr id="35" name="连接符: 肘形 34">
                <a:extLst>
                  <a:ext uri="{FF2B5EF4-FFF2-40B4-BE49-F238E27FC236}">
                    <a16:creationId xmlns:a16="http://schemas.microsoft.com/office/drawing/2014/main" id="{288AD44E-EB7F-4304-B9AF-220D23A096C9}"/>
                  </a:ext>
                </a:extLst>
              </p:cNvPr>
              <p:cNvCxnSpPr>
                <a:cxnSpLocks/>
                <a:stCxn id="34" idx="1"/>
                <a:endCxn id="34" idx="3"/>
              </p:cNvCxnSpPr>
              <p:nvPr/>
            </p:nvCxnSpPr>
            <p:spPr>
              <a:xfrm rot="10800000" flipH="1">
                <a:off x="6382761" y="1703111"/>
                <a:ext cx="2509020" cy="12700"/>
              </a:xfrm>
              <a:prstGeom prst="bentConnector5">
                <a:avLst>
                  <a:gd name="adj1" fmla="val -9111"/>
                  <a:gd name="adj2" fmla="val -6805283"/>
                  <a:gd name="adj3" fmla="val 109111"/>
                </a:avLst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D5D24D6D-020E-4874-8879-846B9E500D65}"/>
                </a:ext>
              </a:extLst>
            </p:cNvPr>
            <p:cNvSpPr txBox="1"/>
            <p:nvPr/>
          </p:nvSpPr>
          <p:spPr>
            <a:xfrm>
              <a:off x="7281985" y="4042830"/>
              <a:ext cx="5201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/>
                <a:t>Xba</a:t>
              </a:r>
              <a:r>
                <a:rPr lang="en-US" altLang="zh-CN" sz="1000" dirty="0"/>
                <a:t> I</a:t>
              </a:r>
              <a:endParaRPr lang="zh-CN" altLang="en-US" sz="1000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6A819B77-E8E7-4E18-B5BF-88C900CC69AF}"/>
                </a:ext>
              </a:extLst>
            </p:cNvPr>
            <p:cNvSpPr txBox="1"/>
            <p:nvPr/>
          </p:nvSpPr>
          <p:spPr>
            <a:xfrm>
              <a:off x="8094320" y="4028997"/>
              <a:ext cx="5276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/>
                <a:t>Xho</a:t>
              </a:r>
              <a:r>
                <a:rPr lang="en-US" altLang="zh-CN" sz="1000" dirty="0"/>
                <a:t> I</a:t>
              </a:r>
              <a:endParaRPr lang="zh-CN" altLang="en-US" sz="1000" dirty="0"/>
            </a:p>
          </p:txBody>
        </p: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F1E8D7B6-382C-4B77-B36E-69934707EF3F}"/>
                </a:ext>
              </a:extLst>
            </p:cNvPr>
            <p:cNvCxnSpPr/>
            <p:nvPr/>
          </p:nvCxnSpPr>
          <p:spPr>
            <a:xfrm>
              <a:off x="7264567" y="4297281"/>
              <a:ext cx="5276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DFF507D9-B5F8-4B72-ADB1-1FA7D7B905A4}"/>
                </a:ext>
              </a:extLst>
            </p:cNvPr>
            <p:cNvCxnSpPr/>
            <p:nvPr/>
          </p:nvCxnSpPr>
          <p:spPr>
            <a:xfrm>
              <a:off x="8109709" y="4286856"/>
              <a:ext cx="5276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D8AD6B38-C80C-41BB-90F0-535FDDD3D8FE}"/>
                </a:ext>
              </a:extLst>
            </p:cNvPr>
            <p:cNvSpPr txBox="1"/>
            <p:nvPr/>
          </p:nvSpPr>
          <p:spPr>
            <a:xfrm>
              <a:off x="6383519" y="4029056"/>
              <a:ext cx="5201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/>
                <a:t>Xba</a:t>
              </a:r>
              <a:r>
                <a:rPr lang="en-US" altLang="zh-CN" sz="1000" dirty="0"/>
                <a:t> I</a:t>
              </a:r>
              <a:endParaRPr lang="zh-CN" altLang="en-US" sz="1000" dirty="0"/>
            </a:p>
          </p:txBody>
        </p:sp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4AF3CE13-D31A-41C4-B45E-C614C4FA80C2}"/>
                </a:ext>
              </a:extLst>
            </p:cNvPr>
            <p:cNvCxnSpPr/>
            <p:nvPr/>
          </p:nvCxnSpPr>
          <p:spPr>
            <a:xfrm>
              <a:off x="6366101" y="4283507"/>
              <a:ext cx="5276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4EFB692E-9EFB-4378-A211-00EE4A9D4A0C}"/>
                </a:ext>
              </a:extLst>
            </p:cNvPr>
            <p:cNvSpPr txBox="1"/>
            <p:nvPr/>
          </p:nvSpPr>
          <p:spPr>
            <a:xfrm>
              <a:off x="6381555" y="3705983"/>
              <a:ext cx="5201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/>
                <a:t>Spe</a:t>
              </a:r>
              <a:r>
                <a:rPr lang="en-US" altLang="zh-CN" sz="1000" dirty="0"/>
                <a:t> I</a:t>
              </a:r>
              <a:endParaRPr lang="zh-CN" altLang="en-US" sz="1000" dirty="0"/>
            </a:p>
          </p:txBody>
        </p: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1885CB1A-4BED-4DD6-A86E-778B468995AD}"/>
                </a:ext>
              </a:extLst>
            </p:cNvPr>
            <p:cNvCxnSpPr/>
            <p:nvPr/>
          </p:nvCxnSpPr>
          <p:spPr>
            <a:xfrm>
              <a:off x="6364137" y="3960434"/>
              <a:ext cx="527640" cy="0"/>
            </a:xfrm>
            <a:prstGeom prst="line">
              <a:avLst/>
            </a:prstGeom>
            <a:ln w="19050">
              <a:solidFill>
                <a:schemeClr val="accent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82630388-D5B9-4071-B5E5-0D2104DA520E}"/>
                </a:ext>
              </a:extLst>
            </p:cNvPr>
            <p:cNvGrpSpPr/>
            <p:nvPr/>
          </p:nvGrpSpPr>
          <p:grpSpPr>
            <a:xfrm rot="2921094">
              <a:off x="6343165" y="3954834"/>
              <a:ext cx="569585" cy="150769"/>
              <a:chOff x="6473838" y="4079950"/>
              <a:chExt cx="589157" cy="158947"/>
            </a:xfrm>
          </p:grpSpPr>
          <p:cxnSp>
            <p:nvCxnSpPr>
              <p:cNvPr id="32" name="直接连接符 31">
                <a:extLst>
                  <a:ext uri="{FF2B5EF4-FFF2-40B4-BE49-F238E27FC236}">
                    <a16:creationId xmlns:a16="http://schemas.microsoft.com/office/drawing/2014/main" id="{679BF84D-15E8-4EB4-9F4F-36CAB0FFB776}"/>
                  </a:ext>
                </a:extLst>
              </p:cNvPr>
              <p:cNvCxnSpPr>
                <a:cxnSpLocks/>
              </p:cNvCxnSpPr>
              <p:nvPr/>
            </p:nvCxnSpPr>
            <p:spPr>
              <a:xfrm rot="18678906">
                <a:off x="6703422" y="3879323"/>
                <a:ext cx="129990" cy="589157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接连接符 32">
                <a:extLst>
                  <a:ext uri="{FF2B5EF4-FFF2-40B4-BE49-F238E27FC236}">
                    <a16:creationId xmlns:a16="http://schemas.microsoft.com/office/drawing/2014/main" id="{8B09BEE5-DFA5-4690-B399-6D0251699DEA}"/>
                  </a:ext>
                </a:extLst>
              </p:cNvPr>
              <p:cNvCxnSpPr>
                <a:cxnSpLocks/>
              </p:cNvCxnSpPr>
              <p:nvPr/>
            </p:nvCxnSpPr>
            <p:spPr>
              <a:xfrm rot="18678906" flipV="1">
                <a:off x="6673878" y="3897098"/>
                <a:ext cx="158369" cy="524073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2BD34C5C-6635-4606-8F2B-09CD4E9B25DE}"/>
              </a:ext>
            </a:extLst>
          </p:cNvPr>
          <p:cNvCxnSpPr>
            <a:cxnSpLocks/>
          </p:cNvCxnSpPr>
          <p:nvPr/>
        </p:nvCxnSpPr>
        <p:spPr>
          <a:xfrm>
            <a:off x="7297214" y="3293999"/>
            <a:ext cx="0" cy="356455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矩形 36">
            <a:extLst>
              <a:ext uri="{FF2B5EF4-FFF2-40B4-BE49-F238E27FC236}">
                <a16:creationId xmlns:a16="http://schemas.microsoft.com/office/drawing/2014/main" id="{69A40B42-9CF2-4FDD-9800-5177F4C2D0F9}"/>
              </a:ext>
            </a:extLst>
          </p:cNvPr>
          <p:cNvSpPr/>
          <p:nvPr/>
        </p:nvSpPr>
        <p:spPr>
          <a:xfrm>
            <a:off x="3463386" y="1332803"/>
            <a:ext cx="17700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b="1" dirty="0">
                <a:solidFill>
                  <a:schemeClr val="accent1"/>
                </a:solidFill>
              </a:rPr>
              <a:t>Digested insert</a:t>
            </a:r>
            <a:endParaRPr lang="zh-CN" altLang="en-US" b="1" dirty="0">
              <a:solidFill>
                <a:schemeClr val="accent1"/>
              </a:solidFill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B4231276-CF6D-4A91-8D59-CA278927182F}"/>
              </a:ext>
            </a:extLst>
          </p:cNvPr>
          <p:cNvSpPr/>
          <p:nvPr/>
        </p:nvSpPr>
        <p:spPr>
          <a:xfrm>
            <a:off x="3463386" y="2559418"/>
            <a:ext cx="1838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b="1" dirty="0"/>
              <a:t>Digested vector</a:t>
            </a:r>
            <a:endParaRPr lang="zh-CN" altLang="en-US" b="1" dirty="0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835DADF7-2C47-4376-BB50-86D5D21EFDD4}"/>
              </a:ext>
            </a:extLst>
          </p:cNvPr>
          <p:cNvSpPr/>
          <p:nvPr/>
        </p:nvSpPr>
        <p:spPr>
          <a:xfrm>
            <a:off x="3463386" y="4482858"/>
            <a:ext cx="13789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b="1" dirty="0">
                <a:solidFill>
                  <a:schemeClr val="accent1"/>
                </a:solidFill>
              </a:rPr>
              <a:t>New vector</a:t>
            </a:r>
            <a:endParaRPr lang="zh-CN" altLang="en-US" b="1" dirty="0">
              <a:solidFill>
                <a:schemeClr val="accent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485932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4" name="组合 73">
            <a:extLst>
              <a:ext uri="{FF2B5EF4-FFF2-40B4-BE49-F238E27FC236}">
                <a16:creationId xmlns:a16="http://schemas.microsoft.com/office/drawing/2014/main" id="{B748A051-C182-4FA1-A520-8FF09EE1F124}"/>
              </a:ext>
            </a:extLst>
          </p:cNvPr>
          <p:cNvGrpSpPr/>
          <p:nvPr/>
        </p:nvGrpSpPr>
        <p:grpSpPr>
          <a:xfrm>
            <a:off x="2138344" y="532624"/>
            <a:ext cx="1841947" cy="3216539"/>
            <a:chOff x="2138344" y="532624"/>
            <a:chExt cx="1841947" cy="3216539"/>
          </a:xfrm>
        </p:grpSpPr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581C39A7-0D3D-44EA-BA1E-21F82CF9FFAB}"/>
                </a:ext>
              </a:extLst>
            </p:cNvPr>
            <p:cNvGrpSpPr/>
            <p:nvPr/>
          </p:nvGrpSpPr>
          <p:grpSpPr>
            <a:xfrm>
              <a:off x="2268259" y="874532"/>
              <a:ext cx="1423678" cy="369332"/>
              <a:chOff x="4147325" y="2697312"/>
              <a:chExt cx="1423678" cy="369332"/>
            </a:xfrm>
          </p:grpSpPr>
          <p:cxnSp>
            <p:nvCxnSpPr>
              <p:cNvPr id="25" name="直接连接符 24">
                <a:extLst>
                  <a:ext uri="{FF2B5EF4-FFF2-40B4-BE49-F238E27FC236}">
                    <a16:creationId xmlns:a16="http://schemas.microsoft.com/office/drawing/2014/main" id="{940CE637-7019-4806-93F5-F82604DCA25D}"/>
                  </a:ext>
                </a:extLst>
              </p:cNvPr>
              <p:cNvCxnSpPr>
                <a:cxnSpLocks/>
                <a:stCxn id="27" idx="3"/>
                <a:endCxn id="30" idx="1"/>
              </p:cNvCxnSpPr>
              <p:nvPr/>
            </p:nvCxnSpPr>
            <p:spPr bwMode="auto">
              <a:xfrm>
                <a:off x="4732742" y="2881978"/>
                <a:ext cx="713449" cy="0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26" name="Right Arrow 11">
                <a:extLst>
                  <a:ext uri="{FF2B5EF4-FFF2-40B4-BE49-F238E27FC236}">
                    <a16:creationId xmlns:a16="http://schemas.microsoft.com/office/drawing/2014/main" id="{533E2EBC-B538-4271-BA31-AD3CD485D92B}"/>
                  </a:ext>
                </a:extLst>
              </p:cNvPr>
              <p:cNvSpPr/>
              <p:nvPr/>
            </p:nvSpPr>
            <p:spPr bwMode="auto">
              <a:xfrm>
                <a:off x="4229017" y="2737978"/>
                <a:ext cx="473729" cy="288000"/>
              </a:xfrm>
              <a:prstGeom prst="rightArrow">
                <a:avLst>
                  <a:gd name="adj1" fmla="val 73759"/>
                  <a:gd name="adj2" fmla="val 50000"/>
                </a:avLst>
              </a:prstGeom>
              <a:solidFill>
                <a:srgbClr val="00B0F0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 typeface="Arial" panose="020B0604020202020204" pitchFamily="34" charset="0"/>
                  <a:buNone/>
                  <a:tabLst/>
                </a:pPr>
                <a:endParaRPr kumimoji="0" lang="zh-CN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27" name="TextBox 12">
                <a:extLst>
                  <a:ext uri="{FF2B5EF4-FFF2-40B4-BE49-F238E27FC236}">
                    <a16:creationId xmlns:a16="http://schemas.microsoft.com/office/drawing/2014/main" id="{CBDB833D-457C-43AC-8853-803CCD8B4A25}"/>
                  </a:ext>
                </a:extLst>
              </p:cNvPr>
              <p:cNvSpPr txBox="1"/>
              <p:nvPr/>
            </p:nvSpPr>
            <p:spPr>
              <a:xfrm>
                <a:off x="4147325" y="2697312"/>
                <a:ext cx="58541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P</a:t>
                </a:r>
                <a:r>
                  <a:rPr lang="en-US" altLang="zh-CN" sz="1200" dirty="0"/>
                  <a:t>35S</a:t>
                </a:r>
                <a:endParaRPr lang="zh-CN" altLang="en-US" sz="1200" dirty="0"/>
              </a:p>
            </p:txBody>
          </p:sp>
          <p:sp>
            <p:nvSpPr>
              <p:cNvPr id="28" name="Rectangle 14">
                <a:extLst>
                  <a:ext uri="{FF2B5EF4-FFF2-40B4-BE49-F238E27FC236}">
                    <a16:creationId xmlns:a16="http://schemas.microsoft.com/office/drawing/2014/main" id="{65F8C01E-13C9-4A09-B5E0-5667EA40072E}"/>
                  </a:ext>
                </a:extLst>
              </p:cNvPr>
              <p:cNvSpPr/>
              <p:nvPr/>
            </p:nvSpPr>
            <p:spPr bwMode="auto">
              <a:xfrm>
                <a:off x="4760391" y="2773978"/>
                <a:ext cx="641884" cy="216000"/>
              </a:xfrm>
              <a:prstGeom prst="rect">
                <a:avLst/>
              </a:prstGeom>
              <a:solidFill>
                <a:srgbClr val="00B050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 typeface="Arial" panose="020B0604020202020204" pitchFamily="34" charset="0"/>
                  <a:buNone/>
                  <a:tabLst/>
                </a:pPr>
                <a:endParaRPr kumimoji="0" lang="zh-CN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29" name="TextBox 15">
                <a:extLst>
                  <a:ext uri="{FF2B5EF4-FFF2-40B4-BE49-F238E27FC236}">
                    <a16:creationId xmlns:a16="http://schemas.microsoft.com/office/drawing/2014/main" id="{1506DA81-4112-4E2B-9099-6667149C5067}"/>
                  </a:ext>
                </a:extLst>
              </p:cNvPr>
              <p:cNvSpPr txBox="1"/>
              <p:nvPr/>
            </p:nvSpPr>
            <p:spPr>
              <a:xfrm>
                <a:off x="4828429" y="2728090"/>
                <a:ext cx="5533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GFP</a:t>
                </a:r>
                <a:endParaRPr lang="zh-CN" altLang="en-US" sz="1400" dirty="0"/>
              </a:p>
            </p:txBody>
          </p:sp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id="{10A8CE8B-7255-4A8F-AE5F-B3DB1F85B784}"/>
                  </a:ext>
                </a:extLst>
              </p:cNvPr>
              <p:cNvSpPr/>
              <p:nvPr/>
            </p:nvSpPr>
            <p:spPr bwMode="auto">
              <a:xfrm>
                <a:off x="5446191" y="2773978"/>
                <a:ext cx="124812" cy="216000"/>
              </a:xfrm>
              <a:prstGeom prst="rect">
                <a:avLst/>
              </a:prstGeom>
              <a:solidFill>
                <a:srgbClr val="C00000"/>
              </a:solidFill>
              <a:ln w="9525" cap="flat" cmpd="sng" algn="ctr">
                <a:solidFill>
                  <a:srgbClr val="C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 typeface="Arial" panose="020B0604020202020204" pitchFamily="34" charset="0"/>
                  <a:buNone/>
                  <a:tabLst/>
                </a:pPr>
                <a:endParaRPr kumimoji="0" lang="zh-CN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DB8287FD-6774-4496-A3AF-19F80466AE3B}"/>
                  </a:ext>
                </a:extLst>
              </p:cNvPr>
              <p:cNvSpPr/>
              <p:nvPr/>
            </p:nvSpPr>
            <p:spPr bwMode="auto">
              <a:xfrm>
                <a:off x="4819675" y="2773421"/>
                <a:ext cx="36000" cy="216000"/>
              </a:xfrm>
              <a:prstGeom prst="rect">
                <a:avLst/>
              </a:prstGeom>
              <a:solidFill>
                <a:srgbClr val="92D050"/>
              </a:solidFill>
              <a:ln w="9525" cap="flat" cmpd="sng" algn="ctr">
                <a:solidFill>
                  <a:srgbClr val="92D05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 typeface="Arial" panose="020B0604020202020204" pitchFamily="34" charset="0"/>
                  <a:buNone/>
                  <a:tabLst/>
                </a:pPr>
                <a:endParaRPr kumimoji="0" lang="zh-CN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</p:grp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382ABB7C-FF8F-470A-9826-C50672835FD7}"/>
                </a:ext>
              </a:extLst>
            </p:cNvPr>
            <p:cNvSpPr/>
            <p:nvPr/>
          </p:nvSpPr>
          <p:spPr>
            <a:xfrm>
              <a:off x="2138344" y="1681460"/>
              <a:ext cx="1841947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600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L  X  </a:t>
              </a:r>
              <a:r>
                <a:rPr lang="en-US" altLang="zh-CN" sz="600" dirty="0" err="1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X</a:t>
              </a:r>
              <a:r>
                <a:rPr lang="en-US" altLang="zh-CN" sz="600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</a:t>
              </a:r>
              <a:r>
                <a:rPr lang="en-US" altLang="zh-CN" sz="600" dirty="0" err="1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X</a:t>
              </a:r>
              <a:r>
                <a:rPr lang="en-US" altLang="zh-CN" sz="600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</a:t>
              </a:r>
              <a:r>
                <a:rPr lang="en-US" altLang="zh-CN" sz="600" dirty="0" err="1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X</a:t>
              </a:r>
              <a:r>
                <a:rPr lang="en-US" altLang="zh-CN" sz="600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</a:t>
              </a:r>
              <a:r>
                <a:rPr lang="en-US" altLang="zh-CN" sz="600" dirty="0" err="1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X</a:t>
              </a:r>
              <a:r>
                <a:rPr lang="en-US" altLang="zh-CN" sz="600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</a:t>
              </a:r>
              <a:r>
                <a:rPr lang="en-US" altLang="zh-CN" sz="600" dirty="0" err="1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X</a:t>
              </a:r>
              <a:r>
                <a:rPr lang="en-US" altLang="zh-CN" sz="600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</a:t>
              </a:r>
              <a:r>
                <a:rPr lang="en-US" altLang="zh-CN" sz="600" dirty="0" err="1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X</a:t>
              </a:r>
              <a:r>
                <a:rPr lang="en-US" altLang="zh-CN" sz="600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</a:t>
              </a:r>
              <a:r>
                <a:rPr lang="en-US" altLang="zh-CN" sz="600" dirty="0" err="1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X</a:t>
              </a:r>
              <a:r>
                <a:rPr lang="en-US" altLang="zh-CN" sz="600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</a:t>
              </a:r>
              <a:r>
                <a:rPr lang="en-US" altLang="zh-CN" sz="600" dirty="0" err="1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X</a:t>
              </a:r>
              <a:r>
                <a:rPr lang="en-US" altLang="zh-CN" sz="600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</a:t>
              </a:r>
              <a:r>
                <a:rPr lang="en-US" altLang="zh-CN" sz="600" dirty="0" err="1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X</a:t>
              </a:r>
              <a:r>
                <a:rPr lang="en-US" altLang="zh-CN" sz="600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R</a:t>
              </a:r>
            </a:p>
            <a:p>
              <a:r>
                <a:rPr lang="en-US" altLang="zh-CN" sz="600" b="1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en-US" altLang="zh-CN" sz="600" u="sng" dirty="0">
                  <a:solidFill>
                    <a:srgbClr val="92D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CGANNNNNNNNNNNNNNNNNNNNNNNNNN</a:t>
              </a:r>
              <a:r>
                <a:rPr lang="en-US" altLang="zh-CN" sz="600" b="1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TAGA</a:t>
              </a:r>
            </a:p>
            <a:p>
              <a:r>
                <a:rPr lang="en-US" altLang="zh-CN" sz="600" b="1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AGCT</a:t>
              </a:r>
              <a:r>
                <a:rPr lang="en-US" altLang="zh-CN" sz="600" u="sng" dirty="0">
                  <a:solidFill>
                    <a:srgbClr val="92D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NNNNNNNNNNNNNNNNNNNNNNNNNNGATC</a:t>
              </a:r>
              <a:r>
                <a:rPr lang="en-US" altLang="zh-CN" sz="600" b="1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</a:p>
            <a:p>
              <a:r>
                <a:rPr lang="en-US" altLang="zh-CN" sz="600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zh-CN" sz="600" dirty="0" err="1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XhoI</a:t>
              </a:r>
              <a:r>
                <a:rPr lang="en-US" altLang="zh-CN" sz="600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 </a:t>
              </a:r>
              <a:r>
                <a:rPr lang="en-US" altLang="zh-CN" sz="600" b="1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miRNA binding site</a:t>
              </a:r>
              <a:r>
                <a:rPr lang="en-US" altLang="zh-CN" sz="600" dirty="0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  </a:t>
              </a:r>
              <a:r>
                <a:rPr lang="en-US" altLang="zh-CN" sz="600" dirty="0" err="1">
                  <a:solidFill>
                    <a:srgbClr val="0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XbaI</a:t>
              </a:r>
              <a:endParaRPr lang="en-US" altLang="zh-CN" sz="600" b="1" dirty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9F70317F-AA01-4327-8C14-152781439C2E}"/>
                </a:ext>
              </a:extLst>
            </p:cNvPr>
            <p:cNvGrpSpPr/>
            <p:nvPr/>
          </p:nvGrpSpPr>
          <p:grpSpPr>
            <a:xfrm>
              <a:off x="2263834" y="1824067"/>
              <a:ext cx="198000" cy="180000"/>
              <a:chOff x="4953000" y="3361869"/>
              <a:chExt cx="282678" cy="238490"/>
            </a:xfrm>
          </p:grpSpPr>
          <p:cxnSp>
            <p:nvCxnSpPr>
              <p:cNvPr id="34" name="直接连接符 33">
                <a:extLst>
                  <a:ext uri="{FF2B5EF4-FFF2-40B4-BE49-F238E27FC236}">
                    <a16:creationId xmlns:a16="http://schemas.microsoft.com/office/drawing/2014/main" id="{6F9E088A-065F-464D-809B-6B14489CA979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4953000" y="3361869"/>
                <a:ext cx="0" cy="115586"/>
              </a:xfrm>
              <a:prstGeom prst="line">
                <a:avLst/>
              </a:prstGeom>
              <a:solidFill>
                <a:schemeClr val="accent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35" name="直接连接符 34">
                <a:extLst>
                  <a:ext uri="{FF2B5EF4-FFF2-40B4-BE49-F238E27FC236}">
                    <a16:creationId xmlns:a16="http://schemas.microsoft.com/office/drawing/2014/main" id="{380BA368-0A07-4231-AC76-AF44596622CE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5235678" y="3484773"/>
                <a:ext cx="0" cy="115586"/>
              </a:xfrm>
              <a:prstGeom prst="line">
                <a:avLst/>
              </a:prstGeom>
              <a:solidFill>
                <a:schemeClr val="accent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36" name="直接连接符 35">
                <a:extLst>
                  <a:ext uri="{FF2B5EF4-FFF2-40B4-BE49-F238E27FC236}">
                    <a16:creationId xmlns:a16="http://schemas.microsoft.com/office/drawing/2014/main" id="{9F2AEB1A-C834-4F47-8FF8-AE79ADCA8EAA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4953000" y="3477455"/>
                <a:ext cx="282678" cy="0"/>
              </a:xfrm>
              <a:prstGeom prst="line">
                <a:avLst/>
              </a:prstGeom>
              <a:solidFill>
                <a:schemeClr val="accent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sp>
          <p:nvSpPr>
            <p:cNvPr id="37" name="任意多边形: 形状 36">
              <a:extLst>
                <a:ext uri="{FF2B5EF4-FFF2-40B4-BE49-F238E27FC236}">
                  <a16:creationId xmlns:a16="http://schemas.microsoft.com/office/drawing/2014/main" id="{524D3AF4-7C6C-4547-90EA-C439AE9ECA8F}"/>
                </a:ext>
              </a:extLst>
            </p:cNvPr>
            <p:cNvSpPr/>
            <p:nvPr/>
          </p:nvSpPr>
          <p:spPr bwMode="auto">
            <a:xfrm>
              <a:off x="2241424" y="1186925"/>
              <a:ext cx="1651820" cy="528112"/>
            </a:xfrm>
            <a:custGeom>
              <a:avLst/>
              <a:gdLst>
                <a:gd name="connsiteX0" fmla="*/ 715297 w 1651820"/>
                <a:gd name="connsiteY0" fmla="*/ 0 h 442451"/>
                <a:gd name="connsiteX1" fmla="*/ 0 w 1651820"/>
                <a:gd name="connsiteY1" fmla="*/ 442451 h 442451"/>
                <a:gd name="connsiteX2" fmla="*/ 1651820 w 1651820"/>
                <a:gd name="connsiteY2" fmla="*/ 442451 h 442451"/>
                <a:gd name="connsiteX3" fmla="*/ 715297 w 1651820"/>
                <a:gd name="connsiteY3" fmla="*/ 0 h 4424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51820" h="442451">
                  <a:moveTo>
                    <a:pt x="715297" y="0"/>
                  </a:moveTo>
                  <a:lnTo>
                    <a:pt x="0" y="442451"/>
                  </a:lnTo>
                  <a:lnTo>
                    <a:pt x="1651820" y="442451"/>
                  </a:lnTo>
                  <a:lnTo>
                    <a:pt x="715297" y="0"/>
                  </a:lnTo>
                  <a:close/>
                </a:path>
              </a:pathLst>
            </a:custGeom>
            <a:gradFill flip="none" rotWithShape="1">
              <a:gsLst>
                <a:gs pos="0">
                  <a:srgbClr val="00B050"/>
                </a:gs>
                <a:gs pos="100000">
                  <a:srgbClr val="BAE18F"/>
                </a:gs>
              </a:gsLst>
              <a:lin ang="5400000" scaled="1"/>
              <a:tileRect/>
            </a:gra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None/>
                <a:tabLst/>
              </a:pPr>
              <a:endParaRPr kumimoji="0" lang="zh-CN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grpSp>
          <p:nvGrpSpPr>
            <p:cNvPr id="38" name="组合 37">
              <a:extLst>
                <a:ext uri="{FF2B5EF4-FFF2-40B4-BE49-F238E27FC236}">
                  <a16:creationId xmlns:a16="http://schemas.microsoft.com/office/drawing/2014/main" id="{9AE24B69-DD41-423C-B9C3-69C4BEB2BF33}"/>
                </a:ext>
              </a:extLst>
            </p:cNvPr>
            <p:cNvGrpSpPr/>
            <p:nvPr/>
          </p:nvGrpSpPr>
          <p:grpSpPr>
            <a:xfrm>
              <a:off x="3644064" y="1825825"/>
              <a:ext cx="198000" cy="180000"/>
              <a:chOff x="4953000" y="3361869"/>
              <a:chExt cx="282678" cy="238490"/>
            </a:xfrm>
          </p:grpSpPr>
          <p:cxnSp>
            <p:nvCxnSpPr>
              <p:cNvPr id="39" name="直接连接符 38">
                <a:extLst>
                  <a:ext uri="{FF2B5EF4-FFF2-40B4-BE49-F238E27FC236}">
                    <a16:creationId xmlns:a16="http://schemas.microsoft.com/office/drawing/2014/main" id="{CDF92684-5661-4541-8DA4-C00B43013D6E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4953000" y="3361869"/>
                <a:ext cx="0" cy="115586"/>
              </a:xfrm>
              <a:prstGeom prst="line">
                <a:avLst/>
              </a:prstGeom>
              <a:solidFill>
                <a:schemeClr val="accent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40" name="直接连接符 39">
                <a:extLst>
                  <a:ext uri="{FF2B5EF4-FFF2-40B4-BE49-F238E27FC236}">
                    <a16:creationId xmlns:a16="http://schemas.microsoft.com/office/drawing/2014/main" id="{40CB20BD-2A2A-46DF-BE1A-5336322EC8E6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5235678" y="3484773"/>
                <a:ext cx="0" cy="115586"/>
              </a:xfrm>
              <a:prstGeom prst="line">
                <a:avLst/>
              </a:prstGeom>
              <a:solidFill>
                <a:schemeClr val="accent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41" name="直接连接符 40">
                <a:extLst>
                  <a:ext uri="{FF2B5EF4-FFF2-40B4-BE49-F238E27FC236}">
                    <a16:creationId xmlns:a16="http://schemas.microsoft.com/office/drawing/2014/main" id="{A3A47ADE-8BE5-452F-A050-1A972C4447CC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4953000" y="3477455"/>
                <a:ext cx="282678" cy="0"/>
              </a:xfrm>
              <a:prstGeom prst="line">
                <a:avLst/>
              </a:prstGeom>
              <a:solidFill>
                <a:schemeClr val="accent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07A91112-0225-4E12-9AD4-F249053CAB9A}"/>
                </a:ext>
              </a:extLst>
            </p:cNvPr>
            <p:cNvSpPr txBox="1"/>
            <p:nvPr/>
          </p:nvSpPr>
          <p:spPr>
            <a:xfrm>
              <a:off x="2241424" y="532624"/>
              <a:ext cx="15905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/>
                <a:t>miRNA sensor construct</a:t>
              </a:r>
              <a:endParaRPr lang="zh-CN" altLang="en-US" sz="1000" b="1" dirty="0"/>
            </a:p>
          </p:txBody>
        </p:sp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id="{D8304017-CC05-4EBD-9247-8DB0DDD0ABFE}"/>
                </a:ext>
              </a:extLst>
            </p:cNvPr>
            <p:cNvGrpSpPr/>
            <p:nvPr/>
          </p:nvGrpSpPr>
          <p:grpSpPr>
            <a:xfrm>
              <a:off x="2339470" y="2627028"/>
              <a:ext cx="1456682" cy="184666"/>
              <a:chOff x="1503111" y="2320505"/>
              <a:chExt cx="1456682" cy="184666"/>
            </a:xfrm>
          </p:grpSpPr>
          <p:grpSp>
            <p:nvGrpSpPr>
              <p:cNvPr id="47" name="组合 46">
                <a:extLst>
                  <a:ext uri="{FF2B5EF4-FFF2-40B4-BE49-F238E27FC236}">
                    <a16:creationId xmlns:a16="http://schemas.microsoft.com/office/drawing/2014/main" id="{FBCE8A4A-D209-4C96-858D-7611D945F436}"/>
                  </a:ext>
                </a:extLst>
              </p:cNvPr>
              <p:cNvGrpSpPr/>
              <p:nvPr/>
            </p:nvGrpSpPr>
            <p:grpSpPr>
              <a:xfrm>
                <a:off x="1555878" y="2412838"/>
                <a:ext cx="1058874" cy="0"/>
                <a:chOff x="1612900" y="2565400"/>
                <a:chExt cx="1058874" cy="0"/>
              </a:xfrm>
            </p:grpSpPr>
            <p:cxnSp>
              <p:nvCxnSpPr>
                <p:cNvPr id="44" name="直接连接符 43">
                  <a:extLst>
                    <a:ext uri="{FF2B5EF4-FFF2-40B4-BE49-F238E27FC236}">
                      <a16:creationId xmlns:a16="http://schemas.microsoft.com/office/drawing/2014/main" id="{1478FF41-087B-43D7-932F-0B44FB19C41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12900" y="2565400"/>
                  <a:ext cx="105887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直接连接符 44">
                  <a:extLst>
                    <a:ext uri="{FF2B5EF4-FFF2-40B4-BE49-F238E27FC236}">
                      <a16:creationId xmlns:a16="http://schemas.microsoft.com/office/drawing/2014/main" id="{3416BB8D-2B36-4381-AF09-1C0CCAA1147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99612" y="2565400"/>
                  <a:ext cx="864000" cy="0"/>
                </a:xfrm>
                <a:prstGeom prst="line">
                  <a:avLst/>
                </a:prstGeom>
                <a:ln w="190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直接连接符 45">
                  <a:extLst>
                    <a:ext uri="{FF2B5EF4-FFF2-40B4-BE49-F238E27FC236}">
                      <a16:creationId xmlns:a16="http://schemas.microsoft.com/office/drawing/2014/main" id="{E5926D22-2D60-4857-BAC8-45536A11ADF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20545" y="2565400"/>
                  <a:ext cx="72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9" name="TextBox 23">
                <a:extLst>
                  <a:ext uri="{FF2B5EF4-FFF2-40B4-BE49-F238E27FC236}">
                    <a16:creationId xmlns:a16="http://schemas.microsoft.com/office/drawing/2014/main" id="{48BABFDE-7079-4204-92F8-A5D3F03687CF}"/>
                  </a:ext>
                </a:extLst>
              </p:cNvPr>
              <p:cNvSpPr txBox="1"/>
              <p:nvPr/>
            </p:nvSpPr>
            <p:spPr>
              <a:xfrm>
                <a:off x="2511576" y="2320505"/>
                <a:ext cx="44821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b="1" dirty="0"/>
                  <a:t>AAAAA</a:t>
                </a:r>
                <a:endParaRPr lang="zh-CN" altLang="en-US" sz="600" b="1" dirty="0"/>
              </a:p>
            </p:txBody>
          </p:sp>
          <p:sp>
            <p:nvSpPr>
              <p:cNvPr id="50" name="椭圆 49">
                <a:extLst>
                  <a:ext uri="{FF2B5EF4-FFF2-40B4-BE49-F238E27FC236}">
                    <a16:creationId xmlns:a16="http://schemas.microsoft.com/office/drawing/2014/main" id="{BD446E14-B330-42AC-9584-107DC5DD6581}"/>
                  </a:ext>
                </a:extLst>
              </p:cNvPr>
              <p:cNvSpPr/>
              <p:nvPr/>
            </p:nvSpPr>
            <p:spPr>
              <a:xfrm>
                <a:off x="1503111" y="2389979"/>
                <a:ext cx="45719" cy="45719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52" name="箭头: 下 51">
              <a:extLst>
                <a:ext uri="{FF2B5EF4-FFF2-40B4-BE49-F238E27FC236}">
                  <a16:creationId xmlns:a16="http://schemas.microsoft.com/office/drawing/2014/main" id="{F520080B-4175-42C9-81DA-3F5E7A7FF39B}"/>
                </a:ext>
              </a:extLst>
            </p:cNvPr>
            <p:cNvSpPr/>
            <p:nvPr/>
          </p:nvSpPr>
          <p:spPr>
            <a:xfrm>
              <a:off x="2945415" y="2272563"/>
              <a:ext cx="45719" cy="184663"/>
            </a:xfrm>
            <a:prstGeom prst="downArrow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" name="箭头: 下 53">
              <a:extLst>
                <a:ext uri="{FF2B5EF4-FFF2-40B4-BE49-F238E27FC236}">
                  <a16:creationId xmlns:a16="http://schemas.microsoft.com/office/drawing/2014/main" id="{7497FD03-31B6-454E-9228-93656B355343}"/>
                </a:ext>
              </a:extLst>
            </p:cNvPr>
            <p:cNvSpPr/>
            <p:nvPr/>
          </p:nvSpPr>
          <p:spPr>
            <a:xfrm>
              <a:off x="2953911" y="2992458"/>
              <a:ext cx="45719" cy="184663"/>
            </a:xfrm>
            <a:prstGeom prst="downArrow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56" name="图片 55">
              <a:extLst>
                <a:ext uri="{FF2B5EF4-FFF2-40B4-BE49-F238E27FC236}">
                  <a16:creationId xmlns:a16="http://schemas.microsoft.com/office/drawing/2014/main" id="{49104BFC-1EC0-4847-B9E5-44341E49AF5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134169">
              <a:off x="2471116" y="3357370"/>
              <a:ext cx="300375" cy="391793"/>
            </a:xfrm>
            <a:prstGeom prst="rect">
              <a:avLst/>
            </a:prstGeom>
          </p:spPr>
        </p:pic>
        <p:pic>
          <p:nvPicPr>
            <p:cNvPr id="58" name="图片 57">
              <a:extLst>
                <a:ext uri="{FF2B5EF4-FFF2-40B4-BE49-F238E27FC236}">
                  <a16:creationId xmlns:a16="http://schemas.microsoft.com/office/drawing/2014/main" id="{9FDEA03D-BCAA-4090-B8B9-96DCB0D6962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134169">
              <a:off x="2840947" y="3357370"/>
              <a:ext cx="300375" cy="391793"/>
            </a:xfrm>
            <a:prstGeom prst="rect">
              <a:avLst/>
            </a:prstGeom>
          </p:spPr>
        </p:pic>
        <p:pic>
          <p:nvPicPr>
            <p:cNvPr id="60" name="图片 59">
              <a:extLst>
                <a:ext uri="{FF2B5EF4-FFF2-40B4-BE49-F238E27FC236}">
                  <a16:creationId xmlns:a16="http://schemas.microsoft.com/office/drawing/2014/main" id="{EA8D3D11-E59F-4E40-8772-FA358FD06AF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134169">
              <a:off x="3210778" y="3357370"/>
              <a:ext cx="300375" cy="391793"/>
            </a:xfrm>
            <a:prstGeom prst="rect">
              <a:avLst/>
            </a:prstGeom>
          </p:spPr>
        </p:pic>
      </p:grpSp>
      <p:grpSp>
        <p:nvGrpSpPr>
          <p:cNvPr id="73" name="组合 72">
            <a:extLst>
              <a:ext uri="{FF2B5EF4-FFF2-40B4-BE49-F238E27FC236}">
                <a16:creationId xmlns:a16="http://schemas.microsoft.com/office/drawing/2014/main" id="{B4B00D5A-DACF-4C3F-8A66-E1BF5183CA26}"/>
              </a:ext>
            </a:extLst>
          </p:cNvPr>
          <p:cNvGrpSpPr/>
          <p:nvPr/>
        </p:nvGrpSpPr>
        <p:grpSpPr>
          <a:xfrm>
            <a:off x="851025" y="532624"/>
            <a:ext cx="1141409" cy="2509986"/>
            <a:chOff x="3594456" y="412577"/>
            <a:chExt cx="1141409" cy="2509986"/>
          </a:xfrm>
        </p:grpSpPr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7922E5D4-CE7D-48D4-9B12-27EB51C0AD79}"/>
                </a:ext>
              </a:extLst>
            </p:cNvPr>
            <p:cNvSpPr/>
            <p:nvPr/>
          </p:nvSpPr>
          <p:spPr bwMode="auto">
            <a:xfrm>
              <a:off x="4418245" y="1542897"/>
              <a:ext cx="101257" cy="128697"/>
            </a:xfrm>
            <a:prstGeom prst="rect">
              <a:avLst/>
            </a:prstGeom>
            <a:solidFill>
              <a:srgbClr val="FF0000"/>
            </a:solidFill>
            <a:ln w="9525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None/>
                <a:tabLst/>
              </a:pPr>
              <a:endParaRPr kumimoji="0" lang="zh-CN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603DCDF3-9628-401A-BACB-C4D098552809}"/>
                </a:ext>
              </a:extLst>
            </p:cNvPr>
            <p:cNvGrpSpPr/>
            <p:nvPr/>
          </p:nvGrpSpPr>
          <p:grpSpPr>
            <a:xfrm>
              <a:off x="3719872" y="978655"/>
              <a:ext cx="683782" cy="730935"/>
              <a:chOff x="2316462" y="2085277"/>
              <a:chExt cx="683782" cy="730935"/>
            </a:xfrm>
          </p:grpSpPr>
          <p:grpSp>
            <p:nvGrpSpPr>
              <p:cNvPr id="4" name="组合 77">
                <a:extLst>
                  <a:ext uri="{FF2B5EF4-FFF2-40B4-BE49-F238E27FC236}">
                    <a16:creationId xmlns:a16="http://schemas.microsoft.com/office/drawing/2014/main" id="{D905FAD3-B393-426C-ADFE-48F710017CCE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2316462" y="2204692"/>
                <a:ext cx="683782" cy="611520"/>
                <a:chOff x="1950884" y="5589996"/>
                <a:chExt cx="879280" cy="815429"/>
              </a:xfrm>
            </p:grpSpPr>
            <p:sp>
              <p:nvSpPr>
                <p:cNvPr id="6" name="右箭头 27">
                  <a:extLst>
                    <a:ext uri="{FF2B5EF4-FFF2-40B4-BE49-F238E27FC236}">
                      <a16:creationId xmlns:a16="http://schemas.microsoft.com/office/drawing/2014/main" id="{87238E55-2044-4E00-92E4-800004B0B7E7}"/>
                    </a:ext>
                  </a:extLst>
                </p:cNvPr>
                <p:cNvSpPr/>
                <p:nvPr/>
              </p:nvSpPr>
              <p:spPr bwMode="auto">
                <a:xfrm>
                  <a:off x="1950884" y="6148655"/>
                  <a:ext cx="478992" cy="256770"/>
                </a:xfrm>
                <a:prstGeom prst="rightArrow">
                  <a:avLst>
                    <a:gd name="adj1" fmla="val 71061"/>
                    <a:gd name="adj2" fmla="val 50000"/>
                  </a:avLst>
                </a:pr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>
                    <a:defRPr/>
                  </a:pPr>
                  <a:endParaRPr lang="zh-CN" altLang="en-US" sz="800" b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" name="任意多边形 31">
                  <a:extLst>
                    <a:ext uri="{FF2B5EF4-FFF2-40B4-BE49-F238E27FC236}">
                      <a16:creationId xmlns:a16="http://schemas.microsoft.com/office/drawing/2014/main" id="{353678E5-5607-43F2-8288-A323D9C7DBF5}"/>
                    </a:ext>
                  </a:extLst>
                </p:cNvPr>
                <p:cNvSpPr/>
                <p:nvPr/>
              </p:nvSpPr>
              <p:spPr>
                <a:xfrm>
                  <a:off x="2420942" y="5589996"/>
                  <a:ext cx="409222" cy="720350"/>
                </a:xfrm>
                <a:custGeom>
                  <a:avLst/>
                  <a:gdLst>
                    <a:gd name="connsiteX0" fmla="*/ 0 w 1289304"/>
                    <a:gd name="connsiteY0" fmla="*/ 873147 h 901772"/>
                    <a:gd name="connsiteX1" fmla="*/ 438912 w 1289304"/>
                    <a:gd name="connsiteY1" fmla="*/ 809139 h 901772"/>
                    <a:gd name="connsiteX2" fmla="*/ 530352 w 1289304"/>
                    <a:gd name="connsiteY2" fmla="*/ 105051 h 901772"/>
                    <a:gd name="connsiteX3" fmla="*/ 786384 w 1289304"/>
                    <a:gd name="connsiteY3" fmla="*/ 77619 h 901772"/>
                    <a:gd name="connsiteX4" fmla="*/ 877824 w 1289304"/>
                    <a:gd name="connsiteY4" fmla="*/ 818283 h 901772"/>
                    <a:gd name="connsiteX5" fmla="*/ 1289304 w 1289304"/>
                    <a:gd name="connsiteY5" fmla="*/ 882291 h 901772"/>
                    <a:gd name="connsiteX6" fmla="*/ 1289304 w 1289304"/>
                    <a:gd name="connsiteY6" fmla="*/ 882291 h 90177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1289304" h="901772">
                      <a:moveTo>
                        <a:pt x="0" y="873147"/>
                      </a:moveTo>
                      <a:cubicBezTo>
                        <a:pt x="175260" y="905151"/>
                        <a:pt x="350520" y="937155"/>
                        <a:pt x="438912" y="809139"/>
                      </a:cubicBezTo>
                      <a:cubicBezTo>
                        <a:pt x="527304" y="681123"/>
                        <a:pt x="472440" y="226971"/>
                        <a:pt x="530352" y="105051"/>
                      </a:cubicBezTo>
                      <a:cubicBezTo>
                        <a:pt x="588264" y="-16869"/>
                        <a:pt x="728472" y="-41253"/>
                        <a:pt x="786384" y="77619"/>
                      </a:cubicBezTo>
                      <a:cubicBezTo>
                        <a:pt x="844296" y="196491"/>
                        <a:pt x="794004" y="684171"/>
                        <a:pt x="877824" y="818283"/>
                      </a:cubicBezTo>
                      <a:cubicBezTo>
                        <a:pt x="961644" y="952395"/>
                        <a:pt x="1289304" y="882291"/>
                        <a:pt x="1289304" y="882291"/>
                      </a:cubicBezTo>
                      <a:lnTo>
                        <a:pt x="1289304" y="882291"/>
                      </a:lnTo>
                    </a:path>
                  </a:pathLst>
                </a:custGeom>
                <a:noFill/>
                <a:ln w="28575"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zh-CN" altLang="en-US"/>
                </a:p>
              </p:txBody>
            </p:sp>
          </p:grpSp>
          <p:sp>
            <p:nvSpPr>
              <p:cNvPr id="5" name="矩形 4">
                <a:extLst>
                  <a:ext uri="{FF2B5EF4-FFF2-40B4-BE49-F238E27FC236}">
                    <a16:creationId xmlns:a16="http://schemas.microsoft.com/office/drawing/2014/main" id="{781D15E8-D3B3-4120-8D7A-B147D5528F05}"/>
                  </a:ext>
                </a:extLst>
              </p:cNvPr>
              <p:cNvSpPr/>
              <p:nvPr/>
            </p:nvSpPr>
            <p:spPr>
              <a:xfrm rot="16200000">
                <a:off x="2400434" y="2200372"/>
                <a:ext cx="47641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>
                  <a:defRPr/>
                </a:pPr>
                <a:r>
                  <a:rPr lang="en-US" altLang="zh-CN" sz="1000" b="1" dirty="0" err="1">
                    <a:solidFill>
                      <a:srgbClr val="00B050"/>
                    </a:solidFill>
                  </a:rPr>
                  <a:t>miRx</a:t>
                </a:r>
                <a:endParaRPr lang="zh-CN" altLang="en-US" sz="1000" b="1" dirty="0">
                  <a:solidFill>
                    <a:srgbClr val="00B050"/>
                  </a:solidFill>
                </a:endParaRPr>
              </a:p>
            </p:txBody>
          </p:sp>
        </p:grp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21CF458D-77B7-4ADB-BFFB-FBEF46CB98A5}"/>
                </a:ext>
              </a:extLst>
            </p:cNvPr>
            <p:cNvGrpSpPr/>
            <p:nvPr/>
          </p:nvGrpSpPr>
          <p:grpSpPr>
            <a:xfrm>
              <a:off x="4224579" y="1184889"/>
              <a:ext cx="45719" cy="167299"/>
              <a:chOff x="1878227" y="2037395"/>
              <a:chExt cx="35305" cy="762000"/>
            </a:xfrm>
          </p:grpSpPr>
          <p:cxnSp>
            <p:nvCxnSpPr>
              <p:cNvPr id="9" name="直接连接符 8">
                <a:extLst>
                  <a:ext uri="{FF2B5EF4-FFF2-40B4-BE49-F238E27FC236}">
                    <a16:creationId xmlns:a16="http://schemas.microsoft.com/office/drawing/2014/main" id="{47EF2592-2CE2-4736-A491-79220FDFB6D0}"/>
                  </a:ext>
                </a:extLst>
              </p:cNvPr>
              <p:cNvCxnSpPr/>
              <p:nvPr/>
            </p:nvCxnSpPr>
            <p:spPr>
              <a:xfrm>
                <a:off x="1878227" y="2037395"/>
                <a:ext cx="35305" cy="0"/>
              </a:xfrm>
              <a:prstGeom prst="line">
                <a:avLst/>
              </a:prstGeom>
              <a:ln w="952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直接连接符 9">
                <a:extLst>
                  <a:ext uri="{FF2B5EF4-FFF2-40B4-BE49-F238E27FC236}">
                    <a16:creationId xmlns:a16="http://schemas.microsoft.com/office/drawing/2014/main" id="{A664015E-6EE0-41B5-8FD5-59A5A8F0A31B}"/>
                  </a:ext>
                </a:extLst>
              </p:cNvPr>
              <p:cNvCxnSpPr/>
              <p:nvPr/>
            </p:nvCxnSpPr>
            <p:spPr>
              <a:xfrm>
                <a:off x="1878227" y="2189795"/>
                <a:ext cx="35305" cy="0"/>
              </a:xfrm>
              <a:prstGeom prst="line">
                <a:avLst/>
              </a:prstGeom>
              <a:ln w="952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接连接符 10">
                <a:extLst>
                  <a:ext uri="{FF2B5EF4-FFF2-40B4-BE49-F238E27FC236}">
                    <a16:creationId xmlns:a16="http://schemas.microsoft.com/office/drawing/2014/main" id="{34423ED2-D5ED-4E43-8882-66F50E44EB2A}"/>
                  </a:ext>
                </a:extLst>
              </p:cNvPr>
              <p:cNvCxnSpPr/>
              <p:nvPr/>
            </p:nvCxnSpPr>
            <p:spPr>
              <a:xfrm>
                <a:off x="1878227" y="2342195"/>
                <a:ext cx="35305" cy="0"/>
              </a:xfrm>
              <a:prstGeom prst="line">
                <a:avLst/>
              </a:prstGeom>
              <a:ln w="952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直接连接符 11">
                <a:extLst>
                  <a:ext uri="{FF2B5EF4-FFF2-40B4-BE49-F238E27FC236}">
                    <a16:creationId xmlns:a16="http://schemas.microsoft.com/office/drawing/2014/main" id="{839F4AF8-6D8E-4DAE-8856-C68170DBF073}"/>
                  </a:ext>
                </a:extLst>
              </p:cNvPr>
              <p:cNvCxnSpPr/>
              <p:nvPr/>
            </p:nvCxnSpPr>
            <p:spPr>
              <a:xfrm>
                <a:off x="1878227" y="2494595"/>
                <a:ext cx="35305" cy="0"/>
              </a:xfrm>
              <a:prstGeom prst="line">
                <a:avLst/>
              </a:prstGeom>
              <a:ln w="952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接连接符 12">
                <a:extLst>
                  <a:ext uri="{FF2B5EF4-FFF2-40B4-BE49-F238E27FC236}">
                    <a16:creationId xmlns:a16="http://schemas.microsoft.com/office/drawing/2014/main" id="{7EA18D84-DFDA-4C8E-B133-7310ED92C353}"/>
                  </a:ext>
                </a:extLst>
              </p:cNvPr>
              <p:cNvCxnSpPr/>
              <p:nvPr/>
            </p:nvCxnSpPr>
            <p:spPr>
              <a:xfrm>
                <a:off x="1878227" y="2646995"/>
                <a:ext cx="35305" cy="0"/>
              </a:xfrm>
              <a:prstGeom prst="line">
                <a:avLst/>
              </a:prstGeom>
              <a:ln w="952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接连接符 13">
                <a:extLst>
                  <a:ext uri="{FF2B5EF4-FFF2-40B4-BE49-F238E27FC236}">
                    <a16:creationId xmlns:a16="http://schemas.microsoft.com/office/drawing/2014/main" id="{36F0BDC6-F6AE-47BB-AFA0-7C2E73BB1315}"/>
                  </a:ext>
                </a:extLst>
              </p:cNvPr>
              <p:cNvCxnSpPr/>
              <p:nvPr/>
            </p:nvCxnSpPr>
            <p:spPr>
              <a:xfrm>
                <a:off x="1878227" y="2799395"/>
                <a:ext cx="35305" cy="0"/>
              </a:xfrm>
              <a:prstGeom prst="line">
                <a:avLst/>
              </a:prstGeom>
              <a:ln w="952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96FFC715-C668-427D-BE95-F8F5E3DE4332}"/>
                </a:ext>
              </a:extLst>
            </p:cNvPr>
            <p:cNvGrpSpPr/>
            <p:nvPr/>
          </p:nvGrpSpPr>
          <p:grpSpPr>
            <a:xfrm>
              <a:off x="4225150" y="1383192"/>
              <a:ext cx="45719" cy="167299"/>
              <a:chOff x="1878227" y="2037395"/>
              <a:chExt cx="35305" cy="762000"/>
            </a:xfrm>
          </p:grpSpPr>
          <p:cxnSp>
            <p:nvCxnSpPr>
              <p:cNvPr id="16" name="直接连接符 15">
                <a:extLst>
                  <a:ext uri="{FF2B5EF4-FFF2-40B4-BE49-F238E27FC236}">
                    <a16:creationId xmlns:a16="http://schemas.microsoft.com/office/drawing/2014/main" id="{398062D0-097A-40D2-AE5A-841F48A2C051}"/>
                  </a:ext>
                </a:extLst>
              </p:cNvPr>
              <p:cNvCxnSpPr/>
              <p:nvPr/>
            </p:nvCxnSpPr>
            <p:spPr>
              <a:xfrm>
                <a:off x="1878227" y="2037395"/>
                <a:ext cx="35305" cy="0"/>
              </a:xfrm>
              <a:prstGeom prst="line">
                <a:avLst/>
              </a:prstGeom>
              <a:ln w="952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>
                <a:extLst>
                  <a:ext uri="{FF2B5EF4-FFF2-40B4-BE49-F238E27FC236}">
                    <a16:creationId xmlns:a16="http://schemas.microsoft.com/office/drawing/2014/main" id="{374FAA9B-AC86-465A-9FCF-AE17423FF13A}"/>
                  </a:ext>
                </a:extLst>
              </p:cNvPr>
              <p:cNvCxnSpPr/>
              <p:nvPr/>
            </p:nvCxnSpPr>
            <p:spPr>
              <a:xfrm>
                <a:off x="1878227" y="2189795"/>
                <a:ext cx="35305" cy="0"/>
              </a:xfrm>
              <a:prstGeom prst="line">
                <a:avLst/>
              </a:prstGeom>
              <a:ln w="952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连接符 17">
                <a:extLst>
                  <a:ext uri="{FF2B5EF4-FFF2-40B4-BE49-F238E27FC236}">
                    <a16:creationId xmlns:a16="http://schemas.microsoft.com/office/drawing/2014/main" id="{90BC703D-FA0E-4828-9C76-6C8C13F0F08E}"/>
                  </a:ext>
                </a:extLst>
              </p:cNvPr>
              <p:cNvCxnSpPr/>
              <p:nvPr/>
            </p:nvCxnSpPr>
            <p:spPr>
              <a:xfrm>
                <a:off x="1878227" y="2342195"/>
                <a:ext cx="35305" cy="0"/>
              </a:xfrm>
              <a:prstGeom prst="line">
                <a:avLst/>
              </a:prstGeom>
              <a:ln w="952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连接符 18">
                <a:extLst>
                  <a:ext uri="{FF2B5EF4-FFF2-40B4-BE49-F238E27FC236}">
                    <a16:creationId xmlns:a16="http://schemas.microsoft.com/office/drawing/2014/main" id="{6A99AA17-012D-41E6-9719-8B83213CBF72}"/>
                  </a:ext>
                </a:extLst>
              </p:cNvPr>
              <p:cNvCxnSpPr/>
              <p:nvPr/>
            </p:nvCxnSpPr>
            <p:spPr>
              <a:xfrm>
                <a:off x="1878227" y="2494595"/>
                <a:ext cx="35305" cy="0"/>
              </a:xfrm>
              <a:prstGeom prst="line">
                <a:avLst/>
              </a:prstGeom>
              <a:ln w="952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>
                <a:extLst>
                  <a:ext uri="{FF2B5EF4-FFF2-40B4-BE49-F238E27FC236}">
                    <a16:creationId xmlns:a16="http://schemas.microsoft.com/office/drawing/2014/main" id="{A2AD02BA-37D5-4CF1-9910-B10B62F95CFA}"/>
                  </a:ext>
                </a:extLst>
              </p:cNvPr>
              <p:cNvCxnSpPr/>
              <p:nvPr/>
            </p:nvCxnSpPr>
            <p:spPr>
              <a:xfrm>
                <a:off x="1878227" y="2646995"/>
                <a:ext cx="35305" cy="0"/>
              </a:xfrm>
              <a:prstGeom prst="line">
                <a:avLst/>
              </a:prstGeom>
              <a:ln w="952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接连接符 20">
                <a:extLst>
                  <a:ext uri="{FF2B5EF4-FFF2-40B4-BE49-F238E27FC236}">
                    <a16:creationId xmlns:a16="http://schemas.microsoft.com/office/drawing/2014/main" id="{911BAACC-18E3-4E98-94E9-A65742D5AC6A}"/>
                  </a:ext>
                </a:extLst>
              </p:cNvPr>
              <p:cNvCxnSpPr/>
              <p:nvPr/>
            </p:nvCxnSpPr>
            <p:spPr>
              <a:xfrm>
                <a:off x="1878227" y="2799395"/>
                <a:ext cx="35305" cy="0"/>
              </a:xfrm>
              <a:prstGeom prst="line">
                <a:avLst/>
              </a:prstGeom>
              <a:ln w="952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1902E2E3-18B8-45A1-B896-3D8ECCD9E08F}"/>
                </a:ext>
              </a:extLst>
            </p:cNvPr>
            <p:cNvSpPr/>
            <p:nvPr/>
          </p:nvSpPr>
          <p:spPr>
            <a:xfrm>
              <a:off x="3693801" y="1483571"/>
              <a:ext cx="37702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zh-CN" sz="1000" b="1" dirty="0"/>
                <a:t>35S</a:t>
              </a:r>
              <a:endParaRPr lang="zh-CN" altLang="en-US" sz="1000" b="1" dirty="0"/>
            </a:p>
          </p:txBody>
        </p:sp>
        <p:sp>
          <p:nvSpPr>
            <p:cNvPr id="23" name="TextBox 23">
              <a:extLst>
                <a:ext uri="{FF2B5EF4-FFF2-40B4-BE49-F238E27FC236}">
                  <a16:creationId xmlns:a16="http://schemas.microsoft.com/office/drawing/2014/main" id="{72D3B3B1-CDC1-415B-BF69-E1DB586C15BD}"/>
                </a:ext>
              </a:extLst>
            </p:cNvPr>
            <p:cNvSpPr txBox="1"/>
            <p:nvPr/>
          </p:nvSpPr>
          <p:spPr>
            <a:xfrm>
              <a:off x="3594456" y="412577"/>
              <a:ext cx="114140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/>
                <a:t>Artificial MIR construct</a:t>
              </a:r>
              <a:endParaRPr lang="zh-CN" altLang="en-US" sz="1000" b="1" dirty="0"/>
            </a:p>
          </p:txBody>
        </p:sp>
        <p:sp>
          <p:nvSpPr>
            <p:cNvPr id="62" name="箭头: 下 61">
              <a:extLst>
                <a:ext uri="{FF2B5EF4-FFF2-40B4-BE49-F238E27FC236}">
                  <a16:creationId xmlns:a16="http://schemas.microsoft.com/office/drawing/2014/main" id="{9C4C1184-B379-4B09-B55A-F5845ACF94CE}"/>
                </a:ext>
              </a:extLst>
            </p:cNvPr>
            <p:cNvSpPr/>
            <p:nvPr/>
          </p:nvSpPr>
          <p:spPr>
            <a:xfrm>
              <a:off x="4178860" y="2024580"/>
              <a:ext cx="45719" cy="184663"/>
            </a:xfrm>
            <a:prstGeom prst="down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0CD21617-ECCA-4665-8F5F-EE8CD8A9F3DD}"/>
                </a:ext>
              </a:extLst>
            </p:cNvPr>
            <p:cNvCxnSpPr>
              <a:cxnSpLocks/>
            </p:cNvCxnSpPr>
            <p:nvPr/>
          </p:nvCxnSpPr>
          <p:spPr>
            <a:xfrm>
              <a:off x="4101623" y="2331414"/>
              <a:ext cx="216000" cy="0"/>
            </a:xfrm>
            <a:prstGeom prst="line">
              <a:avLst/>
            </a:prstGeom>
            <a:ln w="190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9EA6C1D3-E60A-4B55-A9C3-B5A594376CC8}"/>
                </a:ext>
              </a:extLst>
            </p:cNvPr>
            <p:cNvCxnSpPr>
              <a:cxnSpLocks/>
            </p:cNvCxnSpPr>
            <p:nvPr/>
          </p:nvCxnSpPr>
          <p:spPr>
            <a:xfrm>
              <a:off x="4070860" y="2371877"/>
              <a:ext cx="216000" cy="0"/>
            </a:xfrm>
            <a:prstGeom prst="line">
              <a:avLst/>
            </a:prstGeom>
            <a:ln w="1905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箭头: 下 65">
              <a:extLst>
                <a:ext uri="{FF2B5EF4-FFF2-40B4-BE49-F238E27FC236}">
                  <a16:creationId xmlns:a16="http://schemas.microsoft.com/office/drawing/2014/main" id="{5CAC83ED-E3C6-43E9-8EEB-911459788D12}"/>
                </a:ext>
              </a:extLst>
            </p:cNvPr>
            <p:cNvSpPr/>
            <p:nvPr/>
          </p:nvSpPr>
          <p:spPr>
            <a:xfrm>
              <a:off x="4186763" y="2503204"/>
              <a:ext cx="45719" cy="184663"/>
            </a:xfrm>
            <a:prstGeom prst="down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69" name="组合 68">
              <a:extLst>
                <a:ext uri="{FF2B5EF4-FFF2-40B4-BE49-F238E27FC236}">
                  <a16:creationId xmlns:a16="http://schemas.microsoft.com/office/drawing/2014/main" id="{76277B1D-9779-405B-976E-A36F7EACB59C}"/>
                </a:ext>
              </a:extLst>
            </p:cNvPr>
            <p:cNvGrpSpPr/>
            <p:nvPr/>
          </p:nvGrpSpPr>
          <p:grpSpPr>
            <a:xfrm>
              <a:off x="4107380" y="2780092"/>
              <a:ext cx="216000" cy="142471"/>
              <a:chOff x="4107380" y="2780092"/>
              <a:chExt cx="216000" cy="142471"/>
            </a:xfrm>
          </p:grpSpPr>
          <p:sp>
            <p:nvSpPr>
              <p:cNvPr id="67" name="椭圆 66">
                <a:extLst>
                  <a:ext uri="{FF2B5EF4-FFF2-40B4-BE49-F238E27FC236}">
                    <a16:creationId xmlns:a16="http://schemas.microsoft.com/office/drawing/2014/main" id="{B62C1AA2-77C0-4862-A899-AE6443659D9A}"/>
                  </a:ext>
                </a:extLst>
              </p:cNvPr>
              <p:cNvSpPr/>
              <p:nvPr/>
            </p:nvSpPr>
            <p:spPr>
              <a:xfrm>
                <a:off x="4114659" y="2780092"/>
                <a:ext cx="201442" cy="142471"/>
              </a:xfrm>
              <a:prstGeom prst="ellipse">
                <a:avLst/>
              </a:prstGeom>
              <a:solidFill>
                <a:srgbClr val="FF33CC"/>
              </a:solidFill>
              <a:ln>
                <a:solidFill>
                  <a:srgbClr val="FF33C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68" name="直接连接符 67">
                <a:extLst>
                  <a:ext uri="{FF2B5EF4-FFF2-40B4-BE49-F238E27FC236}">
                    <a16:creationId xmlns:a16="http://schemas.microsoft.com/office/drawing/2014/main" id="{6C5C4874-1E5B-4689-83A5-4A4447D78D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07380" y="2922563"/>
                <a:ext cx="216000" cy="0"/>
              </a:xfrm>
              <a:prstGeom prst="line">
                <a:avLst/>
              </a:prstGeom>
              <a:ln w="190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0" name="组合 69">
            <a:extLst>
              <a:ext uri="{FF2B5EF4-FFF2-40B4-BE49-F238E27FC236}">
                <a16:creationId xmlns:a16="http://schemas.microsoft.com/office/drawing/2014/main" id="{21860D73-D1ED-4238-8DE6-56064F525CEB}"/>
              </a:ext>
            </a:extLst>
          </p:cNvPr>
          <p:cNvGrpSpPr/>
          <p:nvPr/>
        </p:nvGrpSpPr>
        <p:grpSpPr>
          <a:xfrm>
            <a:off x="2580496" y="2541893"/>
            <a:ext cx="90584" cy="142471"/>
            <a:chOff x="4107380" y="2780092"/>
            <a:chExt cx="216000" cy="142471"/>
          </a:xfrm>
        </p:grpSpPr>
        <p:sp>
          <p:nvSpPr>
            <p:cNvPr id="71" name="椭圆 70">
              <a:extLst>
                <a:ext uri="{FF2B5EF4-FFF2-40B4-BE49-F238E27FC236}">
                  <a16:creationId xmlns:a16="http://schemas.microsoft.com/office/drawing/2014/main" id="{511BF36F-F9D0-4C7F-B4C4-8C248D818867}"/>
                </a:ext>
              </a:extLst>
            </p:cNvPr>
            <p:cNvSpPr/>
            <p:nvPr/>
          </p:nvSpPr>
          <p:spPr>
            <a:xfrm>
              <a:off x="4114659" y="2780092"/>
              <a:ext cx="201442" cy="142471"/>
            </a:xfrm>
            <a:prstGeom prst="ellipse">
              <a:avLst/>
            </a:prstGeom>
            <a:solidFill>
              <a:srgbClr val="FF33CC"/>
            </a:solidFill>
            <a:ln>
              <a:solidFill>
                <a:srgbClr val="FF33C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72" name="直接连接符 71">
              <a:extLst>
                <a:ext uri="{FF2B5EF4-FFF2-40B4-BE49-F238E27FC236}">
                  <a16:creationId xmlns:a16="http://schemas.microsoft.com/office/drawing/2014/main" id="{3C2418D9-27EF-4683-9C74-9A4EA85F5099}"/>
                </a:ext>
              </a:extLst>
            </p:cNvPr>
            <p:cNvCxnSpPr>
              <a:cxnSpLocks/>
            </p:cNvCxnSpPr>
            <p:nvPr/>
          </p:nvCxnSpPr>
          <p:spPr>
            <a:xfrm>
              <a:off x="4107380" y="2922563"/>
              <a:ext cx="216000" cy="0"/>
            </a:xfrm>
            <a:prstGeom prst="line">
              <a:avLst/>
            </a:prstGeom>
            <a:ln w="1905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76" name="连接符: 肘形 75">
            <a:extLst>
              <a:ext uri="{FF2B5EF4-FFF2-40B4-BE49-F238E27FC236}">
                <a16:creationId xmlns:a16="http://schemas.microsoft.com/office/drawing/2014/main" id="{4A326141-DE98-4AAA-8E90-E343A6E3C6FC}"/>
              </a:ext>
            </a:extLst>
          </p:cNvPr>
          <p:cNvCxnSpPr>
            <a:cxnSpLocks/>
          </p:cNvCxnSpPr>
          <p:nvPr/>
        </p:nvCxnSpPr>
        <p:spPr>
          <a:xfrm flipV="1">
            <a:off x="1691521" y="2580721"/>
            <a:ext cx="597895" cy="395949"/>
          </a:xfrm>
          <a:prstGeom prst="bentConnector3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弧形 77">
            <a:extLst>
              <a:ext uri="{FF2B5EF4-FFF2-40B4-BE49-F238E27FC236}">
                <a16:creationId xmlns:a16="http://schemas.microsoft.com/office/drawing/2014/main" id="{AA5D8F0E-17D2-4789-935C-935B67FBB498}"/>
              </a:ext>
            </a:extLst>
          </p:cNvPr>
          <p:cNvSpPr/>
          <p:nvPr/>
        </p:nvSpPr>
        <p:spPr>
          <a:xfrm>
            <a:off x="2614302" y="2580721"/>
            <a:ext cx="493661" cy="493415"/>
          </a:xfrm>
          <a:prstGeom prst="arc">
            <a:avLst>
              <a:gd name="adj1" fmla="val 6153873"/>
              <a:gd name="adj2" fmla="val 10799984"/>
            </a:avLst>
          </a:prstGeom>
          <a:ln w="28575">
            <a:solidFill>
              <a:srgbClr val="FF000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82" name="组合 81">
            <a:extLst>
              <a:ext uri="{FF2B5EF4-FFF2-40B4-BE49-F238E27FC236}">
                <a16:creationId xmlns:a16="http://schemas.microsoft.com/office/drawing/2014/main" id="{65CAE92F-A13C-4BA4-8132-E42F69E92166}"/>
              </a:ext>
            </a:extLst>
          </p:cNvPr>
          <p:cNvGrpSpPr/>
          <p:nvPr/>
        </p:nvGrpSpPr>
        <p:grpSpPr>
          <a:xfrm>
            <a:off x="2911124" y="3012915"/>
            <a:ext cx="114300" cy="122441"/>
            <a:chOff x="4191000" y="3306559"/>
            <a:chExt cx="114300" cy="122441"/>
          </a:xfrm>
        </p:grpSpPr>
        <p:cxnSp>
          <p:nvCxnSpPr>
            <p:cNvPr id="80" name="直接连接符 79">
              <a:extLst>
                <a:ext uri="{FF2B5EF4-FFF2-40B4-BE49-F238E27FC236}">
                  <a16:creationId xmlns:a16="http://schemas.microsoft.com/office/drawing/2014/main" id="{FBA3D4B4-1210-4048-BF18-36110AF5CE27}"/>
                </a:ext>
              </a:extLst>
            </p:cNvPr>
            <p:cNvCxnSpPr/>
            <p:nvPr/>
          </p:nvCxnSpPr>
          <p:spPr>
            <a:xfrm>
              <a:off x="4191000" y="3306559"/>
              <a:ext cx="114300" cy="122441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接连接符 80">
              <a:extLst>
                <a:ext uri="{FF2B5EF4-FFF2-40B4-BE49-F238E27FC236}">
                  <a16:creationId xmlns:a16="http://schemas.microsoft.com/office/drawing/2014/main" id="{25E57D86-F109-45C1-9D44-99CF10A9E8B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91000" y="3306559"/>
              <a:ext cx="114300" cy="122441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文本框 42">
            <a:extLst>
              <a:ext uri="{FF2B5EF4-FFF2-40B4-BE49-F238E27FC236}">
                <a16:creationId xmlns:a16="http://schemas.microsoft.com/office/drawing/2014/main" id="{53009BF8-AD91-4654-807F-EFF898723FC0}"/>
              </a:ext>
            </a:extLst>
          </p:cNvPr>
          <p:cNvSpPr txBox="1"/>
          <p:nvPr/>
        </p:nvSpPr>
        <p:spPr>
          <a:xfrm>
            <a:off x="636283" y="355809"/>
            <a:ext cx="34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4561625C-9F15-4994-B425-4F0C92843A28}"/>
              </a:ext>
            </a:extLst>
          </p:cNvPr>
          <p:cNvSpPr txBox="1"/>
          <p:nvPr/>
        </p:nvSpPr>
        <p:spPr>
          <a:xfrm>
            <a:off x="4394191" y="363347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sp>
        <p:nvSpPr>
          <p:cNvPr id="146" name="椭圆 145">
            <a:extLst>
              <a:ext uri="{FF2B5EF4-FFF2-40B4-BE49-F238E27FC236}">
                <a16:creationId xmlns:a16="http://schemas.microsoft.com/office/drawing/2014/main" id="{2590A165-76F9-462B-A036-9F45C9395BFD}"/>
              </a:ext>
            </a:extLst>
          </p:cNvPr>
          <p:cNvSpPr/>
          <p:nvPr/>
        </p:nvSpPr>
        <p:spPr>
          <a:xfrm>
            <a:off x="3659025" y="3572600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8" name="文本框 177">
            <a:extLst>
              <a:ext uri="{FF2B5EF4-FFF2-40B4-BE49-F238E27FC236}">
                <a16:creationId xmlns:a16="http://schemas.microsoft.com/office/drawing/2014/main" id="{42A055B4-ADA1-4222-9A5D-479A2FC1A770}"/>
              </a:ext>
            </a:extLst>
          </p:cNvPr>
          <p:cNvSpPr txBox="1"/>
          <p:nvPr/>
        </p:nvSpPr>
        <p:spPr>
          <a:xfrm>
            <a:off x="7607758" y="33875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C</a:t>
            </a:r>
            <a:endParaRPr lang="zh-CN" altLang="en-US" b="1" dirty="0"/>
          </a:p>
        </p:txBody>
      </p:sp>
      <p:sp>
        <p:nvSpPr>
          <p:cNvPr id="190" name="文本框 90">
            <a:extLst>
              <a:ext uri="{FF2B5EF4-FFF2-40B4-BE49-F238E27FC236}">
                <a16:creationId xmlns:a16="http://schemas.microsoft.com/office/drawing/2014/main" id="{1ED0763A-C5EB-45F3-A38F-85E63BB1B415}"/>
              </a:ext>
            </a:extLst>
          </p:cNvPr>
          <p:cNvSpPr txBox="1"/>
          <p:nvPr/>
        </p:nvSpPr>
        <p:spPr>
          <a:xfrm flipH="1">
            <a:off x="1402281" y="5674027"/>
            <a:ext cx="9614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C4, C1, C2</a:t>
            </a:r>
            <a:endParaRPr lang="zh-CN" altLang="en-US" sz="1200" b="1" dirty="0"/>
          </a:p>
        </p:txBody>
      </p:sp>
      <p:sp>
        <p:nvSpPr>
          <p:cNvPr id="192" name="文本框 90">
            <a:extLst>
              <a:ext uri="{FF2B5EF4-FFF2-40B4-BE49-F238E27FC236}">
                <a16:creationId xmlns:a16="http://schemas.microsoft.com/office/drawing/2014/main" id="{52F34065-0609-4444-860E-5DFB0BFC4EB9}"/>
              </a:ext>
            </a:extLst>
          </p:cNvPr>
          <p:cNvSpPr txBox="1"/>
          <p:nvPr/>
        </p:nvSpPr>
        <p:spPr>
          <a:xfrm flipH="1">
            <a:off x="5941457" y="5833509"/>
            <a:ext cx="1516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 bC1, CP, V2, C3</a:t>
            </a:r>
            <a:endParaRPr lang="zh-CN" altLang="en-US" sz="1200" b="1" dirty="0"/>
          </a:p>
        </p:txBody>
      </p:sp>
      <p:graphicFrame>
        <p:nvGraphicFramePr>
          <p:cNvPr id="257" name="Table 256">
            <a:extLst>
              <a:ext uri="{FF2B5EF4-FFF2-40B4-BE49-F238E27FC236}">
                <a16:creationId xmlns:a16="http://schemas.microsoft.com/office/drawing/2014/main" id="{9537449E-35F2-46FD-8F16-BB6CD64DC799}"/>
              </a:ext>
            </a:extLst>
          </p:cNvPr>
          <p:cNvGraphicFramePr>
            <a:graphicFrameLocks noGrp="1"/>
          </p:cNvGraphicFramePr>
          <p:nvPr/>
        </p:nvGraphicFramePr>
        <p:xfrm>
          <a:off x="3132435" y="4439560"/>
          <a:ext cx="1273986" cy="1219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41652">
                  <a:extLst>
                    <a:ext uri="{9D8B030D-6E8A-4147-A177-3AD203B41FA5}">
                      <a16:colId xmlns:a16="http://schemas.microsoft.com/office/drawing/2014/main" val="1594664830"/>
                    </a:ext>
                  </a:extLst>
                </a:gridCol>
                <a:gridCol w="932334">
                  <a:extLst>
                    <a:ext uri="{9D8B030D-6E8A-4147-A177-3AD203B41FA5}">
                      <a16:colId xmlns:a16="http://schemas.microsoft.com/office/drawing/2014/main" val="1036425226"/>
                    </a:ext>
                  </a:extLst>
                </a:gridCol>
              </a:tblGrid>
              <a:tr h="238189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pMS4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6424158"/>
                  </a:ext>
                </a:extLst>
              </a:tr>
              <a:tr h="224264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pMS4-C4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42233767"/>
                  </a:ext>
                </a:extLst>
              </a:tr>
              <a:tr h="224264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pMS4-C1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7155359"/>
                  </a:ext>
                </a:extLst>
              </a:tr>
              <a:tr h="224264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pMS4-C2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4851930"/>
                  </a:ext>
                </a:extLst>
              </a:tr>
              <a:tr h="224264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1" dirty="0">
                          <a:solidFill>
                            <a:schemeClr val="tx1"/>
                          </a:solidFill>
                        </a:rPr>
                        <a:t>pMS4</a:t>
                      </a:r>
                      <a:endParaRPr lang="zh-CN" altLang="en-US" sz="10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5151834"/>
                  </a:ext>
                </a:extLst>
              </a:tr>
            </a:tbl>
          </a:graphicData>
        </a:graphic>
      </p:graphicFrame>
      <p:graphicFrame>
        <p:nvGraphicFramePr>
          <p:cNvPr id="258" name="Table 257">
            <a:extLst>
              <a:ext uri="{FF2B5EF4-FFF2-40B4-BE49-F238E27FC236}">
                <a16:creationId xmlns:a16="http://schemas.microsoft.com/office/drawing/2014/main" id="{F353F497-2505-4A8E-A9A9-9C9406F7313C}"/>
              </a:ext>
            </a:extLst>
          </p:cNvPr>
          <p:cNvGraphicFramePr>
            <a:graphicFrameLocks noGrp="1"/>
          </p:cNvGraphicFramePr>
          <p:nvPr/>
        </p:nvGraphicFramePr>
        <p:xfrm>
          <a:off x="7811103" y="4431489"/>
          <a:ext cx="1324881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5301">
                  <a:extLst>
                    <a:ext uri="{9D8B030D-6E8A-4147-A177-3AD203B41FA5}">
                      <a16:colId xmlns:a16="http://schemas.microsoft.com/office/drawing/2014/main" val="2791683500"/>
                    </a:ext>
                  </a:extLst>
                </a:gridCol>
                <a:gridCol w="969580">
                  <a:extLst>
                    <a:ext uri="{9D8B030D-6E8A-4147-A177-3AD203B41FA5}">
                      <a16:colId xmlns:a16="http://schemas.microsoft.com/office/drawing/2014/main" val="2522949558"/>
                    </a:ext>
                  </a:extLst>
                </a:gridCol>
              </a:tblGrid>
              <a:tr h="191226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pMS4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5068383"/>
                  </a:ext>
                </a:extLst>
              </a:tr>
              <a:tr h="191226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pMS4-bC1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1431984"/>
                  </a:ext>
                </a:extLst>
              </a:tr>
              <a:tr h="191226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pMS4-CP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3618613"/>
                  </a:ext>
                </a:extLst>
              </a:tr>
              <a:tr h="191226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pMS4-V2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7528440"/>
                  </a:ext>
                </a:extLst>
              </a:tr>
              <a:tr h="191226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pMS4-C3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0501287"/>
                  </a:ext>
                </a:extLst>
              </a:tr>
              <a:tr h="191226">
                <a:tc>
                  <a:txBody>
                    <a:bodyPr/>
                    <a:lstStyle/>
                    <a:p>
                      <a:r>
                        <a:rPr lang="en-US" altLang="zh-CN" sz="1000" dirty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zh-CN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b="1" dirty="0">
                          <a:solidFill>
                            <a:schemeClr val="tx1"/>
                          </a:solidFill>
                        </a:rPr>
                        <a:t>pMS4</a:t>
                      </a:r>
                      <a:endParaRPr lang="zh-CN" altLang="en-US" sz="10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636216"/>
                  </a:ext>
                </a:extLst>
              </a:tr>
            </a:tbl>
          </a:graphicData>
        </a:graphic>
      </p:graphicFrame>
      <p:grpSp>
        <p:nvGrpSpPr>
          <p:cNvPr id="155" name="组合 154">
            <a:extLst>
              <a:ext uri="{FF2B5EF4-FFF2-40B4-BE49-F238E27FC236}">
                <a16:creationId xmlns:a16="http://schemas.microsoft.com/office/drawing/2014/main" id="{6F43DE20-F444-4E6F-B4AA-02D2760A955C}"/>
              </a:ext>
            </a:extLst>
          </p:cNvPr>
          <p:cNvGrpSpPr/>
          <p:nvPr/>
        </p:nvGrpSpPr>
        <p:grpSpPr>
          <a:xfrm>
            <a:off x="801663" y="4090331"/>
            <a:ext cx="2152706" cy="1572734"/>
            <a:chOff x="1531633" y="4166344"/>
            <a:chExt cx="2152706" cy="1572734"/>
          </a:xfrm>
        </p:grpSpPr>
        <p:sp>
          <p:nvSpPr>
            <p:cNvPr id="118" name="文本框 52">
              <a:extLst>
                <a:ext uri="{FF2B5EF4-FFF2-40B4-BE49-F238E27FC236}">
                  <a16:creationId xmlns:a16="http://schemas.microsoft.com/office/drawing/2014/main" id="{3F7BE49F-DA0F-4D38-9085-E349B31C519A}"/>
                </a:ext>
              </a:extLst>
            </p:cNvPr>
            <p:cNvSpPr txBox="1"/>
            <p:nvPr/>
          </p:nvSpPr>
          <p:spPr>
            <a:xfrm>
              <a:off x="1772267" y="4166344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AMIN6</a:t>
              </a:r>
              <a:endParaRPr lang="zh-CN" altLang="en-US" sz="1200" b="1" dirty="0"/>
            </a:p>
          </p:txBody>
        </p:sp>
        <p:sp>
          <p:nvSpPr>
            <p:cNvPr id="120" name="文本框 54">
              <a:extLst>
                <a:ext uri="{FF2B5EF4-FFF2-40B4-BE49-F238E27FC236}">
                  <a16:creationId xmlns:a16="http://schemas.microsoft.com/office/drawing/2014/main" id="{8C96C9F8-6376-49F6-8712-E8B22CEF1486}"/>
                </a:ext>
              </a:extLst>
            </p:cNvPr>
            <p:cNvSpPr txBox="1"/>
            <p:nvPr/>
          </p:nvSpPr>
          <p:spPr>
            <a:xfrm>
              <a:off x="2744852" y="4166344"/>
              <a:ext cx="6399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AMIE6</a:t>
              </a:r>
              <a:endParaRPr lang="zh-CN" altLang="en-US" sz="1200" b="1" dirty="0"/>
            </a:p>
          </p:txBody>
        </p:sp>
        <p:pic>
          <p:nvPicPr>
            <p:cNvPr id="123" name="Picture 122">
              <a:extLst>
                <a:ext uri="{FF2B5EF4-FFF2-40B4-BE49-F238E27FC236}">
                  <a16:creationId xmlns:a16="http://schemas.microsoft.com/office/drawing/2014/main" id="{7C03862D-4262-4C13-84C0-05795156D6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55972" t="9318" r="25532" b="55145"/>
            <a:stretch/>
          </p:blipFill>
          <p:spPr>
            <a:xfrm>
              <a:off x="2671280" y="4489479"/>
              <a:ext cx="991490" cy="1159995"/>
            </a:xfrm>
            <a:prstGeom prst="rect">
              <a:avLst/>
            </a:prstGeom>
          </p:spPr>
        </p:pic>
        <p:pic>
          <p:nvPicPr>
            <p:cNvPr id="188" name="Picture 187">
              <a:extLst>
                <a:ext uri="{FF2B5EF4-FFF2-40B4-BE49-F238E27FC236}">
                  <a16:creationId xmlns:a16="http://schemas.microsoft.com/office/drawing/2014/main" id="{D4E2C771-C7D2-4813-BD04-29769DF773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33749" t="42173" r="44229" b="7821"/>
            <a:stretch/>
          </p:blipFill>
          <p:spPr>
            <a:xfrm>
              <a:off x="1591575" y="4520122"/>
              <a:ext cx="961469" cy="1159995"/>
            </a:xfrm>
            <a:prstGeom prst="rect">
              <a:avLst/>
            </a:prstGeom>
          </p:spPr>
        </p:pic>
        <p:sp>
          <p:nvSpPr>
            <p:cNvPr id="204" name="Oval 38">
              <a:extLst>
                <a:ext uri="{FF2B5EF4-FFF2-40B4-BE49-F238E27FC236}">
                  <a16:creationId xmlns:a16="http://schemas.microsoft.com/office/drawing/2014/main" id="{DFFE2441-D631-4C96-8303-5639BADF4C5E}"/>
                </a:ext>
              </a:extLst>
            </p:cNvPr>
            <p:cNvSpPr/>
            <p:nvPr/>
          </p:nvSpPr>
          <p:spPr>
            <a:xfrm>
              <a:off x="1681412" y="5231494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6" name="Oval 38">
              <a:extLst>
                <a:ext uri="{FF2B5EF4-FFF2-40B4-BE49-F238E27FC236}">
                  <a16:creationId xmlns:a16="http://schemas.microsoft.com/office/drawing/2014/main" id="{79CB18A8-0E27-41EC-A38B-013B7DC75B1F}"/>
                </a:ext>
              </a:extLst>
            </p:cNvPr>
            <p:cNvSpPr/>
            <p:nvPr/>
          </p:nvSpPr>
          <p:spPr>
            <a:xfrm>
              <a:off x="1734104" y="4870952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8" name="Oval 38">
              <a:extLst>
                <a:ext uri="{FF2B5EF4-FFF2-40B4-BE49-F238E27FC236}">
                  <a16:creationId xmlns:a16="http://schemas.microsoft.com/office/drawing/2014/main" id="{2EF65354-CDB1-4819-AEA4-DE2025817022}"/>
                </a:ext>
              </a:extLst>
            </p:cNvPr>
            <p:cNvSpPr/>
            <p:nvPr/>
          </p:nvSpPr>
          <p:spPr>
            <a:xfrm>
              <a:off x="1883742" y="4511013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4" name="Oval 38">
              <a:extLst>
                <a:ext uri="{FF2B5EF4-FFF2-40B4-BE49-F238E27FC236}">
                  <a16:creationId xmlns:a16="http://schemas.microsoft.com/office/drawing/2014/main" id="{1CA63AC9-484F-4B79-A8A7-3C455BFE17DB}"/>
                </a:ext>
              </a:extLst>
            </p:cNvPr>
            <p:cNvSpPr/>
            <p:nvPr/>
          </p:nvSpPr>
          <p:spPr>
            <a:xfrm>
              <a:off x="3234624" y="4890173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6" name="Oval 38">
              <a:extLst>
                <a:ext uri="{FF2B5EF4-FFF2-40B4-BE49-F238E27FC236}">
                  <a16:creationId xmlns:a16="http://schemas.microsoft.com/office/drawing/2014/main" id="{81314F28-931D-4CC4-A741-E52497ED521D}"/>
                </a:ext>
              </a:extLst>
            </p:cNvPr>
            <p:cNvSpPr/>
            <p:nvPr/>
          </p:nvSpPr>
          <p:spPr>
            <a:xfrm>
              <a:off x="3151303" y="4576658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8" name="Oval 38">
              <a:extLst>
                <a:ext uri="{FF2B5EF4-FFF2-40B4-BE49-F238E27FC236}">
                  <a16:creationId xmlns:a16="http://schemas.microsoft.com/office/drawing/2014/main" id="{B2643B43-90C1-4565-86A2-1501B4B45665}"/>
                </a:ext>
              </a:extLst>
            </p:cNvPr>
            <p:cNvSpPr/>
            <p:nvPr/>
          </p:nvSpPr>
          <p:spPr>
            <a:xfrm>
              <a:off x="2818525" y="5247015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0" name="Oval 38">
              <a:extLst>
                <a:ext uri="{FF2B5EF4-FFF2-40B4-BE49-F238E27FC236}">
                  <a16:creationId xmlns:a16="http://schemas.microsoft.com/office/drawing/2014/main" id="{B09926A9-F040-40DB-A06B-08D97E613F08}"/>
                </a:ext>
              </a:extLst>
            </p:cNvPr>
            <p:cNvSpPr/>
            <p:nvPr/>
          </p:nvSpPr>
          <p:spPr>
            <a:xfrm>
              <a:off x="2761333" y="4936579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2" name="Oval 38">
              <a:extLst>
                <a:ext uri="{FF2B5EF4-FFF2-40B4-BE49-F238E27FC236}">
                  <a16:creationId xmlns:a16="http://schemas.microsoft.com/office/drawing/2014/main" id="{B54EF2C5-B566-43E6-8BA0-0A3E954A9CF8}"/>
                </a:ext>
              </a:extLst>
            </p:cNvPr>
            <p:cNvSpPr/>
            <p:nvPr/>
          </p:nvSpPr>
          <p:spPr>
            <a:xfrm>
              <a:off x="2802743" y="4604103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4" name="Oval 38">
              <a:extLst>
                <a:ext uri="{FF2B5EF4-FFF2-40B4-BE49-F238E27FC236}">
                  <a16:creationId xmlns:a16="http://schemas.microsoft.com/office/drawing/2014/main" id="{7996BE48-5E5E-4A18-978A-04F60AA2508D}"/>
                </a:ext>
              </a:extLst>
            </p:cNvPr>
            <p:cNvSpPr/>
            <p:nvPr/>
          </p:nvSpPr>
          <p:spPr>
            <a:xfrm>
              <a:off x="2167381" y="5013118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6" name="Oval 38">
              <a:extLst>
                <a:ext uri="{FF2B5EF4-FFF2-40B4-BE49-F238E27FC236}">
                  <a16:creationId xmlns:a16="http://schemas.microsoft.com/office/drawing/2014/main" id="{694DC2D7-466A-4122-938C-B8330F94A670}"/>
                </a:ext>
              </a:extLst>
            </p:cNvPr>
            <p:cNvSpPr/>
            <p:nvPr/>
          </p:nvSpPr>
          <p:spPr>
            <a:xfrm>
              <a:off x="2193447" y="4621184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0" name="TextBox 53">
              <a:extLst>
                <a:ext uri="{FF2B5EF4-FFF2-40B4-BE49-F238E27FC236}">
                  <a16:creationId xmlns:a16="http://schemas.microsoft.com/office/drawing/2014/main" id="{19902C68-E034-4CA9-B21F-FF7D754D2720}"/>
                </a:ext>
              </a:extLst>
            </p:cNvPr>
            <p:cNvSpPr txBox="1"/>
            <p:nvPr/>
          </p:nvSpPr>
          <p:spPr>
            <a:xfrm>
              <a:off x="1531633" y="468509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2</a:t>
              </a:r>
            </a:p>
          </p:txBody>
        </p:sp>
        <p:sp>
          <p:nvSpPr>
            <p:cNvPr id="282" name="TextBox 53">
              <a:extLst>
                <a:ext uri="{FF2B5EF4-FFF2-40B4-BE49-F238E27FC236}">
                  <a16:creationId xmlns:a16="http://schemas.microsoft.com/office/drawing/2014/main" id="{759EC7D0-FFDA-4547-A4D4-CEAACAA71D97}"/>
                </a:ext>
              </a:extLst>
            </p:cNvPr>
            <p:cNvSpPr txBox="1"/>
            <p:nvPr/>
          </p:nvSpPr>
          <p:spPr>
            <a:xfrm>
              <a:off x="1554909" y="546207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3</a:t>
              </a:r>
            </a:p>
          </p:txBody>
        </p:sp>
        <p:sp>
          <p:nvSpPr>
            <p:cNvPr id="284" name="TextBox 53">
              <a:extLst>
                <a:ext uri="{FF2B5EF4-FFF2-40B4-BE49-F238E27FC236}">
                  <a16:creationId xmlns:a16="http://schemas.microsoft.com/office/drawing/2014/main" id="{E446ABAE-CA29-46B2-BC27-184A0C2DD79A}"/>
                </a:ext>
              </a:extLst>
            </p:cNvPr>
            <p:cNvSpPr txBox="1"/>
            <p:nvPr/>
          </p:nvSpPr>
          <p:spPr>
            <a:xfrm>
              <a:off x="2348290" y="446161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4</a:t>
              </a:r>
            </a:p>
          </p:txBody>
        </p:sp>
        <p:sp>
          <p:nvSpPr>
            <p:cNvPr id="286" name="TextBox 53">
              <a:extLst>
                <a:ext uri="{FF2B5EF4-FFF2-40B4-BE49-F238E27FC236}">
                  <a16:creationId xmlns:a16="http://schemas.microsoft.com/office/drawing/2014/main" id="{2046CC05-F9AA-403A-A79C-49D36AFE564A}"/>
                </a:ext>
              </a:extLst>
            </p:cNvPr>
            <p:cNvSpPr txBox="1"/>
            <p:nvPr/>
          </p:nvSpPr>
          <p:spPr>
            <a:xfrm>
              <a:off x="1691604" y="448246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1</a:t>
              </a:r>
            </a:p>
          </p:txBody>
        </p:sp>
        <p:sp>
          <p:nvSpPr>
            <p:cNvPr id="288" name="TextBox 53">
              <a:extLst>
                <a:ext uri="{FF2B5EF4-FFF2-40B4-BE49-F238E27FC236}">
                  <a16:creationId xmlns:a16="http://schemas.microsoft.com/office/drawing/2014/main" id="{6FECCAA9-BC6C-4814-92AA-C1C89B9DCB35}"/>
                </a:ext>
              </a:extLst>
            </p:cNvPr>
            <p:cNvSpPr txBox="1"/>
            <p:nvPr/>
          </p:nvSpPr>
          <p:spPr>
            <a:xfrm>
              <a:off x="2210143" y="530453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5</a:t>
              </a:r>
            </a:p>
          </p:txBody>
        </p:sp>
        <p:sp>
          <p:nvSpPr>
            <p:cNvPr id="290" name="TextBox 53">
              <a:extLst>
                <a:ext uri="{FF2B5EF4-FFF2-40B4-BE49-F238E27FC236}">
                  <a16:creationId xmlns:a16="http://schemas.microsoft.com/office/drawing/2014/main" id="{366834CB-E524-4B8C-91AB-E3574F11BE15}"/>
                </a:ext>
              </a:extLst>
            </p:cNvPr>
            <p:cNvSpPr txBox="1"/>
            <p:nvPr/>
          </p:nvSpPr>
          <p:spPr>
            <a:xfrm>
              <a:off x="3414713" y="450128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4</a:t>
              </a:r>
            </a:p>
          </p:txBody>
        </p:sp>
        <p:sp>
          <p:nvSpPr>
            <p:cNvPr id="296" name="TextBox 53">
              <a:extLst>
                <a:ext uri="{FF2B5EF4-FFF2-40B4-BE49-F238E27FC236}">
                  <a16:creationId xmlns:a16="http://schemas.microsoft.com/office/drawing/2014/main" id="{EC846877-6A1C-4D79-B770-4DDF5B0F5CF7}"/>
                </a:ext>
              </a:extLst>
            </p:cNvPr>
            <p:cNvSpPr txBox="1"/>
            <p:nvPr/>
          </p:nvSpPr>
          <p:spPr>
            <a:xfrm>
              <a:off x="2612986" y="44418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1</a:t>
              </a:r>
            </a:p>
          </p:txBody>
        </p:sp>
        <p:sp>
          <p:nvSpPr>
            <p:cNvPr id="302" name="TextBox 53">
              <a:extLst>
                <a:ext uri="{FF2B5EF4-FFF2-40B4-BE49-F238E27FC236}">
                  <a16:creationId xmlns:a16="http://schemas.microsoft.com/office/drawing/2014/main" id="{EA4CA9A8-F94B-4A7E-BF67-F85A5D908C9D}"/>
                </a:ext>
              </a:extLst>
            </p:cNvPr>
            <p:cNvSpPr txBox="1"/>
            <p:nvPr/>
          </p:nvSpPr>
          <p:spPr>
            <a:xfrm>
              <a:off x="2597360" y="478951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2</a:t>
              </a:r>
            </a:p>
          </p:txBody>
        </p:sp>
        <p:sp>
          <p:nvSpPr>
            <p:cNvPr id="308" name="TextBox 53">
              <a:extLst>
                <a:ext uri="{FF2B5EF4-FFF2-40B4-BE49-F238E27FC236}">
                  <a16:creationId xmlns:a16="http://schemas.microsoft.com/office/drawing/2014/main" id="{75D5E209-794E-4051-A7A9-E09524BB0AC4}"/>
                </a:ext>
              </a:extLst>
            </p:cNvPr>
            <p:cNvSpPr txBox="1"/>
            <p:nvPr/>
          </p:nvSpPr>
          <p:spPr>
            <a:xfrm>
              <a:off x="2621494" y="540562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3</a:t>
              </a:r>
            </a:p>
          </p:txBody>
        </p:sp>
        <p:sp>
          <p:nvSpPr>
            <p:cNvPr id="314" name="TextBox 53">
              <a:extLst>
                <a:ext uri="{FF2B5EF4-FFF2-40B4-BE49-F238E27FC236}">
                  <a16:creationId xmlns:a16="http://schemas.microsoft.com/office/drawing/2014/main" id="{570BC6FD-BDE3-49AD-8A1B-40917C2FC153}"/>
                </a:ext>
              </a:extLst>
            </p:cNvPr>
            <p:cNvSpPr txBox="1"/>
            <p:nvPr/>
          </p:nvSpPr>
          <p:spPr>
            <a:xfrm>
              <a:off x="3405822" y="511987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5</a:t>
              </a:r>
            </a:p>
          </p:txBody>
        </p:sp>
      </p:grpSp>
      <p:grpSp>
        <p:nvGrpSpPr>
          <p:cNvPr id="169" name="组合 168">
            <a:extLst>
              <a:ext uri="{FF2B5EF4-FFF2-40B4-BE49-F238E27FC236}">
                <a16:creationId xmlns:a16="http://schemas.microsoft.com/office/drawing/2014/main" id="{379B6136-FF61-48FC-BD9C-5694A14B280C}"/>
              </a:ext>
            </a:extLst>
          </p:cNvPr>
          <p:cNvGrpSpPr/>
          <p:nvPr/>
        </p:nvGrpSpPr>
        <p:grpSpPr>
          <a:xfrm>
            <a:off x="4663079" y="604205"/>
            <a:ext cx="2203636" cy="2934804"/>
            <a:chOff x="4663079" y="604205"/>
            <a:chExt cx="2203636" cy="2934804"/>
          </a:xfrm>
        </p:grpSpPr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AD057F8F-EA8A-4411-A66B-97AB4743732F}"/>
                </a:ext>
              </a:extLst>
            </p:cNvPr>
            <p:cNvSpPr txBox="1"/>
            <p:nvPr/>
          </p:nvSpPr>
          <p:spPr>
            <a:xfrm>
              <a:off x="5204277" y="604205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AMIN-</a:t>
              </a:r>
              <a:endParaRPr lang="zh-CN" altLang="en-US" sz="1200" b="1" dirty="0"/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079AE90E-D354-43E9-90E0-4BFFDB8DF6D9}"/>
                </a:ext>
              </a:extLst>
            </p:cNvPr>
            <p:cNvSpPr txBox="1"/>
            <p:nvPr/>
          </p:nvSpPr>
          <p:spPr>
            <a:xfrm>
              <a:off x="6176862" y="604205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AMIE-</a:t>
              </a:r>
              <a:endParaRPr lang="zh-CN" altLang="en-US" sz="1200" b="1" dirty="0"/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D792BD25-3989-4A15-A734-AB52AB4F912B}"/>
                </a:ext>
              </a:extLst>
            </p:cNvPr>
            <p:cNvSpPr txBox="1"/>
            <p:nvPr/>
          </p:nvSpPr>
          <p:spPr>
            <a:xfrm flipH="1">
              <a:off x="4663079" y="917741"/>
              <a:ext cx="4208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C1</a:t>
              </a:r>
              <a:endParaRPr lang="zh-CN" altLang="en-US" sz="1200" b="1" dirty="0"/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E6E2E181-1DD4-4469-8370-BDC78F4D4958}"/>
                </a:ext>
              </a:extLst>
            </p:cNvPr>
            <p:cNvSpPr txBox="1"/>
            <p:nvPr/>
          </p:nvSpPr>
          <p:spPr>
            <a:xfrm flipH="1">
              <a:off x="4663079" y="1328861"/>
              <a:ext cx="4208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C2</a:t>
              </a:r>
              <a:endParaRPr lang="zh-CN" altLang="en-US" sz="1200" b="1" dirty="0"/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3956C429-02CD-49AC-918E-943FEF692D86}"/>
                </a:ext>
              </a:extLst>
            </p:cNvPr>
            <p:cNvSpPr txBox="1"/>
            <p:nvPr/>
          </p:nvSpPr>
          <p:spPr>
            <a:xfrm flipH="1">
              <a:off x="4663079" y="2444490"/>
              <a:ext cx="4208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CP</a:t>
              </a:r>
              <a:endParaRPr lang="zh-CN" altLang="en-US" sz="1200" b="1" dirty="0"/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B0C92F60-41F8-4011-B9B8-2EC1C1B6957B}"/>
                </a:ext>
              </a:extLst>
            </p:cNvPr>
            <p:cNvSpPr txBox="1"/>
            <p:nvPr/>
          </p:nvSpPr>
          <p:spPr>
            <a:xfrm flipH="1">
              <a:off x="4663079" y="2817438"/>
              <a:ext cx="4208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V1</a:t>
              </a:r>
              <a:endParaRPr lang="zh-CN" altLang="en-US" sz="1200" b="1" dirty="0"/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164B9396-0997-4C6B-81BA-64D3D6C29973}"/>
                </a:ext>
              </a:extLst>
            </p:cNvPr>
            <p:cNvSpPr txBox="1"/>
            <p:nvPr/>
          </p:nvSpPr>
          <p:spPr>
            <a:xfrm flipH="1">
              <a:off x="4663079" y="1729448"/>
              <a:ext cx="4208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C3</a:t>
              </a:r>
              <a:endParaRPr lang="zh-CN" altLang="en-US" sz="1200" b="1" dirty="0"/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F1044E43-C834-43D9-88BA-E9501441C3BF}"/>
                </a:ext>
              </a:extLst>
            </p:cNvPr>
            <p:cNvSpPr txBox="1"/>
            <p:nvPr/>
          </p:nvSpPr>
          <p:spPr>
            <a:xfrm flipH="1">
              <a:off x="4663079" y="2091927"/>
              <a:ext cx="4208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C4</a:t>
              </a:r>
              <a:endParaRPr lang="zh-CN" altLang="en-US" sz="1200" b="1" dirty="0"/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FBEE6AE7-68A7-48B3-B537-25DAF8C11ACF}"/>
                </a:ext>
              </a:extLst>
            </p:cNvPr>
            <p:cNvSpPr txBox="1"/>
            <p:nvPr/>
          </p:nvSpPr>
          <p:spPr>
            <a:xfrm flipH="1">
              <a:off x="4663079" y="3219566"/>
              <a:ext cx="5019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bC1</a:t>
              </a:r>
              <a:endParaRPr lang="zh-CN" altLang="en-US" sz="1200" b="1" dirty="0"/>
            </a:p>
          </p:txBody>
        </p:sp>
        <p:pic>
          <p:nvPicPr>
            <p:cNvPr id="95" name="Picture 101">
              <a:extLst>
                <a:ext uri="{FF2B5EF4-FFF2-40B4-BE49-F238E27FC236}">
                  <a16:creationId xmlns:a16="http://schemas.microsoft.com/office/drawing/2014/main" id="{B379DE08-1A37-42B6-BD8B-447243DE72C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 cstate="email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39697" b="15358"/>
            <a:stretch/>
          </p:blipFill>
          <p:spPr>
            <a:xfrm>
              <a:off x="6146715" y="884685"/>
              <a:ext cx="720000" cy="343110"/>
            </a:xfrm>
            <a:prstGeom prst="rect">
              <a:avLst/>
            </a:prstGeom>
          </p:spPr>
        </p:pic>
        <p:pic>
          <p:nvPicPr>
            <p:cNvPr id="97" name="Picture 102">
              <a:extLst>
                <a:ext uri="{FF2B5EF4-FFF2-40B4-BE49-F238E27FC236}">
                  <a16:creationId xmlns:a16="http://schemas.microsoft.com/office/drawing/2014/main" id="{89FF86FD-3225-4B2D-97B1-F96A1A47D27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 cstate="email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50000"/>
                      </a14:imgEffect>
                      <a14:imgEffect>
                        <a14:saturation sat="2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43465" b="9231"/>
            <a:stretch/>
          </p:blipFill>
          <p:spPr>
            <a:xfrm>
              <a:off x="6146715" y="1288924"/>
              <a:ext cx="720000" cy="356872"/>
            </a:xfrm>
            <a:prstGeom prst="rect">
              <a:avLst/>
            </a:prstGeom>
          </p:spPr>
        </p:pic>
        <p:pic>
          <p:nvPicPr>
            <p:cNvPr id="99" name="Picture 103">
              <a:extLst>
                <a:ext uri="{FF2B5EF4-FFF2-40B4-BE49-F238E27FC236}">
                  <a16:creationId xmlns:a16="http://schemas.microsoft.com/office/drawing/2014/main" id="{8DA832E7-540F-4F04-B525-69194BA5281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0" cstate="email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aturation sat="3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42262" b="10281"/>
            <a:stretch/>
          </p:blipFill>
          <p:spPr>
            <a:xfrm>
              <a:off x="6146715" y="2091927"/>
              <a:ext cx="720000" cy="276999"/>
            </a:xfrm>
            <a:prstGeom prst="rect">
              <a:avLst/>
            </a:prstGeom>
          </p:spPr>
        </p:pic>
        <p:pic>
          <p:nvPicPr>
            <p:cNvPr id="101" name="Picture 104">
              <a:extLst>
                <a:ext uri="{FF2B5EF4-FFF2-40B4-BE49-F238E27FC236}">
                  <a16:creationId xmlns:a16="http://schemas.microsoft.com/office/drawing/2014/main" id="{0E39AEBB-1C28-42D7-BC70-077F22850DF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2" cstate="email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aturation sat="200000"/>
                      </a14:imgEffect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48265" b="8663"/>
            <a:stretch/>
          </p:blipFill>
          <p:spPr>
            <a:xfrm>
              <a:off x="6146715" y="2425515"/>
              <a:ext cx="720000" cy="314949"/>
            </a:xfrm>
            <a:prstGeom prst="rect">
              <a:avLst/>
            </a:prstGeom>
          </p:spPr>
        </p:pic>
        <p:pic>
          <p:nvPicPr>
            <p:cNvPr id="103" name="Picture 105">
              <a:extLst>
                <a:ext uri="{FF2B5EF4-FFF2-40B4-BE49-F238E27FC236}">
                  <a16:creationId xmlns:a16="http://schemas.microsoft.com/office/drawing/2014/main" id="{3F7D15E2-6DCB-4DB6-93CA-5197E12B92F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4" cstate="email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aturation sat="3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50206" b="2971"/>
            <a:stretch/>
          </p:blipFill>
          <p:spPr>
            <a:xfrm>
              <a:off x="6146715" y="2798462"/>
              <a:ext cx="720000" cy="314950"/>
            </a:xfrm>
            <a:prstGeom prst="rect">
              <a:avLst/>
            </a:prstGeom>
          </p:spPr>
        </p:pic>
        <p:pic>
          <p:nvPicPr>
            <p:cNvPr id="105" name="Picture 106">
              <a:extLst>
                <a:ext uri="{FF2B5EF4-FFF2-40B4-BE49-F238E27FC236}">
                  <a16:creationId xmlns:a16="http://schemas.microsoft.com/office/drawing/2014/main" id="{97A4A501-C3F7-4B84-9C02-3864F0061A9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6" cstate="email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saturation sat="200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44566" b="7035"/>
            <a:stretch/>
          </p:blipFill>
          <p:spPr>
            <a:xfrm>
              <a:off x="6146715" y="3177122"/>
              <a:ext cx="720000" cy="361887"/>
            </a:xfrm>
            <a:prstGeom prst="rect">
              <a:avLst/>
            </a:prstGeom>
          </p:spPr>
        </p:pic>
        <p:pic>
          <p:nvPicPr>
            <p:cNvPr id="107" name="Picture 107">
              <a:extLst>
                <a:ext uri="{FF2B5EF4-FFF2-40B4-BE49-F238E27FC236}">
                  <a16:creationId xmlns:a16="http://schemas.microsoft.com/office/drawing/2014/main" id="{04AB4A67-FD49-4432-B904-871CD40A27D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8" cstate="email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sharpenSoften amount="50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45392" b="10071"/>
            <a:stretch/>
          </p:blipFill>
          <p:spPr>
            <a:xfrm>
              <a:off x="6146715" y="1703154"/>
              <a:ext cx="720000" cy="329587"/>
            </a:xfrm>
            <a:prstGeom prst="rect">
              <a:avLst/>
            </a:prstGeom>
          </p:spPr>
        </p:pic>
        <p:pic>
          <p:nvPicPr>
            <p:cNvPr id="109" name="Picture 108">
              <a:extLst>
                <a:ext uri="{FF2B5EF4-FFF2-40B4-BE49-F238E27FC236}">
                  <a16:creationId xmlns:a16="http://schemas.microsoft.com/office/drawing/2014/main" id="{158A86F7-44F9-40A5-A878-5351460B71AC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0" cstate="email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45283" b="8504"/>
            <a:stretch/>
          </p:blipFill>
          <p:spPr>
            <a:xfrm>
              <a:off x="5126011" y="1703154"/>
              <a:ext cx="720000" cy="329586"/>
            </a:xfrm>
            <a:prstGeom prst="rect">
              <a:avLst/>
            </a:prstGeom>
          </p:spPr>
        </p:pic>
        <p:pic>
          <p:nvPicPr>
            <p:cNvPr id="111" name="Picture 109">
              <a:extLst>
                <a:ext uri="{FF2B5EF4-FFF2-40B4-BE49-F238E27FC236}">
                  <a16:creationId xmlns:a16="http://schemas.microsoft.com/office/drawing/2014/main" id="{9CFF41FC-28CD-4367-8C7A-F2BA0CCB845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2" cstate="email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saturation sat="200000"/>
                      </a14:imgEffect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44882" b="6731"/>
            <a:stretch/>
          </p:blipFill>
          <p:spPr>
            <a:xfrm>
              <a:off x="5126011" y="884685"/>
              <a:ext cx="720000" cy="343110"/>
            </a:xfrm>
            <a:prstGeom prst="rect">
              <a:avLst/>
            </a:prstGeom>
          </p:spPr>
        </p:pic>
        <p:pic>
          <p:nvPicPr>
            <p:cNvPr id="113" name="Picture 110">
              <a:extLst>
                <a:ext uri="{FF2B5EF4-FFF2-40B4-BE49-F238E27FC236}">
                  <a16:creationId xmlns:a16="http://schemas.microsoft.com/office/drawing/2014/main" id="{5F1FD9B8-E22B-4259-B552-C093C92C378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4" cstate="email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saturation sat="20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45241" b="11381"/>
            <a:stretch/>
          </p:blipFill>
          <p:spPr>
            <a:xfrm>
              <a:off x="5126011" y="2425515"/>
              <a:ext cx="720000" cy="314948"/>
            </a:xfrm>
            <a:prstGeom prst="rect">
              <a:avLst/>
            </a:prstGeom>
          </p:spPr>
        </p:pic>
        <p:pic>
          <p:nvPicPr>
            <p:cNvPr id="115" name="Picture 111">
              <a:extLst>
                <a:ext uri="{FF2B5EF4-FFF2-40B4-BE49-F238E27FC236}">
                  <a16:creationId xmlns:a16="http://schemas.microsoft.com/office/drawing/2014/main" id="{651FF5FD-59C1-4245-BA7B-79329FA861C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6" cstate="email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48904" b="12113"/>
            <a:stretch/>
          </p:blipFill>
          <p:spPr>
            <a:xfrm>
              <a:off x="5126011" y="2087091"/>
              <a:ext cx="720000" cy="286671"/>
            </a:xfrm>
            <a:prstGeom prst="rect">
              <a:avLst/>
            </a:prstGeom>
          </p:spPr>
        </p:pic>
        <p:pic>
          <p:nvPicPr>
            <p:cNvPr id="117" name="Picture 112">
              <a:extLst>
                <a:ext uri="{FF2B5EF4-FFF2-40B4-BE49-F238E27FC236}">
                  <a16:creationId xmlns:a16="http://schemas.microsoft.com/office/drawing/2014/main" id="{024506C8-3FFE-45D3-BFBC-BAE2CAB796C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8" cstate="email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42146" b="19155"/>
            <a:stretch/>
          </p:blipFill>
          <p:spPr>
            <a:xfrm>
              <a:off x="5126011" y="2798463"/>
              <a:ext cx="720000" cy="314949"/>
            </a:xfrm>
            <a:prstGeom prst="rect">
              <a:avLst/>
            </a:prstGeom>
          </p:spPr>
        </p:pic>
        <p:pic>
          <p:nvPicPr>
            <p:cNvPr id="119" name="Picture 113">
              <a:extLst>
                <a:ext uri="{FF2B5EF4-FFF2-40B4-BE49-F238E27FC236}">
                  <a16:creationId xmlns:a16="http://schemas.microsoft.com/office/drawing/2014/main" id="{E7DAB008-C5EE-423E-BAF6-BECF4C15B04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0" cstate="email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43261" b="4721"/>
            <a:stretch/>
          </p:blipFill>
          <p:spPr>
            <a:xfrm>
              <a:off x="5126011" y="1288925"/>
              <a:ext cx="720000" cy="356871"/>
            </a:xfrm>
            <a:prstGeom prst="rect">
              <a:avLst/>
            </a:prstGeom>
          </p:spPr>
        </p:pic>
        <p:pic>
          <p:nvPicPr>
            <p:cNvPr id="121" name="Picture 114" descr="A picture containing animal, sitting, table, surface&#10;&#10;Description automatically generated">
              <a:extLst>
                <a:ext uri="{FF2B5EF4-FFF2-40B4-BE49-F238E27FC236}">
                  <a16:creationId xmlns:a16="http://schemas.microsoft.com/office/drawing/2014/main" id="{9C1DBAEF-937D-475B-8AAA-F0B484F3149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2" cstate="email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saturation sat="200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41387" b="8069"/>
            <a:stretch/>
          </p:blipFill>
          <p:spPr>
            <a:xfrm>
              <a:off x="5126011" y="3177121"/>
              <a:ext cx="720000" cy="361888"/>
            </a:xfrm>
            <a:prstGeom prst="rect">
              <a:avLst/>
            </a:prstGeom>
          </p:spPr>
        </p:pic>
        <p:sp>
          <p:nvSpPr>
            <p:cNvPr id="122" name="椭圆 121">
              <a:extLst>
                <a:ext uri="{FF2B5EF4-FFF2-40B4-BE49-F238E27FC236}">
                  <a16:creationId xmlns:a16="http://schemas.microsoft.com/office/drawing/2014/main" id="{A5D0174F-FB1C-4716-83A7-AF5754D8324E}"/>
                </a:ext>
              </a:extLst>
            </p:cNvPr>
            <p:cNvSpPr/>
            <p:nvPr/>
          </p:nvSpPr>
          <p:spPr>
            <a:xfrm>
              <a:off x="5571811" y="950641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" name="椭圆 123">
              <a:extLst>
                <a:ext uri="{FF2B5EF4-FFF2-40B4-BE49-F238E27FC236}">
                  <a16:creationId xmlns:a16="http://schemas.microsoft.com/office/drawing/2014/main" id="{8318F664-79D9-41B0-93A1-E34DFFEB6FEA}"/>
                </a:ext>
              </a:extLst>
            </p:cNvPr>
            <p:cNvSpPr/>
            <p:nvPr/>
          </p:nvSpPr>
          <p:spPr>
            <a:xfrm>
              <a:off x="6546144" y="964307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6" name="椭圆 125">
              <a:extLst>
                <a:ext uri="{FF2B5EF4-FFF2-40B4-BE49-F238E27FC236}">
                  <a16:creationId xmlns:a16="http://schemas.microsoft.com/office/drawing/2014/main" id="{69F67DFE-D5ED-4F5B-9ADE-DC21267C06E2}"/>
                </a:ext>
              </a:extLst>
            </p:cNvPr>
            <p:cNvSpPr/>
            <p:nvPr/>
          </p:nvSpPr>
          <p:spPr>
            <a:xfrm>
              <a:off x="5539465" y="1380225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8" name="椭圆 127">
              <a:extLst>
                <a:ext uri="{FF2B5EF4-FFF2-40B4-BE49-F238E27FC236}">
                  <a16:creationId xmlns:a16="http://schemas.microsoft.com/office/drawing/2014/main" id="{47FA1DF2-BABE-4A51-9D76-8AEF5FBA8249}"/>
                </a:ext>
              </a:extLst>
            </p:cNvPr>
            <p:cNvSpPr/>
            <p:nvPr/>
          </p:nvSpPr>
          <p:spPr>
            <a:xfrm>
              <a:off x="6558505" y="1395239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0" name="椭圆 129">
              <a:extLst>
                <a:ext uri="{FF2B5EF4-FFF2-40B4-BE49-F238E27FC236}">
                  <a16:creationId xmlns:a16="http://schemas.microsoft.com/office/drawing/2014/main" id="{9BBCFF86-AC6F-465D-B592-FC6285611F77}"/>
                </a:ext>
              </a:extLst>
            </p:cNvPr>
            <p:cNvSpPr/>
            <p:nvPr/>
          </p:nvSpPr>
          <p:spPr>
            <a:xfrm>
              <a:off x="5539464" y="1744448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" name="椭圆 131">
              <a:extLst>
                <a:ext uri="{FF2B5EF4-FFF2-40B4-BE49-F238E27FC236}">
                  <a16:creationId xmlns:a16="http://schemas.microsoft.com/office/drawing/2014/main" id="{F08A56CB-174C-4710-8708-4F487EA6114A}"/>
                </a:ext>
              </a:extLst>
            </p:cNvPr>
            <p:cNvSpPr/>
            <p:nvPr/>
          </p:nvSpPr>
          <p:spPr>
            <a:xfrm>
              <a:off x="6535251" y="1739996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4" name="椭圆 133">
              <a:extLst>
                <a:ext uri="{FF2B5EF4-FFF2-40B4-BE49-F238E27FC236}">
                  <a16:creationId xmlns:a16="http://schemas.microsoft.com/office/drawing/2014/main" id="{B5A561F1-A717-48DC-80EC-888F4BB38044}"/>
                </a:ext>
              </a:extLst>
            </p:cNvPr>
            <p:cNvSpPr/>
            <p:nvPr/>
          </p:nvSpPr>
          <p:spPr>
            <a:xfrm>
              <a:off x="5513498" y="2128958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6" name="椭圆 135">
              <a:extLst>
                <a:ext uri="{FF2B5EF4-FFF2-40B4-BE49-F238E27FC236}">
                  <a16:creationId xmlns:a16="http://schemas.microsoft.com/office/drawing/2014/main" id="{269DC734-39E1-4919-BB5C-C89EF0425A1B}"/>
                </a:ext>
              </a:extLst>
            </p:cNvPr>
            <p:cNvSpPr/>
            <p:nvPr/>
          </p:nvSpPr>
          <p:spPr>
            <a:xfrm>
              <a:off x="6532107" y="2113290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8" name="椭圆 137">
              <a:extLst>
                <a:ext uri="{FF2B5EF4-FFF2-40B4-BE49-F238E27FC236}">
                  <a16:creationId xmlns:a16="http://schemas.microsoft.com/office/drawing/2014/main" id="{57163D43-73E6-42DC-A6B7-9B4D70F9BA49}"/>
                </a:ext>
              </a:extLst>
            </p:cNvPr>
            <p:cNvSpPr/>
            <p:nvPr/>
          </p:nvSpPr>
          <p:spPr>
            <a:xfrm>
              <a:off x="5539463" y="2472721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0" name="椭圆 139">
              <a:extLst>
                <a:ext uri="{FF2B5EF4-FFF2-40B4-BE49-F238E27FC236}">
                  <a16:creationId xmlns:a16="http://schemas.microsoft.com/office/drawing/2014/main" id="{051737E5-FC71-40DC-8AD0-3F279AD41876}"/>
                </a:ext>
              </a:extLst>
            </p:cNvPr>
            <p:cNvSpPr/>
            <p:nvPr/>
          </p:nvSpPr>
          <p:spPr>
            <a:xfrm>
              <a:off x="6527145" y="2468364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2" name="椭圆 141">
              <a:extLst>
                <a:ext uri="{FF2B5EF4-FFF2-40B4-BE49-F238E27FC236}">
                  <a16:creationId xmlns:a16="http://schemas.microsoft.com/office/drawing/2014/main" id="{E21C2566-CC78-49CE-AC46-61C7CCC699AD}"/>
                </a:ext>
              </a:extLst>
            </p:cNvPr>
            <p:cNvSpPr/>
            <p:nvPr/>
          </p:nvSpPr>
          <p:spPr>
            <a:xfrm>
              <a:off x="5507985" y="2847937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4" name="椭圆 143">
              <a:extLst>
                <a:ext uri="{FF2B5EF4-FFF2-40B4-BE49-F238E27FC236}">
                  <a16:creationId xmlns:a16="http://schemas.microsoft.com/office/drawing/2014/main" id="{EADFB442-B500-4812-8631-13D3D60030F9}"/>
                </a:ext>
              </a:extLst>
            </p:cNvPr>
            <p:cNvSpPr/>
            <p:nvPr/>
          </p:nvSpPr>
          <p:spPr>
            <a:xfrm>
              <a:off x="6549835" y="2811694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8" name="椭圆 147">
              <a:extLst>
                <a:ext uri="{FF2B5EF4-FFF2-40B4-BE49-F238E27FC236}">
                  <a16:creationId xmlns:a16="http://schemas.microsoft.com/office/drawing/2014/main" id="{9AE96EFB-DB79-4C94-89DC-AEF5860C0DDD}"/>
                </a:ext>
              </a:extLst>
            </p:cNvPr>
            <p:cNvSpPr/>
            <p:nvPr/>
          </p:nvSpPr>
          <p:spPr>
            <a:xfrm>
              <a:off x="5546239" y="3254684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0" name="椭圆 149">
              <a:extLst>
                <a:ext uri="{FF2B5EF4-FFF2-40B4-BE49-F238E27FC236}">
                  <a16:creationId xmlns:a16="http://schemas.microsoft.com/office/drawing/2014/main" id="{936E4FE6-8563-46FA-8456-49F6AA47A52A}"/>
                </a:ext>
              </a:extLst>
            </p:cNvPr>
            <p:cNvSpPr/>
            <p:nvPr/>
          </p:nvSpPr>
          <p:spPr>
            <a:xfrm>
              <a:off x="5190416" y="930929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2" name="椭圆 151">
              <a:extLst>
                <a:ext uri="{FF2B5EF4-FFF2-40B4-BE49-F238E27FC236}">
                  <a16:creationId xmlns:a16="http://schemas.microsoft.com/office/drawing/2014/main" id="{17E3E1E5-E7C3-43CE-8C93-1CAD30F6ACB8}"/>
                </a:ext>
              </a:extLst>
            </p:cNvPr>
            <p:cNvSpPr/>
            <p:nvPr/>
          </p:nvSpPr>
          <p:spPr>
            <a:xfrm>
              <a:off x="5160866" y="1338095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4" name="椭圆 153">
              <a:extLst>
                <a:ext uri="{FF2B5EF4-FFF2-40B4-BE49-F238E27FC236}">
                  <a16:creationId xmlns:a16="http://schemas.microsoft.com/office/drawing/2014/main" id="{5C8410A8-5939-4623-9A04-DF4526C0E69B}"/>
                </a:ext>
              </a:extLst>
            </p:cNvPr>
            <p:cNvSpPr/>
            <p:nvPr/>
          </p:nvSpPr>
          <p:spPr>
            <a:xfrm>
              <a:off x="5170197" y="1722000"/>
              <a:ext cx="261536" cy="233996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6" name="椭圆 155">
              <a:extLst>
                <a:ext uri="{FF2B5EF4-FFF2-40B4-BE49-F238E27FC236}">
                  <a16:creationId xmlns:a16="http://schemas.microsoft.com/office/drawing/2014/main" id="{405AEAEE-54B4-488B-BD23-CF2077AC0EE0}"/>
                </a:ext>
              </a:extLst>
            </p:cNvPr>
            <p:cNvSpPr/>
            <p:nvPr/>
          </p:nvSpPr>
          <p:spPr>
            <a:xfrm>
              <a:off x="5163855" y="2066236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8" name="椭圆 157">
              <a:extLst>
                <a:ext uri="{FF2B5EF4-FFF2-40B4-BE49-F238E27FC236}">
                  <a16:creationId xmlns:a16="http://schemas.microsoft.com/office/drawing/2014/main" id="{1357A2FD-AD9F-41FB-BCB6-83005509838D}"/>
                </a:ext>
              </a:extLst>
            </p:cNvPr>
            <p:cNvSpPr/>
            <p:nvPr/>
          </p:nvSpPr>
          <p:spPr>
            <a:xfrm>
              <a:off x="5232915" y="2542717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0" name="椭圆 159">
              <a:extLst>
                <a:ext uri="{FF2B5EF4-FFF2-40B4-BE49-F238E27FC236}">
                  <a16:creationId xmlns:a16="http://schemas.microsoft.com/office/drawing/2014/main" id="{66E9FE4E-C0EF-4DA5-96AE-3584C649F0C3}"/>
                </a:ext>
              </a:extLst>
            </p:cNvPr>
            <p:cNvSpPr/>
            <p:nvPr/>
          </p:nvSpPr>
          <p:spPr>
            <a:xfrm>
              <a:off x="5232905" y="2811694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2" name="椭圆 161">
              <a:extLst>
                <a:ext uri="{FF2B5EF4-FFF2-40B4-BE49-F238E27FC236}">
                  <a16:creationId xmlns:a16="http://schemas.microsoft.com/office/drawing/2014/main" id="{5BBA0B21-E1E3-403A-8785-E01BF6F7111E}"/>
                </a:ext>
              </a:extLst>
            </p:cNvPr>
            <p:cNvSpPr/>
            <p:nvPr/>
          </p:nvSpPr>
          <p:spPr>
            <a:xfrm>
              <a:off x="5208000" y="3277474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4" name="椭圆 163">
              <a:extLst>
                <a:ext uri="{FF2B5EF4-FFF2-40B4-BE49-F238E27FC236}">
                  <a16:creationId xmlns:a16="http://schemas.microsoft.com/office/drawing/2014/main" id="{2F03BCC9-5DA6-412B-8F33-FF75C45E7888}"/>
                </a:ext>
              </a:extLst>
            </p:cNvPr>
            <p:cNvSpPr/>
            <p:nvPr/>
          </p:nvSpPr>
          <p:spPr>
            <a:xfrm>
              <a:off x="6234117" y="937793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6" name="椭圆 165">
              <a:extLst>
                <a:ext uri="{FF2B5EF4-FFF2-40B4-BE49-F238E27FC236}">
                  <a16:creationId xmlns:a16="http://schemas.microsoft.com/office/drawing/2014/main" id="{6D116DAF-65A1-410D-929E-A24A26335803}"/>
                </a:ext>
              </a:extLst>
            </p:cNvPr>
            <p:cNvSpPr/>
            <p:nvPr/>
          </p:nvSpPr>
          <p:spPr>
            <a:xfrm>
              <a:off x="6184420" y="1387618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8" name="椭圆 167">
              <a:extLst>
                <a:ext uri="{FF2B5EF4-FFF2-40B4-BE49-F238E27FC236}">
                  <a16:creationId xmlns:a16="http://schemas.microsoft.com/office/drawing/2014/main" id="{CB0310F2-5124-4629-859C-DA83CE82A578}"/>
                </a:ext>
              </a:extLst>
            </p:cNvPr>
            <p:cNvSpPr/>
            <p:nvPr/>
          </p:nvSpPr>
          <p:spPr>
            <a:xfrm>
              <a:off x="6208811" y="1722000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0" name="椭圆 169">
              <a:extLst>
                <a:ext uri="{FF2B5EF4-FFF2-40B4-BE49-F238E27FC236}">
                  <a16:creationId xmlns:a16="http://schemas.microsoft.com/office/drawing/2014/main" id="{4E4C3822-F068-4774-A084-C2DD664DCA4B}"/>
                </a:ext>
              </a:extLst>
            </p:cNvPr>
            <p:cNvSpPr/>
            <p:nvPr/>
          </p:nvSpPr>
          <p:spPr>
            <a:xfrm>
              <a:off x="6207547" y="2087091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2" name="椭圆 171">
              <a:extLst>
                <a:ext uri="{FF2B5EF4-FFF2-40B4-BE49-F238E27FC236}">
                  <a16:creationId xmlns:a16="http://schemas.microsoft.com/office/drawing/2014/main" id="{7C4786EC-E831-4E51-8AC8-3187F4795A5B}"/>
                </a:ext>
              </a:extLst>
            </p:cNvPr>
            <p:cNvSpPr/>
            <p:nvPr/>
          </p:nvSpPr>
          <p:spPr>
            <a:xfrm>
              <a:off x="6212571" y="2451461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4" name="椭圆 173">
              <a:extLst>
                <a:ext uri="{FF2B5EF4-FFF2-40B4-BE49-F238E27FC236}">
                  <a16:creationId xmlns:a16="http://schemas.microsoft.com/office/drawing/2014/main" id="{B8CFEFED-09DC-4D08-BB24-255AC1B4BDCE}"/>
                </a:ext>
              </a:extLst>
            </p:cNvPr>
            <p:cNvSpPr/>
            <p:nvPr/>
          </p:nvSpPr>
          <p:spPr>
            <a:xfrm>
              <a:off x="6194468" y="2800704"/>
              <a:ext cx="262220" cy="241906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6" name="椭圆 175">
              <a:extLst>
                <a:ext uri="{FF2B5EF4-FFF2-40B4-BE49-F238E27FC236}">
                  <a16:creationId xmlns:a16="http://schemas.microsoft.com/office/drawing/2014/main" id="{8E56CD0D-BC9F-4940-9C9D-EA7730642427}"/>
                </a:ext>
              </a:extLst>
            </p:cNvPr>
            <p:cNvSpPr/>
            <p:nvPr/>
          </p:nvSpPr>
          <p:spPr>
            <a:xfrm>
              <a:off x="6197076" y="3174303"/>
              <a:ext cx="259612" cy="291762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9" name="椭圆 148">
              <a:extLst>
                <a:ext uri="{FF2B5EF4-FFF2-40B4-BE49-F238E27FC236}">
                  <a16:creationId xmlns:a16="http://schemas.microsoft.com/office/drawing/2014/main" id="{EE615B67-845C-4144-9FA3-43FC2B91E888}"/>
                </a:ext>
              </a:extLst>
            </p:cNvPr>
            <p:cNvSpPr/>
            <p:nvPr/>
          </p:nvSpPr>
          <p:spPr>
            <a:xfrm>
              <a:off x="6519209" y="3232439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1" name="组合 160">
            <a:extLst>
              <a:ext uri="{FF2B5EF4-FFF2-40B4-BE49-F238E27FC236}">
                <a16:creationId xmlns:a16="http://schemas.microsoft.com/office/drawing/2014/main" id="{C7564563-DA70-4104-9B98-4E99944570FE}"/>
              </a:ext>
            </a:extLst>
          </p:cNvPr>
          <p:cNvGrpSpPr/>
          <p:nvPr/>
        </p:nvGrpSpPr>
        <p:grpSpPr>
          <a:xfrm>
            <a:off x="5454000" y="4106669"/>
            <a:ext cx="2218402" cy="1632940"/>
            <a:chOff x="7334438" y="3784134"/>
            <a:chExt cx="2218402" cy="1632940"/>
          </a:xfrm>
        </p:grpSpPr>
        <p:pic>
          <p:nvPicPr>
            <p:cNvPr id="182" name="Picture 181">
              <a:extLst>
                <a:ext uri="{FF2B5EF4-FFF2-40B4-BE49-F238E27FC236}">
                  <a16:creationId xmlns:a16="http://schemas.microsoft.com/office/drawing/2014/main" id="{65D4A4AF-663D-495A-A64D-DEABCB03A3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303" t="4819" r="80271" b="52427"/>
            <a:stretch/>
          </p:blipFill>
          <p:spPr>
            <a:xfrm>
              <a:off x="7395179" y="4108954"/>
              <a:ext cx="1016521" cy="1242516"/>
            </a:xfrm>
            <a:prstGeom prst="rect">
              <a:avLst/>
            </a:prstGeom>
          </p:spPr>
        </p:pic>
        <p:pic>
          <p:nvPicPr>
            <p:cNvPr id="184" name="Picture 183">
              <a:extLst>
                <a:ext uri="{FF2B5EF4-FFF2-40B4-BE49-F238E27FC236}">
                  <a16:creationId xmlns:a16="http://schemas.microsoft.com/office/drawing/2014/main" id="{17001EC2-FA5E-4846-8073-EA2B1A22F2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58359" r="20773" b="55013"/>
            <a:stretch/>
          </p:blipFill>
          <p:spPr>
            <a:xfrm>
              <a:off x="8471675" y="4108954"/>
              <a:ext cx="1016521" cy="1249054"/>
            </a:xfrm>
            <a:prstGeom prst="rect">
              <a:avLst/>
            </a:prstGeom>
          </p:spPr>
        </p:pic>
        <p:sp>
          <p:nvSpPr>
            <p:cNvPr id="196" name="Oval 38">
              <a:extLst>
                <a:ext uri="{FF2B5EF4-FFF2-40B4-BE49-F238E27FC236}">
                  <a16:creationId xmlns:a16="http://schemas.microsoft.com/office/drawing/2014/main" id="{B4DF8A30-6D2A-4864-80CA-54CBD7E237C9}"/>
                </a:ext>
              </a:extLst>
            </p:cNvPr>
            <p:cNvSpPr/>
            <p:nvPr/>
          </p:nvSpPr>
          <p:spPr>
            <a:xfrm>
              <a:off x="9014014" y="4773739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8" name="Oval 38">
              <a:extLst>
                <a:ext uri="{FF2B5EF4-FFF2-40B4-BE49-F238E27FC236}">
                  <a16:creationId xmlns:a16="http://schemas.microsoft.com/office/drawing/2014/main" id="{335DE242-78EF-4530-AECF-EC6D555C7846}"/>
                </a:ext>
              </a:extLst>
            </p:cNvPr>
            <p:cNvSpPr/>
            <p:nvPr/>
          </p:nvSpPr>
          <p:spPr>
            <a:xfrm>
              <a:off x="8963053" y="4460492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0" name="Oval 38">
              <a:extLst>
                <a:ext uri="{FF2B5EF4-FFF2-40B4-BE49-F238E27FC236}">
                  <a16:creationId xmlns:a16="http://schemas.microsoft.com/office/drawing/2014/main" id="{49036517-BFA6-4C9D-A268-D2CA71F0A45D}"/>
                </a:ext>
              </a:extLst>
            </p:cNvPr>
            <p:cNvSpPr/>
            <p:nvPr/>
          </p:nvSpPr>
          <p:spPr>
            <a:xfrm>
              <a:off x="8484681" y="4852134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2" name="Oval 38">
              <a:extLst>
                <a:ext uri="{FF2B5EF4-FFF2-40B4-BE49-F238E27FC236}">
                  <a16:creationId xmlns:a16="http://schemas.microsoft.com/office/drawing/2014/main" id="{B24A56CD-3F8C-48CD-AB09-BA3A2F230C6C}"/>
                </a:ext>
              </a:extLst>
            </p:cNvPr>
            <p:cNvSpPr/>
            <p:nvPr/>
          </p:nvSpPr>
          <p:spPr>
            <a:xfrm>
              <a:off x="8591335" y="4591925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0" name="Oval 38">
              <a:extLst>
                <a:ext uri="{FF2B5EF4-FFF2-40B4-BE49-F238E27FC236}">
                  <a16:creationId xmlns:a16="http://schemas.microsoft.com/office/drawing/2014/main" id="{A05FDA34-D7FE-44C3-8D83-2C8A4DE7E72D}"/>
                </a:ext>
              </a:extLst>
            </p:cNvPr>
            <p:cNvSpPr/>
            <p:nvPr/>
          </p:nvSpPr>
          <p:spPr>
            <a:xfrm>
              <a:off x="8963054" y="4147245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2" name="Oval 38">
              <a:extLst>
                <a:ext uri="{FF2B5EF4-FFF2-40B4-BE49-F238E27FC236}">
                  <a16:creationId xmlns:a16="http://schemas.microsoft.com/office/drawing/2014/main" id="{A4DD9F0C-D66A-421E-99A9-69398666DD09}"/>
                </a:ext>
              </a:extLst>
            </p:cNvPr>
            <p:cNvSpPr/>
            <p:nvPr/>
          </p:nvSpPr>
          <p:spPr>
            <a:xfrm>
              <a:off x="8647885" y="4189721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8" name="Oval 38">
              <a:extLst>
                <a:ext uri="{FF2B5EF4-FFF2-40B4-BE49-F238E27FC236}">
                  <a16:creationId xmlns:a16="http://schemas.microsoft.com/office/drawing/2014/main" id="{FFC1607E-C757-4583-9968-62CA1D66FD32}"/>
                </a:ext>
              </a:extLst>
            </p:cNvPr>
            <p:cNvSpPr/>
            <p:nvPr/>
          </p:nvSpPr>
          <p:spPr>
            <a:xfrm>
              <a:off x="7972628" y="4949056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0" name="Oval 38">
              <a:extLst>
                <a:ext uri="{FF2B5EF4-FFF2-40B4-BE49-F238E27FC236}">
                  <a16:creationId xmlns:a16="http://schemas.microsoft.com/office/drawing/2014/main" id="{7283CB8D-FCF1-4777-9566-AA2975267E53}"/>
                </a:ext>
              </a:extLst>
            </p:cNvPr>
            <p:cNvSpPr/>
            <p:nvPr/>
          </p:nvSpPr>
          <p:spPr>
            <a:xfrm>
              <a:off x="7963527" y="4571602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2" name="Oval 38">
              <a:extLst>
                <a:ext uri="{FF2B5EF4-FFF2-40B4-BE49-F238E27FC236}">
                  <a16:creationId xmlns:a16="http://schemas.microsoft.com/office/drawing/2014/main" id="{1908B227-1E7C-4660-9E1F-931ED8311E2D}"/>
                </a:ext>
              </a:extLst>
            </p:cNvPr>
            <p:cNvSpPr/>
            <p:nvPr/>
          </p:nvSpPr>
          <p:spPr>
            <a:xfrm>
              <a:off x="7969759" y="4228305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4" name="Oval 38">
              <a:extLst>
                <a:ext uri="{FF2B5EF4-FFF2-40B4-BE49-F238E27FC236}">
                  <a16:creationId xmlns:a16="http://schemas.microsoft.com/office/drawing/2014/main" id="{9D912856-7B16-4328-BD03-868AC1D1E360}"/>
                </a:ext>
              </a:extLst>
            </p:cNvPr>
            <p:cNvSpPr/>
            <p:nvPr/>
          </p:nvSpPr>
          <p:spPr>
            <a:xfrm>
              <a:off x="7518876" y="4895726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6" name="Oval 38">
              <a:extLst>
                <a:ext uri="{FF2B5EF4-FFF2-40B4-BE49-F238E27FC236}">
                  <a16:creationId xmlns:a16="http://schemas.microsoft.com/office/drawing/2014/main" id="{33108641-F73F-4BDC-9E5C-2F470BB4F27A}"/>
                </a:ext>
              </a:extLst>
            </p:cNvPr>
            <p:cNvSpPr/>
            <p:nvPr/>
          </p:nvSpPr>
          <p:spPr>
            <a:xfrm>
              <a:off x="7554667" y="4532175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8" name="Oval 38">
              <a:extLst>
                <a:ext uri="{FF2B5EF4-FFF2-40B4-BE49-F238E27FC236}">
                  <a16:creationId xmlns:a16="http://schemas.microsoft.com/office/drawing/2014/main" id="{BF8FCB52-1AC8-40B3-BF06-1AF90FADA0C5}"/>
                </a:ext>
              </a:extLst>
            </p:cNvPr>
            <p:cNvSpPr/>
            <p:nvPr/>
          </p:nvSpPr>
          <p:spPr>
            <a:xfrm>
              <a:off x="7597347" y="4203659"/>
              <a:ext cx="303019" cy="303801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TextBox 53">
              <a:extLst>
                <a:ext uri="{FF2B5EF4-FFF2-40B4-BE49-F238E27FC236}">
                  <a16:creationId xmlns:a16="http://schemas.microsoft.com/office/drawing/2014/main" id="{1CED6902-6FCD-46E0-A363-C66F4B180536}"/>
                </a:ext>
              </a:extLst>
            </p:cNvPr>
            <p:cNvSpPr txBox="1"/>
            <p:nvPr/>
          </p:nvSpPr>
          <p:spPr>
            <a:xfrm>
              <a:off x="9258909" y="408980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4</a:t>
              </a:r>
            </a:p>
          </p:txBody>
        </p:sp>
        <p:sp>
          <p:nvSpPr>
            <p:cNvPr id="294" name="TextBox 53">
              <a:extLst>
                <a:ext uri="{FF2B5EF4-FFF2-40B4-BE49-F238E27FC236}">
                  <a16:creationId xmlns:a16="http://schemas.microsoft.com/office/drawing/2014/main" id="{29DC4EF3-C199-4D03-BC70-1CD1315FE02C}"/>
                </a:ext>
              </a:extLst>
            </p:cNvPr>
            <p:cNvSpPr txBox="1"/>
            <p:nvPr/>
          </p:nvSpPr>
          <p:spPr>
            <a:xfrm>
              <a:off x="8183741" y="409286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4</a:t>
              </a:r>
            </a:p>
          </p:txBody>
        </p:sp>
        <p:sp>
          <p:nvSpPr>
            <p:cNvPr id="298" name="TextBox 53">
              <a:extLst>
                <a:ext uri="{FF2B5EF4-FFF2-40B4-BE49-F238E27FC236}">
                  <a16:creationId xmlns:a16="http://schemas.microsoft.com/office/drawing/2014/main" id="{AF2175E8-D5B3-4BCF-975C-9B67253174C8}"/>
                </a:ext>
              </a:extLst>
            </p:cNvPr>
            <p:cNvSpPr txBox="1"/>
            <p:nvPr/>
          </p:nvSpPr>
          <p:spPr>
            <a:xfrm>
              <a:off x="7351504" y="409673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1</a:t>
              </a:r>
            </a:p>
          </p:txBody>
        </p:sp>
        <p:sp>
          <p:nvSpPr>
            <p:cNvPr id="300" name="TextBox 53">
              <a:extLst>
                <a:ext uri="{FF2B5EF4-FFF2-40B4-BE49-F238E27FC236}">
                  <a16:creationId xmlns:a16="http://schemas.microsoft.com/office/drawing/2014/main" id="{FB8BF358-551A-41FF-847A-765B3D743AED}"/>
                </a:ext>
              </a:extLst>
            </p:cNvPr>
            <p:cNvSpPr txBox="1"/>
            <p:nvPr/>
          </p:nvSpPr>
          <p:spPr>
            <a:xfrm>
              <a:off x="8426318" y="412906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1</a:t>
              </a:r>
            </a:p>
          </p:txBody>
        </p:sp>
        <p:sp>
          <p:nvSpPr>
            <p:cNvPr id="304" name="TextBox 53">
              <a:extLst>
                <a:ext uri="{FF2B5EF4-FFF2-40B4-BE49-F238E27FC236}">
                  <a16:creationId xmlns:a16="http://schemas.microsoft.com/office/drawing/2014/main" id="{325D62D6-AC10-4EEE-B098-21577A7C27E5}"/>
                </a:ext>
              </a:extLst>
            </p:cNvPr>
            <p:cNvSpPr txBox="1"/>
            <p:nvPr/>
          </p:nvSpPr>
          <p:spPr>
            <a:xfrm>
              <a:off x="7334438" y="442707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2</a:t>
              </a:r>
            </a:p>
          </p:txBody>
        </p:sp>
        <p:sp>
          <p:nvSpPr>
            <p:cNvPr id="306" name="TextBox 53">
              <a:extLst>
                <a:ext uri="{FF2B5EF4-FFF2-40B4-BE49-F238E27FC236}">
                  <a16:creationId xmlns:a16="http://schemas.microsoft.com/office/drawing/2014/main" id="{FA6E84A7-D5FC-4FD2-AFFF-E5DA0884D19E}"/>
                </a:ext>
              </a:extLst>
            </p:cNvPr>
            <p:cNvSpPr txBox="1"/>
            <p:nvPr/>
          </p:nvSpPr>
          <p:spPr>
            <a:xfrm>
              <a:off x="8410482" y="444446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2</a:t>
              </a:r>
            </a:p>
          </p:txBody>
        </p:sp>
        <p:sp>
          <p:nvSpPr>
            <p:cNvPr id="310" name="TextBox 53">
              <a:extLst>
                <a:ext uri="{FF2B5EF4-FFF2-40B4-BE49-F238E27FC236}">
                  <a16:creationId xmlns:a16="http://schemas.microsoft.com/office/drawing/2014/main" id="{2E29ECFA-2E9A-4783-9FC8-5D1CFE0A84B7}"/>
                </a:ext>
              </a:extLst>
            </p:cNvPr>
            <p:cNvSpPr txBox="1"/>
            <p:nvPr/>
          </p:nvSpPr>
          <p:spPr>
            <a:xfrm>
              <a:off x="7358350" y="510933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3</a:t>
              </a:r>
            </a:p>
          </p:txBody>
        </p:sp>
        <p:sp>
          <p:nvSpPr>
            <p:cNvPr id="312" name="TextBox 53">
              <a:extLst>
                <a:ext uri="{FF2B5EF4-FFF2-40B4-BE49-F238E27FC236}">
                  <a16:creationId xmlns:a16="http://schemas.microsoft.com/office/drawing/2014/main" id="{793F0ADA-E013-4EB7-91C3-DEE3E5A28A0D}"/>
                </a:ext>
              </a:extLst>
            </p:cNvPr>
            <p:cNvSpPr txBox="1"/>
            <p:nvPr/>
          </p:nvSpPr>
          <p:spPr>
            <a:xfrm>
              <a:off x="8465692" y="514007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3</a:t>
              </a:r>
            </a:p>
          </p:txBody>
        </p:sp>
        <p:sp>
          <p:nvSpPr>
            <p:cNvPr id="316" name="TextBox 53">
              <a:extLst>
                <a:ext uri="{FF2B5EF4-FFF2-40B4-BE49-F238E27FC236}">
                  <a16:creationId xmlns:a16="http://schemas.microsoft.com/office/drawing/2014/main" id="{D10DF7D8-443E-400C-ABDE-4962D9060D4B}"/>
                </a:ext>
              </a:extLst>
            </p:cNvPr>
            <p:cNvSpPr txBox="1"/>
            <p:nvPr/>
          </p:nvSpPr>
          <p:spPr>
            <a:xfrm>
              <a:off x="9283214" y="443767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5</a:t>
              </a:r>
            </a:p>
          </p:txBody>
        </p:sp>
        <p:sp>
          <p:nvSpPr>
            <p:cNvPr id="318" name="TextBox 53">
              <a:extLst>
                <a:ext uri="{FF2B5EF4-FFF2-40B4-BE49-F238E27FC236}">
                  <a16:creationId xmlns:a16="http://schemas.microsoft.com/office/drawing/2014/main" id="{4C95577C-6B08-4CC8-9066-C9DBE66FC1A6}"/>
                </a:ext>
              </a:extLst>
            </p:cNvPr>
            <p:cNvSpPr txBox="1"/>
            <p:nvPr/>
          </p:nvSpPr>
          <p:spPr>
            <a:xfrm>
              <a:off x="8217441" y="461239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5</a:t>
              </a:r>
            </a:p>
          </p:txBody>
        </p:sp>
        <p:sp>
          <p:nvSpPr>
            <p:cNvPr id="320" name="TextBox 53">
              <a:extLst>
                <a:ext uri="{FF2B5EF4-FFF2-40B4-BE49-F238E27FC236}">
                  <a16:creationId xmlns:a16="http://schemas.microsoft.com/office/drawing/2014/main" id="{F97FB891-A571-4163-A456-684E087BA1E0}"/>
                </a:ext>
              </a:extLst>
            </p:cNvPr>
            <p:cNvSpPr txBox="1"/>
            <p:nvPr/>
          </p:nvSpPr>
          <p:spPr>
            <a:xfrm>
              <a:off x="8124269" y="512309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6</a:t>
              </a:r>
            </a:p>
          </p:txBody>
        </p:sp>
        <p:sp>
          <p:nvSpPr>
            <p:cNvPr id="322" name="TextBox 53">
              <a:extLst>
                <a:ext uri="{FF2B5EF4-FFF2-40B4-BE49-F238E27FC236}">
                  <a16:creationId xmlns:a16="http://schemas.microsoft.com/office/drawing/2014/main" id="{590D8372-028E-4CD4-8CC6-36EB37FE35DC}"/>
                </a:ext>
              </a:extLst>
            </p:cNvPr>
            <p:cNvSpPr txBox="1"/>
            <p:nvPr/>
          </p:nvSpPr>
          <p:spPr>
            <a:xfrm>
              <a:off x="9238740" y="495425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6</a:t>
              </a:r>
            </a:p>
          </p:txBody>
        </p:sp>
        <p:sp>
          <p:nvSpPr>
            <p:cNvPr id="157" name="文本框 52">
              <a:extLst>
                <a:ext uri="{FF2B5EF4-FFF2-40B4-BE49-F238E27FC236}">
                  <a16:creationId xmlns:a16="http://schemas.microsoft.com/office/drawing/2014/main" id="{1B250DFE-BC70-40FC-B7D7-36DED10EA147}"/>
                </a:ext>
              </a:extLst>
            </p:cNvPr>
            <p:cNvSpPr txBox="1"/>
            <p:nvPr/>
          </p:nvSpPr>
          <p:spPr>
            <a:xfrm>
              <a:off x="7631076" y="3784134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AMIN8</a:t>
              </a:r>
              <a:endParaRPr lang="zh-CN" altLang="en-US" sz="1200" b="1" dirty="0"/>
            </a:p>
          </p:txBody>
        </p:sp>
        <p:sp>
          <p:nvSpPr>
            <p:cNvPr id="159" name="文本框 54">
              <a:extLst>
                <a:ext uri="{FF2B5EF4-FFF2-40B4-BE49-F238E27FC236}">
                  <a16:creationId xmlns:a16="http://schemas.microsoft.com/office/drawing/2014/main" id="{1A5B35D4-871E-40DB-83F7-CB05A9CA6746}"/>
                </a:ext>
              </a:extLst>
            </p:cNvPr>
            <p:cNvSpPr txBox="1"/>
            <p:nvPr/>
          </p:nvSpPr>
          <p:spPr>
            <a:xfrm>
              <a:off x="8603661" y="3784134"/>
              <a:ext cx="6399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AMIE8</a:t>
              </a:r>
              <a:endParaRPr lang="zh-CN" altLang="en-US" sz="1200" b="1" dirty="0"/>
            </a:p>
          </p:txBody>
        </p:sp>
      </p:grpSp>
      <p:grpSp>
        <p:nvGrpSpPr>
          <p:cNvPr id="167" name="组合 166">
            <a:extLst>
              <a:ext uri="{FF2B5EF4-FFF2-40B4-BE49-F238E27FC236}">
                <a16:creationId xmlns:a16="http://schemas.microsoft.com/office/drawing/2014/main" id="{55973FA9-8C36-4277-BD34-573B838CFAF6}"/>
              </a:ext>
            </a:extLst>
          </p:cNvPr>
          <p:cNvGrpSpPr/>
          <p:nvPr/>
        </p:nvGrpSpPr>
        <p:grpSpPr>
          <a:xfrm>
            <a:off x="7860525" y="604205"/>
            <a:ext cx="2083758" cy="2914917"/>
            <a:chOff x="7860525" y="604205"/>
            <a:chExt cx="2083758" cy="2914917"/>
          </a:xfrm>
        </p:grpSpPr>
        <p:pic>
          <p:nvPicPr>
            <p:cNvPr id="75" name="Picture 74">
              <a:extLst>
                <a:ext uri="{FF2B5EF4-FFF2-40B4-BE49-F238E27FC236}">
                  <a16:creationId xmlns:a16="http://schemas.microsoft.com/office/drawing/2014/main" id="{CA602A2C-7153-4E69-A470-0857AE344E6F}"/>
                </a:ext>
              </a:extLst>
            </p:cNvPr>
            <p:cNvPicPr>
              <a:picLocks/>
            </p:cNvPicPr>
            <p:nvPr/>
          </p:nvPicPr>
          <p:blipFill rotWithShape="1">
            <a:blip r:embed="rId3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10600" r="69390" b="51176"/>
            <a:stretch/>
          </p:blipFill>
          <p:spPr>
            <a:xfrm>
              <a:off x="9184964" y="885795"/>
              <a:ext cx="720000" cy="342000"/>
            </a:xfrm>
            <a:prstGeom prst="rect">
              <a:avLst/>
            </a:prstGeom>
          </p:spPr>
        </p:pic>
        <p:pic>
          <p:nvPicPr>
            <p:cNvPr id="77" name="Picture 76" descr="A picture containing light&#10;&#10;Description generated with very high confidence">
              <a:extLst>
                <a:ext uri="{FF2B5EF4-FFF2-40B4-BE49-F238E27FC236}">
                  <a16:creationId xmlns:a16="http://schemas.microsoft.com/office/drawing/2014/main" id="{952BFD28-68B0-40C3-A0D8-554F8E107708}"/>
                </a:ext>
              </a:extLst>
            </p:cNvPr>
            <p:cNvPicPr>
              <a:picLocks/>
            </p:cNvPicPr>
            <p:nvPr/>
          </p:nvPicPr>
          <p:blipFill rotWithShape="1">
            <a:blip r:embed="rId37" cstate="email">
              <a:extLst>
                <a:ext uri="{BEBA8EAE-BF5A-486C-A8C5-ECC9F3942E4B}">
                  <a14:imgProps xmlns:a14="http://schemas.microsoft.com/office/drawing/2010/main">
                    <a14:imgLayer r:embed="rId38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70371" t="53108" r="7223" b="24629"/>
            <a:stretch/>
          </p:blipFill>
          <p:spPr>
            <a:xfrm>
              <a:off x="8366112" y="885795"/>
              <a:ext cx="720000" cy="342000"/>
            </a:xfrm>
            <a:prstGeom prst="rect">
              <a:avLst/>
            </a:prstGeom>
          </p:spPr>
        </p:pic>
        <p:pic>
          <p:nvPicPr>
            <p:cNvPr id="79" name="Picture 78" descr="A picture containing sitting, animal, pink, top&#10;&#10;Description generated with high confidence">
              <a:extLst>
                <a:ext uri="{FF2B5EF4-FFF2-40B4-BE49-F238E27FC236}">
                  <a16:creationId xmlns:a16="http://schemas.microsoft.com/office/drawing/2014/main" id="{E342F7AC-67A1-4C00-929C-B5CB13BF3910}"/>
                </a:ext>
              </a:extLst>
            </p:cNvPr>
            <p:cNvPicPr>
              <a:picLocks/>
            </p:cNvPicPr>
            <p:nvPr/>
          </p:nvPicPr>
          <p:blipFill rotWithShape="1">
            <a:blip r:embed="rId39" cstate="email">
              <a:extLst>
                <a:ext uri="{BEBA8EAE-BF5A-486C-A8C5-ECC9F3942E4B}">
                  <a14:imgProps xmlns:a14="http://schemas.microsoft.com/office/drawing/2010/main">
                    <a14:imgLayer r:embed="rId40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50582" t="7111" b="57876"/>
            <a:stretch/>
          </p:blipFill>
          <p:spPr>
            <a:xfrm>
              <a:off x="9184964" y="1267683"/>
              <a:ext cx="720000" cy="342000"/>
            </a:xfrm>
            <a:prstGeom prst="rect">
              <a:avLst/>
            </a:prstGeom>
          </p:spPr>
        </p:pic>
        <p:pic>
          <p:nvPicPr>
            <p:cNvPr id="83" name="Picture 82" descr="A picture containing pink, table, sitting&#10;&#10;Description generated with very high confidence">
              <a:extLst>
                <a:ext uri="{FF2B5EF4-FFF2-40B4-BE49-F238E27FC236}">
                  <a16:creationId xmlns:a16="http://schemas.microsoft.com/office/drawing/2014/main" id="{593C550D-27E7-4055-82FD-AC9C7EFEF926}"/>
                </a:ext>
              </a:extLst>
            </p:cNvPr>
            <p:cNvPicPr>
              <a:picLocks/>
            </p:cNvPicPr>
            <p:nvPr/>
          </p:nvPicPr>
          <p:blipFill rotWithShape="1">
            <a:blip r:embed="rId41" cstate="email">
              <a:extLst>
                <a:ext uri="{BEBA8EAE-BF5A-486C-A8C5-ECC9F3942E4B}">
                  <a14:imgProps xmlns:a14="http://schemas.microsoft.com/office/drawing/2010/main">
                    <a14:imgLayer r:embed="rId42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59822" r="5107" b="70710"/>
            <a:stretch/>
          </p:blipFill>
          <p:spPr>
            <a:xfrm>
              <a:off x="8366112" y="1267683"/>
              <a:ext cx="720000" cy="342000"/>
            </a:xfrm>
            <a:prstGeom prst="rect">
              <a:avLst/>
            </a:prstGeom>
          </p:spPr>
        </p:pic>
        <p:pic>
          <p:nvPicPr>
            <p:cNvPr id="84" name="Picture 83">
              <a:extLst>
                <a:ext uri="{FF2B5EF4-FFF2-40B4-BE49-F238E27FC236}">
                  <a16:creationId xmlns:a16="http://schemas.microsoft.com/office/drawing/2014/main" id="{5C03AC37-043A-4A2E-B08F-D8DD76A98161}"/>
                </a:ext>
              </a:extLst>
            </p:cNvPr>
            <p:cNvPicPr>
              <a:picLocks/>
            </p:cNvPicPr>
            <p:nvPr/>
          </p:nvPicPr>
          <p:blipFill rotWithShape="1">
            <a:blip r:embed="rId4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3750" r="76717" b="71223"/>
            <a:stretch/>
          </p:blipFill>
          <p:spPr>
            <a:xfrm>
              <a:off x="9184964" y="1649571"/>
              <a:ext cx="720000" cy="342000"/>
            </a:xfrm>
            <a:prstGeom prst="rect">
              <a:avLst/>
            </a:prstGeom>
          </p:spPr>
        </p:pic>
        <p:pic>
          <p:nvPicPr>
            <p:cNvPr id="85" name="Picture 84">
              <a:extLst>
                <a:ext uri="{FF2B5EF4-FFF2-40B4-BE49-F238E27FC236}">
                  <a16:creationId xmlns:a16="http://schemas.microsoft.com/office/drawing/2014/main" id="{CB49F4E7-6285-4D48-A746-1A068005DB51}"/>
                </a:ext>
              </a:extLst>
            </p:cNvPr>
            <p:cNvPicPr>
              <a:picLocks/>
            </p:cNvPicPr>
            <p:nvPr/>
          </p:nvPicPr>
          <p:blipFill rotWithShape="1">
            <a:blip r:embed="rId4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6106" t="8026" r="57183" b="78113"/>
            <a:stretch/>
          </p:blipFill>
          <p:spPr>
            <a:xfrm>
              <a:off x="8366112" y="1649571"/>
              <a:ext cx="720000" cy="342000"/>
            </a:xfrm>
            <a:prstGeom prst="rect">
              <a:avLst/>
            </a:prstGeom>
          </p:spPr>
        </p:pic>
        <p:pic>
          <p:nvPicPr>
            <p:cNvPr id="86" name="Picture 85">
              <a:extLst>
                <a:ext uri="{FF2B5EF4-FFF2-40B4-BE49-F238E27FC236}">
                  <a16:creationId xmlns:a16="http://schemas.microsoft.com/office/drawing/2014/main" id="{5FEBD2FF-1CB4-4710-8307-A1EE775B2F2C}"/>
                </a:ext>
              </a:extLst>
            </p:cNvPr>
            <p:cNvPicPr>
              <a:picLocks/>
            </p:cNvPicPr>
            <p:nvPr/>
          </p:nvPicPr>
          <p:blipFill rotWithShape="1">
            <a:blip r:embed="rId4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60797" t="12898" r="6117" b="57384"/>
            <a:stretch/>
          </p:blipFill>
          <p:spPr>
            <a:xfrm>
              <a:off x="9184964" y="2031459"/>
              <a:ext cx="720000" cy="342000"/>
            </a:xfrm>
            <a:prstGeom prst="rect">
              <a:avLst/>
            </a:prstGeom>
          </p:spPr>
        </p:pic>
        <p:pic>
          <p:nvPicPr>
            <p:cNvPr id="87" name="Picture 86" descr="A picture containing table, pink, sitting&#10;&#10;Description generated with high confidence">
              <a:extLst>
                <a:ext uri="{FF2B5EF4-FFF2-40B4-BE49-F238E27FC236}">
                  <a16:creationId xmlns:a16="http://schemas.microsoft.com/office/drawing/2014/main" id="{739E34D4-378F-49B5-B9F8-427A12836573}"/>
                </a:ext>
              </a:extLst>
            </p:cNvPr>
            <p:cNvPicPr>
              <a:picLocks/>
            </p:cNvPicPr>
            <p:nvPr/>
          </p:nvPicPr>
          <p:blipFill rotWithShape="1">
            <a:blip r:embed="rId46" cstate="email">
              <a:extLst>
                <a:ext uri="{BEBA8EAE-BF5A-486C-A8C5-ECC9F3942E4B}">
                  <a14:imgProps xmlns:a14="http://schemas.microsoft.com/office/drawing/2010/main">
                    <a14:imgLayer r:embed="rId47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34842" t="8556" r="37298" b="60736"/>
            <a:stretch/>
          </p:blipFill>
          <p:spPr>
            <a:xfrm>
              <a:off x="8366112" y="2031459"/>
              <a:ext cx="720000" cy="342000"/>
            </a:xfrm>
            <a:prstGeom prst="rect">
              <a:avLst/>
            </a:prstGeom>
          </p:spPr>
        </p:pic>
        <p:pic>
          <p:nvPicPr>
            <p:cNvPr id="88" name="Picture 87" descr="A picture containing dark, indoor&#10;&#10;Description generated with high confidence">
              <a:extLst>
                <a:ext uri="{FF2B5EF4-FFF2-40B4-BE49-F238E27FC236}">
                  <a16:creationId xmlns:a16="http://schemas.microsoft.com/office/drawing/2014/main" id="{3AF0DFF0-3A30-4F95-9F7B-EC9AB98D702C}"/>
                </a:ext>
              </a:extLst>
            </p:cNvPr>
            <p:cNvPicPr>
              <a:picLocks/>
            </p:cNvPicPr>
            <p:nvPr/>
          </p:nvPicPr>
          <p:blipFill rotWithShape="1">
            <a:blip r:embed="rId48" cstate="email">
              <a:extLst>
                <a:ext uri="{BEBA8EAE-BF5A-486C-A8C5-ECC9F3942E4B}">
                  <a14:imgProps xmlns:a14="http://schemas.microsoft.com/office/drawing/2010/main">
                    <a14:imgLayer r:embed="rId49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22790" t="13988" r="48944" b="50829"/>
            <a:stretch/>
          </p:blipFill>
          <p:spPr>
            <a:xfrm>
              <a:off x="9184964" y="2413347"/>
              <a:ext cx="720000" cy="342000"/>
            </a:xfrm>
            <a:prstGeom prst="rect">
              <a:avLst/>
            </a:prstGeom>
          </p:spPr>
        </p:pic>
        <p:pic>
          <p:nvPicPr>
            <p:cNvPr id="90" name="Picture 89" descr="A picture containing dark, indoor&#10;&#10;Description generated with high confidence">
              <a:extLst>
                <a:ext uri="{FF2B5EF4-FFF2-40B4-BE49-F238E27FC236}">
                  <a16:creationId xmlns:a16="http://schemas.microsoft.com/office/drawing/2014/main" id="{2E99AF55-971C-45BE-8F54-F0ADFE11D78C}"/>
                </a:ext>
              </a:extLst>
            </p:cNvPr>
            <p:cNvPicPr>
              <a:picLocks/>
            </p:cNvPicPr>
            <p:nvPr/>
          </p:nvPicPr>
          <p:blipFill rotWithShape="1">
            <a:blip r:embed="rId48" cstate="email">
              <a:extLst>
                <a:ext uri="{BEBA8EAE-BF5A-486C-A8C5-ECC9F3942E4B}">
                  <a14:imgProps xmlns:a14="http://schemas.microsoft.com/office/drawing/2010/main">
                    <a14:imgLayer r:embed="rId49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51597" t="183" r="24196" b="51899"/>
            <a:stretch/>
          </p:blipFill>
          <p:spPr>
            <a:xfrm>
              <a:off x="8366112" y="2413347"/>
              <a:ext cx="720000" cy="342000"/>
            </a:xfrm>
            <a:prstGeom prst="rect">
              <a:avLst/>
            </a:prstGeom>
          </p:spPr>
        </p:pic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ECB2E41B-1FE3-4AED-99C2-2986C49C61C4}"/>
                </a:ext>
              </a:extLst>
            </p:cNvPr>
            <p:cNvPicPr>
              <a:picLocks/>
            </p:cNvPicPr>
            <p:nvPr/>
          </p:nvPicPr>
          <p:blipFill rotWithShape="1">
            <a:blip r:embed="rId5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41659" t="11648" r="35357" b="72327"/>
            <a:stretch/>
          </p:blipFill>
          <p:spPr>
            <a:xfrm>
              <a:off x="9184964" y="2795235"/>
              <a:ext cx="720000" cy="342000"/>
            </a:xfrm>
            <a:prstGeom prst="rect">
              <a:avLst/>
            </a:prstGeom>
          </p:spPr>
        </p:pic>
        <p:pic>
          <p:nvPicPr>
            <p:cNvPr id="94" name="Picture 93">
              <a:extLst>
                <a:ext uri="{FF2B5EF4-FFF2-40B4-BE49-F238E27FC236}">
                  <a16:creationId xmlns:a16="http://schemas.microsoft.com/office/drawing/2014/main" id="{F347F3A3-DB3C-48FF-8A68-E29791BBB050}"/>
                </a:ext>
              </a:extLst>
            </p:cNvPr>
            <p:cNvPicPr>
              <a:picLocks/>
            </p:cNvPicPr>
            <p:nvPr/>
          </p:nvPicPr>
          <p:blipFill rotWithShape="1">
            <a:blip r:embed="rId51" cstate="email">
              <a:extLst>
                <a:ext uri="{BEBA8EAE-BF5A-486C-A8C5-ECC9F3942E4B}">
                  <a14:imgProps xmlns:a14="http://schemas.microsoft.com/office/drawing/2010/main">
                    <a14:imgLayer r:embed="rId52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13453" r="69976" b="54114"/>
            <a:stretch/>
          </p:blipFill>
          <p:spPr>
            <a:xfrm>
              <a:off x="8366112" y="2795235"/>
              <a:ext cx="720000" cy="342000"/>
            </a:xfrm>
            <a:prstGeom prst="rect">
              <a:avLst/>
            </a:prstGeom>
          </p:spPr>
        </p:pic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A6C47989-EC87-4F05-B94B-E641F9676BA2}"/>
                </a:ext>
              </a:extLst>
            </p:cNvPr>
            <p:cNvPicPr>
              <a:picLocks/>
            </p:cNvPicPr>
            <p:nvPr/>
          </p:nvPicPr>
          <p:blipFill rotWithShape="1">
            <a:blip r:embed="rId53" cstate="email">
              <a:extLst>
                <a:ext uri="{BEBA8EAE-BF5A-486C-A8C5-ECC9F3942E4B}">
                  <a14:imgProps xmlns:a14="http://schemas.microsoft.com/office/drawing/2010/main">
                    <a14:imgLayer r:embed="rId54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5848" t="15971" r="57189" b="49055"/>
            <a:stretch/>
          </p:blipFill>
          <p:spPr>
            <a:xfrm>
              <a:off x="9184964" y="3177122"/>
              <a:ext cx="720000" cy="342000"/>
            </a:xfrm>
            <a:prstGeom prst="rect">
              <a:avLst/>
            </a:prstGeom>
          </p:spPr>
        </p:pic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D025AE0A-D6EF-43FA-A25A-59AC7798525F}"/>
                </a:ext>
              </a:extLst>
            </p:cNvPr>
            <p:cNvPicPr>
              <a:picLocks/>
            </p:cNvPicPr>
            <p:nvPr/>
          </p:nvPicPr>
          <p:blipFill rotWithShape="1">
            <a:blip r:embed="rId5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4768" t="6839" r="65368" b="53285"/>
            <a:stretch/>
          </p:blipFill>
          <p:spPr>
            <a:xfrm>
              <a:off x="8366112" y="3177122"/>
              <a:ext cx="720000" cy="342000"/>
            </a:xfrm>
            <a:prstGeom prst="rect">
              <a:avLst/>
            </a:prstGeom>
          </p:spPr>
        </p:pic>
        <p:sp>
          <p:nvSpPr>
            <p:cNvPr id="100" name="文本框 52">
              <a:extLst>
                <a:ext uri="{FF2B5EF4-FFF2-40B4-BE49-F238E27FC236}">
                  <a16:creationId xmlns:a16="http://schemas.microsoft.com/office/drawing/2014/main" id="{FE2FB62B-6F30-484E-9EB7-7191DD7EE3F0}"/>
                </a:ext>
              </a:extLst>
            </p:cNvPr>
            <p:cNvSpPr txBox="1"/>
            <p:nvPr/>
          </p:nvSpPr>
          <p:spPr>
            <a:xfrm>
              <a:off x="8339794" y="604205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AMIN-</a:t>
              </a:r>
              <a:endParaRPr lang="zh-CN" altLang="en-US" sz="1200" b="1" dirty="0"/>
            </a:p>
          </p:txBody>
        </p:sp>
        <p:sp>
          <p:nvSpPr>
            <p:cNvPr id="102" name="文本框 54">
              <a:extLst>
                <a:ext uri="{FF2B5EF4-FFF2-40B4-BE49-F238E27FC236}">
                  <a16:creationId xmlns:a16="http://schemas.microsoft.com/office/drawing/2014/main" id="{C1AE477B-EC68-4D00-A153-1FD18A64C98A}"/>
                </a:ext>
              </a:extLst>
            </p:cNvPr>
            <p:cNvSpPr txBox="1"/>
            <p:nvPr/>
          </p:nvSpPr>
          <p:spPr>
            <a:xfrm>
              <a:off x="9312379" y="604205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AMIE-</a:t>
              </a:r>
              <a:endParaRPr lang="zh-CN" altLang="en-US" sz="1200" b="1" dirty="0"/>
            </a:p>
          </p:txBody>
        </p:sp>
        <p:sp>
          <p:nvSpPr>
            <p:cNvPr id="104" name="文本框 56">
              <a:extLst>
                <a:ext uri="{FF2B5EF4-FFF2-40B4-BE49-F238E27FC236}">
                  <a16:creationId xmlns:a16="http://schemas.microsoft.com/office/drawing/2014/main" id="{A6B9F5BE-2482-46B3-9C63-26C2E1931A22}"/>
                </a:ext>
              </a:extLst>
            </p:cNvPr>
            <p:cNvSpPr txBox="1"/>
            <p:nvPr/>
          </p:nvSpPr>
          <p:spPr>
            <a:xfrm flipH="1">
              <a:off x="7895582" y="920698"/>
              <a:ext cx="4208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C1</a:t>
              </a:r>
              <a:endParaRPr lang="zh-CN" altLang="en-US" sz="1200" b="1" dirty="0"/>
            </a:p>
          </p:txBody>
        </p:sp>
        <p:sp>
          <p:nvSpPr>
            <p:cNvPr id="106" name="文本框 58">
              <a:extLst>
                <a:ext uri="{FF2B5EF4-FFF2-40B4-BE49-F238E27FC236}">
                  <a16:creationId xmlns:a16="http://schemas.microsoft.com/office/drawing/2014/main" id="{49370F49-926E-42CA-A72F-2761B1F39C41}"/>
                </a:ext>
              </a:extLst>
            </p:cNvPr>
            <p:cNvSpPr txBox="1"/>
            <p:nvPr/>
          </p:nvSpPr>
          <p:spPr>
            <a:xfrm flipH="1">
              <a:off x="7895582" y="1301344"/>
              <a:ext cx="4208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C2</a:t>
              </a:r>
              <a:endParaRPr lang="zh-CN" altLang="en-US" sz="1200" b="1" dirty="0"/>
            </a:p>
          </p:txBody>
        </p:sp>
        <p:sp>
          <p:nvSpPr>
            <p:cNvPr id="108" name="文本框 60">
              <a:extLst>
                <a:ext uri="{FF2B5EF4-FFF2-40B4-BE49-F238E27FC236}">
                  <a16:creationId xmlns:a16="http://schemas.microsoft.com/office/drawing/2014/main" id="{DF356BD1-549B-4BD1-8AB4-A4CD4B0AAB93}"/>
                </a:ext>
              </a:extLst>
            </p:cNvPr>
            <p:cNvSpPr txBox="1"/>
            <p:nvPr/>
          </p:nvSpPr>
          <p:spPr>
            <a:xfrm flipH="1">
              <a:off x="7895582" y="2443279"/>
              <a:ext cx="4208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CP</a:t>
              </a:r>
              <a:endParaRPr lang="zh-CN" altLang="en-US" sz="1200" b="1" dirty="0"/>
            </a:p>
          </p:txBody>
        </p:sp>
        <p:sp>
          <p:nvSpPr>
            <p:cNvPr id="110" name="文本框 64">
              <a:extLst>
                <a:ext uri="{FF2B5EF4-FFF2-40B4-BE49-F238E27FC236}">
                  <a16:creationId xmlns:a16="http://schemas.microsoft.com/office/drawing/2014/main" id="{995E21B2-68DC-445E-B667-1B9C74CE247A}"/>
                </a:ext>
              </a:extLst>
            </p:cNvPr>
            <p:cNvSpPr txBox="1"/>
            <p:nvPr/>
          </p:nvSpPr>
          <p:spPr>
            <a:xfrm flipH="1">
              <a:off x="7895582" y="2823924"/>
              <a:ext cx="4208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V1</a:t>
              </a:r>
              <a:endParaRPr lang="zh-CN" altLang="en-US" sz="1200" b="1" dirty="0"/>
            </a:p>
          </p:txBody>
        </p:sp>
        <p:sp>
          <p:nvSpPr>
            <p:cNvPr id="112" name="文本框 88">
              <a:extLst>
                <a:ext uri="{FF2B5EF4-FFF2-40B4-BE49-F238E27FC236}">
                  <a16:creationId xmlns:a16="http://schemas.microsoft.com/office/drawing/2014/main" id="{4DA7B1EC-1174-4C48-9F01-BA47A64E81EB}"/>
                </a:ext>
              </a:extLst>
            </p:cNvPr>
            <p:cNvSpPr txBox="1"/>
            <p:nvPr/>
          </p:nvSpPr>
          <p:spPr>
            <a:xfrm flipH="1">
              <a:off x="7895582" y="1681989"/>
              <a:ext cx="4208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C3</a:t>
              </a:r>
              <a:endParaRPr lang="zh-CN" altLang="en-US" sz="1200" b="1" dirty="0"/>
            </a:p>
          </p:txBody>
        </p:sp>
        <p:sp>
          <p:nvSpPr>
            <p:cNvPr id="114" name="文本框 90">
              <a:extLst>
                <a:ext uri="{FF2B5EF4-FFF2-40B4-BE49-F238E27FC236}">
                  <a16:creationId xmlns:a16="http://schemas.microsoft.com/office/drawing/2014/main" id="{049340E0-0031-4ADD-B81C-D24D8DB5FB8A}"/>
                </a:ext>
              </a:extLst>
            </p:cNvPr>
            <p:cNvSpPr txBox="1"/>
            <p:nvPr/>
          </p:nvSpPr>
          <p:spPr>
            <a:xfrm flipH="1">
              <a:off x="7895582" y="2062634"/>
              <a:ext cx="4208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C4</a:t>
              </a:r>
              <a:endParaRPr lang="zh-CN" altLang="en-US" sz="1200" b="1" dirty="0"/>
            </a:p>
          </p:txBody>
        </p:sp>
        <p:sp>
          <p:nvSpPr>
            <p:cNvPr id="116" name="文本框 92">
              <a:extLst>
                <a:ext uri="{FF2B5EF4-FFF2-40B4-BE49-F238E27FC236}">
                  <a16:creationId xmlns:a16="http://schemas.microsoft.com/office/drawing/2014/main" id="{F843FBF9-C828-4705-936C-20D43B90FFF7}"/>
                </a:ext>
              </a:extLst>
            </p:cNvPr>
            <p:cNvSpPr txBox="1"/>
            <p:nvPr/>
          </p:nvSpPr>
          <p:spPr>
            <a:xfrm flipH="1">
              <a:off x="7860525" y="3204569"/>
              <a:ext cx="5019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bC1</a:t>
              </a:r>
              <a:endParaRPr lang="zh-CN" altLang="en-US" sz="1200" b="1" dirty="0"/>
            </a:p>
          </p:txBody>
        </p:sp>
        <p:sp>
          <p:nvSpPr>
            <p:cNvPr id="125" name="椭圆 124">
              <a:extLst>
                <a:ext uri="{FF2B5EF4-FFF2-40B4-BE49-F238E27FC236}">
                  <a16:creationId xmlns:a16="http://schemas.microsoft.com/office/drawing/2014/main" id="{FA21500A-B3BD-425B-9995-50C009673149}"/>
                </a:ext>
              </a:extLst>
            </p:cNvPr>
            <p:cNvSpPr/>
            <p:nvPr/>
          </p:nvSpPr>
          <p:spPr>
            <a:xfrm>
              <a:off x="8801539" y="935525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7" name="椭圆 126">
              <a:extLst>
                <a:ext uri="{FF2B5EF4-FFF2-40B4-BE49-F238E27FC236}">
                  <a16:creationId xmlns:a16="http://schemas.microsoft.com/office/drawing/2014/main" id="{ECADF19F-9A37-4BA5-B55A-3502458636E1}"/>
                </a:ext>
              </a:extLst>
            </p:cNvPr>
            <p:cNvSpPr/>
            <p:nvPr/>
          </p:nvSpPr>
          <p:spPr>
            <a:xfrm>
              <a:off x="9508840" y="905310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9" name="椭圆 128">
              <a:extLst>
                <a:ext uri="{FF2B5EF4-FFF2-40B4-BE49-F238E27FC236}">
                  <a16:creationId xmlns:a16="http://schemas.microsoft.com/office/drawing/2014/main" id="{E8F2099B-A0D8-4B29-8F59-62B358DF79DC}"/>
                </a:ext>
              </a:extLst>
            </p:cNvPr>
            <p:cNvSpPr/>
            <p:nvPr/>
          </p:nvSpPr>
          <p:spPr>
            <a:xfrm>
              <a:off x="8786437" y="1410406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1" name="椭圆 130">
              <a:extLst>
                <a:ext uri="{FF2B5EF4-FFF2-40B4-BE49-F238E27FC236}">
                  <a16:creationId xmlns:a16="http://schemas.microsoft.com/office/drawing/2014/main" id="{33BC28D6-AA72-428D-ABA9-425B5562E386}"/>
                </a:ext>
              </a:extLst>
            </p:cNvPr>
            <p:cNvSpPr/>
            <p:nvPr/>
          </p:nvSpPr>
          <p:spPr>
            <a:xfrm>
              <a:off x="9560027" y="1400922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3" name="椭圆 132">
              <a:extLst>
                <a:ext uri="{FF2B5EF4-FFF2-40B4-BE49-F238E27FC236}">
                  <a16:creationId xmlns:a16="http://schemas.microsoft.com/office/drawing/2014/main" id="{5814E5F2-488E-4A9C-A146-D016C2A9D4BD}"/>
                </a:ext>
              </a:extLst>
            </p:cNvPr>
            <p:cNvSpPr/>
            <p:nvPr/>
          </p:nvSpPr>
          <p:spPr>
            <a:xfrm>
              <a:off x="8795142" y="2157717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5" name="椭圆 134">
              <a:extLst>
                <a:ext uri="{FF2B5EF4-FFF2-40B4-BE49-F238E27FC236}">
                  <a16:creationId xmlns:a16="http://schemas.microsoft.com/office/drawing/2014/main" id="{A7421186-96D7-4020-B1F8-D36472D8FEB1}"/>
                </a:ext>
              </a:extLst>
            </p:cNvPr>
            <p:cNvSpPr/>
            <p:nvPr/>
          </p:nvSpPr>
          <p:spPr>
            <a:xfrm>
              <a:off x="9617109" y="2174236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7" name="椭圆 136">
              <a:extLst>
                <a:ext uri="{FF2B5EF4-FFF2-40B4-BE49-F238E27FC236}">
                  <a16:creationId xmlns:a16="http://schemas.microsoft.com/office/drawing/2014/main" id="{8264C6C3-A0AA-4109-BACD-C99D59167568}"/>
                </a:ext>
              </a:extLst>
            </p:cNvPr>
            <p:cNvSpPr/>
            <p:nvPr/>
          </p:nvSpPr>
          <p:spPr>
            <a:xfrm>
              <a:off x="8811755" y="1793411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9" name="椭圆 138">
              <a:extLst>
                <a:ext uri="{FF2B5EF4-FFF2-40B4-BE49-F238E27FC236}">
                  <a16:creationId xmlns:a16="http://schemas.microsoft.com/office/drawing/2014/main" id="{6B487197-D9E2-486D-903D-9D3670E70748}"/>
                </a:ext>
              </a:extLst>
            </p:cNvPr>
            <p:cNvSpPr/>
            <p:nvPr/>
          </p:nvSpPr>
          <p:spPr>
            <a:xfrm>
              <a:off x="9605235" y="1764301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1" name="椭圆 140">
              <a:extLst>
                <a:ext uri="{FF2B5EF4-FFF2-40B4-BE49-F238E27FC236}">
                  <a16:creationId xmlns:a16="http://schemas.microsoft.com/office/drawing/2014/main" id="{EE78D2BF-790B-4267-B53A-6DE3356446F6}"/>
                </a:ext>
              </a:extLst>
            </p:cNvPr>
            <p:cNvSpPr/>
            <p:nvPr/>
          </p:nvSpPr>
          <p:spPr>
            <a:xfrm>
              <a:off x="9605769" y="2509527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3" name="椭圆 142">
              <a:extLst>
                <a:ext uri="{FF2B5EF4-FFF2-40B4-BE49-F238E27FC236}">
                  <a16:creationId xmlns:a16="http://schemas.microsoft.com/office/drawing/2014/main" id="{B799B676-E179-49A4-B43E-B3A93525B9E7}"/>
                </a:ext>
              </a:extLst>
            </p:cNvPr>
            <p:cNvSpPr/>
            <p:nvPr/>
          </p:nvSpPr>
          <p:spPr>
            <a:xfrm>
              <a:off x="8762231" y="2541893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5" name="椭圆 144">
              <a:extLst>
                <a:ext uri="{FF2B5EF4-FFF2-40B4-BE49-F238E27FC236}">
                  <a16:creationId xmlns:a16="http://schemas.microsoft.com/office/drawing/2014/main" id="{88656D3B-556B-4685-8E29-ED40FA151AE2}"/>
                </a:ext>
              </a:extLst>
            </p:cNvPr>
            <p:cNvSpPr/>
            <p:nvPr/>
          </p:nvSpPr>
          <p:spPr>
            <a:xfrm>
              <a:off x="8788749" y="2889228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7" name="椭圆 146">
              <a:extLst>
                <a:ext uri="{FF2B5EF4-FFF2-40B4-BE49-F238E27FC236}">
                  <a16:creationId xmlns:a16="http://schemas.microsoft.com/office/drawing/2014/main" id="{203235ED-2B4F-4960-8EEB-866908663EAF}"/>
                </a:ext>
              </a:extLst>
            </p:cNvPr>
            <p:cNvSpPr/>
            <p:nvPr/>
          </p:nvSpPr>
          <p:spPr>
            <a:xfrm>
              <a:off x="9607547" y="2881275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3" name="椭圆 162">
              <a:extLst>
                <a:ext uri="{FF2B5EF4-FFF2-40B4-BE49-F238E27FC236}">
                  <a16:creationId xmlns:a16="http://schemas.microsoft.com/office/drawing/2014/main" id="{690CF90E-417A-4F92-BDA1-BF68497E8457}"/>
                </a:ext>
              </a:extLst>
            </p:cNvPr>
            <p:cNvSpPr/>
            <p:nvPr/>
          </p:nvSpPr>
          <p:spPr>
            <a:xfrm>
              <a:off x="8709154" y="3226032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5" name="椭圆 164">
              <a:extLst>
                <a:ext uri="{FF2B5EF4-FFF2-40B4-BE49-F238E27FC236}">
                  <a16:creationId xmlns:a16="http://schemas.microsoft.com/office/drawing/2014/main" id="{7851FD51-887A-4743-8461-364C93E2E26A}"/>
                </a:ext>
              </a:extLst>
            </p:cNvPr>
            <p:cNvSpPr/>
            <p:nvPr/>
          </p:nvSpPr>
          <p:spPr>
            <a:xfrm>
              <a:off x="9553677" y="3226032"/>
              <a:ext cx="223733" cy="216000"/>
            </a:xfrm>
            <a:prstGeom prst="ellipse">
              <a:avLst/>
            </a:prstGeom>
            <a:noFill/>
            <a:ln w="635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73" name="文本框 172">
            <a:extLst>
              <a:ext uri="{FF2B5EF4-FFF2-40B4-BE49-F238E27FC236}">
                <a16:creationId xmlns:a16="http://schemas.microsoft.com/office/drawing/2014/main" id="{A877C6CC-2102-4B14-81CB-0B78C53CA37F}"/>
              </a:ext>
            </a:extLst>
          </p:cNvPr>
          <p:cNvSpPr txBox="1"/>
          <p:nvPr/>
        </p:nvSpPr>
        <p:spPr>
          <a:xfrm>
            <a:off x="581480" y="3675673"/>
            <a:ext cx="349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D</a:t>
            </a:r>
            <a:endParaRPr lang="zh-CN" altLang="en-US" b="1" dirty="0"/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id="{7567E9A1-9019-46EB-ABF0-D99D0E79F4BF}"/>
              </a:ext>
            </a:extLst>
          </p:cNvPr>
          <p:cNvSpPr txBox="1"/>
          <p:nvPr/>
        </p:nvSpPr>
        <p:spPr>
          <a:xfrm>
            <a:off x="5017437" y="3718137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E</a:t>
            </a:r>
            <a:endParaRPr lang="zh-CN" altLang="en-US" b="1" dirty="0"/>
          </a:p>
        </p:txBody>
      </p:sp>
      <p:sp>
        <p:nvSpPr>
          <p:cNvPr id="177" name="椭圆 176">
            <a:extLst>
              <a:ext uri="{FF2B5EF4-FFF2-40B4-BE49-F238E27FC236}">
                <a16:creationId xmlns:a16="http://schemas.microsoft.com/office/drawing/2014/main" id="{C2F71780-8185-44CF-A215-9CF8B629E3FF}"/>
              </a:ext>
            </a:extLst>
          </p:cNvPr>
          <p:cNvSpPr/>
          <p:nvPr/>
        </p:nvSpPr>
        <p:spPr>
          <a:xfrm>
            <a:off x="8528093" y="934749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9" name="椭圆 178">
            <a:extLst>
              <a:ext uri="{FF2B5EF4-FFF2-40B4-BE49-F238E27FC236}">
                <a16:creationId xmlns:a16="http://schemas.microsoft.com/office/drawing/2014/main" id="{8B15B37E-D5A3-41AE-A6F0-0901F623FF27}"/>
              </a:ext>
            </a:extLst>
          </p:cNvPr>
          <p:cNvSpPr/>
          <p:nvPr/>
        </p:nvSpPr>
        <p:spPr>
          <a:xfrm>
            <a:off x="8524077" y="1363881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0" name="椭圆 179">
            <a:extLst>
              <a:ext uri="{FF2B5EF4-FFF2-40B4-BE49-F238E27FC236}">
                <a16:creationId xmlns:a16="http://schemas.microsoft.com/office/drawing/2014/main" id="{FD765E25-F895-40A2-B52B-EEE092013ED1}"/>
              </a:ext>
            </a:extLst>
          </p:cNvPr>
          <p:cNvSpPr/>
          <p:nvPr/>
        </p:nvSpPr>
        <p:spPr>
          <a:xfrm>
            <a:off x="8592253" y="1696761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1" name="椭圆 180">
            <a:extLst>
              <a:ext uri="{FF2B5EF4-FFF2-40B4-BE49-F238E27FC236}">
                <a16:creationId xmlns:a16="http://schemas.microsoft.com/office/drawing/2014/main" id="{ADEB1CBC-C7AE-467D-90AA-56AD67691AA3}"/>
              </a:ext>
            </a:extLst>
          </p:cNvPr>
          <p:cNvSpPr/>
          <p:nvPr/>
        </p:nvSpPr>
        <p:spPr>
          <a:xfrm>
            <a:off x="8491981" y="2029641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3" name="椭圆 182">
            <a:extLst>
              <a:ext uri="{FF2B5EF4-FFF2-40B4-BE49-F238E27FC236}">
                <a16:creationId xmlns:a16="http://schemas.microsoft.com/office/drawing/2014/main" id="{EA4966F8-C387-4BEC-9B59-54F3899D0896}"/>
              </a:ext>
            </a:extLst>
          </p:cNvPr>
          <p:cNvSpPr/>
          <p:nvPr/>
        </p:nvSpPr>
        <p:spPr>
          <a:xfrm>
            <a:off x="8491981" y="2498873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5" name="椭圆 184">
            <a:extLst>
              <a:ext uri="{FF2B5EF4-FFF2-40B4-BE49-F238E27FC236}">
                <a16:creationId xmlns:a16="http://schemas.microsoft.com/office/drawing/2014/main" id="{3A70FBEE-B7D9-48E8-B012-8CA4A55A1306}"/>
              </a:ext>
            </a:extLst>
          </p:cNvPr>
          <p:cNvSpPr/>
          <p:nvPr/>
        </p:nvSpPr>
        <p:spPr>
          <a:xfrm>
            <a:off x="8512029" y="2831753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6" name="椭圆 185">
            <a:extLst>
              <a:ext uri="{FF2B5EF4-FFF2-40B4-BE49-F238E27FC236}">
                <a16:creationId xmlns:a16="http://schemas.microsoft.com/office/drawing/2014/main" id="{2B846EBC-E12A-4F82-A621-07750E4AB56E}"/>
              </a:ext>
            </a:extLst>
          </p:cNvPr>
          <p:cNvSpPr/>
          <p:nvPr/>
        </p:nvSpPr>
        <p:spPr>
          <a:xfrm>
            <a:off x="8435821" y="3224789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9" name="椭圆 198">
            <a:extLst>
              <a:ext uri="{FF2B5EF4-FFF2-40B4-BE49-F238E27FC236}">
                <a16:creationId xmlns:a16="http://schemas.microsoft.com/office/drawing/2014/main" id="{13C1F204-C2F7-48AE-BD4A-10553F5C42A3}"/>
              </a:ext>
            </a:extLst>
          </p:cNvPr>
          <p:cNvSpPr/>
          <p:nvPr/>
        </p:nvSpPr>
        <p:spPr>
          <a:xfrm>
            <a:off x="9282085" y="918701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1" name="椭圆 200">
            <a:extLst>
              <a:ext uri="{FF2B5EF4-FFF2-40B4-BE49-F238E27FC236}">
                <a16:creationId xmlns:a16="http://schemas.microsoft.com/office/drawing/2014/main" id="{2338E8FF-563A-4516-A356-56C8E7731DFB}"/>
              </a:ext>
            </a:extLst>
          </p:cNvPr>
          <p:cNvSpPr/>
          <p:nvPr/>
        </p:nvSpPr>
        <p:spPr>
          <a:xfrm>
            <a:off x="9326197" y="1323769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3" name="椭圆 202">
            <a:extLst>
              <a:ext uri="{FF2B5EF4-FFF2-40B4-BE49-F238E27FC236}">
                <a16:creationId xmlns:a16="http://schemas.microsoft.com/office/drawing/2014/main" id="{D651F704-1819-481B-B8D1-648FA8A145A6}"/>
              </a:ext>
            </a:extLst>
          </p:cNvPr>
          <p:cNvSpPr/>
          <p:nvPr/>
        </p:nvSpPr>
        <p:spPr>
          <a:xfrm>
            <a:off x="9310149" y="1704777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5" name="椭圆 204">
            <a:extLst>
              <a:ext uri="{FF2B5EF4-FFF2-40B4-BE49-F238E27FC236}">
                <a16:creationId xmlns:a16="http://schemas.microsoft.com/office/drawing/2014/main" id="{6DCC5A3A-9829-4CB8-9F0B-2DC2C83F3F63}"/>
              </a:ext>
            </a:extLst>
          </p:cNvPr>
          <p:cNvSpPr/>
          <p:nvPr/>
        </p:nvSpPr>
        <p:spPr>
          <a:xfrm>
            <a:off x="9306133" y="2145945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7" name="椭圆 206">
            <a:extLst>
              <a:ext uri="{FF2B5EF4-FFF2-40B4-BE49-F238E27FC236}">
                <a16:creationId xmlns:a16="http://schemas.microsoft.com/office/drawing/2014/main" id="{C3D003D0-E158-45F0-9D25-824245DAD411}"/>
              </a:ext>
            </a:extLst>
          </p:cNvPr>
          <p:cNvSpPr/>
          <p:nvPr/>
        </p:nvSpPr>
        <p:spPr>
          <a:xfrm>
            <a:off x="9318165" y="2494857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9" name="椭圆 208">
            <a:extLst>
              <a:ext uri="{FF2B5EF4-FFF2-40B4-BE49-F238E27FC236}">
                <a16:creationId xmlns:a16="http://schemas.microsoft.com/office/drawing/2014/main" id="{7DED0BCC-D9F4-4790-9FD9-3D806376CC29}"/>
              </a:ext>
            </a:extLst>
          </p:cNvPr>
          <p:cNvSpPr/>
          <p:nvPr/>
        </p:nvSpPr>
        <p:spPr>
          <a:xfrm>
            <a:off x="9338213" y="2863833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1" name="椭圆 210">
            <a:extLst>
              <a:ext uri="{FF2B5EF4-FFF2-40B4-BE49-F238E27FC236}">
                <a16:creationId xmlns:a16="http://schemas.microsoft.com/office/drawing/2014/main" id="{8CA4060E-84B7-4599-87ED-7AFC0B9C6E23}"/>
              </a:ext>
            </a:extLst>
          </p:cNvPr>
          <p:cNvSpPr/>
          <p:nvPr/>
        </p:nvSpPr>
        <p:spPr>
          <a:xfrm>
            <a:off x="9322165" y="3244837"/>
            <a:ext cx="223733" cy="216000"/>
          </a:xfrm>
          <a:prstGeom prst="ellipse">
            <a:avLst/>
          </a:prstGeom>
          <a:noFill/>
          <a:ln w="63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53053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109">
            <a:extLst>
              <a:ext uri="{FF2B5EF4-FFF2-40B4-BE49-F238E27FC236}">
                <a16:creationId xmlns:a16="http://schemas.microsoft.com/office/drawing/2014/main" id="{F7CEA3EA-B344-861A-DF5B-88C236549472}"/>
              </a:ext>
            </a:extLst>
          </p:cNvPr>
          <p:cNvSpPr txBox="1"/>
          <p:nvPr/>
        </p:nvSpPr>
        <p:spPr>
          <a:xfrm>
            <a:off x="3070721" y="5345211"/>
            <a:ext cx="899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ACTIN</a:t>
            </a:r>
          </a:p>
        </p:txBody>
      </p:sp>
      <p:sp>
        <p:nvSpPr>
          <p:cNvPr id="12" name="TextBox 110">
            <a:extLst>
              <a:ext uri="{FF2B5EF4-FFF2-40B4-BE49-F238E27FC236}">
                <a16:creationId xmlns:a16="http://schemas.microsoft.com/office/drawing/2014/main" id="{DFDD131E-ECA5-984D-0F86-96F2D8EB88AF}"/>
              </a:ext>
            </a:extLst>
          </p:cNvPr>
          <p:cNvSpPr txBox="1"/>
          <p:nvPr/>
        </p:nvSpPr>
        <p:spPr>
          <a:xfrm>
            <a:off x="2603403" y="4975879"/>
            <a:ext cx="1366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AMIR DNA</a:t>
            </a:r>
          </a:p>
        </p:txBody>
      </p:sp>
      <p:sp>
        <p:nvSpPr>
          <p:cNvPr id="24" name="Rectangle 118">
            <a:extLst>
              <a:ext uri="{FF2B5EF4-FFF2-40B4-BE49-F238E27FC236}">
                <a16:creationId xmlns:a16="http://schemas.microsoft.com/office/drawing/2014/main" id="{E53CF1D6-22F5-4278-26BA-7CE3744382CC}"/>
              </a:ext>
            </a:extLst>
          </p:cNvPr>
          <p:cNvSpPr/>
          <p:nvPr/>
        </p:nvSpPr>
        <p:spPr>
          <a:xfrm>
            <a:off x="2522396" y="2134400"/>
            <a:ext cx="1447799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 err="1"/>
              <a:t>TYLCVAxV</a:t>
            </a:r>
            <a:endParaRPr lang="en-US" b="1" dirty="0"/>
          </a:p>
        </p:txBody>
      </p:sp>
      <p:sp>
        <p:nvSpPr>
          <p:cNvPr id="28" name="Rectangle 122">
            <a:extLst>
              <a:ext uri="{FF2B5EF4-FFF2-40B4-BE49-F238E27FC236}">
                <a16:creationId xmlns:a16="http://schemas.microsoft.com/office/drawing/2014/main" id="{4BD84BF3-FCA9-3E21-B89E-FB423AFB8A98}"/>
              </a:ext>
            </a:extLst>
          </p:cNvPr>
          <p:cNvSpPr/>
          <p:nvPr/>
        </p:nvSpPr>
        <p:spPr>
          <a:xfrm>
            <a:off x="2522395" y="1697240"/>
            <a:ext cx="144780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TYLCVGUV</a:t>
            </a:r>
          </a:p>
        </p:txBody>
      </p:sp>
      <p:sp>
        <p:nvSpPr>
          <p:cNvPr id="29" name="Rectangle 123">
            <a:extLst>
              <a:ext uri="{FF2B5EF4-FFF2-40B4-BE49-F238E27FC236}">
                <a16:creationId xmlns:a16="http://schemas.microsoft.com/office/drawing/2014/main" id="{5F2FF086-DFBA-BD5A-A4B7-EBD498B3EC46}"/>
              </a:ext>
            </a:extLst>
          </p:cNvPr>
          <p:cNvSpPr/>
          <p:nvPr/>
        </p:nvSpPr>
        <p:spPr>
          <a:xfrm>
            <a:off x="2633745" y="2592311"/>
            <a:ext cx="133645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TYLCVCID</a:t>
            </a:r>
          </a:p>
        </p:txBody>
      </p:sp>
      <p:sp>
        <p:nvSpPr>
          <p:cNvPr id="33" name="Rectangle 127">
            <a:extLst>
              <a:ext uri="{FF2B5EF4-FFF2-40B4-BE49-F238E27FC236}">
                <a16:creationId xmlns:a16="http://schemas.microsoft.com/office/drawing/2014/main" id="{6CAE5A3B-DB3D-DD38-CE50-9D6774EA4312}"/>
              </a:ext>
            </a:extLst>
          </p:cNvPr>
          <p:cNvSpPr/>
          <p:nvPr/>
        </p:nvSpPr>
        <p:spPr>
          <a:xfrm>
            <a:off x="2486299" y="3583728"/>
            <a:ext cx="1483896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TYLCVMAV</a:t>
            </a:r>
          </a:p>
        </p:txBody>
      </p:sp>
      <p:sp>
        <p:nvSpPr>
          <p:cNvPr id="37" name="Rectangle 131">
            <a:extLst>
              <a:ext uri="{FF2B5EF4-FFF2-40B4-BE49-F238E27FC236}">
                <a16:creationId xmlns:a16="http://schemas.microsoft.com/office/drawing/2014/main" id="{073FD023-AE20-4C86-7D4F-9354D6FE07F3}"/>
              </a:ext>
            </a:extLst>
          </p:cNvPr>
          <p:cNvSpPr/>
          <p:nvPr/>
        </p:nvSpPr>
        <p:spPr>
          <a:xfrm>
            <a:off x="2545601" y="3078739"/>
            <a:ext cx="1424594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TYLCVCSV</a:t>
            </a:r>
          </a:p>
        </p:txBody>
      </p:sp>
      <p:sp>
        <p:nvSpPr>
          <p:cNvPr id="59" name="Rectangle 135">
            <a:extLst>
              <a:ext uri="{FF2B5EF4-FFF2-40B4-BE49-F238E27FC236}">
                <a16:creationId xmlns:a16="http://schemas.microsoft.com/office/drawing/2014/main" id="{EF86A042-4792-74B7-F5CB-F4BEFAD97018}"/>
              </a:ext>
            </a:extLst>
          </p:cNvPr>
          <p:cNvSpPr/>
          <p:nvPr/>
        </p:nvSpPr>
        <p:spPr>
          <a:xfrm>
            <a:off x="2540875" y="4126983"/>
            <a:ext cx="142932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TYLCVKAV</a:t>
            </a:r>
          </a:p>
        </p:txBody>
      </p:sp>
      <p:sp>
        <p:nvSpPr>
          <p:cNvPr id="66" name="Rectangle 139">
            <a:extLst>
              <a:ext uri="{FF2B5EF4-FFF2-40B4-BE49-F238E27FC236}">
                <a16:creationId xmlns:a16="http://schemas.microsoft.com/office/drawing/2014/main" id="{81067270-FFBB-3EC8-D6B4-B85F37EBFDA9}"/>
              </a:ext>
            </a:extLst>
          </p:cNvPr>
          <p:cNvSpPr/>
          <p:nvPr/>
        </p:nvSpPr>
        <p:spPr>
          <a:xfrm>
            <a:off x="2540875" y="4551431"/>
            <a:ext cx="142932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TYLCVMLV</a:t>
            </a:r>
          </a:p>
        </p:txBody>
      </p:sp>
      <p:sp>
        <p:nvSpPr>
          <p:cNvPr id="70" name="TextBox 143">
            <a:extLst>
              <a:ext uri="{FF2B5EF4-FFF2-40B4-BE49-F238E27FC236}">
                <a16:creationId xmlns:a16="http://schemas.microsoft.com/office/drawing/2014/main" id="{6D12E49D-FF0A-822C-01D1-234CCDF28F4B}"/>
              </a:ext>
            </a:extLst>
          </p:cNvPr>
          <p:cNvSpPr txBox="1"/>
          <p:nvPr/>
        </p:nvSpPr>
        <p:spPr>
          <a:xfrm rot="19174352">
            <a:off x="3957689" y="916273"/>
            <a:ext cx="1107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 AMIN14 </a:t>
            </a:r>
          </a:p>
        </p:txBody>
      </p:sp>
      <p:graphicFrame>
        <p:nvGraphicFramePr>
          <p:cNvPr id="75" name="对象 74">
            <a:extLst>
              <a:ext uri="{FF2B5EF4-FFF2-40B4-BE49-F238E27FC236}">
                <a16:creationId xmlns:a16="http://schemas.microsoft.com/office/drawing/2014/main" id="{0A70B034-835F-4B14-7A7C-81711B247E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5579929"/>
              </p:ext>
            </p:extLst>
          </p:nvPr>
        </p:nvGraphicFramePr>
        <p:xfrm>
          <a:off x="4016918" y="1595492"/>
          <a:ext cx="1447200" cy="4316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3" imgW="1447560" imgH="431640" progId="Photoshop.Image.13">
                  <p:embed/>
                </p:oleObj>
              </mc:Choice>
              <mc:Fallback>
                <p:oleObj name="Image" r:id="rId3" imgW="1447560" imgH="431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16918" y="1595492"/>
                        <a:ext cx="1447200" cy="4316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6" name="对象 75">
            <a:extLst>
              <a:ext uri="{FF2B5EF4-FFF2-40B4-BE49-F238E27FC236}">
                <a16:creationId xmlns:a16="http://schemas.microsoft.com/office/drawing/2014/main" id="{A15B455C-FE9B-5691-D3F2-548058FC406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8255962"/>
              </p:ext>
            </p:extLst>
          </p:nvPr>
        </p:nvGraphicFramePr>
        <p:xfrm>
          <a:off x="4016918" y="2076279"/>
          <a:ext cx="1447200" cy="4316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5" imgW="1409400" imgH="431640" progId="Photoshop.Image.13">
                  <p:embed/>
                </p:oleObj>
              </mc:Choice>
              <mc:Fallback>
                <p:oleObj name="Image" r:id="rId5" imgW="1409400" imgH="431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16918" y="2076279"/>
                        <a:ext cx="1447200" cy="4316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7" name="对象 76">
            <a:extLst>
              <a:ext uri="{FF2B5EF4-FFF2-40B4-BE49-F238E27FC236}">
                <a16:creationId xmlns:a16="http://schemas.microsoft.com/office/drawing/2014/main" id="{24735C9A-FB34-15F3-AB60-4C685946719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72573647"/>
              </p:ext>
            </p:extLst>
          </p:nvPr>
        </p:nvGraphicFramePr>
        <p:xfrm>
          <a:off x="4016918" y="2572003"/>
          <a:ext cx="1447200" cy="4062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7" imgW="1409400" imgH="406080" progId="Photoshop.Image.13">
                  <p:embed/>
                </p:oleObj>
              </mc:Choice>
              <mc:Fallback>
                <p:oleObj name="Image" r:id="rId7" imgW="1409400" imgH="4060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016918" y="2572003"/>
                        <a:ext cx="1447200" cy="4062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8" name="对象 77">
            <a:extLst>
              <a:ext uri="{FF2B5EF4-FFF2-40B4-BE49-F238E27FC236}">
                <a16:creationId xmlns:a16="http://schemas.microsoft.com/office/drawing/2014/main" id="{7EDEE0A6-F898-9873-9ADF-0CAD7090C9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7728634"/>
              </p:ext>
            </p:extLst>
          </p:nvPr>
        </p:nvGraphicFramePr>
        <p:xfrm>
          <a:off x="4016918" y="3044840"/>
          <a:ext cx="1447200" cy="425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9" imgW="1396800" imgH="419040" progId="Photoshop.Image.13">
                  <p:embed/>
                </p:oleObj>
              </mc:Choice>
              <mc:Fallback>
                <p:oleObj name="Image" r:id="rId9" imgW="1396800" imgH="4190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016918" y="3044840"/>
                        <a:ext cx="1447200" cy="425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9" name="对象 78">
            <a:extLst>
              <a:ext uri="{FF2B5EF4-FFF2-40B4-BE49-F238E27FC236}">
                <a16:creationId xmlns:a16="http://schemas.microsoft.com/office/drawing/2014/main" id="{157E723A-9EA2-669E-7B66-EC9855EE68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4746264"/>
              </p:ext>
            </p:extLst>
          </p:nvPr>
        </p:nvGraphicFramePr>
        <p:xfrm>
          <a:off x="4016918" y="3543424"/>
          <a:ext cx="1447200" cy="4134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11" imgW="1422000" imgH="406080" progId="Photoshop.Image.13">
                  <p:embed/>
                </p:oleObj>
              </mc:Choice>
              <mc:Fallback>
                <p:oleObj name="Image" r:id="rId11" imgW="1422000" imgH="4060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016918" y="3543424"/>
                        <a:ext cx="1447200" cy="4134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0" name="对象 79">
            <a:extLst>
              <a:ext uri="{FF2B5EF4-FFF2-40B4-BE49-F238E27FC236}">
                <a16:creationId xmlns:a16="http://schemas.microsoft.com/office/drawing/2014/main" id="{088E9C6B-BB81-728A-307D-7053FCF975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9452596"/>
              </p:ext>
            </p:extLst>
          </p:nvPr>
        </p:nvGraphicFramePr>
        <p:xfrm>
          <a:off x="4016918" y="4013044"/>
          <a:ext cx="1447200" cy="4678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13" imgW="1396800" imgH="456840" progId="Photoshop.Image.13">
                  <p:embed/>
                </p:oleObj>
              </mc:Choice>
              <mc:Fallback>
                <p:oleObj name="Image" r:id="rId13" imgW="1396800" imgH="4568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016918" y="4013044"/>
                        <a:ext cx="1447200" cy="4678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1" name="对象 80">
            <a:extLst>
              <a:ext uri="{FF2B5EF4-FFF2-40B4-BE49-F238E27FC236}">
                <a16:creationId xmlns:a16="http://schemas.microsoft.com/office/drawing/2014/main" id="{CD1648CF-C5A8-A887-82D2-3677CB6887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9437045"/>
              </p:ext>
            </p:extLst>
          </p:nvPr>
        </p:nvGraphicFramePr>
        <p:xfrm>
          <a:off x="4016918" y="4533464"/>
          <a:ext cx="1447200" cy="3946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15" imgW="1396800" imgH="380880" progId="Photoshop.Image.13">
                  <p:embed/>
                </p:oleObj>
              </mc:Choice>
              <mc:Fallback>
                <p:oleObj name="Image" r:id="rId15" imgW="1396800" imgH="3808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016918" y="4533464"/>
                        <a:ext cx="1447200" cy="3946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2" name="Picture 3">
            <a:extLst>
              <a:ext uri="{FF2B5EF4-FFF2-40B4-BE49-F238E27FC236}">
                <a16:creationId xmlns:a16="http://schemas.microsoft.com/office/drawing/2014/main" id="{E0FCC883-E837-76FD-828A-5E2793B69D8B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12627" t="29034" r="7586" b="49498"/>
          <a:stretch/>
        </p:blipFill>
        <p:spPr>
          <a:xfrm>
            <a:off x="4016918" y="4977940"/>
            <a:ext cx="1447200" cy="316434"/>
          </a:xfrm>
          <a:prstGeom prst="rect">
            <a:avLst/>
          </a:prstGeom>
        </p:spPr>
      </p:pic>
      <p:pic>
        <p:nvPicPr>
          <p:cNvPr id="83" name="Picture 2">
            <a:extLst>
              <a:ext uri="{FF2B5EF4-FFF2-40B4-BE49-F238E27FC236}">
                <a16:creationId xmlns:a16="http://schemas.microsoft.com/office/drawing/2014/main" id="{E063C60E-4472-CACF-5C1E-9A922C866AAA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9423" t="25294" r="22539" b="47517"/>
          <a:stretch/>
        </p:blipFill>
        <p:spPr>
          <a:xfrm>
            <a:off x="4016918" y="5384644"/>
            <a:ext cx="1447200" cy="351528"/>
          </a:xfrm>
          <a:prstGeom prst="rect">
            <a:avLst/>
          </a:prstGeom>
        </p:spPr>
      </p:pic>
      <p:sp>
        <p:nvSpPr>
          <p:cNvPr id="84" name="TextBox 143">
            <a:extLst>
              <a:ext uri="{FF2B5EF4-FFF2-40B4-BE49-F238E27FC236}">
                <a16:creationId xmlns:a16="http://schemas.microsoft.com/office/drawing/2014/main" id="{EDEBA785-CB4A-6965-3710-9700DC892755}"/>
              </a:ext>
            </a:extLst>
          </p:cNvPr>
          <p:cNvSpPr txBox="1"/>
          <p:nvPr/>
        </p:nvSpPr>
        <p:spPr>
          <a:xfrm rot="19174352">
            <a:off x="4499091" y="916273"/>
            <a:ext cx="1107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 AMIE14 </a:t>
            </a:r>
          </a:p>
        </p:txBody>
      </p:sp>
      <p:sp>
        <p:nvSpPr>
          <p:cNvPr id="85" name="TextBox 143">
            <a:extLst>
              <a:ext uri="{FF2B5EF4-FFF2-40B4-BE49-F238E27FC236}">
                <a16:creationId xmlns:a16="http://schemas.microsoft.com/office/drawing/2014/main" id="{3B026C97-D821-FE2F-8BF5-6626F6B5B65E}"/>
              </a:ext>
            </a:extLst>
          </p:cNvPr>
          <p:cNvSpPr txBox="1"/>
          <p:nvPr/>
        </p:nvSpPr>
        <p:spPr>
          <a:xfrm rot="19174352">
            <a:off x="5000690" y="916273"/>
            <a:ext cx="1107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 WT</a:t>
            </a:r>
          </a:p>
        </p:txBody>
      </p: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711983C9-8CB1-3D7B-1463-51ADD913A3A0}"/>
              </a:ext>
            </a:extLst>
          </p:cNvPr>
          <p:cNvCxnSpPr>
            <a:cxnSpLocks/>
          </p:cNvCxnSpPr>
          <p:nvPr/>
        </p:nvCxnSpPr>
        <p:spPr>
          <a:xfrm>
            <a:off x="4078727" y="1522658"/>
            <a:ext cx="42164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EC895D65-DEAE-838B-D08B-F453B673E9D3}"/>
              </a:ext>
            </a:extLst>
          </p:cNvPr>
          <p:cNvCxnSpPr>
            <a:cxnSpLocks/>
          </p:cNvCxnSpPr>
          <p:nvPr/>
        </p:nvCxnSpPr>
        <p:spPr>
          <a:xfrm>
            <a:off x="4540351" y="1522658"/>
            <a:ext cx="42164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5CFEDCEF-FA73-E8AC-A602-C53220CDACC1}"/>
              </a:ext>
            </a:extLst>
          </p:cNvPr>
          <p:cNvCxnSpPr>
            <a:cxnSpLocks/>
          </p:cNvCxnSpPr>
          <p:nvPr/>
        </p:nvCxnSpPr>
        <p:spPr>
          <a:xfrm>
            <a:off x="5001974" y="1522658"/>
            <a:ext cx="42164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7873,&quot;width&quot;:6224}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10800,&quot;width&quot;:16199}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0</TotalTime>
  <Words>802</Words>
  <Application>Microsoft Office PowerPoint</Application>
  <PresentationFormat>宽屏</PresentationFormat>
  <Paragraphs>197</Paragraphs>
  <Slides>10</Slides>
  <Notes>5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6" baseType="lpstr">
      <vt:lpstr>等线</vt:lpstr>
      <vt:lpstr>Arial</vt:lpstr>
      <vt:lpstr>Courier New</vt:lpstr>
      <vt:lpstr>Wingdings</vt:lpstr>
      <vt:lpstr>Office 主题​​</vt:lpstr>
      <vt:lpstr>Adobe Photoshop Imag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lenovo</dc:creator>
  <cp:lastModifiedBy>lenovo</cp:lastModifiedBy>
  <cp:revision>170</cp:revision>
  <dcterms:created xsi:type="dcterms:W3CDTF">2019-06-19T02:08:00Z</dcterms:created>
  <dcterms:modified xsi:type="dcterms:W3CDTF">2023-05-28T11:38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828</vt:lpwstr>
  </property>
</Properties>
</file>